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6AAE075-5F84-486F-943C-038E0CB5B1B3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94CA28E-345B-440F-9A3E-B014A6FF6295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EB177BF-FDCE-4760-B265-4ADD9B992B1B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ADFDA34-D311-48BE-A6C1-43E098B3C1D1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398E958-BA2A-4B40-9ABA-C92EC0DB96C5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4B60A90-813D-43FE-93FB-FC6DD9275075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70EA0FC-A107-493E-A0D9-F59D928A00E2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4941FC3-AB42-4D20-85CC-5A74DF278EA3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A667254-283C-4709-B87D-73FBB027CBA4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9C0CC93-0B41-4BFA-B4CE-0F4243489E5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A732312-5E22-428A-AF6B-BE8AB1A807D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A8C466B-F572-42FA-98C5-880DB6077A3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326440"/>
            <a:ext cx="217152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1B433AD1-E1BD-4A8C-831E-24DB3C79FD2C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slideLayout" Target="../slideLayouts/slideLayout2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" descr=""/>
          <p:cNvPicPr/>
          <p:nvPr/>
        </p:nvPicPr>
        <p:blipFill>
          <a:blip r:embed="rId1"/>
          <a:stretch/>
        </p:blipFill>
        <p:spPr>
          <a:xfrm>
            <a:off x="2138400" y="2293920"/>
            <a:ext cx="3070080" cy="2170080"/>
          </a:xfrm>
          <a:prstGeom prst="rect">
            <a:avLst/>
          </a:prstGeom>
          <a:ln w="0">
            <a:noFill/>
          </a:ln>
        </p:spPr>
      </p:pic>
      <p:sp>
        <p:nvSpPr>
          <p:cNvPr id="42" name=""/>
          <p:cNvSpPr/>
          <p:nvPr/>
        </p:nvSpPr>
        <p:spPr>
          <a:xfrm>
            <a:off x="2519280" y="474840"/>
            <a:ext cx="157176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ff0000"/>
                </a:solidFill>
                <a:latin typeface="Arial"/>
              </a:rPr>
              <a:t>Memory neuron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"/>
          <p:cNvSpPr/>
          <p:nvPr/>
        </p:nvSpPr>
        <p:spPr>
          <a:xfrm>
            <a:off x="3631320" y="1440000"/>
            <a:ext cx="1222200" cy="267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1000" spc="-1" strike="noStrike">
                <a:solidFill>
                  <a:srgbClr val="000000"/>
                </a:solidFill>
                <a:latin typeface="Arial"/>
              </a:rPr>
              <a:t>I</a:t>
            </a:r>
            <a:r>
              <a:rPr b="0" i="1" lang="en-US" sz="1000" spc="-1" strike="noStrike" baseline="-25000">
                <a:solidFill>
                  <a:srgbClr val="000000"/>
                </a:solidFill>
                <a:latin typeface="Arial"/>
              </a:rPr>
              <a:t>Att</a:t>
            </a:r>
            <a:r>
              <a:rPr b="0" i="1" lang="en-US" sz="1000" spc="-1" strike="noStrike">
                <a:solidFill>
                  <a:srgbClr val="000000"/>
                </a:solidFill>
                <a:latin typeface="Arial"/>
              </a:rPr>
              <a:t>= 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0.95</a:t>
            </a:r>
            <a:r>
              <a:rPr b="0" i="1" lang="en-US" sz="1000" spc="-1" strike="noStrike">
                <a:solidFill>
                  <a:srgbClr val="000000"/>
                </a:solidFill>
                <a:latin typeface="Arial"/>
              </a:rPr>
              <a:t>; I</a:t>
            </a:r>
            <a:r>
              <a:rPr b="0" i="1" lang="en-US" sz="1000" spc="-1" strike="noStrike" baseline="-25000">
                <a:solidFill>
                  <a:srgbClr val="000000"/>
                </a:solidFill>
                <a:latin typeface="Arial"/>
              </a:rPr>
              <a:t>Rem </a:t>
            </a:r>
            <a:r>
              <a:rPr b="0" i="1" lang="en-US" sz="1000" spc="-1" strike="noStrike">
                <a:solidFill>
                  <a:srgbClr val="000000"/>
                </a:solidFill>
                <a:latin typeface="Arial"/>
              </a:rPr>
              <a:t>= 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2.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"/>
          <p:cNvSpPr/>
          <p:nvPr/>
        </p:nvSpPr>
        <p:spPr>
          <a:xfrm>
            <a:off x="3579480" y="1168560"/>
            <a:ext cx="10357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1000" spc="-1" strike="noStrike">
                <a:solidFill>
                  <a:srgbClr val="000000"/>
                </a:solidFill>
                <a:latin typeface="Arial"/>
              </a:rPr>
              <a:t>F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 =</a:t>
            </a:r>
            <a:r>
              <a:rPr b="0" lang="ru-RU" sz="10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14 spikes/s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45" name=""/>
          <p:cNvGrpSpPr/>
          <p:nvPr/>
        </p:nvGrpSpPr>
        <p:grpSpPr>
          <a:xfrm>
            <a:off x="2725200" y="1058760"/>
            <a:ext cx="860760" cy="858600"/>
            <a:chOff x="2725200" y="1058760"/>
            <a:chExt cx="860760" cy="858600"/>
          </a:xfrm>
        </p:grpSpPr>
        <p:sp>
          <p:nvSpPr>
            <p:cNvPr id="46" name=""/>
            <p:cNvSpPr/>
            <p:nvPr/>
          </p:nvSpPr>
          <p:spPr>
            <a:xfrm>
              <a:off x="2725200" y="1916280"/>
              <a:ext cx="1080" cy="1080"/>
            </a:xfrm>
            <a:prstGeom prst="line">
              <a:avLst/>
            </a:prstGeom>
            <a:ln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" name=""/>
            <p:cNvSpPr/>
            <p:nvPr/>
          </p:nvSpPr>
          <p:spPr>
            <a:xfrm>
              <a:off x="2725200" y="1058760"/>
              <a:ext cx="214560" cy="213840"/>
            </a:xfrm>
            <a:prstGeom prst="rect">
              <a:avLst/>
            </a:prstGeom>
            <a:noFill/>
            <a:ln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" name=""/>
            <p:cNvSpPr/>
            <p:nvPr/>
          </p:nvSpPr>
          <p:spPr>
            <a:xfrm>
              <a:off x="2744280" y="1077480"/>
              <a:ext cx="175680" cy="174600"/>
            </a:xfrm>
            <a:custGeom>
              <a:avLst/>
              <a:gdLst/>
              <a:ahLst/>
              <a:rect l="l" t="t" r="r" b="b"/>
              <a:pathLst>
                <a:path w="3355" h="3341">
                  <a:moveTo>
                    <a:pt x="3355" y="1677"/>
                  </a:moveTo>
                  <a:lnTo>
                    <a:pt x="3341" y="1636"/>
                  </a:lnTo>
                  <a:lnTo>
                    <a:pt x="3341" y="1608"/>
                  </a:lnTo>
                  <a:lnTo>
                    <a:pt x="3341" y="1582"/>
                  </a:lnTo>
                  <a:lnTo>
                    <a:pt x="3341" y="1554"/>
                  </a:lnTo>
                  <a:lnTo>
                    <a:pt x="3341" y="1526"/>
                  </a:lnTo>
                  <a:lnTo>
                    <a:pt x="3341" y="1498"/>
                  </a:lnTo>
                  <a:lnTo>
                    <a:pt x="3341" y="1472"/>
                  </a:lnTo>
                  <a:lnTo>
                    <a:pt x="3328" y="1444"/>
                  </a:lnTo>
                  <a:lnTo>
                    <a:pt x="3328" y="1403"/>
                  </a:lnTo>
                  <a:lnTo>
                    <a:pt x="3328" y="1375"/>
                  </a:lnTo>
                  <a:lnTo>
                    <a:pt x="3314" y="1347"/>
                  </a:lnTo>
                  <a:lnTo>
                    <a:pt x="3314" y="1320"/>
                  </a:lnTo>
                  <a:lnTo>
                    <a:pt x="3300" y="1293"/>
                  </a:lnTo>
                  <a:lnTo>
                    <a:pt x="3300" y="1265"/>
                  </a:lnTo>
                  <a:lnTo>
                    <a:pt x="3286" y="1237"/>
                  </a:lnTo>
                  <a:lnTo>
                    <a:pt x="3286" y="1210"/>
                  </a:lnTo>
                  <a:lnTo>
                    <a:pt x="3273" y="1182"/>
                  </a:lnTo>
                  <a:lnTo>
                    <a:pt x="3273" y="1155"/>
                  </a:lnTo>
                  <a:lnTo>
                    <a:pt x="3259" y="1128"/>
                  </a:lnTo>
                  <a:lnTo>
                    <a:pt x="3245" y="1100"/>
                  </a:lnTo>
                  <a:lnTo>
                    <a:pt x="3231" y="1072"/>
                  </a:lnTo>
                  <a:lnTo>
                    <a:pt x="3231" y="1045"/>
                  </a:lnTo>
                  <a:lnTo>
                    <a:pt x="3217" y="1018"/>
                  </a:lnTo>
                  <a:lnTo>
                    <a:pt x="3204" y="990"/>
                  </a:lnTo>
                  <a:lnTo>
                    <a:pt x="3190" y="962"/>
                  </a:lnTo>
                  <a:lnTo>
                    <a:pt x="3176" y="935"/>
                  </a:lnTo>
                  <a:lnTo>
                    <a:pt x="3163" y="908"/>
                  </a:lnTo>
                  <a:lnTo>
                    <a:pt x="3149" y="880"/>
                  </a:lnTo>
                  <a:lnTo>
                    <a:pt x="3135" y="852"/>
                  </a:lnTo>
                  <a:lnTo>
                    <a:pt x="3122" y="839"/>
                  </a:lnTo>
                  <a:lnTo>
                    <a:pt x="3107" y="811"/>
                  </a:lnTo>
                  <a:lnTo>
                    <a:pt x="3094" y="783"/>
                  </a:lnTo>
                  <a:lnTo>
                    <a:pt x="3080" y="757"/>
                  </a:lnTo>
                  <a:lnTo>
                    <a:pt x="3066" y="729"/>
                  </a:lnTo>
                  <a:lnTo>
                    <a:pt x="3038" y="715"/>
                  </a:lnTo>
                  <a:lnTo>
                    <a:pt x="3025" y="688"/>
                  </a:lnTo>
                  <a:lnTo>
                    <a:pt x="3012" y="660"/>
                  </a:lnTo>
                  <a:lnTo>
                    <a:pt x="2997" y="632"/>
                  </a:lnTo>
                  <a:lnTo>
                    <a:pt x="2971" y="619"/>
                  </a:lnTo>
                  <a:lnTo>
                    <a:pt x="2956" y="591"/>
                  </a:lnTo>
                  <a:lnTo>
                    <a:pt x="2943" y="564"/>
                  </a:lnTo>
                  <a:lnTo>
                    <a:pt x="2915" y="550"/>
                  </a:lnTo>
                  <a:lnTo>
                    <a:pt x="2902" y="522"/>
                  </a:lnTo>
                  <a:lnTo>
                    <a:pt x="2874" y="509"/>
                  </a:lnTo>
                  <a:lnTo>
                    <a:pt x="2860" y="481"/>
                  </a:lnTo>
                  <a:lnTo>
                    <a:pt x="2833" y="467"/>
                  </a:lnTo>
                  <a:lnTo>
                    <a:pt x="2818" y="440"/>
                  </a:lnTo>
                  <a:lnTo>
                    <a:pt x="2792" y="426"/>
                  </a:lnTo>
                  <a:lnTo>
                    <a:pt x="2777" y="399"/>
                  </a:lnTo>
                  <a:lnTo>
                    <a:pt x="2750" y="385"/>
                  </a:lnTo>
                  <a:lnTo>
                    <a:pt x="2723" y="371"/>
                  </a:lnTo>
                  <a:lnTo>
                    <a:pt x="2709" y="344"/>
                  </a:lnTo>
                  <a:lnTo>
                    <a:pt x="2681" y="330"/>
                  </a:lnTo>
                  <a:lnTo>
                    <a:pt x="2654" y="316"/>
                  </a:lnTo>
                  <a:lnTo>
                    <a:pt x="2626" y="303"/>
                  </a:lnTo>
                  <a:lnTo>
                    <a:pt x="2613" y="275"/>
                  </a:lnTo>
                  <a:lnTo>
                    <a:pt x="2585" y="262"/>
                  </a:lnTo>
                  <a:lnTo>
                    <a:pt x="2558" y="247"/>
                  </a:lnTo>
                  <a:lnTo>
                    <a:pt x="2530" y="234"/>
                  </a:lnTo>
                  <a:lnTo>
                    <a:pt x="2516" y="220"/>
                  </a:lnTo>
                  <a:lnTo>
                    <a:pt x="2489" y="206"/>
                  </a:lnTo>
                  <a:lnTo>
                    <a:pt x="2461" y="193"/>
                  </a:lnTo>
                  <a:lnTo>
                    <a:pt x="2434" y="178"/>
                  </a:lnTo>
                  <a:lnTo>
                    <a:pt x="2407" y="165"/>
                  </a:lnTo>
                  <a:lnTo>
                    <a:pt x="2379" y="152"/>
                  </a:lnTo>
                  <a:lnTo>
                    <a:pt x="2351" y="137"/>
                  </a:lnTo>
                  <a:lnTo>
                    <a:pt x="2323" y="124"/>
                  </a:lnTo>
                  <a:lnTo>
                    <a:pt x="2297" y="110"/>
                  </a:lnTo>
                  <a:lnTo>
                    <a:pt x="2269" y="110"/>
                  </a:lnTo>
                  <a:lnTo>
                    <a:pt x="2241" y="96"/>
                  </a:lnTo>
                  <a:lnTo>
                    <a:pt x="2213" y="83"/>
                  </a:lnTo>
                  <a:lnTo>
                    <a:pt x="2187" y="68"/>
                  </a:lnTo>
                  <a:lnTo>
                    <a:pt x="2159" y="68"/>
                  </a:lnTo>
                  <a:lnTo>
                    <a:pt x="2131" y="55"/>
                  </a:lnTo>
                  <a:lnTo>
                    <a:pt x="2103" y="55"/>
                  </a:lnTo>
                  <a:lnTo>
                    <a:pt x="2076" y="42"/>
                  </a:lnTo>
                  <a:lnTo>
                    <a:pt x="2049" y="42"/>
                  </a:lnTo>
                  <a:lnTo>
                    <a:pt x="2021" y="27"/>
                  </a:lnTo>
                  <a:lnTo>
                    <a:pt x="1994" y="27"/>
                  </a:lnTo>
                  <a:lnTo>
                    <a:pt x="1966" y="14"/>
                  </a:lnTo>
                  <a:lnTo>
                    <a:pt x="1939" y="14"/>
                  </a:lnTo>
                  <a:lnTo>
                    <a:pt x="1897" y="14"/>
                  </a:lnTo>
                  <a:lnTo>
                    <a:pt x="1870" y="0"/>
                  </a:lnTo>
                  <a:lnTo>
                    <a:pt x="1843" y="0"/>
                  </a:lnTo>
                  <a:lnTo>
                    <a:pt x="1815" y="0"/>
                  </a:lnTo>
                  <a:lnTo>
                    <a:pt x="1787" y="0"/>
                  </a:lnTo>
                  <a:lnTo>
                    <a:pt x="1760" y="0"/>
                  </a:lnTo>
                  <a:lnTo>
                    <a:pt x="1733" y="0"/>
                  </a:lnTo>
                  <a:lnTo>
                    <a:pt x="1705" y="0"/>
                  </a:lnTo>
                  <a:lnTo>
                    <a:pt x="1677" y="0"/>
                  </a:lnTo>
                  <a:lnTo>
                    <a:pt x="1636" y="0"/>
                  </a:lnTo>
                  <a:lnTo>
                    <a:pt x="1608" y="0"/>
                  </a:lnTo>
                  <a:lnTo>
                    <a:pt x="1582" y="0"/>
                  </a:lnTo>
                  <a:lnTo>
                    <a:pt x="1554" y="0"/>
                  </a:lnTo>
                  <a:lnTo>
                    <a:pt x="1526" y="0"/>
                  </a:lnTo>
                  <a:lnTo>
                    <a:pt x="1498" y="0"/>
                  </a:lnTo>
                  <a:lnTo>
                    <a:pt x="1472" y="0"/>
                  </a:lnTo>
                  <a:lnTo>
                    <a:pt x="1444" y="14"/>
                  </a:lnTo>
                  <a:lnTo>
                    <a:pt x="1403" y="14"/>
                  </a:lnTo>
                  <a:lnTo>
                    <a:pt x="1375" y="14"/>
                  </a:lnTo>
                  <a:lnTo>
                    <a:pt x="1347" y="27"/>
                  </a:lnTo>
                  <a:lnTo>
                    <a:pt x="1320" y="27"/>
                  </a:lnTo>
                  <a:lnTo>
                    <a:pt x="1293" y="42"/>
                  </a:lnTo>
                  <a:lnTo>
                    <a:pt x="1265" y="42"/>
                  </a:lnTo>
                  <a:lnTo>
                    <a:pt x="1237" y="55"/>
                  </a:lnTo>
                  <a:lnTo>
                    <a:pt x="1210" y="55"/>
                  </a:lnTo>
                  <a:lnTo>
                    <a:pt x="1182" y="68"/>
                  </a:lnTo>
                  <a:lnTo>
                    <a:pt x="1155" y="68"/>
                  </a:lnTo>
                  <a:lnTo>
                    <a:pt x="1128" y="83"/>
                  </a:lnTo>
                  <a:lnTo>
                    <a:pt x="1100" y="96"/>
                  </a:lnTo>
                  <a:lnTo>
                    <a:pt x="1072" y="110"/>
                  </a:lnTo>
                  <a:lnTo>
                    <a:pt x="1045" y="110"/>
                  </a:lnTo>
                  <a:lnTo>
                    <a:pt x="1018" y="124"/>
                  </a:lnTo>
                  <a:lnTo>
                    <a:pt x="990" y="137"/>
                  </a:lnTo>
                  <a:lnTo>
                    <a:pt x="962" y="152"/>
                  </a:lnTo>
                  <a:lnTo>
                    <a:pt x="935" y="165"/>
                  </a:lnTo>
                  <a:lnTo>
                    <a:pt x="908" y="178"/>
                  </a:lnTo>
                  <a:lnTo>
                    <a:pt x="880" y="193"/>
                  </a:lnTo>
                  <a:lnTo>
                    <a:pt x="852" y="206"/>
                  </a:lnTo>
                  <a:lnTo>
                    <a:pt x="839" y="220"/>
                  </a:lnTo>
                  <a:lnTo>
                    <a:pt x="811" y="234"/>
                  </a:lnTo>
                  <a:lnTo>
                    <a:pt x="783" y="247"/>
                  </a:lnTo>
                  <a:lnTo>
                    <a:pt x="757" y="262"/>
                  </a:lnTo>
                  <a:lnTo>
                    <a:pt x="729" y="275"/>
                  </a:lnTo>
                  <a:lnTo>
                    <a:pt x="715" y="303"/>
                  </a:lnTo>
                  <a:lnTo>
                    <a:pt x="688" y="316"/>
                  </a:lnTo>
                  <a:lnTo>
                    <a:pt x="660" y="330"/>
                  </a:lnTo>
                  <a:lnTo>
                    <a:pt x="632" y="344"/>
                  </a:lnTo>
                  <a:lnTo>
                    <a:pt x="619" y="371"/>
                  </a:lnTo>
                  <a:lnTo>
                    <a:pt x="591" y="385"/>
                  </a:lnTo>
                  <a:lnTo>
                    <a:pt x="564" y="399"/>
                  </a:lnTo>
                  <a:lnTo>
                    <a:pt x="550" y="426"/>
                  </a:lnTo>
                  <a:lnTo>
                    <a:pt x="522" y="440"/>
                  </a:lnTo>
                  <a:lnTo>
                    <a:pt x="509" y="467"/>
                  </a:lnTo>
                  <a:lnTo>
                    <a:pt x="481" y="481"/>
                  </a:lnTo>
                  <a:lnTo>
                    <a:pt x="467" y="509"/>
                  </a:lnTo>
                  <a:lnTo>
                    <a:pt x="440" y="522"/>
                  </a:lnTo>
                  <a:lnTo>
                    <a:pt x="426" y="550"/>
                  </a:lnTo>
                  <a:lnTo>
                    <a:pt x="399" y="564"/>
                  </a:lnTo>
                  <a:lnTo>
                    <a:pt x="385" y="591"/>
                  </a:lnTo>
                  <a:lnTo>
                    <a:pt x="371" y="619"/>
                  </a:lnTo>
                  <a:lnTo>
                    <a:pt x="344" y="632"/>
                  </a:lnTo>
                  <a:lnTo>
                    <a:pt x="330" y="660"/>
                  </a:lnTo>
                  <a:lnTo>
                    <a:pt x="316" y="688"/>
                  </a:lnTo>
                  <a:lnTo>
                    <a:pt x="303" y="715"/>
                  </a:lnTo>
                  <a:lnTo>
                    <a:pt x="275" y="729"/>
                  </a:lnTo>
                  <a:lnTo>
                    <a:pt x="262" y="757"/>
                  </a:lnTo>
                  <a:lnTo>
                    <a:pt x="247" y="783"/>
                  </a:lnTo>
                  <a:lnTo>
                    <a:pt x="234" y="811"/>
                  </a:lnTo>
                  <a:lnTo>
                    <a:pt x="220" y="825"/>
                  </a:lnTo>
                  <a:lnTo>
                    <a:pt x="206" y="852"/>
                  </a:lnTo>
                  <a:lnTo>
                    <a:pt x="193" y="880"/>
                  </a:lnTo>
                  <a:lnTo>
                    <a:pt x="178" y="908"/>
                  </a:lnTo>
                  <a:lnTo>
                    <a:pt x="165" y="935"/>
                  </a:lnTo>
                  <a:lnTo>
                    <a:pt x="152" y="962"/>
                  </a:lnTo>
                  <a:lnTo>
                    <a:pt x="137" y="990"/>
                  </a:lnTo>
                  <a:lnTo>
                    <a:pt x="124" y="1018"/>
                  </a:lnTo>
                  <a:lnTo>
                    <a:pt x="110" y="1045"/>
                  </a:lnTo>
                  <a:lnTo>
                    <a:pt x="110" y="1072"/>
                  </a:lnTo>
                  <a:lnTo>
                    <a:pt x="96" y="1100"/>
                  </a:lnTo>
                  <a:lnTo>
                    <a:pt x="83" y="1128"/>
                  </a:lnTo>
                  <a:lnTo>
                    <a:pt x="68" y="1155"/>
                  </a:lnTo>
                  <a:lnTo>
                    <a:pt x="68" y="1182"/>
                  </a:lnTo>
                  <a:lnTo>
                    <a:pt x="55" y="1210"/>
                  </a:lnTo>
                  <a:lnTo>
                    <a:pt x="55" y="1237"/>
                  </a:lnTo>
                  <a:lnTo>
                    <a:pt x="42" y="1265"/>
                  </a:lnTo>
                  <a:lnTo>
                    <a:pt x="42" y="1293"/>
                  </a:lnTo>
                  <a:lnTo>
                    <a:pt x="27" y="1320"/>
                  </a:lnTo>
                  <a:lnTo>
                    <a:pt x="27" y="1347"/>
                  </a:lnTo>
                  <a:lnTo>
                    <a:pt x="14" y="1375"/>
                  </a:lnTo>
                  <a:lnTo>
                    <a:pt x="14" y="1403"/>
                  </a:lnTo>
                  <a:lnTo>
                    <a:pt x="14" y="1444"/>
                  </a:lnTo>
                  <a:lnTo>
                    <a:pt x="0" y="1472"/>
                  </a:lnTo>
                  <a:lnTo>
                    <a:pt x="0" y="1498"/>
                  </a:lnTo>
                  <a:lnTo>
                    <a:pt x="0" y="1526"/>
                  </a:lnTo>
                  <a:lnTo>
                    <a:pt x="0" y="1554"/>
                  </a:lnTo>
                  <a:lnTo>
                    <a:pt x="0" y="1582"/>
                  </a:lnTo>
                  <a:lnTo>
                    <a:pt x="0" y="1608"/>
                  </a:lnTo>
                  <a:lnTo>
                    <a:pt x="0" y="1636"/>
                  </a:lnTo>
                  <a:lnTo>
                    <a:pt x="0" y="1664"/>
                  </a:lnTo>
                  <a:lnTo>
                    <a:pt x="0" y="1705"/>
                  </a:lnTo>
                  <a:lnTo>
                    <a:pt x="0" y="1733"/>
                  </a:lnTo>
                  <a:lnTo>
                    <a:pt x="0" y="1760"/>
                  </a:lnTo>
                  <a:lnTo>
                    <a:pt x="0" y="1787"/>
                  </a:lnTo>
                  <a:lnTo>
                    <a:pt x="0" y="1815"/>
                  </a:lnTo>
                  <a:lnTo>
                    <a:pt x="0" y="1843"/>
                  </a:lnTo>
                  <a:lnTo>
                    <a:pt x="0" y="1870"/>
                  </a:lnTo>
                  <a:lnTo>
                    <a:pt x="14" y="1897"/>
                  </a:lnTo>
                  <a:lnTo>
                    <a:pt x="14" y="1939"/>
                  </a:lnTo>
                  <a:lnTo>
                    <a:pt x="14" y="1966"/>
                  </a:lnTo>
                  <a:lnTo>
                    <a:pt x="27" y="1994"/>
                  </a:lnTo>
                  <a:lnTo>
                    <a:pt x="27" y="2021"/>
                  </a:lnTo>
                  <a:lnTo>
                    <a:pt x="42" y="2049"/>
                  </a:lnTo>
                  <a:lnTo>
                    <a:pt x="42" y="2076"/>
                  </a:lnTo>
                  <a:lnTo>
                    <a:pt x="55" y="2103"/>
                  </a:lnTo>
                  <a:lnTo>
                    <a:pt x="55" y="2131"/>
                  </a:lnTo>
                  <a:lnTo>
                    <a:pt x="68" y="2159"/>
                  </a:lnTo>
                  <a:lnTo>
                    <a:pt x="68" y="2187"/>
                  </a:lnTo>
                  <a:lnTo>
                    <a:pt x="83" y="2213"/>
                  </a:lnTo>
                  <a:lnTo>
                    <a:pt x="96" y="2241"/>
                  </a:lnTo>
                  <a:lnTo>
                    <a:pt x="110" y="2269"/>
                  </a:lnTo>
                  <a:lnTo>
                    <a:pt x="110" y="2297"/>
                  </a:lnTo>
                  <a:lnTo>
                    <a:pt x="124" y="2323"/>
                  </a:lnTo>
                  <a:lnTo>
                    <a:pt x="137" y="2351"/>
                  </a:lnTo>
                  <a:lnTo>
                    <a:pt x="152" y="2379"/>
                  </a:lnTo>
                  <a:lnTo>
                    <a:pt x="165" y="2407"/>
                  </a:lnTo>
                  <a:lnTo>
                    <a:pt x="178" y="2434"/>
                  </a:lnTo>
                  <a:lnTo>
                    <a:pt x="193" y="2461"/>
                  </a:lnTo>
                  <a:lnTo>
                    <a:pt x="206" y="2489"/>
                  </a:lnTo>
                  <a:lnTo>
                    <a:pt x="220" y="2502"/>
                  </a:lnTo>
                  <a:lnTo>
                    <a:pt x="234" y="2530"/>
                  </a:lnTo>
                  <a:lnTo>
                    <a:pt x="247" y="2558"/>
                  </a:lnTo>
                  <a:lnTo>
                    <a:pt x="262" y="2585"/>
                  </a:lnTo>
                  <a:lnTo>
                    <a:pt x="275" y="2613"/>
                  </a:lnTo>
                  <a:lnTo>
                    <a:pt x="303" y="2626"/>
                  </a:lnTo>
                  <a:lnTo>
                    <a:pt x="316" y="2654"/>
                  </a:lnTo>
                  <a:lnTo>
                    <a:pt x="330" y="2681"/>
                  </a:lnTo>
                  <a:lnTo>
                    <a:pt x="344" y="2709"/>
                  </a:lnTo>
                  <a:lnTo>
                    <a:pt x="371" y="2723"/>
                  </a:lnTo>
                  <a:lnTo>
                    <a:pt x="385" y="2750"/>
                  </a:lnTo>
                  <a:lnTo>
                    <a:pt x="399" y="2777"/>
                  </a:lnTo>
                  <a:lnTo>
                    <a:pt x="426" y="2792"/>
                  </a:lnTo>
                  <a:lnTo>
                    <a:pt x="440" y="2818"/>
                  </a:lnTo>
                  <a:lnTo>
                    <a:pt x="467" y="2833"/>
                  </a:lnTo>
                  <a:lnTo>
                    <a:pt x="481" y="2860"/>
                  </a:lnTo>
                  <a:lnTo>
                    <a:pt x="509" y="2874"/>
                  </a:lnTo>
                  <a:lnTo>
                    <a:pt x="522" y="2902"/>
                  </a:lnTo>
                  <a:lnTo>
                    <a:pt x="550" y="2915"/>
                  </a:lnTo>
                  <a:lnTo>
                    <a:pt x="564" y="2943"/>
                  </a:lnTo>
                  <a:lnTo>
                    <a:pt x="591" y="2956"/>
                  </a:lnTo>
                  <a:lnTo>
                    <a:pt x="619" y="2971"/>
                  </a:lnTo>
                  <a:lnTo>
                    <a:pt x="632" y="2997"/>
                  </a:lnTo>
                  <a:lnTo>
                    <a:pt x="660" y="3012"/>
                  </a:lnTo>
                  <a:lnTo>
                    <a:pt x="688" y="3025"/>
                  </a:lnTo>
                  <a:lnTo>
                    <a:pt x="715" y="3038"/>
                  </a:lnTo>
                  <a:lnTo>
                    <a:pt x="729" y="3066"/>
                  </a:lnTo>
                  <a:lnTo>
                    <a:pt x="757" y="3080"/>
                  </a:lnTo>
                  <a:lnTo>
                    <a:pt x="783" y="3094"/>
                  </a:lnTo>
                  <a:lnTo>
                    <a:pt x="811" y="3107"/>
                  </a:lnTo>
                  <a:lnTo>
                    <a:pt x="825" y="3122"/>
                  </a:lnTo>
                  <a:lnTo>
                    <a:pt x="852" y="3135"/>
                  </a:lnTo>
                  <a:lnTo>
                    <a:pt x="880" y="3149"/>
                  </a:lnTo>
                  <a:lnTo>
                    <a:pt x="908" y="3163"/>
                  </a:lnTo>
                  <a:lnTo>
                    <a:pt x="935" y="3176"/>
                  </a:lnTo>
                  <a:lnTo>
                    <a:pt x="962" y="3190"/>
                  </a:lnTo>
                  <a:lnTo>
                    <a:pt x="990" y="3204"/>
                  </a:lnTo>
                  <a:lnTo>
                    <a:pt x="1018" y="3217"/>
                  </a:lnTo>
                  <a:lnTo>
                    <a:pt x="1045" y="3231"/>
                  </a:lnTo>
                  <a:lnTo>
                    <a:pt x="1072" y="3231"/>
                  </a:lnTo>
                  <a:lnTo>
                    <a:pt x="1100" y="3245"/>
                  </a:lnTo>
                  <a:lnTo>
                    <a:pt x="1128" y="3259"/>
                  </a:lnTo>
                  <a:lnTo>
                    <a:pt x="1155" y="3273"/>
                  </a:lnTo>
                  <a:lnTo>
                    <a:pt x="1182" y="3273"/>
                  </a:lnTo>
                  <a:lnTo>
                    <a:pt x="1210" y="3286"/>
                  </a:lnTo>
                  <a:lnTo>
                    <a:pt x="1237" y="3286"/>
                  </a:lnTo>
                  <a:lnTo>
                    <a:pt x="1265" y="3300"/>
                  </a:lnTo>
                  <a:lnTo>
                    <a:pt x="1293" y="3300"/>
                  </a:lnTo>
                  <a:lnTo>
                    <a:pt x="1320" y="3314"/>
                  </a:lnTo>
                  <a:lnTo>
                    <a:pt x="1347" y="3314"/>
                  </a:lnTo>
                  <a:lnTo>
                    <a:pt x="1375" y="3328"/>
                  </a:lnTo>
                  <a:lnTo>
                    <a:pt x="1403" y="3328"/>
                  </a:lnTo>
                  <a:lnTo>
                    <a:pt x="1444" y="3328"/>
                  </a:lnTo>
                  <a:lnTo>
                    <a:pt x="1472" y="3341"/>
                  </a:lnTo>
                  <a:lnTo>
                    <a:pt x="1498" y="3341"/>
                  </a:lnTo>
                  <a:lnTo>
                    <a:pt x="1526" y="3341"/>
                  </a:lnTo>
                  <a:lnTo>
                    <a:pt x="1554" y="3341"/>
                  </a:lnTo>
                  <a:lnTo>
                    <a:pt x="1582" y="3341"/>
                  </a:lnTo>
                  <a:lnTo>
                    <a:pt x="1608" y="3341"/>
                  </a:lnTo>
                  <a:lnTo>
                    <a:pt x="1636" y="3341"/>
                  </a:lnTo>
                  <a:lnTo>
                    <a:pt x="1664" y="3341"/>
                  </a:lnTo>
                  <a:lnTo>
                    <a:pt x="1705" y="3341"/>
                  </a:lnTo>
                  <a:lnTo>
                    <a:pt x="1733" y="3341"/>
                  </a:lnTo>
                  <a:lnTo>
                    <a:pt x="1760" y="3341"/>
                  </a:lnTo>
                  <a:lnTo>
                    <a:pt x="1787" y="3341"/>
                  </a:lnTo>
                  <a:lnTo>
                    <a:pt x="1815" y="3341"/>
                  </a:lnTo>
                  <a:lnTo>
                    <a:pt x="1843" y="3341"/>
                  </a:lnTo>
                  <a:lnTo>
                    <a:pt x="1870" y="3341"/>
                  </a:lnTo>
                  <a:lnTo>
                    <a:pt x="1897" y="3328"/>
                  </a:lnTo>
                  <a:lnTo>
                    <a:pt x="1939" y="3328"/>
                  </a:lnTo>
                  <a:lnTo>
                    <a:pt x="1966" y="3328"/>
                  </a:lnTo>
                  <a:lnTo>
                    <a:pt x="1994" y="3314"/>
                  </a:lnTo>
                  <a:lnTo>
                    <a:pt x="2021" y="3314"/>
                  </a:lnTo>
                  <a:lnTo>
                    <a:pt x="2049" y="3300"/>
                  </a:lnTo>
                  <a:lnTo>
                    <a:pt x="2076" y="3300"/>
                  </a:lnTo>
                  <a:lnTo>
                    <a:pt x="2103" y="3286"/>
                  </a:lnTo>
                  <a:lnTo>
                    <a:pt x="2131" y="3286"/>
                  </a:lnTo>
                  <a:lnTo>
                    <a:pt x="2159" y="3273"/>
                  </a:lnTo>
                  <a:lnTo>
                    <a:pt x="2187" y="3273"/>
                  </a:lnTo>
                  <a:lnTo>
                    <a:pt x="2213" y="3259"/>
                  </a:lnTo>
                  <a:lnTo>
                    <a:pt x="2241" y="3245"/>
                  </a:lnTo>
                  <a:lnTo>
                    <a:pt x="2269" y="3231"/>
                  </a:lnTo>
                  <a:lnTo>
                    <a:pt x="2297" y="3231"/>
                  </a:lnTo>
                  <a:lnTo>
                    <a:pt x="2323" y="3217"/>
                  </a:lnTo>
                  <a:lnTo>
                    <a:pt x="2351" y="3204"/>
                  </a:lnTo>
                  <a:lnTo>
                    <a:pt x="2379" y="3190"/>
                  </a:lnTo>
                  <a:lnTo>
                    <a:pt x="2407" y="3176"/>
                  </a:lnTo>
                  <a:lnTo>
                    <a:pt x="2434" y="3163"/>
                  </a:lnTo>
                  <a:lnTo>
                    <a:pt x="2461" y="3149"/>
                  </a:lnTo>
                  <a:lnTo>
                    <a:pt x="2489" y="3135"/>
                  </a:lnTo>
                  <a:lnTo>
                    <a:pt x="2502" y="3122"/>
                  </a:lnTo>
                  <a:lnTo>
                    <a:pt x="2530" y="3107"/>
                  </a:lnTo>
                  <a:lnTo>
                    <a:pt x="2558" y="3094"/>
                  </a:lnTo>
                  <a:lnTo>
                    <a:pt x="2585" y="3080"/>
                  </a:lnTo>
                  <a:lnTo>
                    <a:pt x="2613" y="3066"/>
                  </a:lnTo>
                  <a:lnTo>
                    <a:pt x="2626" y="3038"/>
                  </a:lnTo>
                  <a:lnTo>
                    <a:pt x="2654" y="3025"/>
                  </a:lnTo>
                  <a:lnTo>
                    <a:pt x="2681" y="3012"/>
                  </a:lnTo>
                  <a:lnTo>
                    <a:pt x="2709" y="2997"/>
                  </a:lnTo>
                  <a:lnTo>
                    <a:pt x="2723" y="2971"/>
                  </a:lnTo>
                  <a:lnTo>
                    <a:pt x="2750" y="2956"/>
                  </a:lnTo>
                  <a:lnTo>
                    <a:pt x="2777" y="2943"/>
                  </a:lnTo>
                  <a:lnTo>
                    <a:pt x="2792" y="2915"/>
                  </a:lnTo>
                  <a:lnTo>
                    <a:pt x="2818" y="2902"/>
                  </a:lnTo>
                  <a:lnTo>
                    <a:pt x="2833" y="2874"/>
                  </a:lnTo>
                  <a:lnTo>
                    <a:pt x="2860" y="2860"/>
                  </a:lnTo>
                  <a:lnTo>
                    <a:pt x="2874" y="2833"/>
                  </a:lnTo>
                  <a:lnTo>
                    <a:pt x="2902" y="2818"/>
                  </a:lnTo>
                  <a:lnTo>
                    <a:pt x="2915" y="2792"/>
                  </a:lnTo>
                  <a:lnTo>
                    <a:pt x="2943" y="2777"/>
                  </a:lnTo>
                  <a:lnTo>
                    <a:pt x="2956" y="2750"/>
                  </a:lnTo>
                  <a:lnTo>
                    <a:pt x="2971" y="2723"/>
                  </a:lnTo>
                  <a:lnTo>
                    <a:pt x="2997" y="2709"/>
                  </a:lnTo>
                  <a:lnTo>
                    <a:pt x="3012" y="2681"/>
                  </a:lnTo>
                  <a:lnTo>
                    <a:pt x="3025" y="2654"/>
                  </a:lnTo>
                  <a:lnTo>
                    <a:pt x="3038" y="2626"/>
                  </a:lnTo>
                  <a:lnTo>
                    <a:pt x="3066" y="2613"/>
                  </a:lnTo>
                  <a:lnTo>
                    <a:pt x="3080" y="2585"/>
                  </a:lnTo>
                  <a:lnTo>
                    <a:pt x="3094" y="2558"/>
                  </a:lnTo>
                  <a:lnTo>
                    <a:pt x="3107" y="2530"/>
                  </a:lnTo>
                  <a:lnTo>
                    <a:pt x="3122" y="2516"/>
                  </a:lnTo>
                  <a:lnTo>
                    <a:pt x="3135" y="2489"/>
                  </a:lnTo>
                  <a:lnTo>
                    <a:pt x="3149" y="2461"/>
                  </a:lnTo>
                  <a:lnTo>
                    <a:pt x="3163" y="2434"/>
                  </a:lnTo>
                  <a:lnTo>
                    <a:pt x="3176" y="2407"/>
                  </a:lnTo>
                  <a:lnTo>
                    <a:pt x="3190" y="2379"/>
                  </a:lnTo>
                  <a:lnTo>
                    <a:pt x="3204" y="2351"/>
                  </a:lnTo>
                  <a:lnTo>
                    <a:pt x="3217" y="2323"/>
                  </a:lnTo>
                  <a:lnTo>
                    <a:pt x="3231" y="2297"/>
                  </a:lnTo>
                  <a:lnTo>
                    <a:pt x="3231" y="2269"/>
                  </a:lnTo>
                  <a:lnTo>
                    <a:pt x="3245" y="2241"/>
                  </a:lnTo>
                  <a:lnTo>
                    <a:pt x="3259" y="2213"/>
                  </a:lnTo>
                  <a:lnTo>
                    <a:pt x="3273" y="2187"/>
                  </a:lnTo>
                  <a:lnTo>
                    <a:pt x="3273" y="2159"/>
                  </a:lnTo>
                  <a:lnTo>
                    <a:pt x="3286" y="2131"/>
                  </a:lnTo>
                  <a:lnTo>
                    <a:pt x="3286" y="2103"/>
                  </a:lnTo>
                  <a:lnTo>
                    <a:pt x="3300" y="2076"/>
                  </a:lnTo>
                  <a:lnTo>
                    <a:pt x="3300" y="2049"/>
                  </a:lnTo>
                  <a:lnTo>
                    <a:pt x="3314" y="2021"/>
                  </a:lnTo>
                  <a:lnTo>
                    <a:pt x="3314" y="1994"/>
                  </a:lnTo>
                  <a:lnTo>
                    <a:pt x="3328" y="1966"/>
                  </a:lnTo>
                  <a:lnTo>
                    <a:pt x="3328" y="1939"/>
                  </a:lnTo>
                  <a:lnTo>
                    <a:pt x="3328" y="1897"/>
                  </a:lnTo>
                  <a:lnTo>
                    <a:pt x="3341" y="1870"/>
                  </a:lnTo>
                  <a:lnTo>
                    <a:pt x="3341" y="1843"/>
                  </a:lnTo>
                  <a:lnTo>
                    <a:pt x="3341" y="1815"/>
                  </a:lnTo>
                  <a:lnTo>
                    <a:pt x="3341" y="1787"/>
                  </a:lnTo>
                  <a:lnTo>
                    <a:pt x="3341" y="1760"/>
                  </a:lnTo>
                  <a:lnTo>
                    <a:pt x="3341" y="1733"/>
                  </a:lnTo>
                  <a:lnTo>
                    <a:pt x="3341" y="1705"/>
                  </a:lnTo>
                  <a:lnTo>
                    <a:pt x="3355" y="1677"/>
                  </a:lnTo>
                  <a:close/>
                </a:path>
              </a:pathLst>
            </a:custGeom>
            <a:solidFill>
              <a:srgbClr val="ff33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" name=""/>
            <p:cNvSpPr/>
            <p:nvPr/>
          </p:nvSpPr>
          <p:spPr>
            <a:xfrm>
              <a:off x="2725200" y="1272600"/>
              <a:ext cx="214560" cy="215280"/>
            </a:xfrm>
            <a:prstGeom prst="rect">
              <a:avLst/>
            </a:prstGeom>
            <a:noFill/>
            <a:ln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" name=""/>
            <p:cNvSpPr/>
            <p:nvPr/>
          </p:nvSpPr>
          <p:spPr>
            <a:xfrm>
              <a:off x="2783160" y="1332000"/>
              <a:ext cx="97200" cy="95040"/>
            </a:xfrm>
            <a:custGeom>
              <a:avLst/>
              <a:gdLst/>
              <a:ahLst/>
              <a:rect l="l" t="t" r="r" b="b"/>
              <a:pathLst>
                <a:path w="1871" h="1856">
                  <a:moveTo>
                    <a:pt x="1871" y="935"/>
                  </a:moveTo>
                  <a:lnTo>
                    <a:pt x="1857" y="907"/>
                  </a:lnTo>
                  <a:lnTo>
                    <a:pt x="1857" y="894"/>
                  </a:lnTo>
                  <a:lnTo>
                    <a:pt x="1857" y="879"/>
                  </a:lnTo>
                  <a:lnTo>
                    <a:pt x="1857" y="866"/>
                  </a:lnTo>
                  <a:lnTo>
                    <a:pt x="1857" y="852"/>
                  </a:lnTo>
                  <a:lnTo>
                    <a:pt x="1857" y="825"/>
                  </a:lnTo>
                  <a:lnTo>
                    <a:pt x="1857" y="810"/>
                  </a:lnTo>
                  <a:lnTo>
                    <a:pt x="1857" y="797"/>
                  </a:lnTo>
                  <a:lnTo>
                    <a:pt x="1857" y="784"/>
                  </a:lnTo>
                  <a:lnTo>
                    <a:pt x="1843" y="769"/>
                  </a:lnTo>
                  <a:lnTo>
                    <a:pt x="1843" y="756"/>
                  </a:lnTo>
                  <a:lnTo>
                    <a:pt x="1843" y="728"/>
                  </a:lnTo>
                  <a:lnTo>
                    <a:pt x="1843" y="715"/>
                  </a:lnTo>
                  <a:lnTo>
                    <a:pt x="1829" y="701"/>
                  </a:lnTo>
                  <a:lnTo>
                    <a:pt x="1829" y="687"/>
                  </a:lnTo>
                  <a:lnTo>
                    <a:pt x="1829" y="673"/>
                  </a:lnTo>
                  <a:lnTo>
                    <a:pt x="1829" y="659"/>
                  </a:lnTo>
                  <a:lnTo>
                    <a:pt x="1816" y="632"/>
                  </a:lnTo>
                  <a:lnTo>
                    <a:pt x="1816" y="618"/>
                  </a:lnTo>
                  <a:lnTo>
                    <a:pt x="1802" y="605"/>
                  </a:lnTo>
                  <a:lnTo>
                    <a:pt x="1802" y="591"/>
                  </a:lnTo>
                  <a:lnTo>
                    <a:pt x="1802" y="577"/>
                  </a:lnTo>
                  <a:lnTo>
                    <a:pt x="1788" y="563"/>
                  </a:lnTo>
                  <a:lnTo>
                    <a:pt x="1788" y="549"/>
                  </a:lnTo>
                  <a:lnTo>
                    <a:pt x="1774" y="536"/>
                  </a:lnTo>
                  <a:lnTo>
                    <a:pt x="1774" y="522"/>
                  </a:lnTo>
                  <a:lnTo>
                    <a:pt x="1760" y="508"/>
                  </a:lnTo>
                  <a:lnTo>
                    <a:pt x="1760" y="494"/>
                  </a:lnTo>
                  <a:lnTo>
                    <a:pt x="1747" y="481"/>
                  </a:lnTo>
                  <a:lnTo>
                    <a:pt x="1733" y="467"/>
                  </a:lnTo>
                  <a:lnTo>
                    <a:pt x="1733" y="440"/>
                  </a:lnTo>
                  <a:lnTo>
                    <a:pt x="1719" y="426"/>
                  </a:lnTo>
                  <a:lnTo>
                    <a:pt x="1719" y="412"/>
                  </a:lnTo>
                  <a:lnTo>
                    <a:pt x="1706" y="398"/>
                  </a:lnTo>
                  <a:lnTo>
                    <a:pt x="1692" y="384"/>
                  </a:lnTo>
                  <a:lnTo>
                    <a:pt x="1678" y="371"/>
                  </a:lnTo>
                  <a:lnTo>
                    <a:pt x="1665" y="357"/>
                  </a:lnTo>
                  <a:lnTo>
                    <a:pt x="1650" y="343"/>
                  </a:lnTo>
                  <a:lnTo>
                    <a:pt x="1650" y="330"/>
                  </a:lnTo>
                  <a:lnTo>
                    <a:pt x="1637" y="315"/>
                  </a:lnTo>
                  <a:lnTo>
                    <a:pt x="1623" y="302"/>
                  </a:lnTo>
                  <a:lnTo>
                    <a:pt x="1609" y="289"/>
                  </a:lnTo>
                  <a:lnTo>
                    <a:pt x="1596" y="274"/>
                  </a:lnTo>
                  <a:lnTo>
                    <a:pt x="1596" y="261"/>
                  </a:lnTo>
                  <a:lnTo>
                    <a:pt x="1581" y="261"/>
                  </a:lnTo>
                  <a:lnTo>
                    <a:pt x="1568" y="247"/>
                  </a:lnTo>
                  <a:lnTo>
                    <a:pt x="1555" y="233"/>
                  </a:lnTo>
                  <a:lnTo>
                    <a:pt x="1540" y="220"/>
                  </a:lnTo>
                  <a:lnTo>
                    <a:pt x="1527" y="205"/>
                  </a:lnTo>
                  <a:lnTo>
                    <a:pt x="1514" y="205"/>
                  </a:lnTo>
                  <a:lnTo>
                    <a:pt x="1499" y="192"/>
                  </a:lnTo>
                  <a:lnTo>
                    <a:pt x="1486" y="179"/>
                  </a:lnTo>
                  <a:lnTo>
                    <a:pt x="1471" y="164"/>
                  </a:lnTo>
                  <a:lnTo>
                    <a:pt x="1458" y="151"/>
                  </a:lnTo>
                  <a:lnTo>
                    <a:pt x="1445" y="137"/>
                  </a:lnTo>
                  <a:lnTo>
                    <a:pt x="1430" y="137"/>
                  </a:lnTo>
                  <a:lnTo>
                    <a:pt x="1417" y="123"/>
                  </a:lnTo>
                  <a:lnTo>
                    <a:pt x="1403" y="123"/>
                  </a:lnTo>
                  <a:lnTo>
                    <a:pt x="1376" y="110"/>
                  </a:lnTo>
                  <a:lnTo>
                    <a:pt x="1361" y="95"/>
                  </a:lnTo>
                  <a:lnTo>
                    <a:pt x="1348" y="95"/>
                  </a:lnTo>
                  <a:lnTo>
                    <a:pt x="1334" y="82"/>
                  </a:lnTo>
                  <a:lnTo>
                    <a:pt x="1320" y="82"/>
                  </a:lnTo>
                  <a:lnTo>
                    <a:pt x="1307" y="69"/>
                  </a:lnTo>
                  <a:lnTo>
                    <a:pt x="1293" y="69"/>
                  </a:lnTo>
                  <a:lnTo>
                    <a:pt x="1279" y="54"/>
                  </a:lnTo>
                  <a:lnTo>
                    <a:pt x="1266" y="54"/>
                  </a:lnTo>
                  <a:lnTo>
                    <a:pt x="1252" y="54"/>
                  </a:lnTo>
                  <a:lnTo>
                    <a:pt x="1238" y="41"/>
                  </a:lnTo>
                  <a:lnTo>
                    <a:pt x="1224" y="41"/>
                  </a:lnTo>
                  <a:lnTo>
                    <a:pt x="1197" y="27"/>
                  </a:lnTo>
                  <a:lnTo>
                    <a:pt x="1183" y="27"/>
                  </a:lnTo>
                  <a:lnTo>
                    <a:pt x="1169" y="27"/>
                  </a:lnTo>
                  <a:lnTo>
                    <a:pt x="1155" y="27"/>
                  </a:lnTo>
                  <a:lnTo>
                    <a:pt x="1142" y="13"/>
                  </a:lnTo>
                  <a:lnTo>
                    <a:pt x="1128" y="13"/>
                  </a:lnTo>
                  <a:lnTo>
                    <a:pt x="1101" y="13"/>
                  </a:lnTo>
                  <a:lnTo>
                    <a:pt x="1087" y="13"/>
                  </a:lnTo>
                  <a:lnTo>
                    <a:pt x="1073" y="0"/>
                  </a:lnTo>
                  <a:lnTo>
                    <a:pt x="1059" y="0"/>
                  </a:lnTo>
                  <a:lnTo>
                    <a:pt x="1045" y="0"/>
                  </a:lnTo>
                  <a:lnTo>
                    <a:pt x="1032" y="0"/>
                  </a:lnTo>
                  <a:lnTo>
                    <a:pt x="1004" y="0"/>
                  </a:lnTo>
                  <a:lnTo>
                    <a:pt x="991" y="0"/>
                  </a:lnTo>
                  <a:lnTo>
                    <a:pt x="976" y="0"/>
                  </a:lnTo>
                  <a:lnTo>
                    <a:pt x="963" y="0"/>
                  </a:lnTo>
                  <a:lnTo>
                    <a:pt x="950" y="0"/>
                  </a:lnTo>
                  <a:lnTo>
                    <a:pt x="935" y="0"/>
                  </a:lnTo>
                  <a:lnTo>
                    <a:pt x="908" y="0"/>
                  </a:lnTo>
                  <a:lnTo>
                    <a:pt x="894" y="0"/>
                  </a:lnTo>
                  <a:lnTo>
                    <a:pt x="881" y="0"/>
                  </a:lnTo>
                  <a:lnTo>
                    <a:pt x="866" y="0"/>
                  </a:lnTo>
                  <a:lnTo>
                    <a:pt x="853" y="0"/>
                  </a:lnTo>
                  <a:lnTo>
                    <a:pt x="825" y="0"/>
                  </a:lnTo>
                  <a:lnTo>
                    <a:pt x="812" y="0"/>
                  </a:lnTo>
                  <a:lnTo>
                    <a:pt x="797" y="0"/>
                  </a:lnTo>
                  <a:lnTo>
                    <a:pt x="784" y="0"/>
                  </a:lnTo>
                  <a:lnTo>
                    <a:pt x="771" y="13"/>
                  </a:lnTo>
                  <a:lnTo>
                    <a:pt x="756" y="13"/>
                  </a:lnTo>
                  <a:lnTo>
                    <a:pt x="730" y="13"/>
                  </a:lnTo>
                  <a:lnTo>
                    <a:pt x="715" y="13"/>
                  </a:lnTo>
                  <a:lnTo>
                    <a:pt x="702" y="27"/>
                  </a:lnTo>
                  <a:lnTo>
                    <a:pt x="688" y="27"/>
                  </a:lnTo>
                  <a:lnTo>
                    <a:pt x="674" y="27"/>
                  </a:lnTo>
                  <a:lnTo>
                    <a:pt x="661" y="27"/>
                  </a:lnTo>
                  <a:lnTo>
                    <a:pt x="633" y="41"/>
                  </a:lnTo>
                  <a:lnTo>
                    <a:pt x="619" y="41"/>
                  </a:lnTo>
                  <a:lnTo>
                    <a:pt x="605" y="54"/>
                  </a:lnTo>
                  <a:lnTo>
                    <a:pt x="592" y="54"/>
                  </a:lnTo>
                  <a:lnTo>
                    <a:pt x="578" y="54"/>
                  </a:lnTo>
                  <a:lnTo>
                    <a:pt x="564" y="69"/>
                  </a:lnTo>
                  <a:lnTo>
                    <a:pt x="551" y="69"/>
                  </a:lnTo>
                  <a:lnTo>
                    <a:pt x="537" y="82"/>
                  </a:lnTo>
                  <a:lnTo>
                    <a:pt x="523" y="82"/>
                  </a:lnTo>
                  <a:lnTo>
                    <a:pt x="509" y="95"/>
                  </a:lnTo>
                  <a:lnTo>
                    <a:pt x="495" y="95"/>
                  </a:lnTo>
                  <a:lnTo>
                    <a:pt x="482" y="110"/>
                  </a:lnTo>
                  <a:lnTo>
                    <a:pt x="468" y="123"/>
                  </a:lnTo>
                  <a:lnTo>
                    <a:pt x="440" y="123"/>
                  </a:lnTo>
                  <a:lnTo>
                    <a:pt x="427" y="137"/>
                  </a:lnTo>
                  <a:lnTo>
                    <a:pt x="413" y="137"/>
                  </a:lnTo>
                  <a:lnTo>
                    <a:pt x="399" y="151"/>
                  </a:lnTo>
                  <a:lnTo>
                    <a:pt x="386" y="164"/>
                  </a:lnTo>
                  <a:lnTo>
                    <a:pt x="372" y="179"/>
                  </a:lnTo>
                  <a:lnTo>
                    <a:pt x="358" y="192"/>
                  </a:lnTo>
                  <a:lnTo>
                    <a:pt x="344" y="205"/>
                  </a:lnTo>
                  <a:lnTo>
                    <a:pt x="330" y="205"/>
                  </a:lnTo>
                  <a:lnTo>
                    <a:pt x="317" y="220"/>
                  </a:lnTo>
                  <a:lnTo>
                    <a:pt x="303" y="233"/>
                  </a:lnTo>
                  <a:lnTo>
                    <a:pt x="289" y="247"/>
                  </a:lnTo>
                  <a:lnTo>
                    <a:pt x="276" y="261"/>
                  </a:lnTo>
                  <a:lnTo>
                    <a:pt x="261" y="261"/>
                  </a:lnTo>
                  <a:lnTo>
                    <a:pt x="261" y="274"/>
                  </a:lnTo>
                  <a:lnTo>
                    <a:pt x="248" y="289"/>
                  </a:lnTo>
                  <a:lnTo>
                    <a:pt x="235" y="302"/>
                  </a:lnTo>
                  <a:lnTo>
                    <a:pt x="220" y="315"/>
                  </a:lnTo>
                  <a:lnTo>
                    <a:pt x="207" y="330"/>
                  </a:lnTo>
                  <a:lnTo>
                    <a:pt x="207" y="343"/>
                  </a:lnTo>
                  <a:lnTo>
                    <a:pt x="193" y="357"/>
                  </a:lnTo>
                  <a:lnTo>
                    <a:pt x="179" y="371"/>
                  </a:lnTo>
                  <a:lnTo>
                    <a:pt x="166" y="384"/>
                  </a:lnTo>
                  <a:lnTo>
                    <a:pt x="151" y="398"/>
                  </a:lnTo>
                  <a:lnTo>
                    <a:pt x="138" y="412"/>
                  </a:lnTo>
                  <a:lnTo>
                    <a:pt x="138" y="426"/>
                  </a:lnTo>
                  <a:lnTo>
                    <a:pt x="125" y="440"/>
                  </a:lnTo>
                  <a:lnTo>
                    <a:pt x="125" y="453"/>
                  </a:lnTo>
                  <a:lnTo>
                    <a:pt x="110" y="481"/>
                  </a:lnTo>
                  <a:lnTo>
                    <a:pt x="97" y="494"/>
                  </a:lnTo>
                  <a:lnTo>
                    <a:pt x="97" y="508"/>
                  </a:lnTo>
                  <a:lnTo>
                    <a:pt x="83" y="522"/>
                  </a:lnTo>
                  <a:lnTo>
                    <a:pt x="83" y="536"/>
                  </a:lnTo>
                  <a:lnTo>
                    <a:pt x="69" y="549"/>
                  </a:lnTo>
                  <a:lnTo>
                    <a:pt x="69" y="563"/>
                  </a:lnTo>
                  <a:lnTo>
                    <a:pt x="56" y="577"/>
                  </a:lnTo>
                  <a:lnTo>
                    <a:pt x="56" y="591"/>
                  </a:lnTo>
                  <a:lnTo>
                    <a:pt x="56" y="605"/>
                  </a:lnTo>
                  <a:lnTo>
                    <a:pt x="41" y="618"/>
                  </a:lnTo>
                  <a:lnTo>
                    <a:pt x="41" y="632"/>
                  </a:lnTo>
                  <a:lnTo>
                    <a:pt x="28" y="659"/>
                  </a:lnTo>
                  <a:lnTo>
                    <a:pt x="28" y="673"/>
                  </a:lnTo>
                  <a:lnTo>
                    <a:pt x="28" y="687"/>
                  </a:lnTo>
                  <a:lnTo>
                    <a:pt x="28" y="701"/>
                  </a:lnTo>
                  <a:lnTo>
                    <a:pt x="15" y="715"/>
                  </a:lnTo>
                  <a:lnTo>
                    <a:pt x="15" y="728"/>
                  </a:lnTo>
                  <a:lnTo>
                    <a:pt x="15" y="756"/>
                  </a:lnTo>
                  <a:lnTo>
                    <a:pt x="15" y="769"/>
                  </a:lnTo>
                  <a:lnTo>
                    <a:pt x="0" y="784"/>
                  </a:lnTo>
                  <a:lnTo>
                    <a:pt x="0" y="797"/>
                  </a:lnTo>
                  <a:lnTo>
                    <a:pt x="0" y="810"/>
                  </a:lnTo>
                  <a:lnTo>
                    <a:pt x="0" y="825"/>
                  </a:lnTo>
                  <a:lnTo>
                    <a:pt x="0" y="852"/>
                  </a:lnTo>
                  <a:lnTo>
                    <a:pt x="0" y="866"/>
                  </a:lnTo>
                  <a:lnTo>
                    <a:pt x="0" y="879"/>
                  </a:lnTo>
                  <a:lnTo>
                    <a:pt x="0" y="894"/>
                  </a:lnTo>
                  <a:lnTo>
                    <a:pt x="0" y="907"/>
                  </a:lnTo>
                  <a:lnTo>
                    <a:pt x="0" y="920"/>
                  </a:lnTo>
                  <a:lnTo>
                    <a:pt x="0" y="948"/>
                  </a:lnTo>
                  <a:lnTo>
                    <a:pt x="0" y="962"/>
                  </a:lnTo>
                  <a:lnTo>
                    <a:pt x="0" y="976"/>
                  </a:lnTo>
                  <a:lnTo>
                    <a:pt x="0" y="989"/>
                  </a:lnTo>
                  <a:lnTo>
                    <a:pt x="0" y="1004"/>
                  </a:lnTo>
                  <a:lnTo>
                    <a:pt x="0" y="1030"/>
                  </a:lnTo>
                  <a:lnTo>
                    <a:pt x="0" y="1045"/>
                  </a:lnTo>
                  <a:lnTo>
                    <a:pt x="0" y="1058"/>
                  </a:lnTo>
                  <a:lnTo>
                    <a:pt x="0" y="1072"/>
                  </a:lnTo>
                  <a:lnTo>
                    <a:pt x="15" y="1086"/>
                  </a:lnTo>
                  <a:lnTo>
                    <a:pt x="15" y="1099"/>
                  </a:lnTo>
                  <a:lnTo>
                    <a:pt x="15" y="1127"/>
                  </a:lnTo>
                  <a:lnTo>
                    <a:pt x="15" y="1141"/>
                  </a:lnTo>
                  <a:lnTo>
                    <a:pt x="28" y="1155"/>
                  </a:lnTo>
                  <a:lnTo>
                    <a:pt x="28" y="1168"/>
                  </a:lnTo>
                  <a:lnTo>
                    <a:pt x="28" y="1182"/>
                  </a:lnTo>
                  <a:lnTo>
                    <a:pt x="28" y="1196"/>
                  </a:lnTo>
                  <a:lnTo>
                    <a:pt x="41" y="1223"/>
                  </a:lnTo>
                  <a:lnTo>
                    <a:pt x="41" y="1237"/>
                  </a:lnTo>
                  <a:lnTo>
                    <a:pt x="56" y="1251"/>
                  </a:lnTo>
                  <a:lnTo>
                    <a:pt x="56" y="1264"/>
                  </a:lnTo>
                  <a:lnTo>
                    <a:pt x="56" y="1278"/>
                  </a:lnTo>
                  <a:lnTo>
                    <a:pt x="69" y="1292"/>
                  </a:lnTo>
                  <a:lnTo>
                    <a:pt x="69" y="1306"/>
                  </a:lnTo>
                  <a:lnTo>
                    <a:pt x="83" y="1320"/>
                  </a:lnTo>
                  <a:lnTo>
                    <a:pt x="83" y="1333"/>
                  </a:lnTo>
                  <a:lnTo>
                    <a:pt x="97" y="1347"/>
                  </a:lnTo>
                  <a:lnTo>
                    <a:pt x="97" y="1361"/>
                  </a:lnTo>
                  <a:lnTo>
                    <a:pt x="110" y="1374"/>
                  </a:lnTo>
                  <a:lnTo>
                    <a:pt x="125" y="1388"/>
                  </a:lnTo>
                  <a:lnTo>
                    <a:pt x="125" y="1415"/>
                  </a:lnTo>
                  <a:lnTo>
                    <a:pt x="138" y="1430"/>
                  </a:lnTo>
                  <a:lnTo>
                    <a:pt x="138" y="1443"/>
                  </a:lnTo>
                  <a:lnTo>
                    <a:pt x="151" y="1457"/>
                  </a:lnTo>
                  <a:lnTo>
                    <a:pt x="166" y="1471"/>
                  </a:lnTo>
                  <a:lnTo>
                    <a:pt x="179" y="1484"/>
                  </a:lnTo>
                  <a:lnTo>
                    <a:pt x="193" y="1499"/>
                  </a:lnTo>
                  <a:lnTo>
                    <a:pt x="207" y="1512"/>
                  </a:lnTo>
                  <a:lnTo>
                    <a:pt x="207" y="1525"/>
                  </a:lnTo>
                  <a:lnTo>
                    <a:pt x="220" y="1540"/>
                  </a:lnTo>
                  <a:lnTo>
                    <a:pt x="235" y="1553"/>
                  </a:lnTo>
                  <a:lnTo>
                    <a:pt x="248" y="1567"/>
                  </a:lnTo>
                  <a:lnTo>
                    <a:pt x="261" y="1581"/>
                  </a:lnTo>
                  <a:lnTo>
                    <a:pt x="261" y="1594"/>
                  </a:lnTo>
                  <a:lnTo>
                    <a:pt x="276" y="1594"/>
                  </a:lnTo>
                  <a:lnTo>
                    <a:pt x="289" y="1609"/>
                  </a:lnTo>
                  <a:lnTo>
                    <a:pt x="303" y="1622"/>
                  </a:lnTo>
                  <a:lnTo>
                    <a:pt x="317" y="1635"/>
                  </a:lnTo>
                  <a:lnTo>
                    <a:pt x="330" y="1650"/>
                  </a:lnTo>
                  <a:lnTo>
                    <a:pt x="344" y="1650"/>
                  </a:lnTo>
                  <a:lnTo>
                    <a:pt x="358" y="1663"/>
                  </a:lnTo>
                  <a:lnTo>
                    <a:pt x="372" y="1677"/>
                  </a:lnTo>
                  <a:lnTo>
                    <a:pt x="386" y="1691"/>
                  </a:lnTo>
                  <a:lnTo>
                    <a:pt x="399" y="1704"/>
                  </a:lnTo>
                  <a:lnTo>
                    <a:pt x="413" y="1719"/>
                  </a:lnTo>
                  <a:lnTo>
                    <a:pt x="427" y="1719"/>
                  </a:lnTo>
                  <a:lnTo>
                    <a:pt x="440" y="1732"/>
                  </a:lnTo>
                  <a:lnTo>
                    <a:pt x="454" y="1732"/>
                  </a:lnTo>
                  <a:lnTo>
                    <a:pt x="482" y="1745"/>
                  </a:lnTo>
                  <a:lnTo>
                    <a:pt x="495" y="1760"/>
                  </a:lnTo>
                  <a:lnTo>
                    <a:pt x="509" y="1760"/>
                  </a:lnTo>
                  <a:lnTo>
                    <a:pt x="523" y="1773"/>
                  </a:lnTo>
                  <a:lnTo>
                    <a:pt x="537" y="1773"/>
                  </a:lnTo>
                  <a:lnTo>
                    <a:pt x="551" y="1787"/>
                  </a:lnTo>
                  <a:lnTo>
                    <a:pt x="564" y="1787"/>
                  </a:lnTo>
                  <a:lnTo>
                    <a:pt x="578" y="1801"/>
                  </a:lnTo>
                  <a:lnTo>
                    <a:pt x="592" y="1801"/>
                  </a:lnTo>
                  <a:lnTo>
                    <a:pt x="605" y="1801"/>
                  </a:lnTo>
                  <a:lnTo>
                    <a:pt x="619" y="1814"/>
                  </a:lnTo>
                  <a:lnTo>
                    <a:pt x="633" y="1814"/>
                  </a:lnTo>
                  <a:lnTo>
                    <a:pt x="661" y="1828"/>
                  </a:lnTo>
                  <a:lnTo>
                    <a:pt x="674" y="1828"/>
                  </a:lnTo>
                  <a:lnTo>
                    <a:pt x="688" y="1828"/>
                  </a:lnTo>
                  <a:lnTo>
                    <a:pt x="702" y="1828"/>
                  </a:lnTo>
                  <a:lnTo>
                    <a:pt x="715" y="1842"/>
                  </a:lnTo>
                  <a:lnTo>
                    <a:pt x="730" y="1842"/>
                  </a:lnTo>
                  <a:lnTo>
                    <a:pt x="756" y="1842"/>
                  </a:lnTo>
                  <a:lnTo>
                    <a:pt x="771" y="1842"/>
                  </a:lnTo>
                  <a:lnTo>
                    <a:pt x="784" y="1856"/>
                  </a:lnTo>
                  <a:lnTo>
                    <a:pt x="797" y="1856"/>
                  </a:lnTo>
                  <a:lnTo>
                    <a:pt x="812" y="1856"/>
                  </a:lnTo>
                  <a:lnTo>
                    <a:pt x="825" y="1856"/>
                  </a:lnTo>
                  <a:lnTo>
                    <a:pt x="853" y="1856"/>
                  </a:lnTo>
                  <a:lnTo>
                    <a:pt x="866" y="1856"/>
                  </a:lnTo>
                  <a:lnTo>
                    <a:pt x="881" y="1856"/>
                  </a:lnTo>
                  <a:lnTo>
                    <a:pt x="894" y="1856"/>
                  </a:lnTo>
                  <a:lnTo>
                    <a:pt x="908" y="1856"/>
                  </a:lnTo>
                  <a:lnTo>
                    <a:pt x="922" y="1856"/>
                  </a:lnTo>
                  <a:lnTo>
                    <a:pt x="950" y="1856"/>
                  </a:lnTo>
                  <a:lnTo>
                    <a:pt x="963" y="1856"/>
                  </a:lnTo>
                  <a:lnTo>
                    <a:pt x="976" y="1856"/>
                  </a:lnTo>
                  <a:lnTo>
                    <a:pt x="991" y="1856"/>
                  </a:lnTo>
                  <a:lnTo>
                    <a:pt x="1004" y="1856"/>
                  </a:lnTo>
                  <a:lnTo>
                    <a:pt x="1032" y="1856"/>
                  </a:lnTo>
                  <a:lnTo>
                    <a:pt x="1045" y="1856"/>
                  </a:lnTo>
                  <a:lnTo>
                    <a:pt x="1059" y="1856"/>
                  </a:lnTo>
                  <a:lnTo>
                    <a:pt x="1073" y="1856"/>
                  </a:lnTo>
                  <a:lnTo>
                    <a:pt x="1087" y="1842"/>
                  </a:lnTo>
                  <a:lnTo>
                    <a:pt x="1101" y="1842"/>
                  </a:lnTo>
                  <a:lnTo>
                    <a:pt x="1128" y="1842"/>
                  </a:lnTo>
                  <a:lnTo>
                    <a:pt x="1142" y="1842"/>
                  </a:lnTo>
                  <a:lnTo>
                    <a:pt x="1155" y="1828"/>
                  </a:lnTo>
                  <a:lnTo>
                    <a:pt x="1169" y="1828"/>
                  </a:lnTo>
                  <a:lnTo>
                    <a:pt x="1183" y="1828"/>
                  </a:lnTo>
                  <a:lnTo>
                    <a:pt x="1197" y="1828"/>
                  </a:lnTo>
                  <a:lnTo>
                    <a:pt x="1224" y="1814"/>
                  </a:lnTo>
                  <a:lnTo>
                    <a:pt x="1238" y="1814"/>
                  </a:lnTo>
                  <a:lnTo>
                    <a:pt x="1252" y="1801"/>
                  </a:lnTo>
                  <a:lnTo>
                    <a:pt x="1266" y="1801"/>
                  </a:lnTo>
                  <a:lnTo>
                    <a:pt x="1279" y="1801"/>
                  </a:lnTo>
                  <a:lnTo>
                    <a:pt x="1293" y="1787"/>
                  </a:lnTo>
                  <a:lnTo>
                    <a:pt x="1307" y="1787"/>
                  </a:lnTo>
                  <a:lnTo>
                    <a:pt x="1320" y="1773"/>
                  </a:lnTo>
                  <a:lnTo>
                    <a:pt x="1334" y="1773"/>
                  </a:lnTo>
                  <a:lnTo>
                    <a:pt x="1348" y="1760"/>
                  </a:lnTo>
                  <a:lnTo>
                    <a:pt x="1361" y="1760"/>
                  </a:lnTo>
                  <a:lnTo>
                    <a:pt x="1376" y="1745"/>
                  </a:lnTo>
                  <a:lnTo>
                    <a:pt x="1389" y="1732"/>
                  </a:lnTo>
                  <a:lnTo>
                    <a:pt x="1417" y="1732"/>
                  </a:lnTo>
                  <a:lnTo>
                    <a:pt x="1430" y="1719"/>
                  </a:lnTo>
                  <a:lnTo>
                    <a:pt x="1445" y="1719"/>
                  </a:lnTo>
                  <a:lnTo>
                    <a:pt x="1458" y="1704"/>
                  </a:lnTo>
                  <a:lnTo>
                    <a:pt x="1471" y="1691"/>
                  </a:lnTo>
                  <a:lnTo>
                    <a:pt x="1486" y="1677"/>
                  </a:lnTo>
                  <a:lnTo>
                    <a:pt x="1499" y="1663"/>
                  </a:lnTo>
                  <a:lnTo>
                    <a:pt x="1514" y="1650"/>
                  </a:lnTo>
                  <a:lnTo>
                    <a:pt x="1527" y="1650"/>
                  </a:lnTo>
                  <a:lnTo>
                    <a:pt x="1540" y="1635"/>
                  </a:lnTo>
                  <a:lnTo>
                    <a:pt x="1555" y="1622"/>
                  </a:lnTo>
                  <a:lnTo>
                    <a:pt x="1568" y="1609"/>
                  </a:lnTo>
                  <a:lnTo>
                    <a:pt x="1581" y="1594"/>
                  </a:lnTo>
                  <a:lnTo>
                    <a:pt x="1596" y="1594"/>
                  </a:lnTo>
                  <a:lnTo>
                    <a:pt x="1596" y="1581"/>
                  </a:lnTo>
                  <a:lnTo>
                    <a:pt x="1609" y="1567"/>
                  </a:lnTo>
                  <a:lnTo>
                    <a:pt x="1623" y="1553"/>
                  </a:lnTo>
                  <a:lnTo>
                    <a:pt x="1637" y="1540"/>
                  </a:lnTo>
                  <a:lnTo>
                    <a:pt x="1650" y="1525"/>
                  </a:lnTo>
                  <a:lnTo>
                    <a:pt x="1650" y="1512"/>
                  </a:lnTo>
                  <a:lnTo>
                    <a:pt x="1665" y="1499"/>
                  </a:lnTo>
                  <a:lnTo>
                    <a:pt x="1678" y="1484"/>
                  </a:lnTo>
                  <a:lnTo>
                    <a:pt x="1692" y="1471"/>
                  </a:lnTo>
                  <a:lnTo>
                    <a:pt x="1706" y="1457"/>
                  </a:lnTo>
                  <a:lnTo>
                    <a:pt x="1719" y="1443"/>
                  </a:lnTo>
                  <a:lnTo>
                    <a:pt x="1719" y="1430"/>
                  </a:lnTo>
                  <a:lnTo>
                    <a:pt x="1733" y="1415"/>
                  </a:lnTo>
                  <a:lnTo>
                    <a:pt x="1733" y="1402"/>
                  </a:lnTo>
                  <a:lnTo>
                    <a:pt x="1747" y="1374"/>
                  </a:lnTo>
                  <a:lnTo>
                    <a:pt x="1760" y="1361"/>
                  </a:lnTo>
                  <a:lnTo>
                    <a:pt x="1760" y="1347"/>
                  </a:lnTo>
                  <a:lnTo>
                    <a:pt x="1774" y="1333"/>
                  </a:lnTo>
                  <a:lnTo>
                    <a:pt x="1774" y="1320"/>
                  </a:lnTo>
                  <a:lnTo>
                    <a:pt x="1788" y="1306"/>
                  </a:lnTo>
                  <a:lnTo>
                    <a:pt x="1788" y="1292"/>
                  </a:lnTo>
                  <a:lnTo>
                    <a:pt x="1802" y="1278"/>
                  </a:lnTo>
                  <a:lnTo>
                    <a:pt x="1802" y="1264"/>
                  </a:lnTo>
                  <a:lnTo>
                    <a:pt x="1802" y="1251"/>
                  </a:lnTo>
                  <a:lnTo>
                    <a:pt x="1816" y="1237"/>
                  </a:lnTo>
                  <a:lnTo>
                    <a:pt x="1816" y="1223"/>
                  </a:lnTo>
                  <a:lnTo>
                    <a:pt x="1829" y="1196"/>
                  </a:lnTo>
                  <a:lnTo>
                    <a:pt x="1829" y="1182"/>
                  </a:lnTo>
                  <a:lnTo>
                    <a:pt x="1829" y="1168"/>
                  </a:lnTo>
                  <a:lnTo>
                    <a:pt x="1829" y="1155"/>
                  </a:lnTo>
                  <a:lnTo>
                    <a:pt x="1843" y="1141"/>
                  </a:lnTo>
                  <a:lnTo>
                    <a:pt x="1843" y="1127"/>
                  </a:lnTo>
                  <a:lnTo>
                    <a:pt x="1843" y="1099"/>
                  </a:lnTo>
                  <a:lnTo>
                    <a:pt x="1843" y="1086"/>
                  </a:lnTo>
                  <a:lnTo>
                    <a:pt x="1857" y="1072"/>
                  </a:lnTo>
                  <a:lnTo>
                    <a:pt x="1857" y="1058"/>
                  </a:lnTo>
                  <a:lnTo>
                    <a:pt x="1857" y="1045"/>
                  </a:lnTo>
                  <a:lnTo>
                    <a:pt x="1857" y="1030"/>
                  </a:lnTo>
                  <a:lnTo>
                    <a:pt x="1857" y="1004"/>
                  </a:lnTo>
                  <a:lnTo>
                    <a:pt x="1857" y="989"/>
                  </a:lnTo>
                  <a:lnTo>
                    <a:pt x="1857" y="976"/>
                  </a:lnTo>
                  <a:lnTo>
                    <a:pt x="1857" y="962"/>
                  </a:lnTo>
                  <a:lnTo>
                    <a:pt x="1857" y="948"/>
                  </a:lnTo>
                  <a:lnTo>
                    <a:pt x="1871" y="935"/>
                  </a:lnTo>
                  <a:close/>
                </a:path>
              </a:pathLst>
            </a:custGeom>
            <a:solidFill>
              <a:srgbClr val="ff33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" name=""/>
            <p:cNvSpPr/>
            <p:nvPr/>
          </p:nvSpPr>
          <p:spPr>
            <a:xfrm>
              <a:off x="2725200" y="1487880"/>
              <a:ext cx="214560" cy="213840"/>
            </a:xfrm>
            <a:prstGeom prst="rect">
              <a:avLst/>
            </a:prstGeom>
            <a:noFill/>
            <a:ln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" name=""/>
            <p:cNvSpPr/>
            <p:nvPr/>
          </p:nvSpPr>
          <p:spPr>
            <a:xfrm>
              <a:off x="2789640" y="1552320"/>
              <a:ext cx="86040" cy="84240"/>
            </a:xfrm>
            <a:custGeom>
              <a:avLst/>
              <a:gdLst/>
              <a:ahLst/>
              <a:rect l="l" t="t" r="r" b="b"/>
              <a:pathLst>
                <a:path w="1650" h="1637">
                  <a:moveTo>
                    <a:pt x="1650" y="825"/>
                  </a:moveTo>
                  <a:lnTo>
                    <a:pt x="1637" y="798"/>
                  </a:lnTo>
                  <a:lnTo>
                    <a:pt x="1637" y="784"/>
                  </a:lnTo>
                  <a:lnTo>
                    <a:pt x="1637" y="771"/>
                  </a:lnTo>
                  <a:lnTo>
                    <a:pt x="1637" y="756"/>
                  </a:lnTo>
                  <a:lnTo>
                    <a:pt x="1637" y="743"/>
                  </a:lnTo>
                  <a:lnTo>
                    <a:pt x="1637" y="730"/>
                  </a:lnTo>
                  <a:lnTo>
                    <a:pt x="1637" y="715"/>
                  </a:lnTo>
                  <a:lnTo>
                    <a:pt x="1637" y="702"/>
                  </a:lnTo>
                  <a:lnTo>
                    <a:pt x="1637" y="688"/>
                  </a:lnTo>
                  <a:lnTo>
                    <a:pt x="1637" y="674"/>
                  </a:lnTo>
                  <a:lnTo>
                    <a:pt x="1623" y="661"/>
                  </a:lnTo>
                  <a:lnTo>
                    <a:pt x="1623" y="647"/>
                  </a:lnTo>
                  <a:lnTo>
                    <a:pt x="1623" y="633"/>
                  </a:lnTo>
                  <a:lnTo>
                    <a:pt x="1623" y="619"/>
                  </a:lnTo>
                  <a:lnTo>
                    <a:pt x="1609" y="605"/>
                  </a:lnTo>
                  <a:lnTo>
                    <a:pt x="1609" y="592"/>
                  </a:lnTo>
                  <a:lnTo>
                    <a:pt x="1609" y="578"/>
                  </a:lnTo>
                  <a:lnTo>
                    <a:pt x="1609" y="564"/>
                  </a:lnTo>
                  <a:lnTo>
                    <a:pt x="1596" y="551"/>
                  </a:lnTo>
                  <a:lnTo>
                    <a:pt x="1596" y="537"/>
                  </a:lnTo>
                  <a:lnTo>
                    <a:pt x="1596" y="523"/>
                  </a:lnTo>
                  <a:lnTo>
                    <a:pt x="1582" y="509"/>
                  </a:lnTo>
                  <a:lnTo>
                    <a:pt x="1582" y="496"/>
                  </a:lnTo>
                  <a:lnTo>
                    <a:pt x="1568" y="482"/>
                  </a:lnTo>
                  <a:lnTo>
                    <a:pt x="1568" y="468"/>
                  </a:lnTo>
                  <a:lnTo>
                    <a:pt x="1555" y="454"/>
                  </a:lnTo>
                  <a:lnTo>
                    <a:pt x="1555" y="440"/>
                  </a:lnTo>
                  <a:lnTo>
                    <a:pt x="1540" y="427"/>
                  </a:lnTo>
                  <a:lnTo>
                    <a:pt x="1540" y="413"/>
                  </a:lnTo>
                  <a:lnTo>
                    <a:pt x="1527" y="413"/>
                  </a:lnTo>
                  <a:lnTo>
                    <a:pt x="1527" y="399"/>
                  </a:lnTo>
                  <a:lnTo>
                    <a:pt x="1513" y="386"/>
                  </a:lnTo>
                  <a:lnTo>
                    <a:pt x="1513" y="372"/>
                  </a:lnTo>
                  <a:lnTo>
                    <a:pt x="1499" y="358"/>
                  </a:lnTo>
                  <a:lnTo>
                    <a:pt x="1499" y="345"/>
                  </a:lnTo>
                  <a:lnTo>
                    <a:pt x="1486" y="330"/>
                  </a:lnTo>
                  <a:lnTo>
                    <a:pt x="1471" y="317"/>
                  </a:lnTo>
                  <a:lnTo>
                    <a:pt x="1458" y="303"/>
                  </a:lnTo>
                  <a:lnTo>
                    <a:pt x="1445" y="289"/>
                  </a:lnTo>
                  <a:lnTo>
                    <a:pt x="1445" y="276"/>
                  </a:lnTo>
                  <a:lnTo>
                    <a:pt x="1430" y="261"/>
                  </a:lnTo>
                  <a:lnTo>
                    <a:pt x="1417" y="261"/>
                  </a:lnTo>
                  <a:lnTo>
                    <a:pt x="1417" y="248"/>
                  </a:lnTo>
                  <a:lnTo>
                    <a:pt x="1404" y="235"/>
                  </a:lnTo>
                  <a:lnTo>
                    <a:pt x="1389" y="220"/>
                  </a:lnTo>
                  <a:lnTo>
                    <a:pt x="1376" y="220"/>
                  </a:lnTo>
                  <a:lnTo>
                    <a:pt x="1376" y="207"/>
                  </a:lnTo>
                  <a:lnTo>
                    <a:pt x="1361" y="193"/>
                  </a:lnTo>
                  <a:lnTo>
                    <a:pt x="1348" y="193"/>
                  </a:lnTo>
                  <a:lnTo>
                    <a:pt x="1335" y="179"/>
                  </a:lnTo>
                  <a:lnTo>
                    <a:pt x="1320" y="166"/>
                  </a:lnTo>
                  <a:lnTo>
                    <a:pt x="1307" y="151"/>
                  </a:lnTo>
                  <a:lnTo>
                    <a:pt x="1293" y="138"/>
                  </a:lnTo>
                  <a:lnTo>
                    <a:pt x="1279" y="138"/>
                  </a:lnTo>
                  <a:lnTo>
                    <a:pt x="1266" y="125"/>
                  </a:lnTo>
                  <a:lnTo>
                    <a:pt x="1251" y="125"/>
                  </a:lnTo>
                  <a:lnTo>
                    <a:pt x="1238" y="110"/>
                  </a:lnTo>
                  <a:lnTo>
                    <a:pt x="1224" y="97"/>
                  </a:lnTo>
                  <a:lnTo>
                    <a:pt x="1210" y="97"/>
                  </a:lnTo>
                  <a:lnTo>
                    <a:pt x="1197" y="83"/>
                  </a:lnTo>
                  <a:lnTo>
                    <a:pt x="1183" y="83"/>
                  </a:lnTo>
                  <a:lnTo>
                    <a:pt x="1169" y="69"/>
                  </a:lnTo>
                  <a:lnTo>
                    <a:pt x="1156" y="69"/>
                  </a:lnTo>
                  <a:lnTo>
                    <a:pt x="1142" y="56"/>
                  </a:lnTo>
                  <a:lnTo>
                    <a:pt x="1128" y="56"/>
                  </a:lnTo>
                  <a:lnTo>
                    <a:pt x="1114" y="41"/>
                  </a:lnTo>
                  <a:lnTo>
                    <a:pt x="1100" y="41"/>
                  </a:lnTo>
                  <a:lnTo>
                    <a:pt x="1087" y="41"/>
                  </a:lnTo>
                  <a:lnTo>
                    <a:pt x="1073" y="28"/>
                  </a:lnTo>
                  <a:lnTo>
                    <a:pt x="1059" y="28"/>
                  </a:lnTo>
                  <a:lnTo>
                    <a:pt x="1045" y="28"/>
                  </a:lnTo>
                  <a:lnTo>
                    <a:pt x="1032" y="28"/>
                  </a:lnTo>
                  <a:lnTo>
                    <a:pt x="1018" y="15"/>
                  </a:lnTo>
                  <a:lnTo>
                    <a:pt x="1004" y="15"/>
                  </a:lnTo>
                  <a:lnTo>
                    <a:pt x="991" y="15"/>
                  </a:lnTo>
                  <a:lnTo>
                    <a:pt x="977" y="15"/>
                  </a:lnTo>
                  <a:lnTo>
                    <a:pt x="963" y="0"/>
                  </a:lnTo>
                  <a:lnTo>
                    <a:pt x="949" y="0"/>
                  </a:lnTo>
                  <a:lnTo>
                    <a:pt x="935" y="0"/>
                  </a:lnTo>
                  <a:lnTo>
                    <a:pt x="922" y="0"/>
                  </a:lnTo>
                  <a:lnTo>
                    <a:pt x="908" y="0"/>
                  </a:lnTo>
                  <a:lnTo>
                    <a:pt x="894" y="0"/>
                  </a:lnTo>
                  <a:lnTo>
                    <a:pt x="881" y="0"/>
                  </a:lnTo>
                  <a:lnTo>
                    <a:pt x="866" y="0"/>
                  </a:lnTo>
                  <a:lnTo>
                    <a:pt x="853" y="0"/>
                  </a:lnTo>
                  <a:lnTo>
                    <a:pt x="840" y="0"/>
                  </a:lnTo>
                  <a:lnTo>
                    <a:pt x="825" y="0"/>
                  </a:lnTo>
                  <a:lnTo>
                    <a:pt x="798" y="0"/>
                  </a:lnTo>
                  <a:lnTo>
                    <a:pt x="784" y="0"/>
                  </a:lnTo>
                  <a:lnTo>
                    <a:pt x="771" y="0"/>
                  </a:lnTo>
                  <a:lnTo>
                    <a:pt x="756" y="0"/>
                  </a:lnTo>
                  <a:lnTo>
                    <a:pt x="743" y="0"/>
                  </a:lnTo>
                  <a:lnTo>
                    <a:pt x="730" y="0"/>
                  </a:lnTo>
                  <a:lnTo>
                    <a:pt x="715" y="0"/>
                  </a:lnTo>
                  <a:lnTo>
                    <a:pt x="702" y="0"/>
                  </a:lnTo>
                  <a:lnTo>
                    <a:pt x="687" y="0"/>
                  </a:lnTo>
                  <a:lnTo>
                    <a:pt x="674" y="0"/>
                  </a:lnTo>
                  <a:lnTo>
                    <a:pt x="661" y="15"/>
                  </a:lnTo>
                  <a:lnTo>
                    <a:pt x="646" y="15"/>
                  </a:lnTo>
                  <a:lnTo>
                    <a:pt x="633" y="15"/>
                  </a:lnTo>
                  <a:lnTo>
                    <a:pt x="620" y="15"/>
                  </a:lnTo>
                  <a:lnTo>
                    <a:pt x="605" y="28"/>
                  </a:lnTo>
                  <a:lnTo>
                    <a:pt x="592" y="28"/>
                  </a:lnTo>
                  <a:lnTo>
                    <a:pt x="578" y="28"/>
                  </a:lnTo>
                  <a:lnTo>
                    <a:pt x="564" y="28"/>
                  </a:lnTo>
                  <a:lnTo>
                    <a:pt x="551" y="41"/>
                  </a:lnTo>
                  <a:lnTo>
                    <a:pt x="536" y="41"/>
                  </a:lnTo>
                  <a:lnTo>
                    <a:pt x="523" y="41"/>
                  </a:lnTo>
                  <a:lnTo>
                    <a:pt x="509" y="56"/>
                  </a:lnTo>
                  <a:lnTo>
                    <a:pt x="495" y="56"/>
                  </a:lnTo>
                  <a:lnTo>
                    <a:pt x="482" y="69"/>
                  </a:lnTo>
                  <a:lnTo>
                    <a:pt x="468" y="69"/>
                  </a:lnTo>
                  <a:lnTo>
                    <a:pt x="454" y="83"/>
                  </a:lnTo>
                  <a:lnTo>
                    <a:pt x="441" y="83"/>
                  </a:lnTo>
                  <a:lnTo>
                    <a:pt x="427" y="97"/>
                  </a:lnTo>
                  <a:lnTo>
                    <a:pt x="413" y="97"/>
                  </a:lnTo>
                  <a:lnTo>
                    <a:pt x="413" y="110"/>
                  </a:lnTo>
                  <a:lnTo>
                    <a:pt x="399" y="110"/>
                  </a:lnTo>
                  <a:lnTo>
                    <a:pt x="385" y="125"/>
                  </a:lnTo>
                  <a:lnTo>
                    <a:pt x="372" y="125"/>
                  </a:lnTo>
                  <a:lnTo>
                    <a:pt x="358" y="138"/>
                  </a:lnTo>
                  <a:lnTo>
                    <a:pt x="344" y="138"/>
                  </a:lnTo>
                  <a:lnTo>
                    <a:pt x="330" y="151"/>
                  </a:lnTo>
                  <a:lnTo>
                    <a:pt x="317" y="166"/>
                  </a:lnTo>
                  <a:lnTo>
                    <a:pt x="303" y="179"/>
                  </a:lnTo>
                  <a:lnTo>
                    <a:pt x="289" y="193"/>
                  </a:lnTo>
                  <a:lnTo>
                    <a:pt x="276" y="193"/>
                  </a:lnTo>
                  <a:lnTo>
                    <a:pt x="262" y="207"/>
                  </a:lnTo>
                  <a:lnTo>
                    <a:pt x="262" y="220"/>
                  </a:lnTo>
                  <a:lnTo>
                    <a:pt x="248" y="220"/>
                  </a:lnTo>
                  <a:lnTo>
                    <a:pt x="234" y="235"/>
                  </a:lnTo>
                  <a:lnTo>
                    <a:pt x="220" y="248"/>
                  </a:lnTo>
                  <a:lnTo>
                    <a:pt x="220" y="261"/>
                  </a:lnTo>
                  <a:lnTo>
                    <a:pt x="207" y="261"/>
                  </a:lnTo>
                  <a:lnTo>
                    <a:pt x="193" y="276"/>
                  </a:lnTo>
                  <a:lnTo>
                    <a:pt x="193" y="289"/>
                  </a:lnTo>
                  <a:lnTo>
                    <a:pt x="179" y="303"/>
                  </a:lnTo>
                  <a:lnTo>
                    <a:pt x="166" y="317"/>
                  </a:lnTo>
                  <a:lnTo>
                    <a:pt x="151" y="330"/>
                  </a:lnTo>
                  <a:lnTo>
                    <a:pt x="138" y="345"/>
                  </a:lnTo>
                  <a:lnTo>
                    <a:pt x="138" y="358"/>
                  </a:lnTo>
                  <a:lnTo>
                    <a:pt x="125" y="372"/>
                  </a:lnTo>
                  <a:lnTo>
                    <a:pt x="125" y="386"/>
                  </a:lnTo>
                  <a:lnTo>
                    <a:pt x="110" y="399"/>
                  </a:lnTo>
                  <a:lnTo>
                    <a:pt x="97" y="413"/>
                  </a:lnTo>
                  <a:lnTo>
                    <a:pt x="97" y="427"/>
                  </a:lnTo>
                  <a:lnTo>
                    <a:pt x="83" y="440"/>
                  </a:lnTo>
                  <a:lnTo>
                    <a:pt x="83" y="454"/>
                  </a:lnTo>
                  <a:lnTo>
                    <a:pt x="69" y="468"/>
                  </a:lnTo>
                  <a:lnTo>
                    <a:pt x="69" y="482"/>
                  </a:lnTo>
                  <a:lnTo>
                    <a:pt x="56" y="496"/>
                  </a:lnTo>
                  <a:lnTo>
                    <a:pt x="56" y="509"/>
                  </a:lnTo>
                  <a:lnTo>
                    <a:pt x="41" y="523"/>
                  </a:lnTo>
                  <a:lnTo>
                    <a:pt x="41" y="537"/>
                  </a:lnTo>
                  <a:lnTo>
                    <a:pt x="41" y="551"/>
                  </a:lnTo>
                  <a:lnTo>
                    <a:pt x="28" y="564"/>
                  </a:lnTo>
                  <a:lnTo>
                    <a:pt x="28" y="578"/>
                  </a:lnTo>
                  <a:lnTo>
                    <a:pt x="28" y="592"/>
                  </a:lnTo>
                  <a:lnTo>
                    <a:pt x="28" y="605"/>
                  </a:lnTo>
                  <a:lnTo>
                    <a:pt x="15" y="619"/>
                  </a:lnTo>
                  <a:lnTo>
                    <a:pt x="15" y="633"/>
                  </a:lnTo>
                  <a:lnTo>
                    <a:pt x="15" y="647"/>
                  </a:lnTo>
                  <a:lnTo>
                    <a:pt x="15" y="661"/>
                  </a:lnTo>
                  <a:lnTo>
                    <a:pt x="0" y="674"/>
                  </a:lnTo>
                  <a:lnTo>
                    <a:pt x="0" y="688"/>
                  </a:lnTo>
                  <a:lnTo>
                    <a:pt x="0" y="702"/>
                  </a:lnTo>
                  <a:lnTo>
                    <a:pt x="0" y="715"/>
                  </a:lnTo>
                  <a:lnTo>
                    <a:pt x="0" y="730"/>
                  </a:lnTo>
                  <a:lnTo>
                    <a:pt x="0" y="743"/>
                  </a:lnTo>
                  <a:lnTo>
                    <a:pt x="0" y="756"/>
                  </a:lnTo>
                  <a:lnTo>
                    <a:pt x="0" y="771"/>
                  </a:lnTo>
                  <a:lnTo>
                    <a:pt x="0" y="784"/>
                  </a:lnTo>
                  <a:lnTo>
                    <a:pt x="0" y="798"/>
                  </a:lnTo>
                  <a:lnTo>
                    <a:pt x="0" y="812"/>
                  </a:lnTo>
                  <a:lnTo>
                    <a:pt x="0" y="840"/>
                  </a:lnTo>
                  <a:lnTo>
                    <a:pt x="0" y="853"/>
                  </a:lnTo>
                  <a:lnTo>
                    <a:pt x="0" y="866"/>
                  </a:lnTo>
                  <a:lnTo>
                    <a:pt x="0" y="881"/>
                  </a:lnTo>
                  <a:lnTo>
                    <a:pt x="0" y="894"/>
                  </a:lnTo>
                  <a:lnTo>
                    <a:pt x="0" y="908"/>
                  </a:lnTo>
                  <a:lnTo>
                    <a:pt x="0" y="922"/>
                  </a:lnTo>
                  <a:lnTo>
                    <a:pt x="0" y="935"/>
                  </a:lnTo>
                  <a:lnTo>
                    <a:pt x="0" y="950"/>
                  </a:lnTo>
                  <a:lnTo>
                    <a:pt x="0" y="963"/>
                  </a:lnTo>
                  <a:lnTo>
                    <a:pt x="15" y="976"/>
                  </a:lnTo>
                  <a:lnTo>
                    <a:pt x="15" y="991"/>
                  </a:lnTo>
                  <a:lnTo>
                    <a:pt x="15" y="1004"/>
                  </a:lnTo>
                  <a:lnTo>
                    <a:pt x="15" y="1018"/>
                  </a:lnTo>
                  <a:lnTo>
                    <a:pt x="28" y="1032"/>
                  </a:lnTo>
                  <a:lnTo>
                    <a:pt x="28" y="1045"/>
                  </a:lnTo>
                  <a:lnTo>
                    <a:pt x="28" y="1059"/>
                  </a:lnTo>
                  <a:lnTo>
                    <a:pt x="28" y="1073"/>
                  </a:lnTo>
                  <a:lnTo>
                    <a:pt x="41" y="1087"/>
                  </a:lnTo>
                  <a:lnTo>
                    <a:pt x="41" y="1101"/>
                  </a:lnTo>
                  <a:lnTo>
                    <a:pt x="41" y="1114"/>
                  </a:lnTo>
                  <a:lnTo>
                    <a:pt x="56" y="1128"/>
                  </a:lnTo>
                  <a:lnTo>
                    <a:pt x="56" y="1142"/>
                  </a:lnTo>
                  <a:lnTo>
                    <a:pt x="69" y="1155"/>
                  </a:lnTo>
                  <a:lnTo>
                    <a:pt x="69" y="1169"/>
                  </a:lnTo>
                  <a:lnTo>
                    <a:pt x="83" y="1183"/>
                  </a:lnTo>
                  <a:lnTo>
                    <a:pt x="83" y="1197"/>
                  </a:lnTo>
                  <a:lnTo>
                    <a:pt x="97" y="1211"/>
                  </a:lnTo>
                  <a:lnTo>
                    <a:pt x="97" y="1224"/>
                  </a:lnTo>
                  <a:lnTo>
                    <a:pt x="110" y="1224"/>
                  </a:lnTo>
                  <a:lnTo>
                    <a:pt x="110" y="1238"/>
                  </a:lnTo>
                  <a:lnTo>
                    <a:pt x="125" y="1252"/>
                  </a:lnTo>
                  <a:lnTo>
                    <a:pt x="125" y="1266"/>
                  </a:lnTo>
                  <a:lnTo>
                    <a:pt x="138" y="1279"/>
                  </a:lnTo>
                  <a:lnTo>
                    <a:pt x="138" y="1293"/>
                  </a:lnTo>
                  <a:lnTo>
                    <a:pt x="151" y="1307"/>
                  </a:lnTo>
                  <a:lnTo>
                    <a:pt x="166" y="1320"/>
                  </a:lnTo>
                  <a:lnTo>
                    <a:pt x="179" y="1334"/>
                  </a:lnTo>
                  <a:lnTo>
                    <a:pt x="193" y="1348"/>
                  </a:lnTo>
                  <a:lnTo>
                    <a:pt x="193" y="1362"/>
                  </a:lnTo>
                  <a:lnTo>
                    <a:pt x="207" y="1376"/>
                  </a:lnTo>
                  <a:lnTo>
                    <a:pt x="220" y="1376"/>
                  </a:lnTo>
                  <a:lnTo>
                    <a:pt x="220" y="1389"/>
                  </a:lnTo>
                  <a:lnTo>
                    <a:pt x="234" y="1403"/>
                  </a:lnTo>
                  <a:lnTo>
                    <a:pt x="248" y="1417"/>
                  </a:lnTo>
                  <a:lnTo>
                    <a:pt x="262" y="1417"/>
                  </a:lnTo>
                  <a:lnTo>
                    <a:pt x="262" y="1430"/>
                  </a:lnTo>
                  <a:lnTo>
                    <a:pt x="276" y="1445"/>
                  </a:lnTo>
                  <a:lnTo>
                    <a:pt x="289" y="1445"/>
                  </a:lnTo>
                  <a:lnTo>
                    <a:pt x="303" y="1458"/>
                  </a:lnTo>
                  <a:lnTo>
                    <a:pt x="317" y="1471"/>
                  </a:lnTo>
                  <a:lnTo>
                    <a:pt x="330" y="1486"/>
                  </a:lnTo>
                  <a:lnTo>
                    <a:pt x="344" y="1499"/>
                  </a:lnTo>
                  <a:lnTo>
                    <a:pt x="358" y="1499"/>
                  </a:lnTo>
                  <a:lnTo>
                    <a:pt x="372" y="1513"/>
                  </a:lnTo>
                  <a:lnTo>
                    <a:pt x="385" y="1513"/>
                  </a:lnTo>
                  <a:lnTo>
                    <a:pt x="399" y="1527"/>
                  </a:lnTo>
                  <a:lnTo>
                    <a:pt x="413" y="1540"/>
                  </a:lnTo>
                  <a:lnTo>
                    <a:pt x="427" y="1540"/>
                  </a:lnTo>
                  <a:lnTo>
                    <a:pt x="441" y="1555"/>
                  </a:lnTo>
                  <a:lnTo>
                    <a:pt x="454" y="1555"/>
                  </a:lnTo>
                  <a:lnTo>
                    <a:pt x="468" y="1568"/>
                  </a:lnTo>
                  <a:lnTo>
                    <a:pt x="482" y="1568"/>
                  </a:lnTo>
                  <a:lnTo>
                    <a:pt x="495" y="1581"/>
                  </a:lnTo>
                  <a:lnTo>
                    <a:pt x="509" y="1581"/>
                  </a:lnTo>
                  <a:lnTo>
                    <a:pt x="523" y="1596"/>
                  </a:lnTo>
                  <a:lnTo>
                    <a:pt x="536" y="1596"/>
                  </a:lnTo>
                  <a:lnTo>
                    <a:pt x="551" y="1596"/>
                  </a:lnTo>
                  <a:lnTo>
                    <a:pt x="564" y="1609"/>
                  </a:lnTo>
                  <a:lnTo>
                    <a:pt x="578" y="1609"/>
                  </a:lnTo>
                  <a:lnTo>
                    <a:pt x="592" y="1609"/>
                  </a:lnTo>
                  <a:lnTo>
                    <a:pt x="605" y="1609"/>
                  </a:lnTo>
                  <a:lnTo>
                    <a:pt x="620" y="1623"/>
                  </a:lnTo>
                  <a:lnTo>
                    <a:pt x="633" y="1623"/>
                  </a:lnTo>
                  <a:lnTo>
                    <a:pt x="646" y="1623"/>
                  </a:lnTo>
                  <a:lnTo>
                    <a:pt x="661" y="1623"/>
                  </a:lnTo>
                  <a:lnTo>
                    <a:pt x="674" y="1637"/>
                  </a:lnTo>
                  <a:lnTo>
                    <a:pt x="687" y="1637"/>
                  </a:lnTo>
                  <a:lnTo>
                    <a:pt x="702" y="1637"/>
                  </a:lnTo>
                  <a:lnTo>
                    <a:pt x="715" y="1637"/>
                  </a:lnTo>
                  <a:lnTo>
                    <a:pt x="730" y="1637"/>
                  </a:lnTo>
                  <a:lnTo>
                    <a:pt x="743" y="1637"/>
                  </a:lnTo>
                  <a:lnTo>
                    <a:pt x="756" y="1637"/>
                  </a:lnTo>
                  <a:lnTo>
                    <a:pt x="771" y="1637"/>
                  </a:lnTo>
                  <a:lnTo>
                    <a:pt x="784" y="1637"/>
                  </a:lnTo>
                  <a:lnTo>
                    <a:pt x="798" y="1637"/>
                  </a:lnTo>
                  <a:lnTo>
                    <a:pt x="812" y="1637"/>
                  </a:lnTo>
                  <a:lnTo>
                    <a:pt x="840" y="1637"/>
                  </a:lnTo>
                  <a:lnTo>
                    <a:pt x="853" y="1637"/>
                  </a:lnTo>
                  <a:lnTo>
                    <a:pt x="866" y="1637"/>
                  </a:lnTo>
                  <a:lnTo>
                    <a:pt x="881" y="1637"/>
                  </a:lnTo>
                  <a:lnTo>
                    <a:pt x="894" y="1637"/>
                  </a:lnTo>
                  <a:lnTo>
                    <a:pt x="908" y="1637"/>
                  </a:lnTo>
                  <a:lnTo>
                    <a:pt x="922" y="1637"/>
                  </a:lnTo>
                  <a:lnTo>
                    <a:pt x="935" y="1637"/>
                  </a:lnTo>
                  <a:lnTo>
                    <a:pt x="949" y="1637"/>
                  </a:lnTo>
                  <a:lnTo>
                    <a:pt x="963" y="1637"/>
                  </a:lnTo>
                  <a:lnTo>
                    <a:pt x="977" y="1623"/>
                  </a:lnTo>
                  <a:lnTo>
                    <a:pt x="991" y="1623"/>
                  </a:lnTo>
                  <a:lnTo>
                    <a:pt x="1004" y="1623"/>
                  </a:lnTo>
                  <a:lnTo>
                    <a:pt x="1018" y="1623"/>
                  </a:lnTo>
                  <a:lnTo>
                    <a:pt x="1032" y="1609"/>
                  </a:lnTo>
                  <a:lnTo>
                    <a:pt x="1045" y="1609"/>
                  </a:lnTo>
                  <a:lnTo>
                    <a:pt x="1059" y="1609"/>
                  </a:lnTo>
                  <a:lnTo>
                    <a:pt x="1073" y="1609"/>
                  </a:lnTo>
                  <a:lnTo>
                    <a:pt x="1087" y="1596"/>
                  </a:lnTo>
                  <a:lnTo>
                    <a:pt x="1100" y="1596"/>
                  </a:lnTo>
                  <a:lnTo>
                    <a:pt x="1114" y="1596"/>
                  </a:lnTo>
                  <a:lnTo>
                    <a:pt x="1128" y="1581"/>
                  </a:lnTo>
                  <a:lnTo>
                    <a:pt x="1142" y="1581"/>
                  </a:lnTo>
                  <a:lnTo>
                    <a:pt x="1156" y="1568"/>
                  </a:lnTo>
                  <a:lnTo>
                    <a:pt x="1169" y="1568"/>
                  </a:lnTo>
                  <a:lnTo>
                    <a:pt x="1183" y="1555"/>
                  </a:lnTo>
                  <a:lnTo>
                    <a:pt x="1197" y="1555"/>
                  </a:lnTo>
                  <a:lnTo>
                    <a:pt x="1210" y="1540"/>
                  </a:lnTo>
                  <a:lnTo>
                    <a:pt x="1224" y="1540"/>
                  </a:lnTo>
                  <a:lnTo>
                    <a:pt x="1224" y="1527"/>
                  </a:lnTo>
                  <a:lnTo>
                    <a:pt x="1238" y="1527"/>
                  </a:lnTo>
                  <a:lnTo>
                    <a:pt x="1251" y="1513"/>
                  </a:lnTo>
                  <a:lnTo>
                    <a:pt x="1266" y="1513"/>
                  </a:lnTo>
                  <a:lnTo>
                    <a:pt x="1279" y="1499"/>
                  </a:lnTo>
                  <a:lnTo>
                    <a:pt x="1293" y="1499"/>
                  </a:lnTo>
                  <a:lnTo>
                    <a:pt x="1307" y="1486"/>
                  </a:lnTo>
                  <a:lnTo>
                    <a:pt x="1320" y="1471"/>
                  </a:lnTo>
                  <a:lnTo>
                    <a:pt x="1335" y="1458"/>
                  </a:lnTo>
                  <a:lnTo>
                    <a:pt x="1348" y="1445"/>
                  </a:lnTo>
                  <a:lnTo>
                    <a:pt x="1361" y="1445"/>
                  </a:lnTo>
                  <a:lnTo>
                    <a:pt x="1376" y="1430"/>
                  </a:lnTo>
                  <a:lnTo>
                    <a:pt x="1376" y="1417"/>
                  </a:lnTo>
                  <a:lnTo>
                    <a:pt x="1389" y="1417"/>
                  </a:lnTo>
                  <a:lnTo>
                    <a:pt x="1404" y="1403"/>
                  </a:lnTo>
                  <a:lnTo>
                    <a:pt x="1417" y="1389"/>
                  </a:lnTo>
                  <a:lnTo>
                    <a:pt x="1417" y="1376"/>
                  </a:lnTo>
                  <a:lnTo>
                    <a:pt x="1430" y="1376"/>
                  </a:lnTo>
                  <a:lnTo>
                    <a:pt x="1445" y="1362"/>
                  </a:lnTo>
                  <a:lnTo>
                    <a:pt x="1445" y="1348"/>
                  </a:lnTo>
                  <a:lnTo>
                    <a:pt x="1458" y="1334"/>
                  </a:lnTo>
                  <a:lnTo>
                    <a:pt x="1471" y="1320"/>
                  </a:lnTo>
                  <a:lnTo>
                    <a:pt x="1486" y="1307"/>
                  </a:lnTo>
                  <a:lnTo>
                    <a:pt x="1499" y="1293"/>
                  </a:lnTo>
                  <a:lnTo>
                    <a:pt x="1499" y="1279"/>
                  </a:lnTo>
                  <a:lnTo>
                    <a:pt x="1513" y="1266"/>
                  </a:lnTo>
                  <a:lnTo>
                    <a:pt x="1513" y="1252"/>
                  </a:lnTo>
                  <a:lnTo>
                    <a:pt x="1527" y="1238"/>
                  </a:lnTo>
                  <a:lnTo>
                    <a:pt x="1540" y="1224"/>
                  </a:lnTo>
                  <a:lnTo>
                    <a:pt x="1540" y="1211"/>
                  </a:lnTo>
                  <a:lnTo>
                    <a:pt x="1555" y="1197"/>
                  </a:lnTo>
                  <a:lnTo>
                    <a:pt x="1555" y="1183"/>
                  </a:lnTo>
                  <a:lnTo>
                    <a:pt x="1568" y="1169"/>
                  </a:lnTo>
                  <a:lnTo>
                    <a:pt x="1568" y="1155"/>
                  </a:lnTo>
                  <a:lnTo>
                    <a:pt x="1582" y="1142"/>
                  </a:lnTo>
                  <a:lnTo>
                    <a:pt x="1582" y="1128"/>
                  </a:lnTo>
                  <a:lnTo>
                    <a:pt x="1596" y="1114"/>
                  </a:lnTo>
                  <a:lnTo>
                    <a:pt x="1596" y="1101"/>
                  </a:lnTo>
                  <a:lnTo>
                    <a:pt x="1596" y="1087"/>
                  </a:lnTo>
                  <a:lnTo>
                    <a:pt x="1609" y="1073"/>
                  </a:lnTo>
                  <a:lnTo>
                    <a:pt x="1609" y="1059"/>
                  </a:lnTo>
                  <a:lnTo>
                    <a:pt x="1609" y="1045"/>
                  </a:lnTo>
                  <a:lnTo>
                    <a:pt x="1609" y="1032"/>
                  </a:lnTo>
                  <a:lnTo>
                    <a:pt x="1623" y="1018"/>
                  </a:lnTo>
                  <a:lnTo>
                    <a:pt x="1623" y="1004"/>
                  </a:lnTo>
                  <a:lnTo>
                    <a:pt x="1623" y="991"/>
                  </a:lnTo>
                  <a:lnTo>
                    <a:pt x="1623" y="976"/>
                  </a:lnTo>
                  <a:lnTo>
                    <a:pt x="1637" y="963"/>
                  </a:lnTo>
                  <a:lnTo>
                    <a:pt x="1637" y="950"/>
                  </a:lnTo>
                  <a:lnTo>
                    <a:pt x="1637" y="935"/>
                  </a:lnTo>
                  <a:lnTo>
                    <a:pt x="1637" y="922"/>
                  </a:lnTo>
                  <a:lnTo>
                    <a:pt x="1637" y="908"/>
                  </a:lnTo>
                  <a:lnTo>
                    <a:pt x="1637" y="894"/>
                  </a:lnTo>
                  <a:lnTo>
                    <a:pt x="1637" y="881"/>
                  </a:lnTo>
                  <a:lnTo>
                    <a:pt x="1637" y="866"/>
                  </a:lnTo>
                  <a:lnTo>
                    <a:pt x="1637" y="853"/>
                  </a:lnTo>
                  <a:lnTo>
                    <a:pt x="1637" y="840"/>
                  </a:lnTo>
                  <a:lnTo>
                    <a:pt x="1650" y="825"/>
                  </a:lnTo>
                  <a:close/>
                </a:path>
              </a:pathLst>
            </a:custGeom>
            <a:solidFill>
              <a:srgbClr val="ff33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7440" bIns="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" name=""/>
            <p:cNvSpPr/>
            <p:nvPr/>
          </p:nvSpPr>
          <p:spPr>
            <a:xfrm>
              <a:off x="2725200" y="1702080"/>
              <a:ext cx="214560" cy="214200"/>
            </a:xfrm>
            <a:prstGeom prst="rect">
              <a:avLst/>
            </a:prstGeom>
            <a:noFill/>
            <a:ln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" name=""/>
            <p:cNvSpPr/>
            <p:nvPr/>
          </p:nvSpPr>
          <p:spPr>
            <a:xfrm>
              <a:off x="2763000" y="1739520"/>
              <a:ext cx="139320" cy="138960"/>
            </a:xfrm>
            <a:custGeom>
              <a:avLst/>
              <a:gdLst/>
              <a:ahLst/>
              <a:rect l="l" t="t" r="r" b="b"/>
              <a:pathLst>
                <a:path w="2681" h="2668">
                  <a:moveTo>
                    <a:pt x="2681" y="1335"/>
                  </a:moveTo>
                  <a:lnTo>
                    <a:pt x="2668" y="1307"/>
                  </a:lnTo>
                  <a:lnTo>
                    <a:pt x="2668" y="1294"/>
                  </a:lnTo>
                  <a:lnTo>
                    <a:pt x="2668" y="1266"/>
                  </a:lnTo>
                  <a:lnTo>
                    <a:pt x="2668" y="1238"/>
                  </a:lnTo>
                  <a:lnTo>
                    <a:pt x="2668" y="1225"/>
                  </a:lnTo>
                  <a:lnTo>
                    <a:pt x="2668" y="1197"/>
                  </a:lnTo>
                  <a:lnTo>
                    <a:pt x="2668" y="1169"/>
                  </a:lnTo>
                  <a:lnTo>
                    <a:pt x="2668" y="1142"/>
                  </a:lnTo>
                  <a:lnTo>
                    <a:pt x="2653" y="1128"/>
                  </a:lnTo>
                  <a:lnTo>
                    <a:pt x="2653" y="1101"/>
                  </a:lnTo>
                  <a:lnTo>
                    <a:pt x="2653" y="1073"/>
                  </a:lnTo>
                  <a:lnTo>
                    <a:pt x="2640" y="1060"/>
                  </a:lnTo>
                  <a:lnTo>
                    <a:pt x="2640" y="1032"/>
                  </a:lnTo>
                  <a:lnTo>
                    <a:pt x="2640" y="1004"/>
                  </a:lnTo>
                  <a:lnTo>
                    <a:pt x="2627" y="991"/>
                  </a:lnTo>
                  <a:lnTo>
                    <a:pt x="2627" y="963"/>
                  </a:lnTo>
                  <a:lnTo>
                    <a:pt x="2612" y="936"/>
                  </a:lnTo>
                  <a:lnTo>
                    <a:pt x="2612" y="922"/>
                  </a:lnTo>
                  <a:lnTo>
                    <a:pt x="2599" y="894"/>
                  </a:lnTo>
                  <a:lnTo>
                    <a:pt x="2599" y="881"/>
                  </a:lnTo>
                  <a:lnTo>
                    <a:pt x="2584" y="853"/>
                  </a:lnTo>
                  <a:lnTo>
                    <a:pt x="2571" y="825"/>
                  </a:lnTo>
                  <a:lnTo>
                    <a:pt x="2571" y="812"/>
                  </a:lnTo>
                  <a:lnTo>
                    <a:pt x="2558" y="784"/>
                  </a:lnTo>
                  <a:lnTo>
                    <a:pt x="2543" y="771"/>
                  </a:lnTo>
                  <a:lnTo>
                    <a:pt x="2543" y="743"/>
                  </a:lnTo>
                  <a:lnTo>
                    <a:pt x="2530" y="730"/>
                  </a:lnTo>
                  <a:lnTo>
                    <a:pt x="2516" y="702"/>
                  </a:lnTo>
                  <a:lnTo>
                    <a:pt x="2502" y="689"/>
                  </a:lnTo>
                  <a:lnTo>
                    <a:pt x="2489" y="661"/>
                  </a:lnTo>
                  <a:lnTo>
                    <a:pt x="2489" y="647"/>
                  </a:lnTo>
                  <a:lnTo>
                    <a:pt x="2474" y="620"/>
                  </a:lnTo>
                  <a:lnTo>
                    <a:pt x="2461" y="605"/>
                  </a:lnTo>
                  <a:lnTo>
                    <a:pt x="2448" y="578"/>
                  </a:lnTo>
                  <a:lnTo>
                    <a:pt x="2433" y="564"/>
                  </a:lnTo>
                  <a:lnTo>
                    <a:pt x="2420" y="551"/>
                  </a:lnTo>
                  <a:lnTo>
                    <a:pt x="2406" y="523"/>
                  </a:lnTo>
                  <a:lnTo>
                    <a:pt x="2392" y="510"/>
                  </a:lnTo>
                  <a:lnTo>
                    <a:pt x="2379" y="496"/>
                  </a:lnTo>
                  <a:lnTo>
                    <a:pt x="2365" y="468"/>
                  </a:lnTo>
                  <a:lnTo>
                    <a:pt x="2351" y="454"/>
                  </a:lnTo>
                  <a:lnTo>
                    <a:pt x="2323" y="441"/>
                  </a:lnTo>
                  <a:lnTo>
                    <a:pt x="2310" y="427"/>
                  </a:lnTo>
                  <a:lnTo>
                    <a:pt x="2296" y="399"/>
                  </a:lnTo>
                  <a:lnTo>
                    <a:pt x="2282" y="386"/>
                  </a:lnTo>
                  <a:lnTo>
                    <a:pt x="2269" y="372"/>
                  </a:lnTo>
                  <a:lnTo>
                    <a:pt x="2241" y="358"/>
                  </a:lnTo>
                  <a:lnTo>
                    <a:pt x="2227" y="345"/>
                  </a:lnTo>
                  <a:lnTo>
                    <a:pt x="2214" y="317"/>
                  </a:lnTo>
                  <a:lnTo>
                    <a:pt x="2200" y="303"/>
                  </a:lnTo>
                  <a:lnTo>
                    <a:pt x="2172" y="289"/>
                  </a:lnTo>
                  <a:lnTo>
                    <a:pt x="2158" y="276"/>
                  </a:lnTo>
                  <a:lnTo>
                    <a:pt x="2145" y="262"/>
                  </a:lnTo>
                  <a:lnTo>
                    <a:pt x="2117" y="248"/>
                  </a:lnTo>
                  <a:lnTo>
                    <a:pt x="2104" y="235"/>
                  </a:lnTo>
                  <a:lnTo>
                    <a:pt x="2090" y="220"/>
                  </a:lnTo>
                  <a:lnTo>
                    <a:pt x="2063" y="207"/>
                  </a:lnTo>
                  <a:lnTo>
                    <a:pt x="2048" y="194"/>
                  </a:lnTo>
                  <a:lnTo>
                    <a:pt x="2021" y="179"/>
                  </a:lnTo>
                  <a:lnTo>
                    <a:pt x="2007" y="179"/>
                  </a:lnTo>
                  <a:lnTo>
                    <a:pt x="1979" y="166"/>
                  </a:lnTo>
                  <a:lnTo>
                    <a:pt x="1966" y="152"/>
                  </a:lnTo>
                  <a:lnTo>
                    <a:pt x="1938" y="138"/>
                  </a:lnTo>
                  <a:lnTo>
                    <a:pt x="1925" y="125"/>
                  </a:lnTo>
                  <a:lnTo>
                    <a:pt x="1897" y="125"/>
                  </a:lnTo>
                  <a:lnTo>
                    <a:pt x="1884" y="110"/>
                  </a:lnTo>
                  <a:lnTo>
                    <a:pt x="1856" y="97"/>
                  </a:lnTo>
                  <a:lnTo>
                    <a:pt x="1843" y="97"/>
                  </a:lnTo>
                  <a:lnTo>
                    <a:pt x="1815" y="84"/>
                  </a:lnTo>
                  <a:lnTo>
                    <a:pt x="1787" y="69"/>
                  </a:lnTo>
                  <a:lnTo>
                    <a:pt x="1774" y="69"/>
                  </a:lnTo>
                  <a:lnTo>
                    <a:pt x="1746" y="56"/>
                  </a:lnTo>
                  <a:lnTo>
                    <a:pt x="1732" y="56"/>
                  </a:lnTo>
                  <a:lnTo>
                    <a:pt x="1705" y="41"/>
                  </a:lnTo>
                  <a:lnTo>
                    <a:pt x="1677" y="41"/>
                  </a:lnTo>
                  <a:lnTo>
                    <a:pt x="1664" y="28"/>
                  </a:lnTo>
                  <a:lnTo>
                    <a:pt x="1636" y="28"/>
                  </a:lnTo>
                  <a:lnTo>
                    <a:pt x="1608" y="28"/>
                  </a:lnTo>
                  <a:lnTo>
                    <a:pt x="1595" y="15"/>
                  </a:lnTo>
                  <a:lnTo>
                    <a:pt x="1567" y="15"/>
                  </a:lnTo>
                  <a:lnTo>
                    <a:pt x="1540" y="15"/>
                  </a:lnTo>
                  <a:lnTo>
                    <a:pt x="1526" y="0"/>
                  </a:lnTo>
                  <a:lnTo>
                    <a:pt x="1499" y="0"/>
                  </a:lnTo>
                  <a:lnTo>
                    <a:pt x="1471" y="0"/>
                  </a:lnTo>
                  <a:lnTo>
                    <a:pt x="1443" y="0"/>
                  </a:lnTo>
                  <a:lnTo>
                    <a:pt x="1430" y="0"/>
                  </a:lnTo>
                  <a:lnTo>
                    <a:pt x="1402" y="0"/>
                  </a:lnTo>
                  <a:lnTo>
                    <a:pt x="1374" y="0"/>
                  </a:lnTo>
                  <a:lnTo>
                    <a:pt x="1361" y="0"/>
                  </a:lnTo>
                  <a:lnTo>
                    <a:pt x="1333" y="0"/>
                  </a:lnTo>
                  <a:lnTo>
                    <a:pt x="1306" y="0"/>
                  </a:lnTo>
                  <a:lnTo>
                    <a:pt x="1292" y="0"/>
                  </a:lnTo>
                  <a:lnTo>
                    <a:pt x="1264" y="0"/>
                  </a:lnTo>
                  <a:lnTo>
                    <a:pt x="1238" y="0"/>
                  </a:lnTo>
                  <a:lnTo>
                    <a:pt x="1223" y="0"/>
                  </a:lnTo>
                  <a:lnTo>
                    <a:pt x="1195" y="0"/>
                  </a:lnTo>
                  <a:lnTo>
                    <a:pt x="1169" y="0"/>
                  </a:lnTo>
                  <a:lnTo>
                    <a:pt x="1141" y="0"/>
                  </a:lnTo>
                  <a:lnTo>
                    <a:pt x="1128" y="15"/>
                  </a:lnTo>
                  <a:lnTo>
                    <a:pt x="1100" y="15"/>
                  </a:lnTo>
                  <a:lnTo>
                    <a:pt x="1072" y="15"/>
                  </a:lnTo>
                  <a:lnTo>
                    <a:pt x="1059" y="28"/>
                  </a:lnTo>
                  <a:lnTo>
                    <a:pt x="1031" y="28"/>
                  </a:lnTo>
                  <a:lnTo>
                    <a:pt x="1003" y="28"/>
                  </a:lnTo>
                  <a:lnTo>
                    <a:pt x="990" y="41"/>
                  </a:lnTo>
                  <a:lnTo>
                    <a:pt x="962" y="41"/>
                  </a:lnTo>
                  <a:lnTo>
                    <a:pt x="935" y="56"/>
                  </a:lnTo>
                  <a:lnTo>
                    <a:pt x="921" y="56"/>
                  </a:lnTo>
                  <a:lnTo>
                    <a:pt x="893" y="69"/>
                  </a:lnTo>
                  <a:lnTo>
                    <a:pt x="880" y="69"/>
                  </a:lnTo>
                  <a:lnTo>
                    <a:pt x="852" y="84"/>
                  </a:lnTo>
                  <a:lnTo>
                    <a:pt x="825" y="97"/>
                  </a:lnTo>
                  <a:lnTo>
                    <a:pt x="811" y="97"/>
                  </a:lnTo>
                  <a:lnTo>
                    <a:pt x="784" y="110"/>
                  </a:lnTo>
                  <a:lnTo>
                    <a:pt x="770" y="125"/>
                  </a:lnTo>
                  <a:lnTo>
                    <a:pt x="742" y="125"/>
                  </a:lnTo>
                  <a:lnTo>
                    <a:pt x="728" y="138"/>
                  </a:lnTo>
                  <a:lnTo>
                    <a:pt x="701" y="152"/>
                  </a:lnTo>
                  <a:lnTo>
                    <a:pt x="687" y="166"/>
                  </a:lnTo>
                  <a:lnTo>
                    <a:pt x="659" y="179"/>
                  </a:lnTo>
                  <a:lnTo>
                    <a:pt x="646" y="179"/>
                  </a:lnTo>
                  <a:lnTo>
                    <a:pt x="618" y="194"/>
                  </a:lnTo>
                  <a:lnTo>
                    <a:pt x="605" y="207"/>
                  </a:lnTo>
                  <a:lnTo>
                    <a:pt x="577" y="220"/>
                  </a:lnTo>
                  <a:lnTo>
                    <a:pt x="564" y="235"/>
                  </a:lnTo>
                  <a:lnTo>
                    <a:pt x="549" y="248"/>
                  </a:lnTo>
                  <a:lnTo>
                    <a:pt x="523" y="262"/>
                  </a:lnTo>
                  <a:lnTo>
                    <a:pt x="508" y="276"/>
                  </a:lnTo>
                  <a:lnTo>
                    <a:pt x="495" y="289"/>
                  </a:lnTo>
                  <a:lnTo>
                    <a:pt x="467" y="303"/>
                  </a:lnTo>
                  <a:lnTo>
                    <a:pt x="454" y="317"/>
                  </a:lnTo>
                  <a:lnTo>
                    <a:pt x="439" y="345"/>
                  </a:lnTo>
                  <a:lnTo>
                    <a:pt x="426" y="358"/>
                  </a:lnTo>
                  <a:lnTo>
                    <a:pt x="398" y="372"/>
                  </a:lnTo>
                  <a:lnTo>
                    <a:pt x="385" y="386"/>
                  </a:lnTo>
                  <a:lnTo>
                    <a:pt x="371" y="399"/>
                  </a:lnTo>
                  <a:lnTo>
                    <a:pt x="357" y="427"/>
                  </a:lnTo>
                  <a:lnTo>
                    <a:pt x="344" y="441"/>
                  </a:lnTo>
                  <a:lnTo>
                    <a:pt x="316" y="454"/>
                  </a:lnTo>
                  <a:lnTo>
                    <a:pt x="302" y="468"/>
                  </a:lnTo>
                  <a:lnTo>
                    <a:pt x="288" y="496"/>
                  </a:lnTo>
                  <a:lnTo>
                    <a:pt x="275" y="510"/>
                  </a:lnTo>
                  <a:lnTo>
                    <a:pt x="261" y="523"/>
                  </a:lnTo>
                  <a:lnTo>
                    <a:pt x="247" y="551"/>
                  </a:lnTo>
                  <a:lnTo>
                    <a:pt x="234" y="564"/>
                  </a:lnTo>
                  <a:lnTo>
                    <a:pt x="220" y="578"/>
                  </a:lnTo>
                  <a:lnTo>
                    <a:pt x="206" y="605"/>
                  </a:lnTo>
                  <a:lnTo>
                    <a:pt x="192" y="620"/>
                  </a:lnTo>
                  <a:lnTo>
                    <a:pt x="178" y="647"/>
                  </a:lnTo>
                  <a:lnTo>
                    <a:pt x="178" y="661"/>
                  </a:lnTo>
                  <a:lnTo>
                    <a:pt x="165" y="689"/>
                  </a:lnTo>
                  <a:lnTo>
                    <a:pt x="151" y="702"/>
                  </a:lnTo>
                  <a:lnTo>
                    <a:pt x="137" y="730"/>
                  </a:lnTo>
                  <a:lnTo>
                    <a:pt x="123" y="743"/>
                  </a:lnTo>
                  <a:lnTo>
                    <a:pt x="123" y="771"/>
                  </a:lnTo>
                  <a:lnTo>
                    <a:pt x="110" y="784"/>
                  </a:lnTo>
                  <a:lnTo>
                    <a:pt x="96" y="812"/>
                  </a:lnTo>
                  <a:lnTo>
                    <a:pt x="96" y="825"/>
                  </a:lnTo>
                  <a:lnTo>
                    <a:pt x="82" y="853"/>
                  </a:lnTo>
                  <a:lnTo>
                    <a:pt x="69" y="881"/>
                  </a:lnTo>
                  <a:lnTo>
                    <a:pt x="69" y="894"/>
                  </a:lnTo>
                  <a:lnTo>
                    <a:pt x="55" y="922"/>
                  </a:lnTo>
                  <a:lnTo>
                    <a:pt x="55" y="936"/>
                  </a:lnTo>
                  <a:lnTo>
                    <a:pt x="41" y="963"/>
                  </a:lnTo>
                  <a:lnTo>
                    <a:pt x="41" y="991"/>
                  </a:lnTo>
                  <a:lnTo>
                    <a:pt x="27" y="1004"/>
                  </a:lnTo>
                  <a:lnTo>
                    <a:pt x="27" y="1032"/>
                  </a:lnTo>
                  <a:lnTo>
                    <a:pt x="27" y="1060"/>
                  </a:lnTo>
                  <a:lnTo>
                    <a:pt x="13" y="1073"/>
                  </a:lnTo>
                  <a:lnTo>
                    <a:pt x="13" y="1101"/>
                  </a:lnTo>
                  <a:lnTo>
                    <a:pt x="13" y="1128"/>
                  </a:lnTo>
                  <a:lnTo>
                    <a:pt x="0" y="1142"/>
                  </a:lnTo>
                  <a:lnTo>
                    <a:pt x="0" y="1169"/>
                  </a:lnTo>
                  <a:lnTo>
                    <a:pt x="0" y="1197"/>
                  </a:lnTo>
                  <a:lnTo>
                    <a:pt x="0" y="1225"/>
                  </a:lnTo>
                  <a:lnTo>
                    <a:pt x="0" y="1238"/>
                  </a:lnTo>
                  <a:lnTo>
                    <a:pt x="0" y="1266"/>
                  </a:lnTo>
                  <a:lnTo>
                    <a:pt x="0" y="1294"/>
                  </a:lnTo>
                  <a:lnTo>
                    <a:pt x="0" y="1307"/>
                  </a:lnTo>
                  <a:lnTo>
                    <a:pt x="0" y="1335"/>
                  </a:lnTo>
                  <a:lnTo>
                    <a:pt x="0" y="1362"/>
                  </a:lnTo>
                  <a:lnTo>
                    <a:pt x="0" y="1376"/>
                  </a:lnTo>
                  <a:lnTo>
                    <a:pt x="0" y="1404"/>
                  </a:lnTo>
                  <a:lnTo>
                    <a:pt x="0" y="1430"/>
                  </a:lnTo>
                  <a:lnTo>
                    <a:pt x="0" y="1445"/>
                  </a:lnTo>
                  <a:lnTo>
                    <a:pt x="0" y="1473"/>
                  </a:lnTo>
                  <a:lnTo>
                    <a:pt x="0" y="1499"/>
                  </a:lnTo>
                  <a:lnTo>
                    <a:pt x="0" y="1527"/>
                  </a:lnTo>
                  <a:lnTo>
                    <a:pt x="13" y="1540"/>
                  </a:lnTo>
                  <a:lnTo>
                    <a:pt x="13" y="1568"/>
                  </a:lnTo>
                  <a:lnTo>
                    <a:pt x="13" y="1596"/>
                  </a:lnTo>
                  <a:lnTo>
                    <a:pt x="27" y="1609"/>
                  </a:lnTo>
                  <a:lnTo>
                    <a:pt x="27" y="1637"/>
                  </a:lnTo>
                  <a:lnTo>
                    <a:pt x="27" y="1665"/>
                  </a:lnTo>
                  <a:lnTo>
                    <a:pt x="41" y="1678"/>
                  </a:lnTo>
                  <a:lnTo>
                    <a:pt x="41" y="1706"/>
                  </a:lnTo>
                  <a:lnTo>
                    <a:pt x="55" y="1733"/>
                  </a:lnTo>
                  <a:lnTo>
                    <a:pt x="55" y="1747"/>
                  </a:lnTo>
                  <a:lnTo>
                    <a:pt x="69" y="1775"/>
                  </a:lnTo>
                  <a:lnTo>
                    <a:pt x="69" y="1788"/>
                  </a:lnTo>
                  <a:lnTo>
                    <a:pt x="82" y="1816"/>
                  </a:lnTo>
                  <a:lnTo>
                    <a:pt x="96" y="1843"/>
                  </a:lnTo>
                  <a:lnTo>
                    <a:pt x="96" y="1857"/>
                  </a:lnTo>
                  <a:lnTo>
                    <a:pt x="110" y="1884"/>
                  </a:lnTo>
                  <a:lnTo>
                    <a:pt x="123" y="1898"/>
                  </a:lnTo>
                  <a:lnTo>
                    <a:pt x="123" y="1926"/>
                  </a:lnTo>
                  <a:lnTo>
                    <a:pt x="137" y="1940"/>
                  </a:lnTo>
                  <a:lnTo>
                    <a:pt x="151" y="1967"/>
                  </a:lnTo>
                  <a:lnTo>
                    <a:pt x="165" y="1981"/>
                  </a:lnTo>
                  <a:lnTo>
                    <a:pt x="178" y="2009"/>
                  </a:lnTo>
                  <a:lnTo>
                    <a:pt x="178" y="2022"/>
                  </a:lnTo>
                  <a:lnTo>
                    <a:pt x="192" y="2050"/>
                  </a:lnTo>
                  <a:lnTo>
                    <a:pt x="206" y="2063"/>
                  </a:lnTo>
                  <a:lnTo>
                    <a:pt x="220" y="2091"/>
                  </a:lnTo>
                  <a:lnTo>
                    <a:pt x="234" y="2104"/>
                  </a:lnTo>
                  <a:lnTo>
                    <a:pt x="247" y="2119"/>
                  </a:lnTo>
                  <a:lnTo>
                    <a:pt x="261" y="2145"/>
                  </a:lnTo>
                  <a:lnTo>
                    <a:pt x="275" y="2160"/>
                  </a:lnTo>
                  <a:lnTo>
                    <a:pt x="288" y="2173"/>
                  </a:lnTo>
                  <a:lnTo>
                    <a:pt x="302" y="2201"/>
                  </a:lnTo>
                  <a:lnTo>
                    <a:pt x="316" y="2214"/>
                  </a:lnTo>
                  <a:lnTo>
                    <a:pt x="344" y="2229"/>
                  </a:lnTo>
                  <a:lnTo>
                    <a:pt x="357" y="2242"/>
                  </a:lnTo>
                  <a:lnTo>
                    <a:pt x="371" y="2270"/>
                  </a:lnTo>
                  <a:lnTo>
                    <a:pt x="385" y="2283"/>
                  </a:lnTo>
                  <a:lnTo>
                    <a:pt x="398" y="2297"/>
                  </a:lnTo>
                  <a:lnTo>
                    <a:pt x="426" y="2311"/>
                  </a:lnTo>
                  <a:lnTo>
                    <a:pt x="439" y="2324"/>
                  </a:lnTo>
                  <a:lnTo>
                    <a:pt x="454" y="2352"/>
                  </a:lnTo>
                  <a:lnTo>
                    <a:pt x="467" y="2366"/>
                  </a:lnTo>
                  <a:lnTo>
                    <a:pt x="495" y="2380"/>
                  </a:lnTo>
                  <a:lnTo>
                    <a:pt x="508" y="2393"/>
                  </a:lnTo>
                  <a:lnTo>
                    <a:pt x="523" y="2407"/>
                  </a:lnTo>
                  <a:lnTo>
                    <a:pt x="549" y="2421"/>
                  </a:lnTo>
                  <a:lnTo>
                    <a:pt x="564" y="2434"/>
                  </a:lnTo>
                  <a:lnTo>
                    <a:pt x="577" y="2448"/>
                  </a:lnTo>
                  <a:lnTo>
                    <a:pt x="605" y="2462"/>
                  </a:lnTo>
                  <a:lnTo>
                    <a:pt x="618" y="2476"/>
                  </a:lnTo>
                  <a:lnTo>
                    <a:pt x="646" y="2490"/>
                  </a:lnTo>
                  <a:lnTo>
                    <a:pt x="659" y="2490"/>
                  </a:lnTo>
                  <a:lnTo>
                    <a:pt x="687" y="2503"/>
                  </a:lnTo>
                  <a:lnTo>
                    <a:pt x="701" y="2517"/>
                  </a:lnTo>
                  <a:lnTo>
                    <a:pt x="728" y="2531"/>
                  </a:lnTo>
                  <a:lnTo>
                    <a:pt x="742" y="2545"/>
                  </a:lnTo>
                  <a:lnTo>
                    <a:pt x="770" y="2545"/>
                  </a:lnTo>
                  <a:lnTo>
                    <a:pt x="784" y="2558"/>
                  </a:lnTo>
                  <a:lnTo>
                    <a:pt x="811" y="2572"/>
                  </a:lnTo>
                  <a:lnTo>
                    <a:pt x="825" y="2572"/>
                  </a:lnTo>
                  <a:lnTo>
                    <a:pt x="852" y="2586"/>
                  </a:lnTo>
                  <a:lnTo>
                    <a:pt x="880" y="2599"/>
                  </a:lnTo>
                  <a:lnTo>
                    <a:pt x="893" y="2599"/>
                  </a:lnTo>
                  <a:lnTo>
                    <a:pt x="921" y="2613"/>
                  </a:lnTo>
                  <a:lnTo>
                    <a:pt x="935" y="2613"/>
                  </a:lnTo>
                  <a:lnTo>
                    <a:pt x="962" y="2627"/>
                  </a:lnTo>
                  <a:lnTo>
                    <a:pt x="990" y="2627"/>
                  </a:lnTo>
                  <a:lnTo>
                    <a:pt x="1003" y="2641"/>
                  </a:lnTo>
                  <a:lnTo>
                    <a:pt x="1031" y="2641"/>
                  </a:lnTo>
                  <a:lnTo>
                    <a:pt x="1059" y="2641"/>
                  </a:lnTo>
                  <a:lnTo>
                    <a:pt x="1072" y="2655"/>
                  </a:lnTo>
                  <a:lnTo>
                    <a:pt x="1100" y="2655"/>
                  </a:lnTo>
                  <a:lnTo>
                    <a:pt x="1128" y="2655"/>
                  </a:lnTo>
                  <a:lnTo>
                    <a:pt x="1141" y="2668"/>
                  </a:lnTo>
                  <a:lnTo>
                    <a:pt x="1169" y="2668"/>
                  </a:lnTo>
                  <a:lnTo>
                    <a:pt x="1195" y="2668"/>
                  </a:lnTo>
                  <a:lnTo>
                    <a:pt x="1223" y="2668"/>
                  </a:lnTo>
                  <a:lnTo>
                    <a:pt x="1238" y="2668"/>
                  </a:lnTo>
                  <a:lnTo>
                    <a:pt x="1264" y="2668"/>
                  </a:lnTo>
                  <a:lnTo>
                    <a:pt x="1292" y="2668"/>
                  </a:lnTo>
                  <a:lnTo>
                    <a:pt x="1306" y="2668"/>
                  </a:lnTo>
                  <a:lnTo>
                    <a:pt x="1333" y="2668"/>
                  </a:lnTo>
                  <a:lnTo>
                    <a:pt x="1361" y="2668"/>
                  </a:lnTo>
                  <a:lnTo>
                    <a:pt x="1374" y="2668"/>
                  </a:lnTo>
                  <a:lnTo>
                    <a:pt x="1402" y="2668"/>
                  </a:lnTo>
                  <a:lnTo>
                    <a:pt x="1430" y="2668"/>
                  </a:lnTo>
                  <a:lnTo>
                    <a:pt x="1443" y="2668"/>
                  </a:lnTo>
                  <a:lnTo>
                    <a:pt x="1471" y="2668"/>
                  </a:lnTo>
                  <a:lnTo>
                    <a:pt x="1499" y="2668"/>
                  </a:lnTo>
                  <a:lnTo>
                    <a:pt x="1526" y="2668"/>
                  </a:lnTo>
                  <a:lnTo>
                    <a:pt x="1540" y="2655"/>
                  </a:lnTo>
                  <a:lnTo>
                    <a:pt x="1567" y="2655"/>
                  </a:lnTo>
                  <a:lnTo>
                    <a:pt x="1595" y="2655"/>
                  </a:lnTo>
                  <a:lnTo>
                    <a:pt x="1608" y="2641"/>
                  </a:lnTo>
                  <a:lnTo>
                    <a:pt x="1636" y="2641"/>
                  </a:lnTo>
                  <a:lnTo>
                    <a:pt x="1664" y="2641"/>
                  </a:lnTo>
                  <a:lnTo>
                    <a:pt x="1677" y="2627"/>
                  </a:lnTo>
                  <a:lnTo>
                    <a:pt x="1705" y="2627"/>
                  </a:lnTo>
                  <a:lnTo>
                    <a:pt x="1732" y="2613"/>
                  </a:lnTo>
                  <a:lnTo>
                    <a:pt x="1746" y="2613"/>
                  </a:lnTo>
                  <a:lnTo>
                    <a:pt x="1774" y="2599"/>
                  </a:lnTo>
                  <a:lnTo>
                    <a:pt x="1787" y="2599"/>
                  </a:lnTo>
                  <a:lnTo>
                    <a:pt x="1815" y="2586"/>
                  </a:lnTo>
                  <a:lnTo>
                    <a:pt x="1843" y="2572"/>
                  </a:lnTo>
                  <a:lnTo>
                    <a:pt x="1856" y="2572"/>
                  </a:lnTo>
                  <a:lnTo>
                    <a:pt x="1884" y="2558"/>
                  </a:lnTo>
                  <a:lnTo>
                    <a:pt x="1897" y="2545"/>
                  </a:lnTo>
                  <a:lnTo>
                    <a:pt x="1925" y="2545"/>
                  </a:lnTo>
                  <a:lnTo>
                    <a:pt x="1938" y="2531"/>
                  </a:lnTo>
                  <a:lnTo>
                    <a:pt x="1966" y="2517"/>
                  </a:lnTo>
                  <a:lnTo>
                    <a:pt x="1979" y="2503"/>
                  </a:lnTo>
                  <a:lnTo>
                    <a:pt x="2007" y="2490"/>
                  </a:lnTo>
                  <a:lnTo>
                    <a:pt x="2021" y="2490"/>
                  </a:lnTo>
                  <a:lnTo>
                    <a:pt x="2048" y="2476"/>
                  </a:lnTo>
                  <a:lnTo>
                    <a:pt x="2063" y="2462"/>
                  </a:lnTo>
                  <a:lnTo>
                    <a:pt x="2090" y="2448"/>
                  </a:lnTo>
                  <a:lnTo>
                    <a:pt x="2104" y="2434"/>
                  </a:lnTo>
                  <a:lnTo>
                    <a:pt x="2117" y="2421"/>
                  </a:lnTo>
                  <a:lnTo>
                    <a:pt x="2145" y="2407"/>
                  </a:lnTo>
                  <a:lnTo>
                    <a:pt x="2158" y="2393"/>
                  </a:lnTo>
                  <a:lnTo>
                    <a:pt x="2172" y="2380"/>
                  </a:lnTo>
                  <a:lnTo>
                    <a:pt x="2200" y="2366"/>
                  </a:lnTo>
                  <a:lnTo>
                    <a:pt x="2214" y="2352"/>
                  </a:lnTo>
                  <a:lnTo>
                    <a:pt x="2227" y="2324"/>
                  </a:lnTo>
                  <a:lnTo>
                    <a:pt x="2241" y="2311"/>
                  </a:lnTo>
                  <a:lnTo>
                    <a:pt x="2269" y="2297"/>
                  </a:lnTo>
                  <a:lnTo>
                    <a:pt x="2282" y="2283"/>
                  </a:lnTo>
                  <a:lnTo>
                    <a:pt x="2296" y="2270"/>
                  </a:lnTo>
                  <a:lnTo>
                    <a:pt x="2310" y="2242"/>
                  </a:lnTo>
                  <a:lnTo>
                    <a:pt x="2323" y="2229"/>
                  </a:lnTo>
                  <a:lnTo>
                    <a:pt x="2351" y="2214"/>
                  </a:lnTo>
                  <a:lnTo>
                    <a:pt x="2365" y="2201"/>
                  </a:lnTo>
                  <a:lnTo>
                    <a:pt x="2379" y="2173"/>
                  </a:lnTo>
                  <a:lnTo>
                    <a:pt x="2392" y="2160"/>
                  </a:lnTo>
                  <a:lnTo>
                    <a:pt x="2406" y="2145"/>
                  </a:lnTo>
                  <a:lnTo>
                    <a:pt x="2420" y="2119"/>
                  </a:lnTo>
                  <a:lnTo>
                    <a:pt x="2433" y="2104"/>
                  </a:lnTo>
                  <a:lnTo>
                    <a:pt x="2448" y="2091"/>
                  </a:lnTo>
                  <a:lnTo>
                    <a:pt x="2461" y="2063"/>
                  </a:lnTo>
                  <a:lnTo>
                    <a:pt x="2474" y="2050"/>
                  </a:lnTo>
                  <a:lnTo>
                    <a:pt x="2489" y="2022"/>
                  </a:lnTo>
                  <a:lnTo>
                    <a:pt x="2489" y="2009"/>
                  </a:lnTo>
                  <a:lnTo>
                    <a:pt x="2502" y="1981"/>
                  </a:lnTo>
                  <a:lnTo>
                    <a:pt x="2516" y="1967"/>
                  </a:lnTo>
                  <a:lnTo>
                    <a:pt x="2530" y="1940"/>
                  </a:lnTo>
                  <a:lnTo>
                    <a:pt x="2543" y="1926"/>
                  </a:lnTo>
                  <a:lnTo>
                    <a:pt x="2543" y="1898"/>
                  </a:lnTo>
                  <a:lnTo>
                    <a:pt x="2558" y="1884"/>
                  </a:lnTo>
                  <a:lnTo>
                    <a:pt x="2571" y="1857"/>
                  </a:lnTo>
                  <a:lnTo>
                    <a:pt x="2571" y="1843"/>
                  </a:lnTo>
                  <a:lnTo>
                    <a:pt x="2584" y="1816"/>
                  </a:lnTo>
                  <a:lnTo>
                    <a:pt x="2599" y="1788"/>
                  </a:lnTo>
                  <a:lnTo>
                    <a:pt x="2599" y="1775"/>
                  </a:lnTo>
                  <a:lnTo>
                    <a:pt x="2612" y="1747"/>
                  </a:lnTo>
                  <a:lnTo>
                    <a:pt x="2612" y="1733"/>
                  </a:lnTo>
                  <a:lnTo>
                    <a:pt x="2627" y="1706"/>
                  </a:lnTo>
                  <a:lnTo>
                    <a:pt x="2627" y="1678"/>
                  </a:lnTo>
                  <a:lnTo>
                    <a:pt x="2640" y="1665"/>
                  </a:lnTo>
                  <a:lnTo>
                    <a:pt x="2640" y="1637"/>
                  </a:lnTo>
                  <a:lnTo>
                    <a:pt x="2640" y="1609"/>
                  </a:lnTo>
                  <a:lnTo>
                    <a:pt x="2653" y="1596"/>
                  </a:lnTo>
                  <a:lnTo>
                    <a:pt x="2653" y="1568"/>
                  </a:lnTo>
                  <a:lnTo>
                    <a:pt x="2653" y="1540"/>
                  </a:lnTo>
                  <a:lnTo>
                    <a:pt x="2668" y="1527"/>
                  </a:lnTo>
                  <a:lnTo>
                    <a:pt x="2668" y="1499"/>
                  </a:lnTo>
                  <a:lnTo>
                    <a:pt x="2668" y="1473"/>
                  </a:lnTo>
                  <a:lnTo>
                    <a:pt x="2668" y="1445"/>
                  </a:lnTo>
                  <a:lnTo>
                    <a:pt x="2668" y="1430"/>
                  </a:lnTo>
                  <a:lnTo>
                    <a:pt x="2668" y="1404"/>
                  </a:lnTo>
                  <a:lnTo>
                    <a:pt x="2668" y="1376"/>
                  </a:lnTo>
                  <a:lnTo>
                    <a:pt x="2668" y="1362"/>
                  </a:lnTo>
                  <a:lnTo>
                    <a:pt x="2681" y="1335"/>
                  </a:lnTo>
                  <a:close/>
                </a:path>
              </a:pathLst>
            </a:custGeom>
            <a:solidFill>
              <a:srgbClr val="ff33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" name=""/>
            <p:cNvSpPr/>
            <p:nvPr/>
          </p:nvSpPr>
          <p:spPr>
            <a:xfrm>
              <a:off x="2940120" y="1058760"/>
              <a:ext cx="216360" cy="213840"/>
            </a:xfrm>
            <a:prstGeom prst="rect">
              <a:avLst/>
            </a:prstGeom>
            <a:noFill/>
            <a:ln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" name=""/>
            <p:cNvSpPr/>
            <p:nvPr/>
          </p:nvSpPr>
          <p:spPr>
            <a:xfrm>
              <a:off x="2957400" y="1075680"/>
              <a:ext cx="180000" cy="179280"/>
            </a:xfrm>
            <a:custGeom>
              <a:avLst/>
              <a:gdLst/>
              <a:ahLst/>
              <a:rect l="l" t="t" r="r" b="b"/>
              <a:pathLst>
                <a:path w="3451" h="3437">
                  <a:moveTo>
                    <a:pt x="3451" y="1718"/>
                  </a:moveTo>
                  <a:lnTo>
                    <a:pt x="3437" y="1691"/>
                  </a:lnTo>
                  <a:lnTo>
                    <a:pt x="3437" y="1664"/>
                  </a:lnTo>
                  <a:lnTo>
                    <a:pt x="3437" y="1623"/>
                  </a:lnTo>
                  <a:lnTo>
                    <a:pt x="3437" y="1595"/>
                  </a:lnTo>
                  <a:lnTo>
                    <a:pt x="3437" y="1567"/>
                  </a:lnTo>
                  <a:lnTo>
                    <a:pt x="3437" y="1539"/>
                  </a:lnTo>
                  <a:lnTo>
                    <a:pt x="3437" y="1513"/>
                  </a:lnTo>
                  <a:lnTo>
                    <a:pt x="3423" y="1485"/>
                  </a:lnTo>
                  <a:lnTo>
                    <a:pt x="3423" y="1444"/>
                  </a:lnTo>
                  <a:lnTo>
                    <a:pt x="3423" y="1416"/>
                  </a:lnTo>
                  <a:lnTo>
                    <a:pt x="3410" y="1388"/>
                  </a:lnTo>
                  <a:lnTo>
                    <a:pt x="3410" y="1361"/>
                  </a:lnTo>
                  <a:lnTo>
                    <a:pt x="3396" y="1334"/>
                  </a:lnTo>
                  <a:lnTo>
                    <a:pt x="3396" y="1306"/>
                  </a:lnTo>
                  <a:lnTo>
                    <a:pt x="3382" y="1278"/>
                  </a:lnTo>
                  <a:lnTo>
                    <a:pt x="3382" y="1237"/>
                  </a:lnTo>
                  <a:lnTo>
                    <a:pt x="3369" y="1210"/>
                  </a:lnTo>
                  <a:lnTo>
                    <a:pt x="3355" y="1182"/>
                  </a:lnTo>
                  <a:lnTo>
                    <a:pt x="3355" y="1155"/>
                  </a:lnTo>
                  <a:lnTo>
                    <a:pt x="3341" y="1127"/>
                  </a:lnTo>
                  <a:lnTo>
                    <a:pt x="3327" y="1100"/>
                  </a:lnTo>
                  <a:lnTo>
                    <a:pt x="3313" y="1072"/>
                  </a:lnTo>
                  <a:lnTo>
                    <a:pt x="3313" y="1044"/>
                  </a:lnTo>
                  <a:lnTo>
                    <a:pt x="3300" y="1018"/>
                  </a:lnTo>
                  <a:lnTo>
                    <a:pt x="3286" y="990"/>
                  </a:lnTo>
                  <a:lnTo>
                    <a:pt x="3272" y="962"/>
                  </a:lnTo>
                  <a:lnTo>
                    <a:pt x="3259" y="934"/>
                  </a:lnTo>
                  <a:lnTo>
                    <a:pt x="3244" y="908"/>
                  </a:lnTo>
                  <a:lnTo>
                    <a:pt x="3231" y="880"/>
                  </a:lnTo>
                  <a:lnTo>
                    <a:pt x="3218" y="852"/>
                  </a:lnTo>
                  <a:lnTo>
                    <a:pt x="3203" y="824"/>
                  </a:lnTo>
                  <a:lnTo>
                    <a:pt x="3176" y="798"/>
                  </a:lnTo>
                  <a:lnTo>
                    <a:pt x="3162" y="783"/>
                  </a:lnTo>
                  <a:lnTo>
                    <a:pt x="3149" y="756"/>
                  </a:lnTo>
                  <a:lnTo>
                    <a:pt x="3134" y="729"/>
                  </a:lnTo>
                  <a:lnTo>
                    <a:pt x="3121" y="701"/>
                  </a:lnTo>
                  <a:lnTo>
                    <a:pt x="3093" y="673"/>
                  </a:lnTo>
                  <a:lnTo>
                    <a:pt x="3080" y="660"/>
                  </a:lnTo>
                  <a:lnTo>
                    <a:pt x="3065" y="632"/>
                  </a:lnTo>
                  <a:lnTo>
                    <a:pt x="3039" y="605"/>
                  </a:lnTo>
                  <a:lnTo>
                    <a:pt x="3024" y="591"/>
                  </a:lnTo>
                  <a:lnTo>
                    <a:pt x="2998" y="563"/>
                  </a:lnTo>
                  <a:lnTo>
                    <a:pt x="2983" y="536"/>
                  </a:lnTo>
                  <a:lnTo>
                    <a:pt x="2956" y="522"/>
                  </a:lnTo>
                  <a:lnTo>
                    <a:pt x="2942" y="495"/>
                  </a:lnTo>
                  <a:lnTo>
                    <a:pt x="2914" y="481"/>
                  </a:lnTo>
                  <a:lnTo>
                    <a:pt x="2901" y="454"/>
                  </a:lnTo>
                  <a:lnTo>
                    <a:pt x="2873" y="440"/>
                  </a:lnTo>
                  <a:lnTo>
                    <a:pt x="2846" y="412"/>
                  </a:lnTo>
                  <a:lnTo>
                    <a:pt x="2832" y="398"/>
                  </a:lnTo>
                  <a:lnTo>
                    <a:pt x="2805" y="371"/>
                  </a:lnTo>
                  <a:lnTo>
                    <a:pt x="2777" y="357"/>
                  </a:lnTo>
                  <a:lnTo>
                    <a:pt x="2763" y="344"/>
                  </a:lnTo>
                  <a:lnTo>
                    <a:pt x="2736" y="316"/>
                  </a:lnTo>
                  <a:lnTo>
                    <a:pt x="2708" y="303"/>
                  </a:lnTo>
                  <a:lnTo>
                    <a:pt x="2681" y="288"/>
                  </a:lnTo>
                  <a:lnTo>
                    <a:pt x="2654" y="275"/>
                  </a:lnTo>
                  <a:lnTo>
                    <a:pt x="2640" y="261"/>
                  </a:lnTo>
                  <a:lnTo>
                    <a:pt x="2612" y="234"/>
                  </a:lnTo>
                  <a:lnTo>
                    <a:pt x="2585" y="219"/>
                  </a:lnTo>
                  <a:lnTo>
                    <a:pt x="2557" y="206"/>
                  </a:lnTo>
                  <a:lnTo>
                    <a:pt x="2529" y="193"/>
                  </a:lnTo>
                  <a:lnTo>
                    <a:pt x="2503" y="178"/>
                  </a:lnTo>
                  <a:lnTo>
                    <a:pt x="2475" y="165"/>
                  </a:lnTo>
                  <a:lnTo>
                    <a:pt x="2447" y="151"/>
                  </a:lnTo>
                  <a:lnTo>
                    <a:pt x="2419" y="137"/>
                  </a:lnTo>
                  <a:lnTo>
                    <a:pt x="2393" y="124"/>
                  </a:lnTo>
                  <a:lnTo>
                    <a:pt x="2365" y="124"/>
                  </a:lnTo>
                  <a:lnTo>
                    <a:pt x="2337" y="109"/>
                  </a:lnTo>
                  <a:lnTo>
                    <a:pt x="2309" y="96"/>
                  </a:lnTo>
                  <a:lnTo>
                    <a:pt x="2283" y="83"/>
                  </a:lnTo>
                  <a:lnTo>
                    <a:pt x="2255" y="83"/>
                  </a:lnTo>
                  <a:lnTo>
                    <a:pt x="2227" y="68"/>
                  </a:lnTo>
                  <a:lnTo>
                    <a:pt x="2199" y="55"/>
                  </a:lnTo>
                  <a:lnTo>
                    <a:pt x="2158" y="55"/>
                  </a:lnTo>
                  <a:lnTo>
                    <a:pt x="2131" y="41"/>
                  </a:lnTo>
                  <a:lnTo>
                    <a:pt x="2104" y="41"/>
                  </a:lnTo>
                  <a:lnTo>
                    <a:pt x="2076" y="27"/>
                  </a:lnTo>
                  <a:lnTo>
                    <a:pt x="2048" y="27"/>
                  </a:lnTo>
                  <a:lnTo>
                    <a:pt x="2021" y="14"/>
                  </a:lnTo>
                  <a:lnTo>
                    <a:pt x="1993" y="14"/>
                  </a:lnTo>
                  <a:lnTo>
                    <a:pt x="1952" y="14"/>
                  </a:lnTo>
                  <a:lnTo>
                    <a:pt x="1925" y="0"/>
                  </a:lnTo>
                  <a:lnTo>
                    <a:pt x="1897" y="0"/>
                  </a:lnTo>
                  <a:lnTo>
                    <a:pt x="1870" y="0"/>
                  </a:lnTo>
                  <a:lnTo>
                    <a:pt x="1842" y="0"/>
                  </a:lnTo>
                  <a:lnTo>
                    <a:pt x="1814" y="0"/>
                  </a:lnTo>
                  <a:lnTo>
                    <a:pt x="1773" y="0"/>
                  </a:lnTo>
                  <a:lnTo>
                    <a:pt x="1746" y="0"/>
                  </a:lnTo>
                  <a:lnTo>
                    <a:pt x="1719" y="0"/>
                  </a:lnTo>
                  <a:lnTo>
                    <a:pt x="1691" y="0"/>
                  </a:lnTo>
                  <a:lnTo>
                    <a:pt x="1663" y="0"/>
                  </a:lnTo>
                  <a:lnTo>
                    <a:pt x="1622" y="0"/>
                  </a:lnTo>
                  <a:lnTo>
                    <a:pt x="1594" y="0"/>
                  </a:lnTo>
                  <a:lnTo>
                    <a:pt x="1568" y="0"/>
                  </a:lnTo>
                  <a:lnTo>
                    <a:pt x="1540" y="0"/>
                  </a:lnTo>
                  <a:lnTo>
                    <a:pt x="1512" y="0"/>
                  </a:lnTo>
                  <a:lnTo>
                    <a:pt x="1485" y="14"/>
                  </a:lnTo>
                  <a:lnTo>
                    <a:pt x="1443" y="14"/>
                  </a:lnTo>
                  <a:lnTo>
                    <a:pt x="1416" y="14"/>
                  </a:lnTo>
                  <a:lnTo>
                    <a:pt x="1389" y="27"/>
                  </a:lnTo>
                  <a:lnTo>
                    <a:pt x="1361" y="27"/>
                  </a:lnTo>
                  <a:lnTo>
                    <a:pt x="1333" y="41"/>
                  </a:lnTo>
                  <a:lnTo>
                    <a:pt x="1306" y="41"/>
                  </a:lnTo>
                  <a:lnTo>
                    <a:pt x="1278" y="55"/>
                  </a:lnTo>
                  <a:lnTo>
                    <a:pt x="1237" y="55"/>
                  </a:lnTo>
                  <a:lnTo>
                    <a:pt x="1210" y="68"/>
                  </a:lnTo>
                  <a:lnTo>
                    <a:pt x="1182" y="83"/>
                  </a:lnTo>
                  <a:lnTo>
                    <a:pt x="1155" y="83"/>
                  </a:lnTo>
                  <a:lnTo>
                    <a:pt x="1127" y="96"/>
                  </a:lnTo>
                  <a:lnTo>
                    <a:pt x="1099" y="109"/>
                  </a:lnTo>
                  <a:lnTo>
                    <a:pt x="1073" y="124"/>
                  </a:lnTo>
                  <a:lnTo>
                    <a:pt x="1045" y="124"/>
                  </a:lnTo>
                  <a:lnTo>
                    <a:pt x="1017" y="137"/>
                  </a:lnTo>
                  <a:lnTo>
                    <a:pt x="989" y="151"/>
                  </a:lnTo>
                  <a:lnTo>
                    <a:pt x="963" y="165"/>
                  </a:lnTo>
                  <a:lnTo>
                    <a:pt x="935" y="178"/>
                  </a:lnTo>
                  <a:lnTo>
                    <a:pt x="907" y="193"/>
                  </a:lnTo>
                  <a:lnTo>
                    <a:pt x="879" y="206"/>
                  </a:lnTo>
                  <a:lnTo>
                    <a:pt x="853" y="219"/>
                  </a:lnTo>
                  <a:lnTo>
                    <a:pt x="825" y="234"/>
                  </a:lnTo>
                  <a:lnTo>
                    <a:pt x="797" y="261"/>
                  </a:lnTo>
                  <a:lnTo>
                    <a:pt x="784" y="275"/>
                  </a:lnTo>
                  <a:lnTo>
                    <a:pt x="756" y="288"/>
                  </a:lnTo>
                  <a:lnTo>
                    <a:pt x="728" y="303"/>
                  </a:lnTo>
                  <a:lnTo>
                    <a:pt x="701" y="316"/>
                  </a:lnTo>
                  <a:lnTo>
                    <a:pt x="674" y="344"/>
                  </a:lnTo>
                  <a:lnTo>
                    <a:pt x="660" y="357"/>
                  </a:lnTo>
                  <a:lnTo>
                    <a:pt x="632" y="371"/>
                  </a:lnTo>
                  <a:lnTo>
                    <a:pt x="605" y="398"/>
                  </a:lnTo>
                  <a:lnTo>
                    <a:pt x="591" y="412"/>
                  </a:lnTo>
                  <a:lnTo>
                    <a:pt x="563" y="440"/>
                  </a:lnTo>
                  <a:lnTo>
                    <a:pt x="536" y="454"/>
                  </a:lnTo>
                  <a:lnTo>
                    <a:pt x="522" y="481"/>
                  </a:lnTo>
                  <a:lnTo>
                    <a:pt x="495" y="495"/>
                  </a:lnTo>
                  <a:lnTo>
                    <a:pt x="481" y="522"/>
                  </a:lnTo>
                  <a:lnTo>
                    <a:pt x="453" y="536"/>
                  </a:lnTo>
                  <a:lnTo>
                    <a:pt x="440" y="563"/>
                  </a:lnTo>
                  <a:lnTo>
                    <a:pt x="412" y="591"/>
                  </a:lnTo>
                  <a:lnTo>
                    <a:pt x="399" y="605"/>
                  </a:lnTo>
                  <a:lnTo>
                    <a:pt x="371" y="632"/>
                  </a:lnTo>
                  <a:lnTo>
                    <a:pt x="358" y="660"/>
                  </a:lnTo>
                  <a:lnTo>
                    <a:pt x="343" y="673"/>
                  </a:lnTo>
                  <a:lnTo>
                    <a:pt x="316" y="701"/>
                  </a:lnTo>
                  <a:lnTo>
                    <a:pt x="302" y="729"/>
                  </a:lnTo>
                  <a:lnTo>
                    <a:pt x="289" y="756"/>
                  </a:lnTo>
                  <a:lnTo>
                    <a:pt x="274" y="783"/>
                  </a:lnTo>
                  <a:lnTo>
                    <a:pt x="261" y="798"/>
                  </a:lnTo>
                  <a:lnTo>
                    <a:pt x="233" y="824"/>
                  </a:lnTo>
                  <a:lnTo>
                    <a:pt x="220" y="852"/>
                  </a:lnTo>
                  <a:lnTo>
                    <a:pt x="206" y="880"/>
                  </a:lnTo>
                  <a:lnTo>
                    <a:pt x="192" y="908"/>
                  </a:lnTo>
                  <a:lnTo>
                    <a:pt x="179" y="934"/>
                  </a:lnTo>
                  <a:lnTo>
                    <a:pt x="164" y="962"/>
                  </a:lnTo>
                  <a:lnTo>
                    <a:pt x="151" y="990"/>
                  </a:lnTo>
                  <a:lnTo>
                    <a:pt x="138" y="1018"/>
                  </a:lnTo>
                  <a:lnTo>
                    <a:pt x="123" y="1044"/>
                  </a:lnTo>
                  <a:lnTo>
                    <a:pt x="123" y="1072"/>
                  </a:lnTo>
                  <a:lnTo>
                    <a:pt x="110" y="1100"/>
                  </a:lnTo>
                  <a:lnTo>
                    <a:pt x="96" y="1127"/>
                  </a:lnTo>
                  <a:lnTo>
                    <a:pt x="82" y="1155"/>
                  </a:lnTo>
                  <a:lnTo>
                    <a:pt x="82" y="1182"/>
                  </a:lnTo>
                  <a:lnTo>
                    <a:pt x="69" y="1210"/>
                  </a:lnTo>
                  <a:lnTo>
                    <a:pt x="55" y="1237"/>
                  </a:lnTo>
                  <a:lnTo>
                    <a:pt x="55" y="1278"/>
                  </a:lnTo>
                  <a:lnTo>
                    <a:pt x="41" y="1306"/>
                  </a:lnTo>
                  <a:lnTo>
                    <a:pt x="41" y="1334"/>
                  </a:lnTo>
                  <a:lnTo>
                    <a:pt x="27" y="1361"/>
                  </a:lnTo>
                  <a:lnTo>
                    <a:pt x="27" y="1388"/>
                  </a:lnTo>
                  <a:lnTo>
                    <a:pt x="13" y="1416"/>
                  </a:lnTo>
                  <a:lnTo>
                    <a:pt x="13" y="1444"/>
                  </a:lnTo>
                  <a:lnTo>
                    <a:pt x="13" y="1485"/>
                  </a:lnTo>
                  <a:lnTo>
                    <a:pt x="0" y="1513"/>
                  </a:lnTo>
                  <a:lnTo>
                    <a:pt x="0" y="1539"/>
                  </a:lnTo>
                  <a:lnTo>
                    <a:pt x="0" y="1567"/>
                  </a:lnTo>
                  <a:lnTo>
                    <a:pt x="0" y="1595"/>
                  </a:lnTo>
                  <a:lnTo>
                    <a:pt x="0" y="1623"/>
                  </a:lnTo>
                  <a:lnTo>
                    <a:pt x="0" y="1664"/>
                  </a:lnTo>
                  <a:lnTo>
                    <a:pt x="0" y="1691"/>
                  </a:lnTo>
                  <a:lnTo>
                    <a:pt x="0" y="1718"/>
                  </a:lnTo>
                  <a:lnTo>
                    <a:pt x="0" y="1746"/>
                  </a:lnTo>
                  <a:lnTo>
                    <a:pt x="0" y="1774"/>
                  </a:lnTo>
                  <a:lnTo>
                    <a:pt x="0" y="1815"/>
                  </a:lnTo>
                  <a:lnTo>
                    <a:pt x="0" y="1842"/>
                  </a:lnTo>
                  <a:lnTo>
                    <a:pt x="0" y="1870"/>
                  </a:lnTo>
                  <a:lnTo>
                    <a:pt x="0" y="1897"/>
                  </a:lnTo>
                  <a:lnTo>
                    <a:pt x="0" y="1925"/>
                  </a:lnTo>
                  <a:lnTo>
                    <a:pt x="13" y="1952"/>
                  </a:lnTo>
                  <a:lnTo>
                    <a:pt x="13" y="1993"/>
                  </a:lnTo>
                  <a:lnTo>
                    <a:pt x="13" y="2021"/>
                  </a:lnTo>
                  <a:lnTo>
                    <a:pt x="27" y="2049"/>
                  </a:lnTo>
                  <a:lnTo>
                    <a:pt x="27" y="2076"/>
                  </a:lnTo>
                  <a:lnTo>
                    <a:pt x="41" y="2103"/>
                  </a:lnTo>
                  <a:lnTo>
                    <a:pt x="41" y="2131"/>
                  </a:lnTo>
                  <a:lnTo>
                    <a:pt x="55" y="2159"/>
                  </a:lnTo>
                  <a:lnTo>
                    <a:pt x="55" y="2200"/>
                  </a:lnTo>
                  <a:lnTo>
                    <a:pt x="69" y="2228"/>
                  </a:lnTo>
                  <a:lnTo>
                    <a:pt x="82" y="2254"/>
                  </a:lnTo>
                  <a:lnTo>
                    <a:pt x="82" y="2282"/>
                  </a:lnTo>
                  <a:lnTo>
                    <a:pt x="96" y="2310"/>
                  </a:lnTo>
                  <a:lnTo>
                    <a:pt x="110" y="2338"/>
                  </a:lnTo>
                  <a:lnTo>
                    <a:pt x="123" y="2364"/>
                  </a:lnTo>
                  <a:lnTo>
                    <a:pt x="123" y="2392"/>
                  </a:lnTo>
                  <a:lnTo>
                    <a:pt x="138" y="2420"/>
                  </a:lnTo>
                  <a:lnTo>
                    <a:pt x="151" y="2448"/>
                  </a:lnTo>
                  <a:lnTo>
                    <a:pt x="164" y="2475"/>
                  </a:lnTo>
                  <a:lnTo>
                    <a:pt x="179" y="2502"/>
                  </a:lnTo>
                  <a:lnTo>
                    <a:pt x="192" y="2530"/>
                  </a:lnTo>
                  <a:lnTo>
                    <a:pt x="206" y="2557"/>
                  </a:lnTo>
                  <a:lnTo>
                    <a:pt x="220" y="2585"/>
                  </a:lnTo>
                  <a:lnTo>
                    <a:pt x="233" y="2612"/>
                  </a:lnTo>
                  <a:lnTo>
                    <a:pt x="261" y="2640"/>
                  </a:lnTo>
                  <a:lnTo>
                    <a:pt x="274" y="2654"/>
                  </a:lnTo>
                  <a:lnTo>
                    <a:pt x="289" y="2681"/>
                  </a:lnTo>
                  <a:lnTo>
                    <a:pt x="302" y="2708"/>
                  </a:lnTo>
                  <a:lnTo>
                    <a:pt x="316" y="2736"/>
                  </a:lnTo>
                  <a:lnTo>
                    <a:pt x="343" y="2764"/>
                  </a:lnTo>
                  <a:lnTo>
                    <a:pt x="358" y="2777"/>
                  </a:lnTo>
                  <a:lnTo>
                    <a:pt x="371" y="2805"/>
                  </a:lnTo>
                  <a:lnTo>
                    <a:pt x="399" y="2833"/>
                  </a:lnTo>
                  <a:lnTo>
                    <a:pt x="412" y="2846"/>
                  </a:lnTo>
                  <a:lnTo>
                    <a:pt x="440" y="2874"/>
                  </a:lnTo>
                  <a:lnTo>
                    <a:pt x="453" y="2901"/>
                  </a:lnTo>
                  <a:lnTo>
                    <a:pt x="481" y="2915"/>
                  </a:lnTo>
                  <a:lnTo>
                    <a:pt x="495" y="2943"/>
                  </a:lnTo>
                  <a:lnTo>
                    <a:pt x="522" y="2956"/>
                  </a:lnTo>
                  <a:lnTo>
                    <a:pt x="536" y="2984"/>
                  </a:lnTo>
                  <a:lnTo>
                    <a:pt x="563" y="2997"/>
                  </a:lnTo>
                  <a:lnTo>
                    <a:pt x="591" y="3025"/>
                  </a:lnTo>
                  <a:lnTo>
                    <a:pt x="605" y="3038"/>
                  </a:lnTo>
                  <a:lnTo>
                    <a:pt x="632" y="3066"/>
                  </a:lnTo>
                  <a:lnTo>
                    <a:pt x="660" y="3079"/>
                  </a:lnTo>
                  <a:lnTo>
                    <a:pt x="674" y="3094"/>
                  </a:lnTo>
                  <a:lnTo>
                    <a:pt x="701" y="3121"/>
                  </a:lnTo>
                  <a:lnTo>
                    <a:pt x="728" y="3135"/>
                  </a:lnTo>
                  <a:lnTo>
                    <a:pt x="756" y="3148"/>
                  </a:lnTo>
                  <a:lnTo>
                    <a:pt x="784" y="3163"/>
                  </a:lnTo>
                  <a:lnTo>
                    <a:pt x="797" y="3176"/>
                  </a:lnTo>
                  <a:lnTo>
                    <a:pt x="825" y="3204"/>
                  </a:lnTo>
                  <a:lnTo>
                    <a:pt x="853" y="3217"/>
                  </a:lnTo>
                  <a:lnTo>
                    <a:pt x="879" y="3231"/>
                  </a:lnTo>
                  <a:lnTo>
                    <a:pt x="907" y="3245"/>
                  </a:lnTo>
                  <a:lnTo>
                    <a:pt x="935" y="3258"/>
                  </a:lnTo>
                  <a:lnTo>
                    <a:pt x="963" y="3272"/>
                  </a:lnTo>
                  <a:lnTo>
                    <a:pt x="989" y="3286"/>
                  </a:lnTo>
                  <a:lnTo>
                    <a:pt x="1017" y="3300"/>
                  </a:lnTo>
                  <a:lnTo>
                    <a:pt x="1045" y="3314"/>
                  </a:lnTo>
                  <a:lnTo>
                    <a:pt x="1073" y="3314"/>
                  </a:lnTo>
                  <a:lnTo>
                    <a:pt x="1099" y="3327"/>
                  </a:lnTo>
                  <a:lnTo>
                    <a:pt x="1127" y="3341"/>
                  </a:lnTo>
                  <a:lnTo>
                    <a:pt x="1155" y="3355"/>
                  </a:lnTo>
                  <a:lnTo>
                    <a:pt x="1182" y="3355"/>
                  </a:lnTo>
                  <a:lnTo>
                    <a:pt x="1210" y="3369"/>
                  </a:lnTo>
                  <a:lnTo>
                    <a:pt x="1237" y="3382"/>
                  </a:lnTo>
                  <a:lnTo>
                    <a:pt x="1278" y="3382"/>
                  </a:lnTo>
                  <a:lnTo>
                    <a:pt x="1306" y="3396"/>
                  </a:lnTo>
                  <a:lnTo>
                    <a:pt x="1333" y="3396"/>
                  </a:lnTo>
                  <a:lnTo>
                    <a:pt x="1361" y="3410"/>
                  </a:lnTo>
                  <a:lnTo>
                    <a:pt x="1389" y="3410"/>
                  </a:lnTo>
                  <a:lnTo>
                    <a:pt x="1416" y="3423"/>
                  </a:lnTo>
                  <a:lnTo>
                    <a:pt x="1443" y="3423"/>
                  </a:lnTo>
                  <a:lnTo>
                    <a:pt x="1485" y="3423"/>
                  </a:lnTo>
                  <a:lnTo>
                    <a:pt x="1512" y="3437"/>
                  </a:lnTo>
                  <a:lnTo>
                    <a:pt x="1540" y="3437"/>
                  </a:lnTo>
                  <a:lnTo>
                    <a:pt x="1568" y="3437"/>
                  </a:lnTo>
                  <a:lnTo>
                    <a:pt x="1594" y="3437"/>
                  </a:lnTo>
                  <a:lnTo>
                    <a:pt x="1622" y="3437"/>
                  </a:lnTo>
                  <a:lnTo>
                    <a:pt x="1663" y="3437"/>
                  </a:lnTo>
                  <a:lnTo>
                    <a:pt x="1691" y="3437"/>
                  </a:lnTo>
                  <a:lnTo>
                    <a:pt x="1719" y="3437"/>
                  </a:lnTo>
                  <a:lnTo>
                    <a:pt x="1746" y="3437"/>
                  </a:lnTo>
                  <a:lnTo>
                    <a:pt x="1773" y="3437"/>
                  </a:lnTo>
                  <a:lnTo>
                    <a:pt x="1814" y="3437"/>
                  </a:lnTo>
                  <a:lnTo>
                    <a:pt x="1842" y="3437"/>
                  </a:lnTo>
                  <a:lnTo>
                    <a:pt x="1870" y="3437"/>
                  </a:lnTo>
                  <a:lnTo>
                    <a:pt x="1897" y="3437"/>
                  </a:lnTo>
                  <a:lnTo>
                    <a:pt x="1925" y="3437"/>
                  </a:lnTo>
                  <a:lnTo>
                    <a:pt x="1952" y="3423"/>
                  </a:lnTo>
                  <a:lnTo>
                    <a:pt x="1993" y="3423"/>
                  </a:lnTo>
                  <a:lnTo>
                    <a:pt x="2021" y="3423"/>
                  </a:lnTo>
                  <a:lnTo>
                    <a:pt x="2048" y="3410"/>
                  </a:lnTo>
                  <a:lnTo>
                    <a:pt x="2076" y="3410"/>
                  </a:lnTo>
                  <a:lnTo>
                    <a:pt x="2104" y="3396"/>
                  </a:lnTo>
                  <a:lnTo>
                    <a:pt x="2131" y="3396"/>
                  </a:lnTo>
                  <a:lnTo>
                    <a:pt x="2158" y="3382"/>
                  </a:lnTo>
                  <a:lnTo>
                    <a:pt x="2199" y="3382"/>
                  </a:lnTo>
                  <a:lnTo>
                    <a:pt x="2227" y="3369"/>
                  </a:lnTo>
                  <a:lnTo>
                    <a:pt x="2255" y="3355"/>
                  </a:lnTo>
                  <a:lnTo>
                    <a:pt x="2283" y="3355"/>
                  </a:lnTo>
                  <a:lnTo>
                    <a:pt x="2309" y="3341"/>
                  </a:lnTo>
                  <a:lnTo>
                    <a:pt x="2337" y="3327"/>
                  </a:lnTo>
                  <a:lnTo>
                    <a:pt x="2365" y="3314"/>
                  </a:lnTo>
                  <a:lnTo>
                    <a:pt x="2393" y="3314"/>
                  </a:lnTo>
                  <a:lnTo>
                    <a:pt x="2419" y="3300"/>
                  </a:lnTo>
                  <a:lnTo>
                    <a:pt x="2447" y="3286"/>
                  </a:lnTo>
                  <a:lnTo>
                    <a:pt x="2475" y="3272"/>
                  </a:lnTo>
                  <a:lnTo>
                    <a:pt x="2503" y="3258"/>
                  </a:lnTo>
                  <a:lnTo>
                    <a:pt x="2529" y="3245"/>
                  </a:lnTo>
                  <a:lnTo>
                    <a:pt x="2557" y="3231"/>
                  </a:lnTo>
                  <a:lnTo>
                    <a:pt x="2585" y="3217"/>
                  </a:lnTo>
                  <a:lnTo>
                    <a:pt x="2612" y="3204"/>
                  </a:lnTo>
                  <a:lnTo>
                    <a:pt x="2640" y="3176"/>
                  </a:lnTo>
                  <a:lnTo>
                    <a:pt x="2654" y="3163"/>
                  </a:lnTo>
                  <a:lnTo>
                    <a:pt x="2681" y="3148"/>
                  </a:lnTo>
                  <a:lnTo>
                    <a:pt x="2708" y="3135"/>
                  </a:lnTo>
                  <a:lnTo>
                    <a:pt x="2736" y="3121"/>
                  </a:lnTo>
                  <a:lnTo>
                    <a:pt x="2763" y="3094"/>
                  </a:lnTo>
                  <a:lnTo>
                    <a:pt x="2777" y="3079"/>
                  </a:lnTo>
                  <a:lnTo>
                    <a:pt x="2805" y="3066"/>
                  </a:lnTo>
                  <a:lnTo>
                    <a:pt x="2832" y="3038"/>
                  </a:lnTo>
                  <a:lnTo>
                    <a:pt x="2846" y="3025"/>
                  </a:lnTo>
                  <a:lnTo>
                    <a:pt x="2873" y="2997"/>
                  </a:lnTo>
                  <a:lnTo>
                    <a:pt x="2901" y="2984"/>
                  </a:lnTo>
                  <a:lnTo>
                    <a:pt x="2914" y="2956"/>
                  </a:lnTo>
                  <a:lnTo>
                    <a:pt x="2942" y="2943"/>
                  </a:lnTo>
                  <a:lnTo>
                    <a:pt x="2956" y="2915"/>
                  </a:lnTo>
                  <a:lnTo>
                    <a:pt x="2983" y="2901"/>
                  </a:lnTo>
                  <a:lnTo>
                    <a:pt x="2998" y="2874"/>
                  </a:lnTo>
                  <a:lnTo>
                    <a:pt x="3024" y="2846"/>
                  </a:lnTo>
                  <a:lnTo>
                    <a:pt x="3039" y="2833"/>
                  </a:lnTo>
                  <a:lnTo>
                    <a:pt x="3065" y="2805"/>
                  </a:lnTo>
                  <a:lnTo>
                    <a:pt x="3080" y="2777"/>
                  </a:lnTo>
                  <a:lnTo>
                    <a:pt x="3093" y="2764"/>
                  </a:lnTo>
                  <a:lnTo>
                    <a:pt x="3121" y="2736"/>
                  </a:lnTo>
                  <a:lnTo>
                    <a:pt x="3134" y="2708"/>
                  </a:lnTo>
                  <a:lnTo>
                    <a:pt x="3149" y="2681"/>
                  </a:lnTo>
                  <a:lnTo>
                    <a:pt x="3162" y="2654"/>
                  </a:lnTo>
                  <a:lnTo>
                    <a:pt x="3176" y="2640"/>
                  </a:lnTo>
                  <a:lnTo>
                    <a:pt x="3203" y="2612"/>
                  </a:lnTo>
                  <a:lnTo>
                    <a:pt x="3218" y="2585"/>
                  </a:lnTo>
                  <a:lnTo>
                    <a:pt x="3231" y="2557"/>
                  </a:lnTo>
                  <a:lnTo>
                    <a:pt x="3244" y="2530"/>
                  </a:lnTo>
                  <a:lnTo>
                    <a:pt x="3259" y="2502"/>
                  </a:lnTo>
                  <a:lnTo>
                    <a:pt x="3272" y="2475"/>
                  </a:lnTo>
                  <a:lnTo>
                    <a:pt x="3286" y="2448"/>
                  </a:lnTo>
                  <a:lnTo>
                    <a:pt x="3300" y="2420"/>
                  </a:lnTo>
                  <a:lnTo>
                    <a:pt x="3313" y="2392"/>
                  </a:lnTo>
                  <a:lnTo>
                    <a:pt x="3313" y="2364"/>
                  </a:lnTo>
                  <a:lnTo>
                    <a:pt x="3327" y="2338"/>
                  </a:lnTo>
                  <a:lnTo>
                    <a:pt x="3341" y="2310"/>
                  </a:lnTo>
                  <a:lnTo>
                    <a:pt x="3355" y="2282"/>
                  </a:lnTo>
                  <a:lnTo>
                    <a:pt x="3355" y="2254"/>
                  </a:lnTo>
                  <a:lnTo>
                    <a:pt x="3369" y="2228"/>
                  </a:lnTo>
                  <a:lnTo>
                    <a:pt x="3382" y="2200"/>
                  </a:lnTo>
                  <a:lnTo>
                    <a:pt x="3382" y="2159"/>
                  </a:lnTo>
                  <a:lnTo>
                    <a:pt x="3396" y="2131"/>
                  </a:lnTo>
                  <a:lnTo>
                    <a:pt x="3396" y="2103"/>
                  </a:lnTo>
                  <a:lnTo>
                    <a:pt x="3410" y="2076"/>
                  </a:lnTo>
                  <a:lnTo>
                    <a:pt x="3410" y="2049"/>
                  </a:lnTo>
                  <a:lnTo>
                    <a:pt x="3423" y="2021"/>
                  </a:lnTo>
                  <a:lnTo>
                    <a:pt x="3423" y="1993"/>
                  </a:lnTo>
                  <a:lnTo>
                    <a:pt x="3423" y="1952"/>
                  </a:lnTo>
                  <a:lnTo>
                    <a:pt x="3437" y="1925"/>
                  </a:lnTo>
                  <a:lnTo>
                    <a:pt x="3437" y="1897"/>
                  </a:lnTo>
                  <a:lnTo>
                    <a:pt x="3437" y="1870"/>
                  </a:lnTo>
                  <a:lnTo>
                    <a:pt x="3437" y="1842"/>
                  </a:lnTo>
                  <a:lnTo>
                    <a:pt x="3437" y="1815"/>
                  </a:lnTo>
                  <a:lnTo>
                    <a:pt x="3437" y="1774"/>
                  </a:lnTo>
                  <a:lnTo>
                    <a:pt x="3437" y="1746"/>
                  </a:lnTo>
                  <a:lnTo>
                    <a:pt x="3451" y="1718"/>
                  </a:lnTo>
                  <a:close/>
                </a:path>
              </a:pathLst>
            </a:custGeom>
            <a:solidFill>
              <a:srgbClr val="ff33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" name=""/>
            <p:cNvSpPr/>
            <p:nvPr/>
          </p:nvSpPr>
          <p:spPr>
            <a:xfrm>
              <a:off x="2940120" y="1272600"/>
              <a:ext cx="216360" cy="215280"/>
            </a:xfrm>
            <a:prstGeom prst="rect">
              <a:avLst/>
            </a:prstGeom>
            <a:noFill/>
            <a:ln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" name=""/>
            <p:cNvSpPr/>
            <p:nvPr/>
          </p:nvSpPr>
          <p:spPr>
            <a:xfrm>
              <a:off x="2974680" y="1307160"/>
              <a:ext cx="145800" cy="145080"/>
            </a:xfrm>
            <a:custGeom>
              <a:avLst/>
              <a:gdLst/>
              <a:ahLst/>
              <a:rect l="l" t="t" r="r" b="b"/>
              <a:pathLst>
                <a:path w="2805" h="2792">
                  <a:moveTo>
                    <a:pt x="2805" y="1403"/>
                  </a:moveTo>
                  <a:lnTo>
                    <a:pt x="2792" y="1375"/>
                  </a:lnTo>
                  <a:lnTo>
                    <a:pt x="2792" y="1347"/>
                  </a:lnTo>
                  <a:lnTo>
                    <a:pt x="2792" y="1320"/>
                  </a:lnTo>
                  <a:lnTo>
                    <a:pt x="2792" y="1293"/>
                  </a:lnTo>
                  <a:lnTo>
                    <a:pt x="2792" y="1278"/>
                  </a:lnTo>
                  <a:lnTo>
                    <a:pt x="2792" y="1252"/>
                  </a:lnTo>
                  <a:lnTo>
                    <a:pt x="2792" y="1224"/>
                  </a:lnTo>
                  <a:lnTo>
                    <a:pt x="2792" y="1196"/>
                  </a:lnTo>
                  <a:lnTo>
                    <a:pt x="2777" y="1183"/>
                  </a:lnTo>
                  <a:lnTo>
                    <a:pt x="2777" y="1155"/>
                  </a:lnTo>
                  <a:lnTo>
                    <a:pt x="2777" y="1127"/>
                  </a:lnTo>
                  <a:lnTo>
                    <a:pt x="2764" y="1100"/>
                  </a:lnTo>
                  <a:lnTo>
                    <a:pt x="2764" y="1086"/>
                  </a:lnTo>
                  <a:lnTo>
                    <a:pt x="2749" y="1059"/>
                  </a:lnTo>
                  <a:lnTo>
                    <a:pt x="2749" y="1031"/>
                  </a:lnTo>
                  <a:lnTo>
                    <a:pt x="2749" y="1004"/>
                  </a:lnTo>
                  <a:lnTo>
                    <a:pt x="2736" y="990"/>
                  </a:lnTo>
                  <a:lnTo>
                    <a:pt x="2736" y="962"/>
                  </a:lnTo>
                  <a:lnTo>
                    <a:pt x="2723" y="935"/>
                  </a:lnTo>
                  <a:lnTo>
                    <a:pt x="2708" y="921"/>
                  </a:lnTo>
                  <a:lnTo>
                    <a:pt x="2708" y="894"/>
                  </a:lnTo>
                  <a:lnTo>
                    <a:pt x="2695" y="866"/>
                  </a:lnTo>
                  <a:lnTo>
                    <a:pt x="2682" y="852"/>
                  </a:lnTo>
                  <a:lnTo>
                    <a:pt x="2682" y="825"/>
                  </a:lnTo>
                  <a:lnTo>
                    <a:pt x="2667" y="798"/>
                  </a:lnTo>
                  <a:lnTo>
                    <a:pt x="2654" y="783"/>
                  </a:lnTo>
                  <a:lnTo>
                    <a:pt x="2640" y="757"/>
                  </a:lnTo>
                  <a:lnTo>
                    <a:pt x="2640" y="742"/>
                  </a:lnTo>
                  <a:lnTo>
                    <a:pt x="2626" y="715"/>
                  </a:lnTo>
                  <a:lnTo>
                    <a:pt x="2613" y="701"/>
                  </a:lnTo>
                  <a:lnTo>
                    <a:pt x="2598" y="673"/>
                  </a:lnTo>
                  <a:lnTo>
                    <a:pt x="2585" y="647"/>
                  </a:lnTo>
                  <a:lnTo>
                    <a:pt x="2571" y="632"/>
                  </a:lnTo>
                  <a:lnTo>
                    <a:pt x="2557" y="605"/>
                  </a:lnTo>
                  <a:lnTo>
                    <a:pt x="2544" y="591"/>
                  </a:lnTo>
                  <a:lnTo>
                    <a:pt x="2530" y="578"/>
                  </a:lnTo>
                  <a:lnTo>
                    <a:pt x="2516" y="550"/>
                  </a:lnTo>
                  <a:lnTo>
                    <a:pt x="2503" y="537"/>
                  </a:lnTo>
                  <a:lnTo>
                    <a:pt x="2489" y="509"/>
                  </a:lnTo>
                  <a:lnTo>
                    <a:pt x="2475" y="495"/>
                  </a:lnTo>
                  <a:lnTo>
                    <a:pt x="2447" y="481"/>
                  </a:lnTo>
                  <a:lnTo>
                    <a:pt x="2434" y="454"/>
                  </a:lnTo>
                  <a:lnTo>
                    <a:pt x="2420" y="440"/>
                  </a:lnTo>
                  <a:lnTo>
                    <a:pt x="2406" y="426"/>
                  </a:lnTo>
                  <a:lnTo>
                    <a:pt x="2392" y="399"/>
                  </a:lnTo>
                  <a:lnTo>
                    <a:pt x="2365" y="385"/>
                  </a:lnTo>
                  <a:lnTo>
                    <a:pt x="2351" y="371"/>
                  </a:lnTo>
                  <a:lnTo>
                    <a:pt x="2338" y="358"/>
                  </a:lnTo>
                  <a:lnTo>
                    <a:pt x="2310" y="344"/>
                  </a:lnTo>
                  <a:lnTo>
                    <a:pt x="2296" y="316"/>
                  </a:lnTo>
                  <a:lnTo>
                    <a:pt x="2282" y="303"/>
                  </a:lnTo>
                  <a:lnTo>
                    <a:pt x="2255" y="289"/>
                  </a:lnTo>
                  <a:lnTo>
                    <a:pt x="2241" y="275"/>
                  </a:lnTo>
                  <a:lnTo>
                    <a:pt x="2213" y="261"/>
                  </a:lnTo>
                  <a:lnTo>
                    <a:pt x="2200" y="247"/>
                  </a:lnTo>
                  <a:lnTo>
                    <a:pt x="2187" y="234"/>
                  </a:lnTo>
                  <a:lnTo>
                    <a:pt x="2159" y="220"/>
                  </a:lnTo>
                  <a:lnTo>
                    <a:pt x="2145" y="206"/>
                  </a:lnTo>
                  <a:lnTo>
                    <a:pt x="2118" y="193"/>
                  </a:lnTo>
                  <a:lnTo>
                    <a:pt x="2103" y="179"/>
                  </a:lnTo>
                  <a:lnTo>
                    <a:pt x="2077" y="165"/>
                  </a:lnTo>
                  <a:lnTo>
                    <a:pt x="2049" y="151"/>
                  </a:lnTo>
                  <a:lnTo>
                    <a:pt x="2035" y="151"/>
                  </a:lnTo>
                  <a:lnTo>
                    <a:pt x="2008" y="137"/>
                  </a:lnTo>
                  <a:lnTo>
                    <a:pt x="1993" y="124"/>
                  </a:lnTo>
                  <a:lnTo>
                    <a:pt x="1967" y="110"/>
                  </a:lnTo>
                  <a:lnTo>
                    <a:pt x="1939" y="110"/>
                  </a:lnTo>
                  <a:lnTo>
                    <a:pt x="1925" y="96"/>
                  </a:lnTo>
                  <a:lnTo>
                    <a:pt x="1898" y="83"/>
                  </a:lnTo>
                  <a:lnTo>
                    <a:pt x="1870" y="83"/>
                  </a:lnTo>
                  <a:lnTo>
                    <a:pt x="1856" y="68"/>
                  </a:lnTo>
                  <a:lnTo>
                    <a:pt x="1829" y="55"/>
                  </a:lnTo>
                  <a:lnTo>
                    <a:pt x="1801" y="55"/>
                  </a:lnTo>
                  <a:lnTo>
                    <a:pt x="1788" y="42"/>
                  </a:lnTo>
                  <a:lnTo>
                    <a:pt x="1760" y="42"/>
                  </a:lnTo>
                  <a:lnTo>
                    <a:pt x="1732" y="42"/>
                  </a:lnTo>
                  <a:lnTo>
                    <a:pt x="1705" y="27"/>
                  </a:lnTo>
                  <a:lnTo>
                    <a:pt x="1691" y="27"/>
                  </a:lnTo>
                  <a:lnTo>
                    <a:pt x="1664" y="14"/>
                  </a:lnTo>
                  <a:lnTo>
                    <a:pt x="1636" y="14"/>
                  </a:lnTo>
                  <a:lnTo>
                    <a:pt x="1609" y="14"/>
                  </a:lnTo>
                  <a:lnTo>
                    <a:pt x="1595" y="0"/>
                  </a:lnTo>
                  <a:lnTo>
                    <a:pt x="1567" y="0"/>
                  </a:lnTo>
                  <a:lnTo>
                    <a:pt x="1540" y="0"/>
                  </a:lnTo>
                  <a:lnTo>
                    <a:pt x="1513" y="0"/>
                  </a:lnTo>
                  <a:lnTo>
                    <a:pt x="1498" y="0"/>
                  </a:lnTo>
                  <a:lnTo>
                    <a:pt x="1472" y="0"/>
                  </a:lnTo>
                  <a:lnTo>
                    <a:pt x="1444" y="0"/>
                  </a:lnTo>
                  <a:lnTo>
                    <a:pt x="1416" y="0"/>
                  </a:lnTo>
                  <a:lnTo>
                    <a:pt x="1403" y="0"/>
                  </a:lnTo>
                  <a:lnTo>
                    <a:pt x="1375" y="0"/>
                  </a:lnTo>
                  <a:lnTo>
                    <a:pt x="1347" y="0"/>
                  </a:lnTo>
                  <a:lnTo>
                    <a:pt x="1320" y="0"/>
                  </a:lnTo>
                  <a:lnTo>
                    <a:pt x="1293" y="0"/>
                  </a:lnTo>
                  <a:lnTo>
                    <a:pt x="1278" y="0"/>
                  </a:lnTo>
                  <a:lnTo>
                    <a:pt x="1252" y="0"/>
                  </a:lnTo>
                  <a:lnTo>
                    <a:pt x="1224" y="0"/>
                  </a:lnTo>
                  <a:lnTo>
                    <a:pt x="1196" y="0"/>
                  </a:lnTo>
                  <a:lnTo>
                    <a:pt x="1183" y="14"/>
                  </a:lnTo>
                  <a:lnTo>
                    <a:pt x="1155" y="14"/>
                  </a:lnTo>
                  <a:lnTo>
                    <a:pt x="1127" y="14"/>
                  </a:lnTo>
                  <a:lnTo>
                    <a:pt x="1100" y="27"/>
                  </a:lnTo>
                  <a:lnTo>
                    <a:pt x="1086" y="27"/>
                  </a:lnTo>
                  <a:lnTo>
                    <a:pt x="1059" y="42"/>
                  </a:lnTo>
                  <a:lnTo>
                    <a:pt x="1031" y="42"/>
                  </a:lnTo>
                  <a:lnTo>
                    <a:pt x="1004" y="42"/>
                  </a:lnTo>
                  <a:lnTo>
                    <a:pt x="990" y="55"/>
                  </a:lnTo>
                  <a:lnTo>
                    <a:pt x="962" y="55"/>
                  </a:lnTo>
                  <a:lnTo>
                    <a:pt x="935" y="68"/>
                  </a:lnTo>
                  <a:lnTo>
                    <a:pt x="921" y="83"/>
                  </a:lnTo>
                  <a:lnTo>
                    <a:pt x="894" y="83"/>
                  </a:lnTo>
                  <a:lnTo>
                    <a:pt x="866" y="96"/>
                  </a:lnTo>
                  <a:lnTo>
                    <a:pt x="852" y="110"/>
                  </a:lnTo>
                  <a:lnTo>
                    <a:pt x="825" y="110"/>
                  </a:lnTo>
                  <a:lnTo>
                    <a:pt x="798" y="124"/>
                  </a:lnTo>
                  <a:lnTo>
                    <a:pt x="783" y="137"/>
                  </a:lnTo>
                  <a:lnTo>
                    <a:pt x="757" y="151"/>
                  </a:lnTo>
                  <a:lnTo>
                    <a:pt x="742" y="151"/>
                  </a:lnTo>
                  <a:lnTo>
                    <a:pt x="715" y="165"/>
                  </a:lnTo>
                  <a:lnTo>
                    <a:pt x="701" y="179"/>
                  </a:lnTo>
                  <a:lnTo>
                    <a:pt x="673" y="193"/>
                  </a:lnTo>
                  <a:lnTo>
                    <a:pt x="647" y="206"/>
                  </a:lnTo>
                  <a:lnTo>
                    <a:pt x="632" y="220"/>
                  </a:lnTo>
                  <a:lnTo>
                    <a:pt x="605" y="234"/>
                  </a:lnTo>
                  <a:lnTo>
                    <a:pt x="591" y="247"/>
                  </a:lnTo>
                  <a:lnTo>
                    <a:pt x="578" y="261"/>
                  </a:lnTo>
                  <a:lnTo>
                    <a:pt x="550" y="275"/>
                  </a:lnTo>
                  <a:lnTo>
                    <a:pt x="537" y="289"/>
                  </a:lnTo>
                  <a:lnTo>
                    <a:pt x="509" y="303"/>
                  </a:lnTo>
                  <a:lnTo>
                    <a:pt x="495" y="316"/>
                  </a:lnTo>
                  <a:lnTo>
                    <a:pt x="481" y="344"/>
                  </a:lnTo>
                  <a:lnTo>
                    <a:pt x="454" y="358"/>
                  </a:lnTo>
                  <a:lnTo>
                    <a:pt x="440" y="371"/>
                  </a:lnTo>
                  <a:lnTo>
                    <a:pt x="426" y="385"/>
                  </a:lnTo>
                  <a:lnTo>
                    <a:pt x="399" y="399"/>
                  </a:lnTo>
                  <a:lnTo>
                    <a:pt x="385" y="426"/>
                  </a:lnTo>
                  <a:lnTo>
                    <a:pt x="371" y="440"/>
                  </a:lnTo>
                  <a:lnTo>
                    <a:pt x="358" y="454"/>
                  </a:lnTo>
                  <a:lnTo>
                    <a:pt x="344" y="481"/>
                  </a:lnTo>
                  <a:lnTo>
                    <a:pt x="316" y="495"/>
                  </a:lnTo>
                  <a:lnTo>
                    <a:pt x="303" y="509"/>
                  </a:lnTo>
                  <a:lnTo>
                    <a:pt x="289" y="537"/>
                  </a:lnTo>
                  <a:lnTo>
                    <a:pt x="275" y="550"/>
                  </a:lnTo>
                  <a:lnTo>
                    <a:pt x="261" y="578"/>
                  </a:lnTo>
                  <a:lnTo>
                    <a:pt x="247" y="591"/>
                  </a:lnTo>
                  <a:lnTo>
                    <a:pt x="234" y="605"/>
                  </a:lnTo>
                  <a:lnTo>
                    <a:pt x="220" y="632"/>
                  </a:lnTo>
                  <a:lnTo>
                    <a:pt x="206" y="647"/>
                  </a:lnTo>
                  <a:lnTo>
                    <a:pt x="193" y="673"/>
                  </a:lnTo>
                  <a:lnTo>
                    <a:pt x="179" y="688"/>
                  </a:lnTo>
                  <a:lnTo>
                    <a:pt x="165" y="715"/>
                  </a:lnTo>
                  <a:lnTo>
                    <a:pt x="151" y="742"/>
                  </a:lnTo>
                  <a:lnTo>
                    <a:pt x="151" y="757"/>
                  </a:lnTo>
                  <a:lnTo>
                    <a:pt x="137" y="783"/>
                  </a:lnTo>
                  <a:lnTo>
                    <a:pt x="124" y="798"/>
                  </a:lnTo>
                  <a:lnTo>
                    <a:pt x="110" y="825"/>
                  </a:lnTo>
                  <a:lnTo>
                    <a:pt x="110" y="852"/>
                  </a:lnTo>
                  <a:lnTo>
                    <a:pt x="96" y="866"/>
                  </a:lnTo>
                  <a:lnTo>
                    <a:pt x="83" y="894"/>
                  </a:lnTo>
                  <a:lnTo>
                    <a:pt x="83" y="921"/>
                  </a:lnTo>
                  <a:lnTo>
                    <a:pt x="68" y="935"/>
                  </a:lnTo>
                  <a:lnTo>
                    <a:pt x="55" y="962"/>
                  </a:lnTo>
                  <a:lnTo>
                    <a:pt x="55" y="990"/>
                  </a:lnTo>
                  <a:lnTo>
                    <a:pt x="42" y="1004"/>
                  </a:lnTo>
                  <a:lnTo>
                    <a:pt x="42" y="1031"/>
                  </a:lnTo>
                  <a:lnTo>
                    <a:pt x="42" y="1059"/>
                  </a:lnTo>
                  <a:lnTo>
                    <a:pt x="27" y="1086"/>
                  </a:lnTo>
                  <a:lnTo>
                    <a:pt x="27" y="1100"/>
                  </a:lnTo>
                  <a:lnTo>
                    <a:pt x="14" y="1127"/>
                  </a:lnTo>
                  <a:lnTo>
                    <a:pt x="14" y="1155"/>
                  </a:lnTo>
                  <a:lnTo>
                    <a:pt x="14" y="1183"/>
                  </a:lnTo>
                  <a:lnTo>
                    <a:pt x="0" y="1196"/>
                  </a:lnTo>
                  <a:lnTo>
                    <a:pt x="0" y="1224"/>
                  </a:lnTo>
                  <a:lnTo>
                    <a:pt x="0" y="1252"/>
                  </a:lnTo>
                  <a:lnTo>
                    <a:pt x="0" y="1278"/>
                  </a:lnTo>
                  <a:lnTo>
                    <a:pt x="0" y="1293"/>
                  </a:lnTo>
                  <a:lnTo>
                    <a:pt x="0" y="1320"/>
                  </a:lnTo>
                  <a:lnTo>
                    <a:pt x="0" y="1347"/>
                  </a:lnTo>
                  <a:lnTo>
                    <a:pt x="0" y="1375"/>
                  </a:lnTo>
                  <a:lnTo>
                    <a:pt x="0" y="1388"/>
                  </a:lnTo>
                  <a:lnTo>
                    <a:pt x="0" y="1416"/>
                  </a:lnTo>
                  <a:lnTo>
                    <a:pt x="0" y="1444"/>
                  </a:lnTo>
                  <a:lnTo>
                    <a:pt x="0" y="1472"/>
                  </a:lnTo>
                  <a:lnTo>
                    <a:pt x="0" y="1498"/>
                  </a:lnTo>
                  <a:lnTo>
                    <a:pt x="0" y="1513"/>
                  </a:lnTo>
                  <a:lnTo>
                    <a:pt x="0" y="1540"/>
                  </a:lnTo>
                  <a:lnTo>
                    <a:pt x="0" y="1567"/>
                  </a:lnTo>
                  <a:lnTo>
                    <a:pt x="0" y="1595"/>
                  </a:lnTo>
                  <a:lnTo>
                    <a:pt x="14" y="1609"/>
                  </a:lnTo>
                  <a:lnTo>
                    <a:pt x="14" y="1636"/>
                  </a:lnTo>
                  <a:lnTo>
                    <a:pt x="14" y="1664"/>
                  </a:lnTo>
                  <a:lnTo>
                    <a:pt x="27" y="1691"/>
                  </a:lnTo>
                  <a:lnTo>
                    <a:pt x="27" y="1705"/>
                  </a:lnTo>
                  <a:lnTo>
                    <a:pt x="42" y="1732"/>
                  </a:lnTo>
                  <a:lnTo>
                    <a:pt x="42" y="1760"/>
                  </a:lnTo>
                  <a:lnTo>
                    <a:pt x="42" y="1788"/>
                  </a:lnTo>
                  <a:lnTo>
                    <a:pt x="55" y="1801"/>
                  </a:lnTo>
                  <a:lnTo>
                    <a:pt x="55" y="1829"/>
                  </a:lnTo>
                  <a:lnTo>
                    <a:pt x="68" y="1856"/>
                  </a:lnTo>
                  <a:lnTo>
                    <a:pt x="83" y="1870"/>
                  </a:lnTo>
                  <a:lnTo>
                    <a:pt x="83" y="1898"/>
                  </a:lnTo>
                  <a:lnTo>
                    <a:pt x="96" y="1925"/>
                  </a:lnTo>
                  <a:lnTo>
                    <a:pt x="110" y="1939"/>
                  </a:lnTo>
                  <a:lnTo>
                    <a:pt x="110" y="1967"/>
                  </a:lnTo>
                  <a:lnTo>
                    <a:pt x="124" y="1993"/>
                  </a:lnTo>
                  <a:lnTo>
                    <a:pt x="137" y="2008"/>
                  </a:lnTo>
                  <a:lnTo>
                    <a:pt x="151" y="2035"/>
                  </a:lnTo>
                  <a:lnTo>
                    <a:pt x="151" y="2049"/>
                  </a:lnTo>
                  <a:lnTo>
                    <a:pt x="165" y="2077"/>
                  </a:lnTo>
                  <a:lnTo>
                    <a:pt x="179" y="2090"/>
                  </a:lnTo>
                  <a:lnTo>
                    <a:pt x="193" y="2118"/>
                  </a:lnTo>
                  <a:lnTo>
                    <a:pt x="206" y="2145"/>
                  </a:lnTo>
                  <a:lnTo>
                    <a:pt x="220" y="2159"/>
                  </a:lnTo>
                  <a:lnTo>
                    <a:pt x="234" y="2187"/>
                  </a:lnTo>
                  <a:lnTo>
                    <a:pt x="247" y="2200"/>
                  </a:lnTo>
                  <a:lnTo>
                    <a:pt x="261" y="2213"/>
                  </a:lnTo>
                  <a:lnTo>
                    <a:pt x="275" y="2241"/>
                  </a:lnTo>
                  <a:lnTo>
                    <a:pt x="289" y="2255"/>
                  </a:lnTo>
                  <a:lnTo>
                    <a:pt x="303" y="2282"/>
                  </a:lnTo>
                  <a:lnTo>
                    <a:pt x="316" y="2296"/>
                  </a:lnTo>
                  <a:lnTo>
                    <a:pt x="344" y="2310"/>
                  </a:lnTo>
                  <a:lnTo>
                    <a:pt x="358" y="2338"/>
                  </a:lnTo>
                  <a:lnTo>
                    <a:pt x="371" y="2351"/>
                  </a:lnTo>
                  <a:lnTo>
                    <a:pt x="385" y="2365"/>
                  </a:lnTo>
                  <a:lnTo>
                    <a:pt x="399" y="2392"/>
                  </a:lnTo>
                  <a:lnTo>
                    <a:pt x="426" y="2406"/>
                  </a:lnTo>
                  <a:lnTo>
                    <a:pt x="440" y="2420"/>
                  </a:lnTo>
                  <a:lnTo>
                    <a:pt x="454" y="2434"/>
                  </a:lnTo>
                  <a:lnTo>
                    <a:pt x="481" y="2447"/>
                  </a:lnTo>
                  <a:lnTo>
                    <a:pt x="495" y="2475"/>
                  </a:lnTo>
                  <a:lnTo>
                    <a:pt x="509" y="2489"/>
                  </a:lnTo>
                  <a:lnTo>
                    <a:pt x="537" y="2503"/>
                  </a:lnTo>
                  <a:lnTo>
                    <a:pt x="550" y="2516"/>
                  </a:lnTo>
                  <a:lnTo>
                    <a:pt x="578" y="2530"/>
                  </a:lnTo>
                  <a:lnTo>
                    <a:pt x="591" y="2544"/>
                  </a:lnTo>
                  <a:lnTo>
                    <a:pt x="605" y="2557"/>
                  </a:lnTo>
                  <a:lnTo>
                    <a:pt x="632" y="2571"/>
                  </a:lnTo>
                  <a:lnTo>
                    <a:pt x="647" y="2585"/>
                  </a:lnTo>
                  <a:lnTo>
                    <a:pt x="673" y="2598"/>
                  </a:lnTo>
                  <a:lnTo>
                    <a:pt x="688" y="2613"/>
                  </a:lnTo>
                  <a:lnTo>
                    <a:pt x="715" y="2626"/>
                  </a:lnTo>
                  <a:lnTo>
                    <a:pt x="742" y="2640"/>
                  </a:lnTo>
                  <a:lnTo>
                    <a:pt x="757" y="2640"/>
                  </a:lnTo>
                  <a:lnTo>
                    <a:pt x="783" y="2654"/>
                  </a:lnTo>
                  <a:lnTo>
                    <a:pt x="798" y="2667"/>
                  </a:lnTo>
                  <a:lnTo>
                    <a:pt x="825" y="2682"/>
                  </a:lnTo>
                  <a:lnTo>
                    <a:pt x="852" y="2682"/>
                  </a:lnTo>
                  <a:lnTo>
                    <a:pt x="866" y="2695"/>
                  </a:lnTo>
                  <a:lnTo>
                    <a:pt x="894" y="2708"/>
                  </a:lnTo>
                  <a:lnTo>
                    <a:pt x="921" y="2708"/>
                  </a:lnTo>
                  <a:lnTo>
                    <a:pt x="935" y="2723"/>
                  </a:lnTo>
                  <a:lnTo>
                    <a:pt x="962" y="2736"/>
                  </a:lnTo>
                  <a:lnTo>
                    <a:pt x="990" y="2736"/>
                  </a:lnTo>
                  <a:lnTo>
                    <a:pt x="1004" y="2749"/>
                  </a:lnTo>
                  <a:lnTo>
                    <a:pt x="1031" y="2749"/>
                  </a:lnTo>
                  <a:lnTo>
                    <a:pt x="1059" y="2749"/>
                  </a:lnTo>
                  <a:lnTo>
                    <a:pt x="1086" y="2764"/>
                  </a:lnTo>
                  <a:lnTo>
                    <a:pt x="1100" y="2764"/>
                  </a:lnTo>
                  <a:lnTo>
                    <a:pt x="1127" y="2777"/>
                  </a:lnTo>
                  <a:lnTo>
                    <a:pt x="1155" y="2777"/>
                  </a:lnTo>
                  <a:lnTo>
                    <a:pt x="1183" y="2777"/>
                  </a:lnTo>
                  <a:lnTo>
                    <a:pt x="1196" y="2792"/>
                  </a:lnTo>
                  <a:lnTo>
                    <a:pt x="1224" y="2792"/>
                  </a:lnTo>
                  <a:lnTo>
                    <a:pt x="1252" y="2792"/>
                  </a:lnTo>
                  <a:lnTo>
                    <a:pt x="1278" y="2792"/>
                  </a:lnTo>
                  <a:lnTo>
                    <a:pt x="1293" y="2792"/>
                  </a:lnTo>
                  <a:lnTo>
                    <a:pt x="1320" y="2792"/>
                  </a:lnTo>
                  <a:lnTo>
                    <a:pt x="1347" y="2792"/>
                  </a:lnTo>
                  <a:lnTo>
                    <a:pt x="1375" y="2792"/>
                  </a:lnTo>
                  <a:lnTo>
                    <a:pt x="1388" y="2792"/>
                  </a:lnTo>
                  <a:lnTo>
                    <a:pt x="1416" y="2792"/>
                  </a:lnTo>
                  <a:lnTo>
                    <a:pt x="1444" y="2792"/>
                  </a:lnTo>
                  <a:lnTo>
                    <a:pt x="1472" y="2792"/>
                  </a:lnTo>
                  <a:lnTo>
                    <a:pt x="1498" y="2792"/>
                  </a:lnTo>
                  <a:lnTo>
                    <a:pt x="1513" y="2792"/>
                  </a:lnTo>
                  <a:lnTo>
                    <a:pt x="1540" y="2792"/>
                  </a:lnTo>
                  <a:lnTo>
                    <a:pt x="1567" y="2792"/>
                  </a:lnTo>
                  <a:lnTo>
                    <a:pt x="1595" y="2792"/>
                  </a:lnTo>
                  <a:lnTo>
                    <a:pt x="1609" y="2777"/>
                  </a:lnTo>
                  <a:lnTo>
                    <a:pt x="1636" y="2777"/>
                  </a:lnTo>
                  <a:lnTo>
                    <a:pt x="1664" y="2777"/>
                  </a:lnTo>
                  <a:lnTo>
                    <a:pt x="1691" y="2764"/>
                  </a:lnTo>
                  <a:lnTo>
                    <a:pt x="1705" y="2764"/>
                  </a:lnTo>
                  <a:lnTo>
                    <a:pt x="1732" y="2749"/>
                  </a:lnTo>
                  <a:lnTo>
                    <a:pt x="1760" y="2749"/>
                  </a:lnTo>
                  <a:lnTo>
                    <a:pt x="1788" y="2749"/>
                  </a:lnTo>
                  <a:lnTo>
                    <a:pt x="1801" y="2736"/>
                  </a:lnTo>
                  <a:lnTo>
                    <a:pt x="1829" y="2736"/>
                  </a:lnTo>
                  <a:lnTo>
                    <a:pt x="1856" y="2723"/>
                  </a:lnTo>
                  <a:lnTo>
                    <a:pt x="1870" y="2708"/>
                  </a:lnTo>
                  <a:lnTo>
                    <a:pt x="1898" y="2708"/>
                  </a:lnTo>
                  <a:lnTo>
                    <a:pt x="1925" y="2695"/>
                  </a:lnTo>
                  <a:lnTo>
                    <a:pt x="1939" y="2682"/>
                  </a:lnTo>
                  <a:lnTo>
                    <a:pt x="1967" y="2682"/>
                  </a:lnTo>
                  <a:lnTo>
                    <a:pt x="1993" y="2667"/>
                  </a:lnTo>
                  <a:lnTo>
                    <a:pt x="2008" y="2654"/>
                  </a:lnTo>
                  <a:lnTo>
                    <a:pt x="2035" y="2640"/>
                  </a:lnTo>
                  <a:lnTo>
                    <a:pt x="2049" y="2640"/>
                  </a:lnTo>
                  <a:lnTo>
                    <a:pt x="2077" y="2626"/>
                  </a:lnTo>
                  <a:lnTo>
                    <a:pt x="2090" y="2613"/>
                  </a:lnTo>
                  <a:lnTo>
                    <a:pt x="2118" y="2598"/>
                  </a:lnTo>
                  <a:lnTo>
                    <a:pt x="2145" y="2585"/>
                  </a:lnTo>
                  <a:lnTo>
                    <a:pt x="2159" y="2571"/>
                  </a:lnTo>
                  <a:lnTo>
                    <a:pt x="2187" y="2557"/>
                  </a:lnTo>
                  <a:lnTo>
                    <a:pt x="2200" y="2544"/>
                  </a:lnTo>
                  <a:lnTo>
                    <a:pt x="2213" y="2530"/>
                  </a:lnTo>
                  <a:lnTo>
                    <a:pt x="2241" y="2516"/>
                  </a:lnTo>
                  <a:lnTo>
                    <a:pt x="2255" y="2503"/>
                  </a:lnTo>
                  <a:lnTo>
                    <a:pt x="2282" y="2489"/>
                  </a:lnTo>
                  <a:lnTo>
                    <a:pt x="2296" y="2475"/>
                  </a:lnTo>
                  <a:lnTo>
                    <a:pt x="2310" y="2447"/>
                  </a:lnTo>
                  <a:lnTo>
                    <a:pt x="2338" y="2434"/>
                  </a:lnTo>
                  <a:lnTo>
                    <a:pt x="2351" y="2420"/>
                  </a:lnTo>
                  <a:lnTo>
                    <a:pt x="2365" y="2406"/>
                  </a:lnTo>
                  <a:lnTo>
                    <a:pt x="2392" y="2392"/>
                  </a:lnTo>
                  <a:lnTo>
                    <a:pt x="2406" y="2365"/>
                  </a:lnTo>
                  <a:lnTo>
                    <a:pt x="2420" y="2351"/>
                  </a:lnTo>
                  <a:lnTo>
                    <a:pt x="2434" y="2338"/>
                  </a:lnTo>
                  <a:lnTo>
                    <a:pt x="2447" y="2310"/>
                  </a:lnTo>
                  <a:lnTo>
                    <a:pt x="2475" y="2296"/>
                  </a:lnTo>
                  <a:lnTo>
                    <a:pt x="2489" y="2282"/>
                  </a:lnTo>
                  <a:lnTo>
                    <a:pt x="2503" y="2255"/>
                  </a:lnTo>
                  <a:lnTo>
                    <a:pt x="2516" y="2241"/>
                  </a:lnTo>
                  <a:lnTo>
                    <a:pt x="2530" y="2213"/>
                  </a:lnTo>
                  <a:lnTo>
                    <a:pt x="2544" y="2200"/>
                  </a:lnTo>
                  <a:lnTo>
                    <a:pt x="2557" y="2187"/>
                  </a:lnTo>
                  <a:lnTo>
                    <a:pt x="2571" y="2159"/>
                  </a:lnTo>
                  <a:lnTo>
                    <a:pt x="2585" y="2145"/>
                  </a:lnTo>
                  <a:lnTo>
                    <a:pt x="2598" y="2118"/>
                  </a:lnTo>
                  <a:lnTo>
                    <a:pt x="2613" y="2103"/>
                  </a:lnTo>
                  <a:lnTo>
                    <a:pt x="2626" y="2077"/>
                  </a:lnTo>
                  <a:lnTo>
                    <a:pt x="2640" y="2049"/>
                  </a:lnTo>
                  <a:lnTo>
                    <a:pt x="2640" y="2035"/>
                  </a:lnTo>
                  <a:lnTo>
                    <a:pt x="2654" y="2008"/>
                  </a:lnTo>
                  <a:lnTo>
                    <a:pt x="2667" y="1993"/>
                  </a:lnTo>
                  <a:lnTo>
                    <a:pt x="2682" y="1967"/>
                  </a:lnTo>
                  <a:lnTo>
                    <a:pt x="2682" y="1939"/>
                  </a:lnTo>
                  <a:lnTo>
                    <a:pt x="2695" y="1925"/>
                  </a:lnTo>
                  <a:lnTo>
                    <a:pt x="2708" y="1898"/>
                  </a:lnTo>
                  <a:lnTo>
                    <a:pt x="2708" y="1870"/>
                  </a:lnTo>
                  <a:lnTo>
                    <a:pt x="2723" y="1856"/>
                  </a:lnTo>
                  <a:lnTo>
                    <a:pt x="2736" y="1829"/>
                  </a:lnTo>
                  <a:lnTo>
                    <a:pt x="2736" y="1801"/>
                  </a:lnTo>
                  <a:lnTo>
                    <a:pt x="2749" y="1788"/>
                  </a:lnTo>
                  <a:lnTo>
                    <a:pt x="2749" y="1760"/>
                  </a:lnTo>
                  <a:lnTo>
                    <a:pt x="2749" y="1732"/>
                  </a:lnTo>
                  <a:lnTo>
                    <a:pt x="2764" y="1705"/>
                  </a:lnTo>
                  <a:lnTo>
                    <a:pt x="2764" y="1691"/>
                  </a:lnTo>
                  <a:lnTo>
                    <a:pt x="2777" y="1664"/>
                  </a:lnTo>
                  <a:lnTo>
                    <a:pt x="2777" y="1636"/>
                  </a:lnTo>
                  <a:lnTo>
                    <a:pt x="2777" y="1609"/>
                  </a:lnTo>
                  <a:lnTo>
                    <a:pt x="2792" y="1595"/>
                  </a:lnTo>
                  <a:lnTo>
                    <a:pt x="2792" y="1567"/>
                  </a:lnTo>
                  <a:lnTo>
                    <a:pt x="2792" y="1540"/>
                  </a:lnTo>
                  <a:lnTo>
                    <a:pt x="2792" y="1513"/>
                  </a:lnTo>
                  <a:lnTo>
                    <a:pt x="2792" y="1498"/>
                  </a:lnTo>
                  <a:lnTo>
                    <a:pt x="2792" y="1472"/>
                  </a:lnTo>
                  <a:lnTo>
                    <a:pt x="2792" y="1444"/>
                  </a:lnTo>
                  <a:lnTo>
                    <a:pt x="2792" y="1416"/>
                  </a:lnTo>
                  <a:lnTo>
                    <a:pt x="2805" y="1403"/>
                  </a:lnTo>
                  <a:close/>
                </a:path>
              </a:pathLst>
            </a:custGeom>
            <a:solidFill>
              <a:srgbClr val="ff33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" name=""/>
            <p:cNvSpPr/>
            <p:nvPr/>
          </p:nvSpPr>
          <p:spPr>
            <a:xfrm>
              <a:off x="2940120" y="1487880"/>
              <a:ext cx="216360" cy="213840"/>
            </a:xfrm>
            <a:prstGeom prst="rect">
              <a:avLst/>
            </a:prstGeom>
            <a:noFill/>
            <a:ln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0" name=""/>
            <p:cNvSpPr/>
            <p:nvPr/>
          </p:nvSpPr>
          <p:spPr>
            <a:xfrm>
              <a:off x="2996640" y="1544400"/>
              <a:ext cx="103320" cy="101520"/>
            </a:xfrm>
            <a:custGeom>
              <a:avLst/>
              <a:gdLst/>
              <a:ahLst/>
              <a:rect l="l" t="t" r="r" b="b"/>
              <a:pathLst>
                <a:path w="1966" h="1953">
                  <a:moveTo>
                    <a:pt x="1966" y="976"/>
                  </a:moveTo>
                  <a:lnTo>
                    <a:pt x="1953" y="963"/>
                  </a:lnTo>
                  <a:lnTo>
                    <a:pt x="1953" y="949"/>
                  </a:lnTo>
                  <a:lnTo>
                    <a:pt x="1953" y="922"/>
                  </a:lnTo>
                  <a:lnTo>
                    <a:pt x="1953" y="907"/>
                  </a:lnTo>
                  <a:lnTo>
                    <a:pt x="1953" y="894"/>
                  </a:lnTo>
                  <a:lnTo>
                    <a:pt x="1953" y="881"/>
                  </a:lnTo>
                  <a:lnTo>
                    <a:pt x="1953" y="853"/>
                  </a:lnTo>
                  <a:lnTo>
                    <a:pt x="1953" y="839"/>
                  </a:lnTo>
                  <a:lnTo>
                    <a:pt x="1953" y="825"/>
                  </a:lnTo>
                  <a:lnTo>
                    <a:pt x="1939" y="812"/>
                  </a:lnTo>
                  <a:lnTo>
                    <a:pt x="1939" y="784"/>
                  </a:lnTo>
                  <a:lnTo>
                    <a:pt x="1939" y="770"/>
                  </a:lnTo>
                  <a:lnTo>
                    <a:pt x="1939" y="756"/>
                  </a:lnTo>
                  <a:lnTo>
                    <a:pt x="1925" y="743"/>
                  </a:lnTo>
                  <a:lnTo>
                    <a:pt x="1925" y="715"/>
                  </a:lnTo>
                  <a:lnTo>
                    <a:pt x="1925" y="702"/>
                  </a:lnTo>
                  <a:lnTo>
                    <a:pt x="1912" y="688"/>
                  </a:lnTo>
                  <a:lnTo>
                    <a:pt x="1912" y="674"/>
                  </a:lnTo>
                  <a:lnTo>
                    <a:pt x="1912" y="660"/>
                  </a:lnTo>
                  <a:lnTo>
                    <a:pt x="1898" y="647"/>
                  </a:lnTo>
                  <a:lnTo>
                    <a:pt x="1898" y="619"/>
                  </a:lnTo>
                  <a:lnTo>
                    <a:pt x="1884" y="605"/>
                  </a:lnTo>
                  <a:lnTo>
                    <a:pt x="1884" y="591"/>
                  </a:lnTo>
                  <a:lnTo>
                    <a:pt x="1870" y="578"/>
                  </a:lnTo>
                  <a:lnTo>
                    <a:pt x="1870" y="564"/>
                  </a:lnTo>
                  <a:lnTo>
                    <a:pt x="1856" y="550"/>
                  </a:lnTo>
                  <a:lnTo>
                    <a:pt x="1856" y="537"/>
                  </a:lnTo>
                  <a:lnTo>
                    <a:pt x="1843" y="509"/>
                  </a:lnTo>
                  <a:lnTo>
                    <a:pt x="1843" y="496"/>
                  </a:lnTo>
                  <a:lnTo>
                    <a:pt x="1829" y="481"/>
                  </a:lnTo>
                  <a:lnTo>
                    <a:pt x="1815" y="468"/>
                  </a:lnTo>
                  <a:lnTo>
                    <a:pt x="1815" y="454"/>
                  </a:lnTo>
                  <a:lnTo>
                    <a:pt x="1802" y="440"/>
                  </a:lnTo>
                  <a:lnTo>
                    <a:pt x="1787" y="427"/>
                  </a:lnTo>
                  <a:lnTo>
                    <a:pt x="1787" y="412"/>
                  </a:lnTo>
                  <a:lnTo>
                    <a:pt x="1774" y="399"/>
                  </a:lnTo>
                  <a:lnTo>
                    <a:pt x="1761" y="386"/>
                  </a:lnTo>
                  <a:lnTo>
                    <a:pt x="1746" y="371"/>
                  </a:lnTo>
                  <a:lnTo>
                    <a:pt x="1746" y="358"/>
                  </a:lnTo>
                  <a:lnTo>
                    <a:pt x="1733" y="344"/>
                  </a:lnTo>
                  <a:lnTo>
                    <a:pt x="1719" y="330"/>
                  </a:lnTo>
                  <a:lnTo>
                    <a:pt x="1705" y="317"/>
                  </a:lnTo>
                  <a:lnTo>
                    <a:pt x="1692" y="302"/>
                  </a:lnTo>
                  <a:lnTo>
                    <a:pt x="1677" y="289"/>
                  </a:lnTo>
                  <a:lnTo>
                    <a:pt x="1677" y="276"/>
                  </a:lnTo>
                  <a:lnTo>
                    <a:pt x="1664" y="276"/>
                  </a:lnTo>
                  <a:lnTo>
                    <a:pt x="1651" y="261"/>
                  </a:lnTo>
                  <a:lnTo>
                    <a:pt x="1636" y="248"/>
                  </a:lnTo>
                  <a:lnTo>
                    <a:pt x="1623" y="234"/>
                  </a:lnTo>
                  <a:lnTo>
                    <a:pt x="1609" y="220"/>
                  </a:lnTo>
                  <a:lnTo>
                    <a:pt x="1595" y="207"/>
                  </a:lnTo>
                  <a:lnTo>
                    <a:pt x="1582" y="207"/>
                  </a:lnTo>
                  <a:lnTo>
                    <a:pt x="1567" y="192"/>
                  </a:lnTo>
                  <a:lnTo>
                    <a:pt x="1554" y="179"/>
                  </a:lnTo>
                  <a:lnTo>
                    <a:pt x="1541" y="166"/>
                  </a:lnTo>
                  <a:lnTo>
                    <a:pt x="1526" y="166"/>
                  </a:lnTo>
                  <a:lnTo>
                    <a:pt x="1513" y="151"/>
                  </a:lnTo>
                  <a:lnTo>
                    <a:pt x="1499" y="138"/>
                  </a:lnTo>
                  <a:lnTo>
                    <a:pt x="1485" y="138"/>
                  </a:lnTo>
                  <a:lnTo>
                    <a:pt x="1472" y="124"/>
                  </a:lnTo>
                  <a:lnTo>
                    <a:pt x="1457" y="110"/>
                  </a:lnTo>
                  <a:lnTo>
                    <a:pt x="1444" y="110"/>
                  </a:lnTo>
                  <a:lnTo>
                    <a:pt x="1416" y="97"/>
                  </a:lnTo>
                  <a:lnTo>
                    <a:pt x="1403" y="97"/>
                  </a:lnTo>
                  <a:lnTo>
                    <a:pt x="1389" y="83"/>
                  </a:lnTo>
                  <a:lnTo>
                    <a:pt x="1375" y="83"/>
                  </a:lnTo>
                  <a:lnTo>
                    <a:pt x="1362" y="69"/>
                  </a:lnTo>
                  <a:lnTo>
                    <a:pt x="1348" y="69"/>
                  </a:lnTo>
                  <a:lnTo>
                    <a:pt x="1334" y="55"/>
                  </a:lnTo>
                  <a:lnTo>
                    <a:pt x="1306" y="55"/>
                  </a:lnTo>
                  <a:lnTo>
                    <a:pt x="1293" y="41"/>
                  </a:lnTo>
                  <a:lnTo>
                    <a:pt x="1279" y="41"/>
                  </a:lnTo>
                  <a:lnTo>
                    <a:pt x="1265" y="41"/>
                  </a:lnTo>
                  <a:lnTo>
                    <a:pt x="1251" y="28"/>
                  </a:lnTo>
                  <a:lnTo>
                    <a:pt x="1238" y="28"/>
                  </a:lnTo>
                  <a:lnTo>
                    <a:pt x="1210" y="28"/>
                  </a:lnTo>
                  <a:lnTo>
                    <a:pt x="1197" y="14"/>
                  </a:lnTo>
                  <a:lnTo>
                    <a:pt x="1183" y="14"/>
                  </a:lnTo>
                  <a:lnTo>
                    <a:pt x="1169" y="14"/>
                  </a:lnTo>
                  <a:lnTo>
                    <a:pt x="1141" y="14"/>
                  </a:lnTo>
                  <a:lnTo>
                    <a:pt x="1128" y="0"/>
                  </a:lnTo>
                  <a:lnTo>
                    <a:pt x="1114" y="0"/>
                  </a:lnTo>
                  <a:lnTo>
                    <a:pt x="1100" y="0"/>
                  </a:lnTo>
                  <a:lnTo>
                    <a:pt x="1072" y="0"/>
                  </a:lnTo>
                  <a:lnTo>
                    <a:pt x="1059" y="0"/>
                  </a:lnTo>
                  <a:lnTo>
                    <a:pt x="1046" y="0"/>
                  </a:lnTo>
                  <a:lnTo>
                    <a:pt x="1031" y="0"/>
                  </a:lnTo>
                  <a:lnTo>
                    <a:pt x="1004" y="0"/>
                  </a:lnTo>
                  <a:lnTo>
                    <a:pt x="990" y="0"/>
                  </a:lnTo>
                  <a:lnTo>
                    <a:pt x="977" y="0"/>
                  </a:lnTo>
                  <a:lnTo>
                    <a:pt x="962" y="0"/>
                  </a:lnTo>
                  <a:lnTo>
                    <a:pt x="949" y="0"/>
                  </a:lnTo>
                  <a:lnTo>
                    <a:pt x="921" y="0"/>
                  </a:lnTo>
                  <a:lnTo>
                    <a:pt x="908" y="0"/>
                  </a:lnTo>
                  <a:lnTo>
                    <a:pt x="894" y="0"/>
                  </a:lnTo>
                  <a:lnTo>
                    <a:pt x="880" y="0"/>
                  </a:lnTo>
                  <a:lnTo>
                    <a:pt x="852" y="0"/>
                  </a:lnTo>
                  <a:lnTo>
                    <a:pt x="839" y="0"/>
                  </a:lnTo>
                  <a:lnTo>
                    <a:pt x="826" y="0"/>
                  </a:lnTo>
                  <a:lnTo>
                    <a:pt x="811" y="14"/>
                  </a:lnTo>
                  <a:lnTo>
                    <a:pt x="784" y="14"/>
                  </a:lnTo>
                  <a:lnTo>
                    <a:pt x="770" y="14"/>
                  </a:lnTo>
                  <a:lnTo>
                    <a:pt x="757" y="14"/>
                  </a:lnTo>
                  <a:lnTo>
                    <a:pt x="743" y="28"/>
                  </a:lnTo>
                  <a:lnTo>
                    <a:pt x="715" y="28"/>
                  </a:lnTo>
                  <a:lnTo>
                    <a:pt x="701" y="28"/>
                  </a:lnTo>
                  <a:lnTo>
                    <a:pt x="688" y="41"/>
                  </a:lnTo>
                  <a:lnTo>
                    <a:pt x="674" y="41"/>
                  </a:lnTo>
                  <a:lnTo>
                    <a:pt x="660" y="41"/>
                  </a:lnTo>
                  <a:lnTo>
                    <a:pt x="647" y="55"/>
                  </a:lnTo>
                  <a:lnTo>
                    <a:pt x="619" y="55"/>
                  </a:lnTo>
                  <a:lnTo>
                    <a:pt x="605" y="69"/>
                  </a:lnTo>
                  <a:lnTo>
                    <a:pt x="591" y="69"/>
                  </a:lnTo>
                  <a:lnTo>
                    <a:pt x="578" y="83"/>
                  </a:lnTo>
                  <a:lnTo>
                    <a:pt x="564" y="83"/>
                  </a:lnTo>
                  <a:lnTo>
                    <a:pt x="550" y="97"/>
                  </a:lnTo>
                  <a:lnTo>
                    <a:pt x="536" y="97"/>
                  </a:lnTo>
                  <a:lnTo>
                    <a:pt x="509" y="110"/>
                  </a:lnTo>
                  <a:lnTo>
                    <a:pt x="495" y="110"/>
                  </a:lnTo>
                  <a:lnTo>
                    <a:pt x="482" y="124"/>
                  </a:lnTo>
                  <a:lnTo>
                    <a:pt x="468" y="138"/>
                  </a:lnTo>
                  <a:lnTo>
                    <a:pt x="454" y="138"/>
                  </a:lnTo>
                  <a:lnTo>
                    <a:pt x="440" y="151"/>
                  </a:lnTo>
                  <a:lnTo>
                    <a:pt x="426" y="166"/>
                  </a:lnTo>
                  <a:lnTo>
                    <a:pt x="413" y="166"/>
                  </a:lnTo>
                  <a:lnTo>
                    <a:pt x="399" y="179"/>
                  </a:lnTo>
                  <a:lnTo>
                    <a:pt x="385" y="192"/>
                  </a:lnTo>
                  <a:lnTo>
                    <a:pt x="372" y="207"/>
                  </a:lnTo>
                  <a:lnTo>
                    <a:pt x="357" y="207"/>
                  </a:lnTo>
                  <a:lnTo>
                    <a:pt x="344" y="220"/>
                  </a:lnTo>
                  <a:lnTo>
                    <a:pt x="331" y="234"/>
                  </a:lnTo>
                  <a:lnTo>
                    <a:pt x="316" y="248"/>
                  </a:lnTo>
                  <a:lnTo>
                    <a:pt x="303" y="261"/>
                  </a:lnTo>
                  <a:lnTo>
                    <a:pt x="289" y="276"/>
                  </a:lnTo>
                  <a:lnTo>
                    <a:pt x="275" y="276"/>
                  </a:lnTo>
                  <a:lnTo>
                    <a:pt x="275" y="289"/>
                  </a:lnTo>
                  <a:lnTo>
                    <a:pt x="262" y="302"/>
                  </a:lnTo>
                  <a:lnTo>
                    <a:pt x="247" y="317"/>
                  </a:lnTo>
                  <a:lnTo>
                    <a:pt x="234" y="330"/>
                  </a:lnTo>
                  <a:lnTo>
                    <a:pt x="221" y="344"/>
                  </a:lnTo>
                  <a:lnTo>
                    <a:pt x="206" y="358"/>
                  </a:lnTo>
                  <a:lnTo>
                    <a:pt x="206" y="371"/>
                  </a:lnTo>
                  <a:lnTo>
                    <a:pt x="193" y="386"/>
                  </a:lnTo>
                  <a:lnTo>
                    <a:pt x="179" y="399"/>
                  </a:lnTo>
                  <a:lnTo>
                    <a:pt x="165" y="412"/>
                  </a:lnTo>
                  <a:lnTo>
                    <a:pt x="165" y="427"/>
                  </a:lnTo>
                  <a:lnTo>
                    <a:pt x="152" y="440"/>
                  </a:lnTo>
                  <a:lnTo>
                    <a:pt x="137" y="454"/>
                  </a:lnTo>
                  <a:lnTo>
                    <a:pt x="137" y="468"/>
                  </a:lnTo>
                  <a:lnTo>
                    <a:pt x="124" y="481"/>
                  </a:lnTo>
                  <a:lnTo>
                    <a:pt x="111" y="496"/>
                  </a:lnTo>
                  <a:lnTo>
                    <a:pt x="111" y="509"/>
                  </a:lnTo>
                  <a:lnTo>
                    <a:pt x="96" y="537"/>
                  </a:lnTo>
                  <a:lnTo>
                    <a:pt x="96" y="550"/>
                  </a:lnTo>
                  <a:lnTo>
                    <a:pt x="83" y="564"/>
                  </a:lnTo>
                  <a:lnTo>
                    <a:pt x="83" y="578"/>
                  </a:lnTo>
                  <a:lnTo>
                    <a:pt x="69" y="591"/>
                  </a:lnTo>
                  <a:lnTo>
                    <a:pt x="69" y="605"/>
                  </a:lnTo>
                  <a:lnTo>
                    <a:pt x="55" y="619"/>
                  </a:lnTo>
                  <a:lnTo>
                    <a:pt x="55" y="647"/>
                  </a:lnTo>
                  <a:lnTo>
                    <a:pt x="42" y="660"/>
                  </a:lnTo>
                  <a:lnTo>
                    <a:pt x="42" y="674"/>
                  </a:lnTo>
                  <a:lnTo>
                    <a:pt x="42" y="688"/>
                  </a:lnTo>
                  <a:lnTo>
                    <a:pt x="28" y="702"/>
                  </a:lnTo>
                  <a:lnTo>
                    <a:pt x="28" y="715"/>
                  </a:lnTo>
                  <a:lnTo>
                    <a:pt x="28" y="743"/>
                  </a:lnTo>
                  <a:lnTo>
                    <a:pt x="14" y="756"/>
                  </a:lnTo>
                  <a:lnTo>
                    <a:pt x="14" y="770"/>
                  </a:lnTo>
                  <a:lnTo>
                    <a:pt x="14" y="784"/>
                  </a:lnTo>
                  <a:lnTo>
                    <a:pt x="14" y="812"/>
                  </a:lnTo>
                  <a:lnTo>
                    <a:pt x="0" y="825"/>
                  </a:lnTo>
                  <a:lnTo>
                    <a:pt x="0" y="839"/>
                  </a:lnTo>
                  <a:lnTo>
                    <a:pt x="0" y="853"/>
                  </a:lnTo>
                  <a:lnTo>
                    <a:pt x="0" y="881"/>
                  </a:lnTo>
                  <a:lnTo>
                    <a:pt x="0" y="894"/>
                  </a:lnTo>
                  <a:lnTo>
                    <a:pt x="0" y="907"/>
                  </a:lnTo>
                  <a:lnTo>
                    <a:pt x="0" y="922"/>
                  </a:lnTo>
                  <a:lnTo>
                    <a:pt x="0" y="949"/>
                  </a:lnTo>
                  <a:lnTo>
                    <a:pt x="0" y="963"/>
                  </a:lnTo>
                  <a:lnTo>
                    <a:pt x="0" y="976"/>
                  </a:lnTo>
                  <a:lnTo>
                    <a:pt x="0" y="991"/>
                  </a:lnTo>
                  <a:lnTo>
                    <a:pt x="0" y="1004"/>
                  </a:lnTo>
                  <a:lnTo>
                    <a:pt x="0" y="1032"/>
                  </a:lnTo>
                  <a:lnTo>
                    <a:pt x="0" y="1045"/>
                  </a:lnTo>
                  <a:lnTo>
                    <a:pt x="0" y="1059"/>
                  </a:lnTo>
                  <a:lnTo>
                    <a:pt x="0" y="1073"/>
                  </a:lnTo>
                  <a:lnTo>
                    <a:pt x="0" y="1101"/>
                  </a:lnTo>
                  <a:lnTo>
                    <a:pt x="0" y="1114"/>
                  </a:lnTo>
                  <a:lnTo>
                    <a:pt x="0" y="1127"/>
                  </a:lnTo>
                  <a:lnTo>
                    <a:pt x="14" y="1142"/>
                  </a:lnTo>
                  <a:lnTo>
                    <a:pt x="14" y="1169"/>
                  </a:lnTo>
                  <a:lnTo>
                    <a:pt x="14" y="1183"/>
                  </a:lnTo>
                  <a:lnTo>
                    <a:pt x="14" y="1196"/>
                  </a:lnTo>
                  <a:lnTo>
                    <a:pt x="28" y="1210"/>
                  </a:lnTo>
                  <a:lnTo>
                    <a:pt x="28" y="1238"/>
                  </a:lnTo>
                  <a:lnTo>
                    <a:pt x="28" y="1252"/>
                  </a:lnTo>
                  <a:lnTo>
                    <a:pt x="42" y="1265"/>
                  </a:lnTo>
                  <a:lnTo>
                    <a:pt x="42" y="1279"/>
                  </a:lnTo>
                  <a:lnTo>
                    <a:pt x="42" y="1293"/>
                  </a:lnTo>
                  <a:lnTo>
                    <a:pt x="55" y="1306"/>
                  </a:lnTo>
                  <a:lnTo>
                    <a:pt x="55" y="1334"/>
                  </a:lnTo>
                  <a:lnTo>
                    <a:pt x="69" y="1348"/>
                  </a:lnTo>
                  <a:lnTo>
                    <a:pt x="69" y="1362"/>
                  </a:lnTo>
                  <a:lnTo>
                    <a:pt x="83" y="1375"/>
                  </a:lnTo>
                  <a:lnTo>
                    <a:pt x="83" y="1389"/>
                  </a:lnTo>
                  <a:lnTo>
                    <a:pt x="96" y="1403"/>
                  </a:lnTo>
                  <a:lnTo>
                    <a:pt x="96" y="1417"/>
                  </a:lnTo>
                  <a:lnTo>
                    <a:pt x="111" y="1444"/>
                  </a:lnTo>
                  <a:lnTo>
                    <a:pt x="111" y="1458"/>
                  </a:lnTo>
                  <a:lnTo>
                    <a:pt x="124" y="1471"/>
                  </a:lnTo>
                  <a:lnTo>
                    <a:pt x="137" y="1485"/>
                  </a:lnTo>
                  <a:lnTo>
                    <a:pt x="137" y="1499"/>
                  </a:lnTo>
                  <a:lnTo>
                    <a:pt x="152" y="1513"/>
                  </a:lnTo>
                  <a:lnTo>
                    <a:pt x="165" y="1527"/>
                  </a:lnTo>
                  <a:lnTo>
                    <a:pt x="165" y="1540"/>
                  </a:lnTo>
                  <a:lnTo>
                    <a:pt x="179" y="1554"/>
                  </a:lnTo>
                  <a:lnTo>
                    <a:pt x="193" y="1568"/>
                  </a:lnTo>
                  <a:lnTo>
                    <a:pt x="206" y="1581"/>
                  </a:lnTo>
                  <a:lnTo>
                    <a:pt x="206" y="1596"/>
                  </a:lnTo>
                  <a:lnTo>
                    <a:pt x="221" y="1609"/>
                  </a:lnTo>
                  <a:lnTo>
                    <a:pt x="234" y="1622"/>
                  </a:lnTo>
                  <a:lnTo>
                    <a:pt x="247" y="1637"/>
                  </a:lnTo>
                  <a:lnTo>
                    <a:pt x="262" y="1650"/>
                  </a:lnTo>
                  <a:lnTo>
                    <a:pt x="275" y="1664"/>
                  </a:lnTo>
                  <a:lnTo>
                    <a:pt x="275" y="1678"/>
                  </a:lnTo>
                  <a:lnTo>
                    <a:pt x="289" y="1678"/>
                  </a:lnTo>
                  <a:lnTo>
                    <a:pt x="303" y="1691"/>
                  </a:lnTo>
                  <a:lnTo>
                    <a:pt x="316" y="1706"/>
                  </a:lnTo>
                  <a:lnTo>
                    <a:pt x="331" y="1719"/>
                  </a:lnTo>
                  <a:lnTo>
                    <a:pt x="344" y="1732"/>
                  </a:lnTo>
                  <a:lnTo>
                    <a:pt x="357" y="1747"/>
                  </a:lnTo>
                  <a:lnTo>
                    <a:pt x="372" y="1747"/>
                  </a:lnTo>
                  <a:lnTo>
                    <a:pt x="385" y="1760"/>
                  </a:lnTo>
                  <a:lnTo>
                    <a:pt x="399" y="1774"/>
                  </a:lnTo>
                  <a:lnTo>
                    <a:pt x="413" y="1788"/>
                  </a:lnTo>
                  <a:lnTo>
                    <a:pt x="426" y="1788"/>
                  </a:lnTo>
                  <a:lnTo>
                    <a:pt x="440" y="1801"/>
                  </a:lnTo>
                  <a:lnTo>
                    <a:pt x="454" y="1816"/>
                  </a:lnTo>
                  <a:lnTo>
                    <a:pt x="468" y="1816"/>
                  </a:lnTo>
                  <a:lnTo>
                    <a:pt x="482" y="1829"/>
                  </a:lnTo>
                  <a:lnTo>
                    <a:pt x="495" y="1842"/>
                  </a:lnTo>
                  <a:lnTo>
                    <a:pt x="509" y="1842"/>
                  </a:lnTo>
                  <a:lnTo>
                    <a:pt x="536" y="1857"/>
                  </a:lnTo>
                  <a:lnTo>
                    <a:pt x="550" y="1857"/>
                  </a:lnTo>
                  <a:lnTo>
                    <a:pt x="564" y="1870"/>
                  </a:lnTo>
                  <a:lnTo>
                    <a:pt x="578" y="1870"/>
                  </a:lnTo>
                  <a:lnTo>
                    <a:pt x="591" y="1884"/>
                  </a:lnTo>
                  <a:lnTo>
                    <a:pt x="605" y="1884"/>
                  </a:lnTo>
                  <a:lnTo>
                    <a:pt x="619" y="1898"/>
                  </a:lnTo>
                  <a:lnTo>
                    <a:pt x="647" y="1898"/>
                  </a:lnTo>
                  <a:lnTo>
                    <a:pt x="660" y="1911"/>
                  </a:lnTo>
                  <a:lnTo>
                    <a:pt x="674" y="1911"/>
                  </a:lnTo>
                  <a:lnTo>
                    <a:pt x="688" y="1911"/>
                  </a:lnTo>
                  <a:lnTo>
                    <a:pt x="701" y="1925"/>
                  </a:lnTo>
                  <a:lnTo>
                    <a:pt x="715" y="1925"/>
                  </a:lnTo>
                  <a:lnTo>
                    <a:pt x="743" y="1925"/>
                  </a:lnTo>
                  <a:lnTo>
                    <a:pt x="757" y="1939"/>
                  </a:lnTo>
                  <a:lnTo>
                    <a:pt x="770" y="1939"/>
                  </a:lnTo>
                  <a:lnTo>
                    <a:pt x="784" y="1939"/>
                  </a:lnTo>
                  <a:lnTo>
                    <a:pt x="811" y="1939"/>
                  </a:lnTo>
                  <a:lnTo>
                    <a:pt x="826" y="1953"/>
                  </a:lnTo>
                  <a:lnTo>
                    <a:pt x="839" y="1953"/>
                  </a:lnTo>
                  <a:lnTo>
                    <a:pt x="852" y="1953"/>
                  </a:lnTo>
                  <a:lnTo>
                    <a:pt x="880" y="1953"/>
                  </a:lnTo>
                  <a:lnTo>
                    <a:pt x="894" y="1953"/>
                  </a:lnTo>
                  <a:lnTo>
                    <a:pt x="908" y="1953"/>
                  </a:lnTo>
                  <a:lnTo>
                    <a:pt x="921" y="1953"/>
                  </a:lnTo>
                  <a:lnTo>
                    <a:pt x="949" y="1953"/>
                  </a:lnTo>
                  <a:lnTo>
                    <a:pt x="962" y="1953"/>
                  </a:lnTo>
                  <a:lnTo>
                    <a:pt x="977" y="1953"/>
                  </a:lnTo>
                  <a:lnTo>
                    <a:pt x="990" y="1953"/>
                  </a:lnTo>
                  <a:lnTo>
                    <a:pt x="1004" y="1953"/>
                  </a:lnTo>
                  <a:lnTo>
                    <a:pt x="1031" y="1953"/>
                  </a:lnTo>
                  <a:lnTo>
                    <a:pt x="1046" y="1953"/>
                  </a:lnTo>
                  <a:lnTo>
                    <a:pt x="1059" y="1953"/>
                  </a:lnTo>
                  <a:lnTo>
                    <a:pt x="1072" y="1953"/>
                  </a:lnTo>
                  <a:lnTo>
                    <a:pt x="1100" y="1953"/>
                  </a:lnTo>
                  <a:lnTo>
                    <a:pt x="1114" y="1953"/>
                  </a:lnTo>
                  <a:lnTo>
                    <a:pt x="1128" y="1953"/>
                  </a:lnTo>
                  <a:lnTo>
                    <a:pt x="1141" y="1939"/>
                  </a:lnTo>
                  <a:lnTo>
                    <a:pt x="1169" y="1939"/>
                  </a:lnTo>
                  <a:lnTo>
                    <a:pt x="1183" y="1939"/>
                  </a:lnTo>
                  <a:lnTo>
                    <a:pt x="1197" y="1939"/>
                  </a:lnTo>
                  <a:lnTo>
                    <a:pt x="1210" y="1925"/>
                  </a:lnTo>
                  <a:lnTo>
                    <a:pt x="1238" y="1925"/>
                  </a:lnTo>
                  <a:lnTo>
                    <a:pt x="1251" y="1925"/>
                  </a:lnTo>
                  <a:lnTo>
                    <a:pt x="1265" y="1911"/>
                  </a:lnTo>
                  <a:lnTo>
                    <a:pt x="1279" y="1911"/>
                  </a:lnTo>
                  <a:lnTo>
                    <a:pt x="1293" y="1911"/>
                  </a:lnTo>
                  <a:lnTo>
                    <a:pt x="1306" y="1898"/>
                  </a:lnTo>
                  <a:lnTo>
                    <a:pt x="1334" y="1898"/>
                  </a:lnTo>
                  <a:lnTo>
                    <a:pt x="1348" y="1884"/>
                  </a:lnTo>
                  <a:lnTo>
                    <a:pt x="1362" y="1884"/>
                  </a:lnTo>
                  <a:lnTo>
                    <a:pt x="1375" y="1870"/>
                  </a:lnTo>
                  <a:lnTo>
                    <a:pt x="1389" y="1870"/>
                  </a:lnTo>
                  <a:lnTo>
                    <a:pt x="1403" y="1857"/>
                  </a:lnTo>
                  <a:lnTo>
                    <a:pt x="1416" y="1857"/>
                  </a:lnTo>
                  <a:lnTo>
                    <a:pt x="1444" y="1842"/>
                  </a:lnTo>
                  <a:lnTo>
                    <a:pt x="1457" y="1842"/>
                  </a:lnTo>
                  <a:lnTo>
                    <a:pt x="1472" y="1829"/>
                  </a:lnTo>
                  <a:lnTo>
                    <a:pt x="1485" y="1816"/>
                  </a:lnTo>
                  <a:lnTo>
                    <a:pt x="1499" y="1816"/>
                  </a:lnTo>
                  <a:lnTo>
                    <a:pt x="1513" y="1801"/>
                  </a:lnTo>
                  <a:lnTo>
                    <a:pt x="1526" y="1788"/>
                  </a:lnTo>
                  <a:lnTo>
                    <a:pt x="1541" y="1788"/>
                  </a:lnTo>
                  <a:lnTo>
                    <a:pt x="1554" y="1774"/>
                  </a:lnTo>
                  <a:lnTo>
                    <a:pt x="1567" y="1760"/>
                  </a:lnTo>
                  <a:lnTo>
                    <a:pt x="1582" y="1747"/>
                  </a:lnTo>
                  <a:lnTo>
                    <a:pt x="1595" y="1747"/>
                  </a:lnTo>
                  <a:lnTo>
                    <a:pt x="1609" y="1732"/>
                  </a:lnTo>
                  <a:lnTo>
                    <a:pt x="1623" y="1719"/>
                  </a:lnTo>
                  <a:lnTo>
                    <a:pt x="1636" y="1706"/>
                  </a:lnTo>
                  <a:lnTo>
                    <a:pt x="1651" y="1691"/>
                  </a:lnTo>
                  <a:lnTo>
                    <a:pt x="1664" y="1678"/>
                  </a:lnTo>
                  <a:lnTo>
                    <a:pt x="1677" y="1678"/>
                  </a:lnTo>
                  <a:lnTo>
                    <a:pt x="1677" y="1664"/>
                  </a:lnTo>
                  <a:lnTo>
                    <a:pt x="1692" y="1650"/>
                  </a:lnTo>
                  <a:lnTo>
                    <a:pt x="1705" y="1637"/>
                  </a:lnTo>
                  <a:lnTo>
                    <a:pt x="1719" y="1622"/>
                  </a:lnTo>
                  <a:lnTo>
                    <a:pt x="1733" y="1609"/>
                  </a:lnTo>
                  <a:lnTo>
                    <a:pt x="1746" y="1596"/>
                  </a:lnTo>
                  <a:lnTo>
                    <a:pt x="1746" y="1581"/>
                  </a:lnTo>
                  <a:lnTo>
                    <a:pt x="1761" y="1568"/>
                  </a:lnTo>
                  <a:lnTo>
                    <a:pt x="1774" y="1554"/>
                  </a:lnTo>
                  <a:lnTo>
                    <a:pt x="1787" y="1540"/>
                  </a:lnTo>
                  <a:lnTo>
                    <a:pt x="1787" y="1527"/>
                  </a:lnTo>
                  <a:lnTo>
                    <a:pt x="1802" y="1513"/>
                  </a:lnTo>
                  <a:lnTo>
                    <a:pt x="1815" y="1499"/>
                  </a:lnTo>
                  <a:lnTo>
                    <a:pt x="1815" y="1485"/>
                  </a:lnTo>
                  <a:lnTo>
                    <a:pt x="1829" y="1471"/>
                  </a:lnTo>
                  <a:lnTo>
                    <a:pt x="1843" y="1458"/>
                  </a:lnTo>
                  <a:lnTo>
                    <a:pt x="1843" y="1444"/>
                  </a:lnTo>
                  <a:lnTo>
                    <a:pt x="1856" y="1417"/>
                  </a:lnTo>
                  <a:lnTo>
                    <a:pt x="1856" y="1403"/>
                  </a:lnTo>
                  <a:lnTo>
                    <a:pt x="1870" y="1389"/>
                  </a:lnTo>
                  <a:lnTo>
                    <a:pt x="1870" y="1375"/>
                  </a:lnTo>
                  <a:lnTo>
                    <a:pt x="1884" y="1362"/>
                  </a:lnTo>
                  <a:lnTo>
                    <a:pt x="1884" y="1348"/>
                  </a:lnTo>
                  <a:lnTo>
                    <a:pt x="1898" y="1334"/>
                  </a:lnTo>
                  <a:lnTo>
                    <a:pt x="1898" y="1306"/>
                  </a:lnTo>
                  <a:lnTo>
                    <a:pt x="1912" y="1293"/>
                  </a:lnTo>
                  <a:lnTo>
                    <a:pt x="1912" y="1279"/>
                  </a:lnTo>
                  <a:lnTo>
                    <a:pt x="1912" y="1265"/>
                  </a:lnTo>
                  <a:lnTo>
                    <a:pt x="1925" y="1252"/>
                  </a:lnTo>
                  <a:lnTo>
                    <a:pt x="1925" y="1238"/>
                  </a:lnTo>
                  <a:lnTo>
                    <a:pt x="1925" y="1210"/>
                  </a:lnTo>
                  <a:lnTo>
                    <a:pt x="1939" y="1196"/>
                  </a:lnTo>
                  <a:lnTo>
                    <a:pt x="1939" y="1183"/>
                  </a:lnTo>
                  <a:lnTo>
                    <a:pt x="1939" y="1169"/>
                  </a:lnTo>
                  <a:lnTo>
                    <a:pt x="1939" y="1142"/>
                  </a:lnTo>
                  <a:lnTo>
                    <a:pt x="1953" y="1127"/>
                  </a:lnTo>
                  <a:lnTo>
                    <a:pt x="1953" y="1114"/>
                  </a:lnTo>
                  <a:lnTo>
                    <a:pt x="1953" y="1101"/>
                  </a:lnTo>
                  <a:lnTo>
                    <a:pt x="1953" y="1073"/>
                  </a:lnTo>
                  <a:lnTo>
                    <a:pt x="1953" y="1059"/>
                  </a:lnTo>
                  <a:lnTo>
                    <a:pt x="1953" y="1045"/>
                  </a:lnTo>
                  <a:lnTo>
                    <a:pt x="1953" y="1032"/>
                  </a:lnTo>
                  <a:lnTo>
                    <a:pt x="1953" y="1004"/>
                  </a:lnTo>
                  <a:lnTo>
                    <a:pt x="1953" y="991"/>
                  </a:lnTo>
                  <a:lnTo>
                    <a:pt x="1966" y="976"/>
                  </a:lnTo>
                  <a:close/>
                </a:path>
              </a:pathLst>
            </a:custGeom>
            <a:solidFill>
              <a:srgbClr val="ff33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1" name=""/>
            <p:cNvSpPr/>
            <p:nvPr/>
          </p:nvSpPr>
          <p:spPr>
            <a:xfrm>
              <a:off x="2940120" y="1702080"/>
              <a:ext cx="216360" cy="214200"/>
            </a:xfrm>
            <a:prstGeom prst="rect">
              <a:avLst/>
            </a:prstGeom>
            <a:noFill/>
            <a:ln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2" name=""/>
            <p:cNvSpPr/>
            <p:nvPr/>
          </p:nvSpPr>
          <p:spPr>
            <a:xfrm>
              <a:off x="2974680" y="1736280"/>
              <a:ext cx="145800" cy="145440"/>
            </a:xfrm>
            <a:custGeom>
              <a:avLst/>
              <a:gdLst/>
              <a:ahLst/>
              <a:rect l="l" t="t" r="r" b="b"/>
              <a:pathLst>
                <a:path w="2778" h="2763">
                  <a:moveTo>
                    <a:pt x="2778" y="1389"/>
                  </a:moveTo>
                  <a:lnTo>
                    <a:pt x="2763" y="1361"/>
                  </a:lnTo>
                  <a:lnTo>
                    <a:pt x="2763" y="1333"/>
                  </a:lnTo>
                  <a:lnTo>
                    <a:pt x="2763" y="1306"/>
                  </a:lnTo>
                  <a:lnTo>
                    <a:pt x="2763" y="1279"/>
                  </a:lnTo>
                  <a:lnTo>
                    <a:pt x="2763" y="1265"/>
                  </a:lnTo>
                  <a:lnTo>
                    <a:pt x="2763" y="1237"/>
                  </a:lnTo>
                  <a:lnTo>
                    <a:pt x="2763" y="1210"/>
                  </a:lnTo>
                  <a:lnTo>
                    <a:pt x="2763" y="1182"/>
                  </a:lnTo>
                  <a:lnTo>
                    <a:pt x="2750" y="1169"/>
                  </a:lnTo>
                  <a:lnTo>
                    <a:pt x="2750" y="1141"/>
                  </a:lnTo>
                  <a:lnTo>
                    <a:pt x="2750" y="1114"/>
                  </a:lnTo>
                  <a:lnTo>
                    <a:pt x="2735" y="1100"/>
                  </a:lnTo>
                  <a:lnTo>
                    <a:pt x="2735" y="1072"/>
                  </a:lnTo>
                  <a:lnTo>
                    <a:pt x="2722" y="1045"/>
                  </a:lnTo>
                  <a:lnTo>
                    <a:pt x="2722" y="1017"/>
                  </a:lnTo>
                  <a:lnTo>
                    <a:pt x="2722" y="1004"/>
                  </a:lnTo>
                  <a:lnTo>
                    <a:pt x="2709" y="976"/>
                  </a:lnTo>
                  <a:lnTo>
                    <a:pt x="2709" y="948"/>
                  </a:lnTo>
                  <a:lnTo>
                    <a:pt x="2694" y="935"/>
                  </a:lnTo>
                  <a:lnTo>
                    <a:pt x="2681" y="907"/>
                  </a:lnTo>
                  <a:lnTo>
                    <a:pt x="2681" y="879"/>
                  </a:lnTo>
                  <a:lnTo>
                    <a:pt x="2668" y="866"/>
                  </a:lnTo>
                  <a:lnTo>
                    <a:pt x="2653" y="838"/>
                  </a:lnTo>
                  <a:lnTo>
                    <a:pt x="2653" y="812"/>
                  </a:lnTo>
                  <a:lnTo>
                    <a:pt x="2640" y="797"/>
                  </a:lnTo>
                  <a:lnTo>
                    <a:pt x="2626" y="769"/>
                  </a:lnTo>
                  <a:lnTo>
                    <a:pt x="2612" y="756"/>
                  </a:lnTo>
                  <a:lnTo>
                    <a:pt x="2612" y="728"/>
                  </a:lnTo>
                  <a:lnTo>
                    <a:pt x="2599" y="715"/>
                  </a:lnTo>
                  <a:lnTo>
                    <a:pt x="2584" y="687"/>
                  </a:lnTo>
                  <a:lnTo>
                    <a:pt x="2571" y="659"/>
                  </a:lnTo>
                  <a:lnTo>
                    <a:pt x="2557" y="646"/>
                  </a:lnTo>
                  <a:lnTo>
                    <a:pt x="2543" y="618"/>
                  </a:lnTo>
                  <a:lnTo>
                    <a:pt x="2530" y="605"/>
                  </a:lnTo>
                  <a:lnTo>
                    <a:pt x="2516" y="591"/>
                  </a:lnTo>
                  <a:lnTo>
                    <a:pt x="2502" y="564"/>
                  </a:lnTo>
                  <a:lnTo>
                    <a:pt x="2489" y="550"/>
                  </a:lnTo>
                  <a:lnTo>
                    <a:pt x="2475" y="522"/>
                  </a:lnTo>
                  <a:lnTo>
                    <a:pt x="2461" y="508"/>
                  </a:lnTo>
                  <a:lnTo>
                    <a:pt x="2447" y="495"/>
                  </a:lnTo>
                  <a:lnTo>
                    <a:pt x="2433" y="467"/>
                  </a:lnTo>
                  <a:lnTo>
                    <a:pt x="2420" y="453"/>
                  </a:lnTo>
                  <a:lnTo>
                    <a:pt x="2392" y="440"/>
                  </a:lnTo>
                  <a:lnTo>
                    <a:pt x="2378" y="412"/>
                  </a:lnTo>
                  <a:lnTo>
                    <a:pt x="2365" y="399"/>
                  </a:lnTo>
                  <a:lnTo>
                    <a:pt x="2351" y="385"/>
                  </a:lnTo>
                  <a:lnTo>
                    <a:pt x="2324" y="371"/>
                  </a:lnTo>
                  <a:lnTo>
                    <a:pt x="2310" y="343"/>
                  </a:lnTo>
                  <a:lnTo>
                    <a:pt x="2296" y="330"/>
                  </a:lnTo>
                  <a:lnTo>
                    <a:pt x="2268" y="316"/>
                  </a:lnTo>
                  <a:lnTo>
                    <a:pt x="2255" y="302"/>
                  </a:lnTo>
                  <a:lnTo>
                    <a:pt x="2241" y="289"/>
                  </a:lnTo>
                  <a:lnTo>
                    <a:pt x="2214" y="274"/>
                  </a:lnTo>
                  <a:lnTo>
                    <a:pt x="2199" y="261"/>
                  </a:lnTo>
                  <a:lnTo>
                    <a:pt x="2173" y="248"/>
                  </a:lnTo>
                  <a:lnTo>
                    <a:pt x="2158" y="233"/>
                  </a:lnTo>
                  <a:lnTo>
                    <a:pt x="2145" y="220"/>
                  </a:lnTo>
                  <a:lnTo>
                    <a:pt x="2117" y="206"/>
                  </a:lnTo>
                  <a:lnTo>
                    <a:pt x="2104" y="192"/>
                  </a:lnTo>
                  <a:lnTo>
                    <a:pt x="2076" y="179"/>
                  </a:lnTo>
                  <a:lnTo>
                    <a:pt x="2048" y="164"/>
                  </a:lnTo>
                  <a:lnTo>
                    <a:pt x="2035" y="151"/>
                  </a:lnTo>
                  <a:lnTo>
                    <a:pt x="2007" y="151"/>
                  </a:lnTo>
                  <a:lnTo>
                    <a:pt x="1994" y="138"/>
                  </a:lnTo>
                  <a:lnTo>
                    <a:pt x="1966" y="123"/>
                  </a:lnTo>
                  <a:lnTo>
                    <a:pt x="1953" y="110"/>
                  </a:lnTo>
                  <a:lnTo>
                    <a:pt x="1925" y="110"/>
                  </a:lnTo>
                  <a:lnTo>
                    <a:pt x="1897" y="95"/>
                  </a:lnTo>
                  <a:lnTo>
                    <a:pt x="1884" y="82"/>
                  </a:lnTo>
                  <a:lnTo>
                    <a:pt x="1856" y="82"/>
                  </a:lnTo>
                  <a:lnTo>
                    <a:pt x="1828" y="69"/>
                  </a:lnTo>
                  <a:lnTo>
                    <a:pt x="1815" y="54"/>
                  </a:lnTo>
                  <a:lnTo>
                    <a:pt x="1787" y="54"/>
                  </a:lnTo>
                  <a:lnTo>
                    <a:pt x="1760" y="41"/>
                  </a:lnTo>
                  <a:lnTo>
                    <a:pt x="1746" y="41"/>
                  </a:lnTo>
                  <a:lnTo>
                    <a:pt x="1718" y="41"/>
                  </a:lnTo>
                  <a:lnTo>
                    <a:pt x="1691" y="28"/>
                  </a:lnTo>
                  <a:lnTo>
                    <a:pt x="1663" y="28"/>
                  </a:lnTo>
                  <a:lnTo>
                    <a:pt x="1650" y="13"/>
                  </a:lnTo>
                  <a:lnTo>
                    <a:pt x="1622" y="13"/>
                  </a:lnTo>
                  <a:lnTo>
                    <a:pt x="1595" y="13"/>
                  </a:lnTo>
                  <a:lnTo>
                    <a:pt x="1581" y="0"/>
                  </a:lnTo>
                  <a:lnTo>
                    <a:pt x="1553" y="0"/>
                  </a:lnTo>
                  <a:lnTo>
                    <a:pt x="1526" y="0"/>
                  </a:lnTo>
                  <a:lnTo>
                    <a:pt x="1499" y="0"/>
                  </a:lnTo>
                  <a:lnTo>
                    <a:pt x="1484" y="0"/>
                  </a:lnTo>
                  <a:lnTo>
                    <a:pt x="1458" y="0"/>
                  </a:lnTo>
                  <a:lnTo>
                    <a:pt x="1430" y="0"/>
                  </a:lnTo>
                  <a:lnTo>
                    <a:pt x="1402" y="0"/>
                  </a:lnTo>
                  <a:lnTo>
                    <a:pt x="1389" y="0"/>
                  </a:lnTo>
                  <a:lnTo>
                    <a:pt x="1361" y="0"/>
                  </a:lnTo>
                  <a:lnTo>
                    <a:pt x="1333" y="0"/>
                  </a:lnTo>
                  <a:lnTo>
                    <a:pt x="1306" y="0"/>
                  </a:lnTo>
                  <a:lnTo>
                    <a:pt x="1279" y="0"/>
                  </a:lnTo>
                  <a:lnTo>
                    <a:pt x="1264" y="0"/>
                  </a:lnTo>
                  <a:lnTo>
                    <a:pt x="1238" y="0"/>
                  </a:lnTo>
                  <a:lnTo>
                    <a:pt x="1210" y="0"/>
                  </a:lnTo>
                  <a:lnTo>
                    <a:pt x="1182" y="0"/>
                  </a:lnTo>
                  <a:lnTo>
                    <a:pt x="1169" y="13"/>
                  </a:lnTo>
                  <a:lnTo>
                    <a:pt x="1141" y="13"/>
                  </a:lnTo>
                  <a:lnTo>
                    <a:pt x="1113" y="13"/>
                  </a:lnTo>
                  <a:lnTo>
                    <a:pt x="1100" y="28"/>
                  </a:lnTo>
                  <a:lnTo>
                    <a:pt x="1072" y="28"/>
                  </a:lnTo>
                  <a:lnTo>
                    <a:pt x="1045" y="41"/>
                  </a:lnTo>
                  <a:lnTo>
                    <a:pt x="1017" y="41"/>
                  </a:lnTo>
                  <a:lnTo>
                    <a:pt x="1003" y="41"/>
                  </a:lnTo>
                  <a:lnTo>
                    <a:pt x="976" y="54"/>
                  </a:lnTo>
                  <a:lnTo>
                    <a:pt x="948" y="54"/>
                  </a:lnTo>
                  <a:lnTo>
                    <a:pt x="935" y="69"/>
                  </a:lnTo>
                  <a:lnTo>
                    <a:pt x="907" y="82"/>
                  </a:lnTo>
                  <a:lnTo>
                    <a:pt x="880" y="82"/>
                  </a:lnTo>
                  <a:lnTo>
                    <a:pt x="866" y="95"/>
                  </a:lnTo>
                  <a:lnTo>
                    <a:pt x="838" y="110"/>
                  </a:lnTo>
                  <a:lnTo>
                    <a:pt x="811" y="110"/>
                  </a:lnTo>
                  <a:lnTo>
                    <a:pt x="797" y="123"/>
                  </a:lnTo>
                  <a:lnTo>
                    <a:pt x="769" y="138"/>
                  </a:lnTo>
                  <a:lnTo>
                    <a:pt x="756" y="151"/>
                  </a:lnTo>
                  <a:lnTo>
                    <a:pt x="728" y="151"/>
                  </a:lnTo>
                  <a:lnTo>
                    <a:pt x="715" y="164"/>
                  </a:lnTo>
                  <a:lnTo>
                    <a:pt x="687" y="179"/>
                  </a:lnTo>
                  <a:lnTo>
                    <a:pt x="659" y="192"/>
                  </a:lnTo>
                  <a:lnTo>
                    <a:pt x="646" y="206"/>
                  </a:lnTo>
                  <a:lnTo>
                    <a:pt x="618" y="220"/>
                  </a:lnTo>
                  <a:lnTo>
                    <a:pt x="605" y="233"/>
                  </a:lnTo>
                  <a:lnTo>
                    <a:pt x="591" y="248"/>
                  </a:lnTo>
                  <a:lnTo>
                    <a:pt x="564" y="261"/>
                  </a:lnTo>
                  <a:lnTo>
                    <a:pt x="549" y="274"/>
                  </a:lnTo>
                  <a:lnTo>
                    <a:pt x="523" y="289"/>
                  </a:lnTo>
                  <a:lnTo>
                    <a:pt x="508" y="302"/>
                  </a:lnTo>
                  <a:lnTo>
                    <a:pt x="495" y="316"/>
                  </a:lnTo>
                  <a:lnTo>
                    <a:pt x="467" y="330"/>
                  </a:lnTo>
                  <a:lnTo>
                    <a:pt x="454" y="343"/>
                  </a:lnTo>
                  <a:lnTo>
                    <a:pt x="440" y="371"/>
                  </a:lnTo>
                  <a:lnTo>
                    <a:pt x="412" y="385"/>
                  </a:lnTo>
                  <a:lnTo>
                    <a:pt x="398" y="399"/>
                  </a:lnTo>
                  <a:lnTo>
                    <a:pt x="385" y="412"/>
                  </a:lnTo>
                  <a:lnTo>
                    <a:pt x="371" y="440"/>
                  </a:lnTo>
                  <a:lnTo>
                    <a:pt x="344" y="453"/>
                  </a:lnTo>
                  <a:lnTo>
                    <a:pt x="330" y="467"/>
                  </a:lnTo>
                  <a:lnTo>
                    <a:pt x="316" y="495"/>
                  </a:lnTo>
                  <a:lnTo>
                    <a:pt x="302" y="508"/>
                  </a:lnTo>
                  <a:lnTo>
                    <a:pt x="289" y="522"/>
                  </a:lnTo>
                  <a:lnTo>
                    <a:pt x="275" y="550"/>
                  </a:lnTo>
                  <a:lnTo>
                    <a:pt x="261" y="564"/>
                  </a:lnTo>
                  <a:lnTo>
                    <a:pt x="247" y="591"/>
                  </a:lnTo>
                  <a:lnTo>
                    <a:pt x="233" y="605"/>
                  </a:lnTo>
                  <a:lnTo>
                    <a:pt x="220" y="618"/>
                  </a:lnTo>
                  <a:lnTo>
                    <a:pt x="206" y="646"/>
                  </a:lnTo>
                  <a:lnTo>
                    <a:pt x="192" y="659"/>
                  </a:lnTo>
                  <a:lnTo>
                    <a:pt x="179" y="687"/>
                  </a:lnTo>
                  <a:lnTo>
                    <a:pt x="165" y="715"/>
                  </a:lnTo>
                  <a:lnTo>
                    <a:pt x="151" y="728"/>
                  </a:lnTo>
                  <a:lnTo>
                    <a:pt x="151" y="756"/>
                  </a:lnTo>
                  <a:lnTo>
                    <a:pt x="137" y="769"/>
                  </a:lnTo>
                  <a:lnTo>
                    <a:pt x="123" y="797"/>
                  </a:lnTo>
                  <a:lnTo>
                    <a:pt x="110" y="812"/>
                  </a:lnTo>
                  <a:lnTo>
                    <a:pt x="110" y="838"/>
                  </a:lnTo>
                  <a:lnTo>
                    <a:pt x="96" y="866"/>
                  </a:lnTo>
                  <a:lnTo>
                    <a:pt x="82" y="879"/>
                  </a:lnTo>
                  <a:lnTo>
                    <a:pt x="82" y="907"/>
                  </a:lnTo>
                  <a:lnTo>
                    <a:pt x="69" y="935"/>
                  </a:lnTo>
                  <a:lnTo>
                    <a:pt x="54" y="948"/>
                  </a:lnTo>
                  <a:lnTo>
                    <a:pt x="54" y="976"/>
                  </a:lnTo>
                  <a:lnTo>
                    <a:pt x="41" y="1004"/>
                  </a:lnTo>
                  <a:lnTo>
                    <a:pt x="41" y="1017"/>
                  </a:lnTo>
                  <a:lnTo>
                    <a:pt x="41" y="1045"/>
                  </a:lnTo>
                  <a:lnTo>
                    <a:pt x="28" y="1072"/>
                  </a:lnTo>
                  <a:lnTo>
                    <a:pt x="28" y="1100"/>
                  </a:lnTo>
                  <a:lnTo>
                    <a:pt x="13" y="1114"/>
                  </a:lnTo>
                  <a:lnTo>
                    <a:pt x="13" y="1141"/>
                  </a:lnTo>
                  <a:lnTo>
                    <a:pt x="13" y="1169"/>
                  </a:lnTo>
                  <a:lnTo>
                    <a:pt x="0" y="1182"/>
                  </a:lnTo>
                  <a:lnTo>
                    <a:pt x="0" y="1210"/>
                  </a:lnTo>
                  <a:lnTo>
                    <a:pt x="0" y="1237"/>
                  </a:lnTo>
                  <a:lnTo>
                    <a:pt x="0" y="1265"/>
                  </a:lnTo>
                  <a:lnTo>
                    <a:pt x="0" y="1279"/>
                  </a:lnTo>
                  <a:lnTo>
                    <a:pt x="0" y="1306"/>
                  </a:lnTo>
                  <a:lnTo>
                    <a:pt x="0" y="1333"/>
                  </a:lnTo>
                  <a:lnTo>
                    <a:pt x="0" y="1361"/>
                  </a:lnTo>
                  <a:lnTo>
                    <a:pt x="0" y="1374"/>
                  </a:lnTo>
                  <a:lnTo>
                    <a:pt x="0" y="1402"/>
                  </a:lnTo>
                  <a:lnTo>
                    <a:pt x="0" y="1430"/>
                  </a:lnTo>
                  <a:lnTo>
                    <a:pt x="0" y="1458"/>
                  </a:lnTo>
                  <a:lnTo>
                    <a:pt x="0" y="1484"/>
                  </a:lnTo>
                  <a:lnTo>
                    <a:pt x="0" y="1499"/>
                  </a:lnTo>
                  <a:lnTo>
                    <a:pt x="0" y="1527"/>
                  </a:lnTo>
                  <a:lnTo>
                    <a:pt x="0" y="1553"/>
                  </a:lnTo>
                  <a:lnTo>
                    <a:pt x="0" y="1581"/>
                  </a:lnTo>
                  <a:lnTo>
                    <a:pt x="13" y="1594"/>
                  </a:lnTo>
                  <a:lnTo>
                    <a:pt x="13" y="1622"/>
                  </a:lnTo>
                  <a:lnTo>
                    <a:pt x="13" y="1650"/>
                  </a:lnTo>
                  <a:lnTo>
                    <a:pt x="28" y="1663"/>
                  </a:lnTo>
                  <a:lnTo>
                    <a:pt x="28" y="1691"/>
                  </a:lnTo>
                  <a:lnTo>
                    <a:pt x="41" y="1719"/>
                  </a:lnTo>
                  <a:lnTo>
                    <a:pt x="41" y="1746"/>
                  </a:lnTo>
                  <a:lnTo>
                    <a:pt x="41" y="1760"/>
                  </a:lnTo>
                  <a:lnTo>
                    <a:pt x="54" y="1787"/>
                  </a:lnTo>
                  <a:lnTo>
                    <a:pt x="54" y="1815"/>
                  </a:lnTo>
                  <a:lnTo>
                    <a:pt x="69" y="1829"/>
                  </a:lnTo>
                  <a:lnTo>
                    <a:pt x="82" y="1856"/>
                  </a:lnTo>
                  <a:lnTo>
                    <a:pt x="82" y="1884"/>
                  </a:lnTo>
                  <a:lnTo>
                    <a:pt x="96" y="1897"/>
                  </a:lnTo>
                  <a:lnTo>
                    <a:pt x="110" y="1925"/>
                  </a:lnTo>
                  <a:lnTo>
                    <a:pt x="110" y="1952"/>
                  </a:lnTo>
                  <a:lnTo>
                    <a:pt x="123" y="1966"/>
                  </a:lnTo>
                  <a:lnTo>
                    <a:pt x="137" y="1994"/>
                  </a:lnTo>
                  <a:lnTo>
                    <a:pt x="151" y="2007"/>
                  </a:lnTo>
                  <a:lnTo>
                    <a:pt x="151" y="2035"/>
                  </a:lnTo>
                  <a:lnTo>
                    <a:pt x="165" y="2048"/>
                  </a:lnTo>
                  <a:lnTo>
                    <a:pt x="179" y="2076"/>
                  </a:lnTo>
                  <a:lnTo>
                    <a:pt x="192" y="2104"/>
                  </a:lnTo>
                  <a:lnTo>
                    <a:pt x="206" y="2117"/>
                  </a:lnTo>
                  <a:lnTo>
                    <a:pt x="220" y="2145"/>
                  </a:lnTo>
                  <a:lnTo>
                    <a:pt x="233" y="2158"/>
                  </a:lnTo>
                  <a:lnTo>
                    <a:pt x="247" y="2173"/>
                  </a:lnTo>
                  <a:lnTo>
                    <a:pt x="261" y="2199"/>
                  </a:lnTo>
                  <a:lnTo>
                    <a:pt x="275" y="2214"/>
                  </a:lnTo>
                  <a:lnTo>
                    <a:pt x="289" y="2241"/>
                  </a:lnTo>
                  <a:lnTo>
                    <a:pt x="302" y="2255"/>
                  </a:lnTo>
                  <a:lnTo>
                    <a:pt x="316" y="2268"/>
                  </a:lnTo>
                  <a:lnTo>
                    <a:pt x="330" y="2296"/>
                  </a:lnTo>
                  <a:lnTo>
                    <a:pt x="344" y="2309"/>
                  </a:lnTo>
                  <a:lnTo>
                    <a:pt x="371" y="2324"/>
                  </a:lnTo>
                  <a:lnTo>
                    <a:pt x="385" y="2351"/>
                  </a:lnTo>
                  <a:lnTo>
                    <a:pt x="398" y="2365"/>
                  </a:lnTo>
                  <a:lnTo>
                    <a:pt x="412" y="2378"/>
                  </a:lnTo>
                  <a:lnTo>
                    <a:pt x="440" y="2393"/>
                  </a:lnTo>
                  <a:lnTo>
                    <a:pt x="454" y="2420"/>
                  </a:lnTo>
                  <a:lnTo>
                    <a:pt x="467" y="2434"/>
                  </a:lnTo>
                  <a:lnTo>
                    <a:pt x="495" y="2447"/>
                  </a:lnTo>
                  <a:lnTo>
                    <a:pt x="508" y="2461"/>
                  </a:lnTo>
                  <a:lnTo>
                    <a:pt x="523" y="2475"/>
                  </a:lnTo>
                  <a:lnTo>
                    <a:pt x="549" y="2488"/>
                  </a:lnTo>
                  <a:lnTo>
                    <a:pt x="564" y="2502"/>
                  </a:lnTo>
                  <a:lnTo>
                    <a:pt x="591" y="2516"/>
                  </a:lnTo>
                  <a:lnTo>
                    <a:pt x="605" y="2530"/>
                  </a:lnTo>
                  <a:lnTo>
                    <a:pt x="618" y="2544"/>
                  </a:lnTo>
                  <a:lnTo>
                    <a:pt x="646" y="2557"/>
                  </a:lnTo>
                  <a:lnTo>
                    <a:pt x="659" y="2571"/>
                  </a:lnTo>
                  <a:lnTo>
                    <a:pt x="687" y="2585"/>
                  </a:lnTo>
                  <a:lnTo>
                    <a:pt x="715" y="2599"/>
                  </a:lnTo>
                  <a:lnTo>
                    <a:pt x="728" y="2612"/>
                  </a:lnTo>
                  <a:lnTo>
                    <a:pt x="756" y="2612"/>
                  </a:lnTo>
                  <a:lnTo>
                    <a:pt x="769" y="2626"/>
                  </a:lnTo>
                  <a:lnTo>
                    <a:pt x="797" y="2640"/>
                  </a:lnTo>
                  <a:lnTo>
                    <a:pt x="811" y="2653"/>
                  </a:lnTo>
                  <a:lnTo>
                    <a:pt x="838" y="2653"/>
                  </a:lnTo>
                  <a:lnTo>
                    <a:pt x="866" y="2667"/>
                  </a:lnTo>
                  <a:lnTo>
                    <a:pt x="880" y="2681"/>
                  </a:lnTo>
                  <a:lnTo>
                    <a:pt x="907" y="2681"/>
                  </a:lnTo>
                  <a:lnTo>
                    <a:pt x="935" y="2695"/>
                  </a:lnTo>
                  <a:lnTo>
                    <a:pt x="948" y="2709"/>
                  </a:lnTo>
                  <a:lnTo>
                    <a:pt x="976" y="2709"/>
                  </a:lnTo>
                  <a:lnTo>
                    <a:pt x="1003" y="2722"/>
                  </a:lnTo>
                  <a:lnTo>
                    <a:pt x="1017" y="2722"/>
                  </a:lnTo>
                  <a:lnTo>
                    <a:pt x="1045" y="2722"/>
                  </a:lnTo>
                  <a:lnTo>
                    <a:pt x="1072" y="2736"/>
                  </a:lnTo>
                  <a:lnTo>
                    <a:pt x="1100" y="2736"/>
                  </a:lnTo>
                  <a:lnTo>
                    <a:pt x="1113" y="2750"/>
                  </a:lnTo>
                  <a:lnTo>
                    <a:pt x="1141" y="2750"/>
                  </a:lnTo>
                  <a:lnTo>
                    <a:pt x="1169" y="2750"/>
                  </a:lnTo>
                  <a:lnTo>
                    <a:pt x="1182" y="2763"/>
                  </a:lnTo>
                  <a:lnTo>
                    <a:pt x="1210" y="2763"/>
                  </a:lnTo>
                  <a:lnTo>
                    <a:pt x="1238" y="2763"/>
                  </a:lnTo>
                  <a:lnTo>
                    <a:pt x="1264" y="2763"/>
                  </a:lnTo>
                  <a:lnTo>
                    <a:pt x="1279" y="2763"/>
                  </a:lnTo>
                  <a:lnTo>
                    <a:pt x="1306" y="2763"/>
                  </a:lnTo>
                  <a:lnTo>
                    <a:pt x="1333" y="2763"/>
                  </a:lnTo>
                  <a:lnTo>
                    <a:pt x="1361" y="2763"/>
                  </a:lnTo>
                  <a:lnTo>
                    <a:pt x="1374" y="2763"/>
                  </a:lnTo>
                  <a:lnTo>
                    <a:pt x="1402" y="2763"/>
                  </a:lnTo>
                  <a:lnTo>
                    <a:pt x="1430" y="2763"/>
                  </a:lnTo>
                  <a:lnTo>
                    <a:pt x="1458" y="2763"/>
                  </a:lnTo>
                  <a:lnTo>
                    <a:pt x="1484" y="2763"/>
                  </a:lnTo>
                  <a:lnTo>
                    <a:pt x="1499" y="2763"/>
                  </a:lnTo>
                  <a:lnTo>
                    <a:pt x="1526" y="2763"/>
                  </a:lnTo>
                  <a:lnTo>
                    <a:pt x="1553" y="2763"/>
                  </a:lnTo>
                  <a:lnTo>
                    <a:pt x="1581" y="2763"/>
                  </a:lnTo>
                  <a:lnTo>
                    <a:pt x="1595" y="2750"/>
                  </a:lnTo>
                  <a:lnTo>
                    <a:pt x="1622" y="2750"/>
                  </a:lnTo>
                  <a:lnTo>
                    <a:pt x="1650" y="2750"/>
                  </a:lnTo>
                  <a:lnTo>
                    <a:pt x="1663" y="2736"/>
                  </a:lnTo>
                  <a:lnTo>
                    <a:pt x="1691" y="2736"/>
                  </a:lnTo>
                  <a:lnTo>
                    <a:pt x="1718" y="2722"/>
                  </a:lnTo>
                  <a:lnTo>
                    <a:pt x="1746" y="2722"/>
                  </a:lnTo>
                  <a:lnTo>
                    <a:pt x="1760" y="2722"/>
                  </a:lnTo>
                  <a:lnTo>
                    <a:pt x="1787" y="2709"/>
                  </a:lnTo>
                  <a:lnTo>
                    <a:pt x="1815" y="2709"/>
                  </a:lnTo>
                  <a:lnTo>
                    <a:pt x="1828" y="2695"/>
                  </a:lnTo>
                  <a:lnTo>
                    <a:pt x="1856" y="2681"/>
                  </a:lnTo>
                  <a:lnTo>
                    <a:pt x="1884" y="2681"/>
                  </a:lnTo>
                  <a:lnTo>
                    <a:pt x="1897" y="2667"/>
                  </a:lnTo>
                  <a:lnTo>
                    <a:pt x="1925" y="2653"/>
                  </a:lnTo>
                  <a:lnTo>
                    <a:pt x="1953" y="2653"/>
                  </a:lnTo>
                  <a:lnTo>
                    <a:pt x="1966" y="2640"/>
                  </a:lnTo>
                  <a:lnTo>
                    <a:pt x="1994" y="2626"/>
                  </a:lnTo>
                  <a:lnTo>
                    <a:pt x="2007" y="2612"/>
                  </a:lnTo>
                  <a:lnTo>
                    <a:pt x="2035" y="2612"/>
                  </a:lnTo>
                  <a:lnTo>
                    <a:pt x="2048" y="2599"/>
                  </a:lnTo>
                  <a:lnTo>
                    <a:pt x="2076" y="2585"/>
                  </a:lnTo>
                  <a:lnTo>
                    <a:pt x="2104" y="2571"/>
                  </a:lnTo>
                  <a:lnTo>
                    <a:pt x="2117" y="2557"/>
                  </a:lnTo>
                  <a:lnTo>
                    <a:pt x="2145" y="2544"/>
                  </a:lnTo>
                  <a:lnTo>
                    <a:pt x="2158" y="2530"/>
                  </a:lnTo>
                  <a:lnTo>
                    <a:pt x="2173" y="2516"/>
                  </a:lnTo>
                  <a:lnTo>
                    <a:pt x="2199" y="2502"/>
                  </a:lnTo>
                  <a:lnTo>
                    <a:pt x="2214" y="2488"/>
                  </a:lnTo>
                  <a:lnTo>
                    <a:pt x="2241" y="2475"/>
                  </a:lnTo>
                  <a:lnTo>
                    <a:pt x="2255" y="2461"/>
                  </a:lnTo>
                  <a:lnTo>
                    <a:pt x="2268" y="2447"/>
                  </a:lnTo>
                  <a:lnTo>
                    <a:pt x="2296" y="2434"/>
                  </a:lnTo>
                  <a:lnTo>
                    <a:pt x="2310" y="2420"/>
                  </a:lnTo>
                  <a:lnTo>
                    <a:pt x="2324" y="2393"/>
                  </a:lnTo>
                  <a:lnTo>
                    <a:pt x="2351" y="2378"/>
                  </a:lnTo>
                  <a:lnTo>
                    <a:pt x="2365" y="2365"/>
                  </a:lnTo>
                  <a:lnTo>
                    <a:pt x="2378" y="2351"/>
                  </a:lnTo>
                  <a:lnTo>
                    <a:pt x="2392" y="2324"/>
                  </a:lnTo>
                  <a:lnTo>
                    <a:pt x="2420" y="2309"/>
                  </a:lnTo>
                  <a:lnTo>
                    <a:pt x="2433" y="2296"/>
                  </a:lnTo>
                  <a:lnTo>
                    <a:pt x="2447" y="2268"/>
                  </a:lnTo>
                  <a:lnTo>
                    <a:pt x="2461" y="2255"/>
                  </a:lnTo>
                  <a:lnTo>
                    <a:pt x="2475" y="2241"/>
                  </a:lnTo>
                  <a:lnTo>
                    <a:pt x="2489" y="2214"/>
                  </a:lnTo>
                  <a:lnTo>
                    <a:pt x="2502" y="2199"/>
                  </a:lnTo>
                  <a:lnTo>
                    <a:pt x="2516" y="2173"/>
                  </a:lnTo>
                  <a:lnTo>
                    <a:pt x="2530" y="2158"/>
                  </a:lnTo>
                  <a:lnTo>
                    <a:pt x="2543" y="2145"/>
                  </a:lnTo>
                  <a:lnTo>
                    <a:pt x="2557" y="2117"/>
                  </a:lnTo>
                  <a:lnTo>
                    <a:pt x="2571" y="2104"/>
                  </a:lnTo>
                  <a:lnTo>
                    <a:pt x="2584" y="2076"/>
                  </a:lnTo>
                  <a:lnTo>
                    <a:pt x="2599" y="2048"/>
                  </a:lnTo>
                  <a:lnTo>
                    <a:pt x="2612" y="2035"/>
                  </a:lnTo>
                  <a:lnTo>
                    <a:pt x="2612" y="2007"/>
                  </a:lnTo>
                  <a:lnTo>
                    <a:pt x="2626" y="1994"/>
                  </a:lnTo>
                  <a:lnTo>
                    <a:pt x="2640" y="1966"/>
                  </a:lnTo>
                  <a:lnTo>
                    <a:pt x="2653" y="1952"/>
                  </a:lnTo>
                  <a:lnTo>
                    <a:pt x="2653" y="1925"/>
                  </a:lnTo>
                  <a:lnTo>
                    <a:pt x="2668" y="1897"/>
                  </a:lnTo>
                  <a:lnTo>
                    <a:pt x="2681" y="1884"/>
                  </a:lnTo>
                  <a:lnTo>
                    <a:pt x="2681" y="1856"/>
                  </a:lnTo>
                  <a:lnTo>
                    <a:pt x="2694" y="1829"/>
                  </a:lnTo>
                  <a:lnTo>
                    <a:pt x="2709" y="1815"/>
                  </a:lnTo>
                  <a:lnTo>
                    <a:pt x="2709" y="1787"/>
                  </a:lnTo>
                  <a:lnTo>
                    <a:pt x="2722" y="1760"/>
                  </a:lnTo>
                  <a:lnTo>
                    <a:pt x="2722" y="1746"/>
                  </a:lnTo>
                  <a:lnTo>
                    <a:pt x="2722" y="1719"/>
                  </a:lnTo>
                  <a:lnTo>
                    <a:pt x="2735" y="1691"/>
                  </a:lnTo>
                  <a:lnTo>
                    <a:pt x="2735" y="1663"/>
                  </a:lnTo>
                  <a:lnTo>
                    <a:pt x="2750" y="1650"/>
                  </a:lnTo>
                  <a:lnTo>
                    <a:pt x="2750" y="1622"/>
                  </a:lnTo>
                  <a:lnTo>
                    <a:pt x="2750" y="1594"/>
                  </a:lnTo>
                  <a:lnTo>
                    <a:pt x="2763" y="1581"/>
                  </a:lnTo>
                  <a:lnTo>
                    <a:pt x="2763" y="1553"/>
                  </a:lnTo>
                  <a:lnTo>
                    <a:pt x="2763" y="1527"/>
                  </a:lnTo>
                  <a:lnTo>
                    <a:pt x="2763" y="1499"/>
                  </a:lnTo>
                  <a:lnTo>
                    <a:pt x="2763" y="1484"/>
                  </a:lnTo>
                  <a:lnTo>
                    <a:pt x="2763" y="1458"/>
                  </a:lnTo>
                  <a:lnTo>
                    <a:pt x="2763" y="1430"/>
                  </a:lnTo>
                  <a:lnTo>
                    <a:pt x="2763" y="1402"/>
                  </a:lnTo>
                  <a:lnTo>
                    <a:pt x="2778" y="1389"/>
                  </a:lnTo>
                  <a:close/>
                </a:path>
              </a:pathLst>
            </a:custGeom>
            <a:solidFill>
              <a:srgbClr val="ff33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3" name=""/>
            <p:cNvSpPr/>
            <p:nvPr/>
          </p:nvSpPr>
          <p:spPr>
            <a:xfrm>
              <a:off x="3156480" y="1058760"/>
              <a:ext cx="214560" cy="213840"/>
            </a:xfrm>
            <a:prstGeom prst="rect">
              <a:avLst/>
            </a:prstGeom>
            <a:noFill/>
            <a:ln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4" name=""/>
            <p:cNvSpPr/>
            <p:nvPr/>
          </p:nvSpPr>
          <p:spPr>
            <a:xfrm>
              <a:off x="3162600" y="1064880"/>
              <a:ext cx="200880" cy="199800"/>
            </a:xfrm>
            <a:custGeom>
              <a:avLst/>
              <a:gdLst/>
              <a:ahLst/>
              <a:rect l="l" t="t" r="r" b="b"/>
              <a:pathLst>
                <a:path w="3863" h="3850">
                  <a:moveTo>
                    <a:pt x="3863" y="1925"/>
                  </a:moveTo>
                  <a:lnTo>
                    <a:pt x="3850" y="1897"/>
                  </a:lnTo>
                  <a:lnTo>
                    <a:pt x="3850" y="1856"/>
                  </a:lnTo>
                  <a:lnTo>
                    <a:pt x="3850" y="1828"/>
                  </a:lnTo>
                  <a:lnTo>
                    <a:pt x="3850" y="1787"/>
                  </a:lnTo>
                  <a:lnTo>
                    <a:pt x="3850" y="1759"/>
                  </a:lnTo>
                  <a:lnTo>
                    <a:pt x="3850" y="1718"/>
                  </a:lnTo>
                  <a:lnTo>
                    <a:pt x="3836" y="1691"/>
                  </a:lnTo>
                  <a:lnTo>
                    <a:pt x="3836" y="1649"/>
                  </a:lnTo>
                  <a:lnTo>
                    <a:pt x="3836" y="1622"/>
                  </a:lnTo>
                  <a:lnTo>
                    <a:pt x="3822" y="1595"/>
                  </a:lnTo>
                  <a:lnTo>
                    <a:pt x="3822" y="1554"/>
                  </a:lnTo>
                  <a:lnTo>
                    <a:pt x="3809" y="1526"/>
                  </a:lnTo>
                  <a:lnTo>
                    <a:pt x="3809" y="1485"/>
                  </a:lnTo>
                  <a:lnTo>
                    <a:pt x="3795" y="1457"/>
                  </a:lnTo>
                  <a:lnTo>
                    <a:pt x="3795" y="1430"/>
                  </a:lnTo>
                  <a:lnTo>
                    <a:pt x="3781" y="1389"/>
                  </a:lnTo>
                  <a:lnTo>
                    <a:pt x="3767" y="1361"/>
                  </a:lnTo>
                  <a:lnTo>
                    <a:pt x="3767" y="1333"/>
                  </a:lnTo>
                  <a:lnTo>
                    <a:pt x="3753" y="1292"/>
                  </a:lnTo>
                  <a:lnTo>
                    <a:pt x="3740" y="1264"/>
                  </a:lnTo>
                  <a:lnTo>
                    <a:pt x="3726" y="1238"/>
                  </a:lnTo>
                  <a:lnTo>
                    <a:pt x="3712" y="1196"/>
                  </a:lnTo>
                  <a:lnTo>
                    <a:pt x="3698" y="1169"/>
                  </a:lnTo>
                  <a:lnTo>
                    <a:pt x="3685" y="1141"/>
                  </a:lnTo>
                  <a:lnTo>
                    <a:pt x="3671" y="1113"/>
                  </a:lnTo>
                  <a:lnTo>
                    <a:pt x="3657" y="1072"/>
                  </a:lnTo>
                  <a:lnTo>
                    <a:pt x="3644" y="1044"/>
                  </a:lnTo>
                  <a:lnTo>
                    <a:pt x="3630" y="1018"/>
                  </a:lnTo>
                  <a:lnTo>
                    <a:pt x="3616" y="990"/>
                  </a:lnTo>
                  <a:lnTo>
                    <a:pt x="3602" y="962"/>
                  </a:lnTo>
                  <a:lnTo>
                    <a:pt x="3575" y="934"/>
                  </a:lnTo>
                  <a:lnTo>
                    <a:pt x="3561" y="907"/>
                  </a:lnTo>
                  <a:lnTo>
                    <a:pt x="3547" y="866"/>
                  </a:lnTo>
                  <a:lnTo>
                    <a:pt x="3519" y="839"/>
                  </a:lnTo>
                  <a:lnTo>
                    <a:pt x="3506" y="811"/>
                  </a:lnTo>
                  <a:lnTo>
                    <a:pt x="3493" y="783"/>
                  </a:lnTo>
                  <a:lnTo>
                    <a:pt x="3465" y="756"/>
                  </a:lnTo>
                  <a:lnTo>
                    <a:pt x="3451" y="728"/>
                  </a:lnTo>
                  <a:lnTo>
                    <a:pt x="3424" y="715"/>
                  </a:lnTo>
                  <a:lnTo>
                    <a:pt x="3409" y="687"/>
                  </a:lnTo>
                  <a:lnTo>
                    <a:pt x="3383" y="660"/>
                  </a:lnTo>
                  <a:lnTo>
                    <a:pt x="3355" y="632"/>
                  </a:lnTo>
                  <a:lnTo>
                    <a:pt x="3341" y="605"/>
                  </a:lnTo>
                  <a:lnTo>
                    <a:pt x="3314" y="577"/>
                  </a:lnTo>
                  <a:lnTo>
                    <a:pt x="3286" y="564"/>
                  </a:lnTo>
                  <a:lnTo>
                    <a:pt x="3273" y="536"/>
                  </a:lnTo>
                  <a:lnTo>
                    <a:pt x="3245" y="508"/>
                  </a:lnTo>
                  <a:lnTo>
                    <a:pt x="3217" y="495"/>
                  </a:lnTo>
                  <a:lnTo>
                    <a:pt x="3190" y="467"/>
                  </a:lnTo>
                  <a:lnTo>
                    <a:pt x="3162" y="439"/>
                  </a:lnTo>
                  <a:lnTo>
                    <a:pt x="3135" y="426"/>
                  </a:lnTo>
                  <a:lnTo>
                    <a:pt x="3121" y="398"/>
                  </a:lnTo>
                  <a:lnTo>
                    <a:pt x="3094" y="385"/>
                  </a:lnTo>
                  <a:lnTo>
                    <a:pt x="3066" y="357"/>
                  </a:lnTo>
                  <a:lnTo>
                    <a:pt x="3038" y="344"/>
                  </a:lnTo>
                  <a:lnTo>
                    <a:pt x="3011" y="329"/>
                  </a:lnTo>
                  <a:lnTo>
                    <a:pt x="2983" y="303"/>
                  </a:lnTo>
                  <a:lnTo>
                    <a:pt x="2942" y="288"/>
                  </a:lnTo>
                  <a:lnTo>
                    <a:pt x="2915" y="275"/>
                  </a:lnTo>
                  <a:lnTo>
                    <a:pt x="2887" y="247"/>
                  </a:lnTo>
                  <a:lnTo>
                    <a:pt x="2860" y="234"/>
                  </a:lnTo>
                  <a:lnTo>
                    <a:pt x="2832" y="220"/>
                  </a:lnTo>
                  <a:lnTo>
                    <a:pt x="2804" y="206"/>
                  </a:lnTo>
                  <a:lnTo>
                    <a:pt x="2778" y="192"/>
                  </a:lnTo>
                  <a:lnTo>
                    <a:pt x="2736" y="178"/>
                  </a:lnTo>
                  <a:lnTo>
                    <a:pt x="2709" y="165"/>
                  </a:lnTo>
                  <a:lnTo>
                    <a:pt x="2681" y="151"/>
                  </a:lnTo>
                  <a:lnTo>
                    <a:pt x="2653" y="137"/>
                  </a:lnTo>
                  <a:lnTo>
                    <a:pt x="2612" y="124"/>
                  </a:lnTo>
                  <a:lnTo>
                    <a:pt x="2584" y="110"/>
                  </a:lnTo>
                  <a:lnTo>
                    <a:pt x="2558" y="96"/>
                  </a:lnTo>
                  <a:lnTo>
                    <a:pt x="2516" y="82"/>
                  </a:lnTo>
                  <a:lnTo>
                    <a:pt x="2489" y="82"/>
                  </a:lnTo>
                  <a:lnTo>
                    <a:pt x="2461" y="68"/>
                  </a:lnTo>
                  <a:lnTo>
                    <a:pt x="2420" y="55"/>
                  </a:lnTo>
                  <a:lnTo>
                    <a:pt x="2392" y="55"/>
                  </a:lnTo>
                  <a:lnTo>
                    <a:pt x="2365" y="41"/>
                  </a:lnTo>
                  <a:lnTo>
                    <a:pt x="2324" y="41"/>
                  </a:lnTo>
                  <a:lnTo>
                    <a:pt x="2296" y="27"/>
                  </a:lnTo>
                  <a:lnTo>
                    <a:pt x="2255" y="27"/>
                  </a:lnTo>
                  <a:lnTo>
                    <a:pt x="2227" y="13"/>
                  </a:lnTo>
                  <a:lnTo>
                    <a:pt x="2200" y="13"/>
                  </a:lnTo>
                  <a:lnTo>
                    <a:pt x="2158" y="13"/>
                  </a:lnTo>
                  <a:lnTo>
                    <a:pt x="2131" y="0"/>
                  </a:lnTo>
                  <a:lnTo>
                    <a:pt x="2089" y="0"/>
                  </a:lnTo>
                  <a:lnTo>
                    <a:pt x="2063" y="0"/>
                  </a:lnTo>
                  <a:lnTo>
                    <a:pt x="2021" y="0"/>
                  </a:lnTo>
                  <a:lnTo>
                    <a:pt x="1994" y="0"/>
                  </a:lnTo>
                  <a:lnTo>
                    <a:pt x="1953" y="0"/>
                  </a:lnTo>
                  <a:lnTo>
                    <a:pt x="1925" y="0"/>
                  </a:lnTo>
                  <a:lnTo>
                    <a:pt x="1897" y="0"/>
                  </a:lnTo>
                  <a:lnTo>
                    <a:pt x="1856" y="0"/>
                  </a:lnTo>
                  <a:lnTo>
                    <a:pt x="1828" y="0"/>
                  </a:lnTo>
                  <a:lnTo>
                    <a:pt x="1787" y="0"/>
                  </a:lnTo>
                  <a:lnTo>
                    <a:pt x="1760" y="0"/>
                  </a:lnTo>
                  <a:lnTo>
                    <a:pt x="1718" y="0"/>
                  </a:lnTo>
                  <a:lnTo>
                    <a:pt x="1691" y="13"/>
                  </a:lnTo>
                  <a:lnTo>
                    <a:pt x="1650" y="13"/>
                  </a:lnTo>
                  <a:lnTo>
                    <a:pt x="1622" y="13"/>
                  </a:lnTo>
                  <a:lnTo>
                    <a:pt x="1595" y="27"/>
                  </a:lnTo>
                  <a:lnTo>
                    <a:pt x="1553" y="27"/>
                  </a:lnTo>
                  <a:lnTo>
                    <a:pt x="1526" y="41"/>
                  </a:lnTo>
                  <a:lnTo>
                    <a:pt x="1485" y="41"/>
                  </a:lnTo>
                  <a:lnTo>
                    <a:pt x="1458" y="55"/>
                  </a:lnTo>
                  <a:lnTo>
                    <a:pt x="1430" y="55"/>
                  </a:lnTo>
                  <a:lnTo>
                    <a:pt x="1389" y="68"/>
                  </a:lnTo>
                  <a:lnTo>
                    <a:pt x="1361" y="82"/>
                  </a:lnTo>
                  <a:lnTo>
                    <a:pt x="1333" y="82"/>
                  </a:lnTo>
                  <a:lnTo>
                    <a:pt x="1292" y="96"/>
                  </a:lnTo>
                  <a:lnTo>
                    <a:pt x="1264" y="110"/>
                  </a:lnTo>
                  <a:lnTo>
                    <a:pt x="1238" y="124"/>
                  </a:lnTo>
                  <a:lnTo>
                    <a:pt x="1196" y="137"/>
                  </a:lnTo>
                  <a:lnTo>
                    <a:pt x="1169" y="151"/>
                  </a:lnTo>
                  <a:lnTo>
                    <a:pt x="1141" y="165"/>
                  </a:lnTo>
                  <a:lnTo>
                    <a:pt x="1113" y="178"/>
                  </a:lnTo>
                  <a:lnTo>
                    <a:pt x="1072" y="192"/>
                  </a:lnTo>
                  <a:lnTo>
                    <a:pt x="1045" y="206"/>
                  </a:lnTo>
                  <a:lnTo>
                    <a:pt x="1017" y="220"/>
                  </a:lnTo>
                  <a:lnTo>
                    <a:pt x="990" y="234"/>
                  </a:lnTo>
                  <a:lnTo>
                    <a:pt x="962" y="247"/>
                  </a:lnTo>
                  <a:lnTo>
                    <a:pt x="935" y="275"/>
                  </a:lnTo>
                  <a:lnTo>
                    <a:pt x="907" y="288"/>
                  </a:lnTo>
                  <a:lnTo>
                    <a:pt x="866" y="303"/>
                  </a:lnTo>
                  <a:lnTo>
                    <a:pt x="838" y="329"/>
                  </a:lnTo>
                  <a:lnTo>
                    <a:pt x="811" y="344"/>
                  </a:lnTo>
                  <a:lnTo>
                    <a:pt x="784" y="357"/>
                  </a:lnTo>
                  <a:lnTo>
                    <a:pt x="756" y="385"/>
                  </a:lnTo>
                  <a:lnTo>
                    <a:pt x="728" y="398"/>
                  </a:lnTo>
                  <a:lnTo>
                    <a:pt x="715" y="426"/>
                  </a:lnTo>
                  <a:lnTo>
                    <a:pt x="687" y="439"/>
                  </a:lnTo>
                  <a:lnTo>
                    <a:pt x="659" y="467"/>
                  </a:lnTo>
                  <a:lnTo>
                    <a:pt x="633" y="495"/>
                  </a:lnTo>
                  <a:lnTo>
                    <a:pt x="605" y="508"/>
                  </a:lnTo>
                  <a:lnTo>
                    <a:pt x="577" y="536"/>
                  </a:lnTo>
                  <a:lnTo>
                    <a:pt x="564" y="564"/>
                  </a:lnTo>
                  <a:lnTo>
                    <a:pt x="536" y="577"/>
                  </a:lnTo>
                  <a:lnTo>
                    <a:pt x="508" y="605"/>
                  </a:lnTo>
                  <a:lnTo>
                    <a:pt x="495" y="632"/>
                  </a:lnTo>
                  <a:lnTo>
                    <a:pt x="467" y="660"/>
                  </a:lnTo>
                  <a:lnTo>
                    <a:pt x="439" y="687"/>
                  </a:lnTo>
                  <a:lnTo>
                    <a:pt x="426" y="715"/>
                  </a:lnTo>
                  <a:lnTo>
                    <a:pt x="398" y="728"/>
                  </a:lnTo>
                  <a:lnTo>
                    <a:pt x="385" y="756"/>
                  </a:lnTo>
                  <a:lnTo>
                    <a:pt x="357" y="783"/>
                  </a:lnTo>
                  <a:lnTo>
                    <a:pt x="344" y="811"/>
                  </a:lnTo>
                  <a:lnTo>
                    <a:pt x="330" y="839"/>
                  </a:lnTo>
                  <a:lnTo>
                    <a:pt x="302" y="866"/>
                  </a:lnTo>
                  <a:lnTo>
                    <a:pt x="288" y="907"/>
                  </a:lnTo>
                  <a:lnTo>
                    <a:pt x="275" y="934"/>
                  </a:lnTo>
                  <a:lnTo>
                    <a:pt x="247" y="962"/>
                  </a:lnTo>
                  <a:lnTo>
                    <a:pt x="234" y="990"/>
                  </a:lnTo>
                  <a:lnTo>
                    <a:pt x="220" y="1018"/>
                  </a:lnTo>
                  <a:lnTo>
                    <a:pt x="206" y="1044"/>
                  </a:lnTo>
                  <a:lnTo>
                    <a:pt x="192" y="1072"/>
                  </a:lnTo>
                  <a:lnTo>
                    <a:pt x="179" y="1113"/>
                  </a:lnTo>
                  <a:lnTo>
                    <a:pt x="165" y="1141"/>
                  </a:lnTo>
                  <a:lnTo>
                    <a:pt x="151" y="1169"/>
                  </a:lnTo>
                  <a:lnTo>
                    <a:pt x="137" y="1196"/>
                  </a:lnTo>
                  <a:lnTo>
                    <a:pt x="123" y="1238"/>
                  </a:lnTo>
                  <a:lnTo>
                    <a:pt x="110" y="1264"/>
                  </a:lnTo>
                  <a:lnTo>
                    <a:pt x="96" y="1292"/>
                  </a:lnTo>
                  <a:lnTo>
                    <a:pt x="82" y="1333"/>
                  </a:lnTo>
                  <a:lnTo>
                    <a:pt x="82" y="1361"/>
                  </a:lnTo>
                  <a:lnTo>
                    <a:pt x="69" y="1389"/>
                  </a:lnTo>
                  <a:lnTo>
                    <a:pt x="55" y="1430"/>
                  </a:lnTo>
                  <a:lnTo>
                    <a:pt x="55" y="1457"/>
                  </a:lnTo>
                  <a:lnTo>
                    <a:pt x="41" y="1485"/>
                  </a:lnTo>
                  <a:lnTo>
                    <a:pt x="41" y="1526"/>
                  </a:lnTo>
                  <a:lnTo>
                    <a:pt x="28" y="1554"/>
                  </a:lnTo>
                  <a:lnTo>
                    <a:pt x="28" y="1595"/>
                  </a:lnTo>
                  <a:lnTo>
                    <a:pt x="13" y="1622"/>
                  </a:lnTo>
                  <a:lnTo>
                    <a:pt x="13" y="1649"/>
                  </a:lnTo>
                  <a:lnTo>
                    <a:pt x="13" y="1691"/>
                  </a:lnTo>
                  <a:lnTo>
                    <a:pt x="0" y="1718"/>
                  </a:lnTo>
                  <a:lnTo>
                    <a:pt x="0" y="1759"/>
                  </a:lnTo>
                  <a:lnTo>
                    <a:pt x="0" y="1787"/>
                  </a:lnTo>
                  <a:lnTo>
                    <a:pt x="0" y="1828"/>
                  </a:lnTo>
                  <a:lnTo>
                    <a:pt x="0" y="1856"/>
                  </a:lnTo>
                  <a:lnTo>
                    <a:pt x="0" y="1897"/>
                  </a:lnTo>
                  <a:lnTo>
                    <a:pt x="0" y="1925"/>
                  </a:lnTo>
                  <a:lnTo>
                    <a:pt x="0" y="1953"/>
                  </a:lnTo>
                  <a:lnTo>
                    <a:pt x="0" y="1994"/>
                  </a:lnTo>
                  <a:lnTo>
                    <a:pt x="0" y="2021"/>
                  </a:lnTo>
                  <a:lnTo>
                    <a:pt x="0" y="2062"/>
                  </a:lnTo>
                  <a:lnTo>
                    <a:pt x="0" y="2090"/>
                  </a:lnTo>
                  <a:lnTo>
                    <a:pt x="0" y="2131"/>
                  </a:lnTo>
                  <a:lnTo>
                    <a:pt x="13" y="2158"/>
                  </a:lnTo>
                  <a:lnTo>
                    <a:pt x="13" y="2200"/>
                  </a:lnTo>
                  <a:lnTo>
                    <a:pt x="13" y="2227"/>
                  </a:lnTo>
                  <a:lnTo>
                    <a:pt x="28" y="2255"/>
                  </a:lnTo>
                  <a:lnTo>
                    <a:pt x="28" y="2296"/>
                  </a:lnTo>
                  <a:lnTo>
                    <a:pt x="41" y="2323"/>
                  </a:lnTo>
                  <a:lnTo>
                    <a:pt x="41" y="2364"/>
                  </a:lnTo>
                  <a:lnTo>
                    <a:pt x="55" y="2392"/>
                  </a:lnTo>
                  <a:lnTo>
                    <a:pt x="55" y="2420"/>
                  </a:lnTo>
                  <a:lnTo>
                    <a:pt x="69" y="2461"/>
                  </a:lnTo>
                  <a:lnTo>
                    <a:pt x="82" y="2489"/>
                  </a:lnTo>
                  <a:lnTo>
                    <a:pt x="82" y="2517"/>
                  </a:lnTo>
                  <a:lnTo>
                    <a:pt x="96" y="2558"/>
                  </a:lnTo>
                  <a:lnTo>
                    <a:pt x="110" y="2584"/>
                  </a:lnTo>
                  <a:lnTo>
                    <a:pt x="123" y="2612"/>
                  </a:lnTo>
                  <a:lnTo>
                    <a:pt x="137" y="2653"/>
                  </a:lnTo>
                  <a:lnTo>
                    <a:pt x="151" y="2681"/>
                  </a:lnTo>
                  <a:lnTo>
                    <a:pt x="165" y="2709"/>
                  </a:lnTo>
                  <a:lnTo>
                    <a:pt x="179" y="2736"/>
                  </a:lnTo>
                  <a:lnTo>
                    <a:pt x="192" y="2777"/>
                  </a:lnTo>
                  <a:lnTo>
                    <a:pt x="206" y="2805"/>
                  </a:lnTo>
                  <a:lnTo>
                    <a:pt x="220" y="2832"/>
                  </a:lnTo>
                  <a:lnTo>
                    <a:pt x="234" y="2860"/>
                  </a:lnTo>
                  <a:lnTo>
                    <a:pt x="247" y="2887"/>
                  </a:lnTo>
                  <a:lnTo>
                    <a:pt x="275" y="2915"/>
                  </a:lnTo>
                  <a:lnTo>
                    <a:pt x="288" y="2942"/>
                  </a:lnTo>
                  <a:lnTo>
                    <a:pt x="302" y="2984"/>
                  </a:lnTo>
                  <a:lnTo>
                    <a:pt x="330" y="3011"/>
                  </a:lnTo>
                  <a:lnTo>
                    <a:pt x="344" y="3038"/>
                  </a:lnTo>
                  <a:lnTo>
                    <a:pt x="357" y="3066"/>
                  </a:lnTo>
                  <a:lnTo>
                    <a:pt x="385" y="3094"/>
                  </a:lnTo>
                  <a:lnTo>
                    <a:pt x="398" y="3121"/>
                  </a:lnTo>
                  <a:lnTo>
                    <a:pt x="426" y="3135"/>
                  </a:lnTo>
                  <a:lnTo>
                    <a:pt x="439" y="3163"/>
                  </a:lnTo>
                  <a:lnTo>
                    <a:pt x="467" y="3189"/>
                  </a:lnTo>
                  <a:lnTo>
                    <a:pt x="495" y="3217"/>
                  </a:lnTo>
                  <a:lnTo>
                    <a:pt x="508" y="3245"/>
                  </a:lnTo>
                  <a:lnTo>
                    <a:pt x="536" y="3273"/>
                  </a:lnTo>
                  <a:lnTo>
                    <a:pt x="564" y="3286"/>
                  </a:lnTo>
                  <a:lnTo>
                    <a:pt x="577" y="3314"/>
                  </a:lnTo>
                  <a:lnTo>
                    <a:pt x="605" y="3341"/>
                  </a:lnTo>
                  <a:lnTo>
                    <a:pt x="633" y="3355"/>
                  </a:lnTo>
                  <a:lnTo>
                    <a:pt x="659" y="3383"/>
                  </a:lnTo>
                  <a:lnTo>
                    <a:pt x="687" y="3410"/>
                  </a:lnTo>
                  <a:lnTo>
                    <a:pt x="715" y="3424"/>
                  </a:lnTo>
                  <a:lnTo>
                    <a:pt x="728" y="3451"/>
                  </a:lnTo>
                  <a:lnTo>
                    <a:pt x="756" y="3465"/>
                  </a:lnTo>
                  <a:lnTo>
                    <a:pt x="784" y="3492"/>
                  </a:lnTo>
                  <a:lnTo>
                    <a:pt x="811" y="3506"/>
                  </a:lnTo>
                  <a:lnTo>
                    <a:pt x="838" y="3520"/>
                  </a:lnTo>
                  <a:lnTo>
                    <a:pt x="866" y="3547"/>
                  </a:lnTo>
                  <a:lnTo>
                    <a:pt x="907" y="3561"/>
                  </a:lnTo>
                  <a:lnTo>
                    <a:pt x="935" y="3575"/>
                  </a:lnTo>
                  <a:lnTo>
                    <a:pt x="962" y="3602"/>
                  </a:lnTo>
                  <a:lnTo>
                    <a:pt x="990" y="3616"/>
                  </a:lnTo>
                  <a:lnTo>
                    <a:pt x="1017" y="3630"/>
                  </a:lnTo>
                  <a:lnTo>
                    <a:pt x="1045" y="3643"/>
                  </a:lnTo>
                  <a:lnTo>
                    <a:pt x="1072" y="3657"/>
                  </a:lnTo>
                  <a:lnTo>
                    <a:pt x="1113" y="3671"/>
                  </a:lnTo>
                  <a:lnTo>
                    <a:pt x="1141" y="3685"/>
                  </a:lnTo>
                  <a:lnTo>
                    <a:pt x="1169" y="3699"/>
                  </a:lnTo>
                  <a:lnTo>
                    <a:pt x="1196" y="3712"/>
                  </a:lnTo>
                  <a:lnTo>
                    <a:pt x="1238" y="3726"/>
                  </a:lnTo>
                  <a:lnTo>
                    <a:pt x="1264" y="3740"/>
                  </a:lnTo>
                  <a:lnTo>
                    <a:pt x="1292" y="3753"/>
                  </a:lnTo>
                  <a:lnTo>
                    <a:pt x="1333" y="3768"/>
                  </a:lnTo>
                  <a:lnTo>
                    <a:pt x="1361" y="3768"/>
                  </a:lnTo>
                  <a:lnTo>
                    <a:pt x="1389" y="3781"/>
                  </a:lnTo>
                  <a:lnTo>
                    <a:pt x="1430" y="3794"/>
                  </a:lnTo>
                  <a:lnTo>
                    <a:pt x="1458" y="3794"/>
                  </a:lnTo>
                  <a:lnTo>
                    <a:pt x="1485" y="3809"/>
                  </a:lnTo>
                  <a:lnTo>
                    <a:pt x="1526" y="3809"/>
                  </a:lnTo>
                  <a:lnTo>
                    <a:pt x="1553" y="3822"/>
                  </a:lnTo>
                  <a:lnTo>
                    <a:pt x="1595" y="3822"/>
                  </a:lnTo>
                  <a:lnTo>
                    <a:pt x="1622" y="3836"/>
                  </a:lnTo>
                  <a:lnTo>
                    <a:pt x="1650" y="3836"/>
                  </a:lnTo>
                  <a:lnTo>
                    <a:pt x="1691" y="3836"/>
                  </a:lnTo>
                  <a:lnTo>
                    <a:pt x="1718" y="3850"/>
                  </a:lnTo>
                  <a:lnTo>
                    <a:pt x="1760" y="3850"/>
                  </a:lnTo>
                  <a:lnTo>
                    <a:pt x="1787" y="3850"/>
                  </a:lnTo>
                  <a:lnTo>
                    <a:pt x="1828" y="3850"/>
                  </a:lnTo>
                  <a:lnTo>
                    <a:pt x="1856" y="3850"/>
                  </a:lnTo>
                  <a:lnTo>
                    <a:pt x="1897" y="3850"/>
                  </a:lnTo>
                  <a:lnTo>
                    <a:pt x="1925" y="3850"/>
                  </a:lnTo>
                  <a:lnTo>
                    <a:pt x="1953" y="3850"/>
                  </a:lnTo>
                  <a:lnTo>
                    <a:pt x="1994" y="3850"/>
                  </a:lnTo>
                  <a:lnTo>
                    <a:pt x="2021" y="3850"/>
                  </a:lnTo>
                  <a:lnTo>
                    <a:pt x="2063" y="3850"/>
                  </a:lnTo>
                  <a:lnTo>
                    <a:pt x="2089" y="3850"/>
                  </a:lnTo>
                  <a:lnTo>
                    <a:pt x="2131" y="3850"/>
                  </a:lnTo>
                  <a:lnTo>
                    <a:pt x="2158" y="3836"/>
                  </a:lnTo>
                  <a:lnTo>
                    <a:pt x="2200" y="3836"/>
                  </a:lnTo>
                  <a:lnTo>
                    <a:pt x="2227" y="3836"/>
                  </a:lnTo>
                  <a:lnTo>
                    <a:pt x="2255" y="3822"/>
                  </a:lnTo>
                  <a:lnTo>
                    <a:pt x="2296" y="3822"/>
                  </a:lnTo>
                  <a:lnTo>
                    <a:pt x="2324" y="3809"/>
                  </a:lnTo>
                  <a:lnTo>
                    <a:pt x="2365" y="3809"/>
                  </a:lnTo>
                  <a:lnTo>
                    <a:pt x="2392" y="3794"/>
                  </a:lnTo>
                  <a:lnTo>
                    <a:pt x="2420" y="3794"/>
                  </a:lnTo>
                  <a:lnTo>
                    <a:pt x="2461" y="3781"/>
                  </a:lnTo>
                  <a:lnTo>
                    <a:pt x="2489" y="3768"/>
                  </a:lnTo>
                  <a:lnTo>
                    <a:pt x="2516" y="3768"/>
                  </a:lnTo>
                  <a:lnTo>
                    <a:pt x="2558" y="3753"/>
                  </a:lnTo>
                  <a:lnTo>
                    <a:pt x="2584" y="3740"/>
                  </a:lnTo>
                  <a:lnTo>
                    <a:pt x="2612" y="3726"/>
                  </a:lnTo>
                  <a:lnTo>
                    <a:pt x="2653" y="3712"/>
                  </a:lnTo>
                  <a:lnTo>
                    <a:pt x="2681" y="3699"/>
                  </a:lnTo>
                  <a:lnTo>
                    <a:pt x="2709" y="3685"/>
                  </a:lnTo>
                  <a:lnTo>
                    <a:pt x="2736" y="3671"/>
                  </a:lnTo>
                  <a:lnTo>
                    <a:pt x="2778" y="3657"/>
                  </a:lnTo>
                  <a:lnTo>
                    <a:pt x="2804" y="3643"/>
                  </a:lnTo>
                  <a:lnTo>
                    <a:pt x="2832" y="3630"/>
                  </a:lnTo>
                  <a:lnTo>
                    <a:pt x="2860" y="3616"/>
                  </a:lnTo>
                  <a:lnTo>
                    <a:pt x="2887" y="3602"/>
                  </a:lnTo>
                  <a:lnTo>
                    <a:pt x="2915" y="3575"/>
                  </a:lnTo>
                  <a:lnTo>
                    <a:pt x="2942" y="3561"/>
                  </a:lnTo>
                  <a:lnTo>
                    <a:pt x="2983" y="3547"/>
                  </a:lnTo>
                  <a:lnTo>
                    <a:pt x="3011" y="3520"/>
                  </a:lnTo>
                  <a:lnTo>
                    <a:pt x="3038" y="3506"/>
                  </a:lnTo>
                  <a:lnTo>
                    <a:pt x="3066" y="3492"/>
                  </a:lnTo>
                  <a:lnTo>
                    <a:pt x="3094" y="3465"/>
                  </a:lnTo>
                  <a:lnTo>
                    <a:pt x="3121" y="3451"/>
                  </a:lnTo>
                  <a:lnTo>
                    <a:pt x="3135" y="3424"/>
                  </a:lnTo>
                  <a:lnTo>
                    <a:pt x="3162" y="3410"/>
                  </a:lnTo>
                  <a:lnTo>
                    <a:pt x="3190" y="3383"/>
                  </a:lnTo>
                  <a:lnTo>
                    <a:pt x="3217" y="3355"/>
                  </a:lnTo>
                  <a:lnTo>
                    <a:pt x="3245" y="3341"/>
                  </a:lnTo>
                  <a:lnTo>
                    <a:pt x="3273" y="3314"/>
                  </a:lnTo>
                  <a:lnTo>
                    <a:pt x="3286" y="3286"/>
                  </a:lnTo>
                  <a:lnTo>
                    <a:pt x="3314" y="3273"/>
                  </a:lnTo>
                  <a:lnTo>
                    <a:pt x="3341" y="3245"/>
                  </a:lnTo>
                  <a:lnTo>
                    <a:pt x="3355" y="3217"/>
                  </a:lnTo>
                  <a:lnTo>
                    <a:pt x="3383" y="3189"/>
                  </a:lnTo>
                  <a:lnTo>
                    <a:pt x="3409" y="3163"/>
                  </a:lnTo>
                  <a:lnTo>
                    <a:pt x="3424" y="3135"/>
                  </a:lnTo>
                  <a:lnTo>
                    <a:pt x="3451" y="3121"/>
                  </a:lnTo>
                  <a:lnTo>
                    <a:pt x="3465" y="3094"/>
                  </a:lnTo>
                  <a:lnTo>
                    <a:pt x="3493" y="3066"/>
                  </a:lnTo>
                  <a:lnTo>
                    <a:pt x="3506" y="3038"/>
                  </a:lnTo>
                  <a:lnTo>
                    <a:pt x="3519" y="3011"/>
                  </a:lnTo>
                  <a:lnTo>
                    <a:pt x="3547" y="2984"/>
                  </a:lnTo>
                  <a:lnTo>
                    <a:pt x="3561" y="2942"/>
                  </a:lnTo>
                  <a:lnTo>
                    <a:pt x="3575" y="2915"/>
                  </a:lnTo>
                  <a:lnTo>
                    <a:pt x="3602" y="2887"/>
                  </a:lnTo>
                  <a:lnTo>
                    <a:pt x="3616" y="2860"/>
                  </a:lnTo>
                  <a:lnTo>
                    <a:pt x="3630" y="2832"/>
                  </a:lnTo>
                  <a:lnTo>
                    <a:pt x="3644" y="2805"/>
                  </a:lnTo>
                  <a:lnTo>
                    <a:pt x="3657" y="2777"/>
                  </a:lnTo>
                  <a:lnTo>
                    <a:pt x="3671" y="2736"/>
                  </a:lnTo>
                  <a:lnTo>
                    <a:pt x="3685" y="2709"/>
                  </a:lnTo>
                  <a:lnTo>
                    <a:pt x="3698" y="2681"/>
                  </a:lnTo>
                  <a:lnTo>
                    <a:pt x="3712" y="2653"/>
                  </a:lnTo>
                  <a:lnTo>
                    <a:pt x="3726" y="2612"/>
                  </a:lnTo>
                  <a:lnTo>
                    <a:pt x="3740" y="2584"/>
                  </a:lnTo>
                  <a:lnTo>
                    <a:pt x="3753" y="2558"/>
                  </a:lnTo>
                  <a:lnTo>
                    <a:pt x="3767" y="2517"/>
                  </a:lnTo>
                  <a:lnTo>
                    <a:pt x="3767" y="2489"/>
                  </a:lnTo>
                  <a:lnTo>
                    <a:pt x="3781" y="2461"/>
                  </a:lnTo>
                  <a:lnTo>
                    <a:pt x="3795" y="2420"/>
                  </a:lnTo>
                  <a:lnTo>
                    <a:pt x="3795" y="2392"/>
                  </a:lnTo>
                  <a:lnTo>
                    <a:pt x="3809" y="2364"/>
                  </a:lnTo>
                  <a:lnTo>
                    <a:pt x="3809" y="2323"/>
                  </a:lnTo>
                  <a:lnTo>
                    <a:pt x="3822" y="2296"/>
                  </a:lnTo>
                  <a:lnTo>
                    <a:pt x="3822" y="2255"/>
                  </a:lnTo>
                  <a:lnTo>
                    <a:pt x="3836" y="2227"/>
                  </a:lnTo>
                  <a:lnTo>
                    <a:pt x="3836" y="2200"/>
                  </a:lnTo>
                  <a:lnTo>
                    <a:pt x="3836" y="2158"/>
                  </a:lnTo>
                  <a:lnTo>
                    <a:pt x="3850" y="2131"/>
                  </a:lnTo>
                  <a:lnTo>
                    <a:pt x="3850" y="2090"/>
                  </a:lnTo>
                  <a:lnTo>
                    <a:pt x="3850" y="2062"/>
                  </a:lnTo>
                  <a:lnTo>
                    <a:pt x="3850" y="2021"/>
                  </a:lnTo>
                  <a:lnTo>
                    <a:pt x="3850" y="1994"/>
                  </a:lnTo>
                  <a:lnTo>
                    <a:pt x="3850" y="1953"/>
                  </a:lnTo>
                  <a:lnTo>
                    <a:pt x="3863" y="1925"/>
                  </a:lnTo>
                  <a:close/>
                </a:path>
              </a:pathLst>
            </a:custGeom>
            <a:solidFill>
              <a:srgbClr val="ff33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5" name=""/>
            <p:cNvSpPr/>
            <p:nvPr/>
          </p:nvSpPr>
          <p:spPr>
            <a:xfrm>
              <a:off x="3156480" y="1272600"/>
              <a:ext cx="214560" cy="215280"/>
            </a:xfrm>
            <a:prstGeom prst="rect">
              <a:avLst/>
            </a:prstGeom>
            <a:noFill/>
            <a:ln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6" name=""/>
            <p:cNvSpPr/>
            <p:nvPr/>
          </p:nvSpPr>
          <p:spPr>
            <a:xfrm>
              <a:off x="3202200" y="1319400"/>
              <a:ext cx="122040" cy="120240"/>
            </a:xfrm>
            <a:custGeom>
              <a:avLst/>
              <a:gdLst/>
              <a:ahLst/>
              <a:rect l="l" t="t" r="r" b="b"/>
              <a:pathLst>
                <a:path w="2337" h="2323">
                  <a:moveTo>
                    <a:pt x="2337" y="1169"/>
                  </a:moveTo>
                  <a:lnTo>
                    <a:pt x="2324" y="1141"/>
                  </a:lnTo>
                  <a:lnTo>
                    <a:pt x="2324" y="1128"/>
                  </a:lnTo>
                  <a:lnTo>
                    <a:pt x="2324" y="1100"/>
                  </a:lnTo>
                  <a:lnTo>
                    <a:pt x="2324" y="1086"/>
                  </a:lnTo>
                  <a:lnTo>
                    <a:pt x="2324" y="1059"/>
                  </a:lnTo>
                  <a:lnTo>
                    <a:pt x="2324" y="1044"/>
                  </a:lnTo>
                  <a:lnTo>
                    <a:pt x="2324" y="1018"/>
                  </a:lnTo>
                  <a:lnTo>
                    <a:pt x="2324" y="1003"/>
                  </a:lnTo>
                  <a:lnTo>
                    <a:pt x="2310" y="976"/>
                  </a:lnTo>
                  <a:lnTo>
                    <a:pt x="2310" y="962"/>
                  </a:lnTo>
                  <a:lnTo>
                    <a:pt x="2310" y="935"/>
                  </a:lnTo>
                  <a:lnTo>
                    <a:pt x="2310" y="921"/>
                  </a:lnTo>
                  <a:lnTo>
                    <a:pt x="2296" y="893"/>
                  </a:lnTo>
                  <a:lnTo>
                    <a:pt x="2296" y="880"/>
                  </a:lnTo>
                  <a:lnTo>
                    <a:pt x="2296" y="866"/>
                  </a:lnTo>
                  <a:lnTo>
                    <a:pt x="2282" y="839"/>
                  </a:lnTo>
                  <a:lnTo>
                    <a:pt x="2282" y="825"/>
                  </a:lnTo>
                  <a:lnTo>
                    <a:pt x="2268" y="797"/>
                  </a:lnTo>
                  <a:lnTo>
                    <a:pt x="2268" y="783"/>
                  </a:lnTo>
                  <a:lnTo>
                    <a:pt x="2255" y="756"/>
                  </a:lnTo>
                  <a:lnTo>
                    <a:pt x="2255" y="742"/>
                  </a:lnTo>
                  <a:lnTo>
                    <a:pt x="2241" y="728"/>
                  </a:lnTo>
                  <a:lnTo>
                    <a:pt x="2241" y="701"/>
                  </a:lnTo>
                  <a:lnTo>
                    <a:pt x="2227" y="687"/>
                  </a:lnTo>
                  <a:lnTo>
                    <a:pt x="2227" y="674"/>
                  </a:lnTo>
                  <a:lnTo>
                    <a:pt x="2213" y="646"/>
                  </a:lnTo>
                  <a:lnTo>
                    <a:pt x="2200" y="632"/>
                  </a:lnTo>
                  <a:lnTo>
                    <a:pt x="2200" y="618"/>
                  </a:lnTo>
                  <a:lnTo>
                    <a:pt x="2186" y="591"/>
                  </a:lnTo>
                  <a:lnTo>
                    <a:pt x="2172" y="577"/>
                  </a:lnTo>
                  <a:lnTo>
                    <a:pt x="2159" y="564"/>
                  </a:lnTo>
                  <a:lnTo>
                    <a:pt x="2159" y="536"/>
                  </a:lnTo>
                  <a:lnTo>
                    <a:pt x="2145" y="523"/>
                  </a:lnTo>
                  <a:lnTo>
                    <a:pt x="2131" y="508"/>
                  </a:lnTo>
                  <a:lnTo>
                    <a:pt x="2117" y="495"/>
                  </a:lnTo>
                  <a:lnTo>
                    <a:pt x="2103" y="481"/>
                  </a:lnTo>
                  <a:lnTo>
                    <a:pt x="2090" y="454"/>
                  </a:lnTo>
                  <a:lnTo>
                    <a:pt x="2076" y="439"/>
                  </a:lnTo>
                  <a:lnTo>
                    <a:pt x="2076" y="426"/>
                  </a:lnTo>
                  <a:lnTo>
                    <a:pt x="2062" y="413"/>
                  </a:lnTo>
                  <a:lnTo>
                    <a:pt x="2049" y="398"/>
                  </a:lnTo>
                  <a:lnTo>
                    <a:pt x="2034" y="385"/>
                  </a:lnTo>
                  <a:lnTo>
                    <a:pt x="2021" y="371"/>
                  </a:lnTo>
                  <a:lnTo>
                    <a:pt x="2008" y="344"/>
                  </a:lnTo>
                  <a:lnTo>
                    <a:pt x="1993" y="329"/>
                  </a:lnTo>
                  <a:lnTo>
                    <a:pt x="1980" y="316"/>
                  </a:lnTo>
                  <a:lnTo>
                    <a:pt x="1952" y="303"/>
                  </a:lnTo>
                  <a:lnTo>
                    <a:pt x="1939" y="288"/>
                  </a:lnTo>
                  <a:lnTo>
                    <a:pt x="1924" y="275"/>
                  </a:lnTo>
                  <a:lnTo>
                    <a:pt x="1911" y="261"/>
                  </a:lnTo>
                  <a:lnTo>
                    <a:pt x="1898" y="247"/>
                  </a:lnTo>
                  <a:lnTo>
                    <a:pt x="1883" y="247"/>
                  </a:lnTo>
                  <a:lnTo>
                    <a:pt x="1870" y="234"/>
                  </a:lnTo>
                  <a:lnTo>
                    <a:pt x="1842" y="220"/>
                  </a:lnTo>
                  <a:lnTo>
                    <a:pt x="1829" y="206"/>
                  </a:lnTo>
                  <a:lnTo>
                    <a:pt x="1814" y="192"/>
                  </a:lnTo>
                  <a:lnTo>
                    <a:pt x="1801" y="178"/>
                  </a:lnTo>
                  <a:lnTo>
                    <a:pt x="1788" y="165"/>
                  </a:lnTo>
                  <a:lnTo>
                    <a:pt x="1760" y="165"/>
                  </a:lnTo>
                  <a:lnTo>
                    <a:pt x="1746" y="151"/>
                  </a:lnTo>
                  <a:lnTo>
                    <a:pt x="1732" y="137"/>
                  </a:lnTo>
                  <a:lnTo>
                    <a:pt x="1705" y="124"/>
                  </a:lnTo>
                  <a:lnTo>
                    <a:pt x="1691" y="124"/>
                  </a:lnTo>
                  <a:lnTo>
                    <a:pt x="1677" y="110"/>
                  </a:lnTo>
                  <a:lnTo>
                    <a:pt x="1650" y="96"/>
                  </a:lnTo>
                  <a:lnTo>
                    <a:pt x="1636" y="96"/>
                  </a:lnTo>
                  <a:lnTo>
                    <a:pt x="1622" y="82"/>
                  </a:lnTo>
                  <a:lnTo>
                    <a:pt x="1595" y="82"/>
                  </a:lnTo>
                  <a:lnTo>
                    <a:pt x="1581" y="69"/>
                  </a:lnTo>
                  <a:lnTo>
                    <a:pt x="1567" y="69"/>
                  </a:lnTo>
                  <a:lnTo>
                    <a:pt x="1540" y="55"/>
                  </a:lnTo>
                  <a:lnTo>
                    <a:pt x="1526" y="55"/>
                  </a:lnTo>
                  <a:lnTo>
                    <a:pt x="1498" y="41"/>
                  </a:lnTo>
                  <a:lnTo>
                    <a:pt x="1485" y="41"/>
                  </a:lnTo>
                  <a:lnTo>
                    <a:pt x="1457" y="27"/>
                  </a:lnTo>
                  <a:lnTo>
                    <a:pt x="1444" y="27"/>
                  </a:lnTo>
                  <a:lnTo>
                    <a:pt x="1430" y="27"/>
                  </a:lnTo>
                  <a:lnTo>
                    <a:pt x="1402" y="13"/>
                  </a:lnTo>
                  <a:lnTo>
                    <a:pt x="1388" y="13"/>
                  </a:lnTo>
                  <a:lnTo>
                    <a:pt x="1361" y="13"/>
                  </a:lnTo>
                  <a:lnTo>
                    <a:pt x="1347" y="13"/>
                  </a:lnTo>
                  <a:lnTo>
                    <a:pt x="1319" y="0"/>
                  </a:lnTo>
                  <a:lnTo>
                    <a:pt x="1306" y="0"/>
                  </a:lnTo>
                  <a:lnTo>
                    <a:pt x="1278" y="0"/>
                  </a:lnTo>
                  <a:lnTo>
                    <a:pt x="1265" y="0"/>
                  </a:lnTo>
                  <a:lnTo>
                    <a:pt x="1237" y="0"/>
                  </a:lnTo>
                  <a:lnTo>
                    <a:pt x="1224" y="0"/>
                  </a:lnTo>
                  <a:lnTo>
                    <a:pt x="1196" y="0"/>
                  </a:lnTo>
                  <a:lnTo>
                    <a:pt x="1183" y="0"/>
                  </a:lnTo>
                  <a:lnTo>
                    <a:pt x="1168" y="0"/>
                  </a:lnTo>
                  <a:lnTo>
                    <a:pt x="1141" y="0"/>
                  </a:lnTo>
                  <a:lnTo>
                    <a:pt x="1127" y="0"/>
                  </a:lnTo>
                  <a:lnTo>
                    <a:pt x="1099" y="0"/>
                  </a:lnTo>
                  <a:lnTo>
                    <a:pt x="1086" y="0"/>
                  </a:lnTo>
                  <a:lnTo>
                    <a:pt x="1058" y="0"/>
                  </a:lnTo>
                  <a:lnTo>
                    <a:pt x="1045" y="0"/>
                  </a:lnTo>
                  <a:lnTo>
                    <a:pt x="1017" y="0"/>
                  </a:lnTo>
                  <a:lnTo>
                    <a:pt x="1004" y="0"/>
                  </a:lnTo>
                  <a:lnTo>
                    <a:pt x="976" y="13"/>
                  </a:lnTo>
                  <a:lnTo>
                    <a:pt x="962" y="13"/>
                  </a:lnTo>
                  <a:lnTo>
                    <a:pt x="935" y="13"/>
                  </a:lnTo>
                  <a:lnTo>
                    <a:pt x="921" y="13"/>
                  </a:lnTo>
                  <a:lnTo>
                    <a:pt x="894" y="27"/>
                  </a:lnTo>
                  <a:lnTo>
                    <a:pt x="880" y="27"/>
                  </a:lnTo>
                  <a:lnTo>
                    <a:pt x="866" y="27"/>
                  </a:lnTo>
                  <a:lnTo>
                    <a:pt x="839" y="41"/>
                  </a:lnTo>
                  <a:lnTo>
                    <a:pt x="825" y="41"/>
                  </a:lnTo>
                  <a:lnTo>
                    <a:pt x="797" y="55"/>
                  </a:lnTo>
                  <a:lnTo>
                    <a:pt x="783" y="55"/>
                  </a:lnTo>
                  <a:lnTo>
                    <a:pt x="756" y="69"/>
                  </a:lnTo>
                  <a:lnTo>
                    <a:pt x="742" y="69"/>
                  </a:lnTo>
                  <a:lnTo>
                    <a:pt x="729" y="82"/>
                  </a:lnTo>
                  <a:lnTo>
                    <a:pt x="701" y="82"/>
                  </a:lnTo>
                  <a:lnTo>
                    <a:pt x="688" y="96"/>
                  </a:lnTo>
                  <a:lnTo>
                    <a:pt x="673" y="96"/>
                  </a:lnTo>
                  <a:lnTo>
                    <a:pt x="646" y="110"/>
                  </a:lnTo>
                  <a:lnTo>
                    <a:pt x="632" y="124"/>
                  </a:lnTo>
                  <a:lnTo>
                    <a:pt x="619" y="124"/>
                  </a:lnTo>
                  <a:lnTo>
                    <a:pt x="591" y="137"/>
                  </a:lnTo>
                  <a:lnTo>
                    <a:pt x="578" y="151"/>
                  </a:lnTo>
                  <a:lnTo>
                    <a:pt x="563" y="165"/>
                  </a:lnTo>
                  <a:lnTo>
                    <a:pt x="536" y="165"/>
                  </a:lnTo>
                  <a:lnTo>
                    <a:pt x="522" y="178"/>
                  </a:lnTo>
                  <a:lnTo>
                    <a:pt x="509" y="192"/>
                  </a:lnTo>
                  <a:lnTo>
                    <a:pt x="494" y="206"/>
                  </a:lnTo>
                  <a:lnTo>
                    <a:pt x="481" y="220"/>
                  </a:lnTo>
                  <a:lnTo>
                    <a:pt x="453" y="234"/>
                  </a:lnTo>
                  <a:lnTo>
                    <a:pt x="440" y="247"/>
                  </a:lnTo>
                  <a:lnTo>
                    <a:pt x="426" y="247"/>
                  </a:lnTo>
                  <a:lnTo>
                    <a:pt x="412" y="261"/>
                  </a:lnTo>
                  <a:lnTo>
                    <a:pt x="399" y="275"/>
                  </a:lnTo>
                  <a:lnTo>
                    <a:pt x="384" y="288"/>
                  </a:lnTo>
                  <a:lnTo>
                    <a:pt x="371" y="303"/>
                  </a:lnTo>
                  <a:lnTo>
                    <a:pt x="343" y="316"/>
                  </a:lnTo>
                  <a:lnTo>
                    <a:pt x="330" y="329"/>
                  </a:lnTo>
                  <a:lnTo>
                    <a:pt x="316" y="344"/>
                  </a:lnTo>
                  <a:lnTo>
                    <a:pt x="302" y="371"/>
                  </a:lnTo>
                  <a:lnTo>
                    <a:pt x="289" y="385"/>
                  </a:lnTo>
                  <a:lnTo>
                    <a:pt x="275" y="398"/>
                  </a:lnTo>
                  <a:lnTo>
                    <a:pt x="261" y="413"/>
                  </a:lnTo>
                  <a:lnTo>
                    <a:pt x="247" y="426"/>
                  </a:lnTo>
                  <a:lnTo>
                    <a:pt x="247" y="439"/>
                  </a:lnTo>
                  <a:lnTo>
                    <a:pt x="233" y="454"/>
                  </a:lnTo>
                  <a:lnTo>
                    <a:pt x="220" y="481"/>
                  </a:lnTo>
                  <a:lnTo>
                    <a:pt x="206" y="495"/>
                  </a:lnTo>
                  <a:lnTo>
                    <a:pt x="192" y="508"/>
                  </a:lnTo>
                  <a:lnTo>
                    <a:pt x="179" y="523"/>
                  </a:lnTo>
                  <a:lnTo>
                    <a:pt x="165" y="536"/>
                  </a:lnTo>
                  <a:lnTo>
                    <a:pt x="165" y="564"/>
                  </a:lnTo>
                  <a:lnTo>
                    <a:pt x="151" y="577"/>
                  </a:lnTo>
                  <a:lnTo>
                    <a:pt x="137" y="591"/>
                  </a:lnTo>
                  <a:lnTo>
                    <a:pt x="124" y="618"/>
                  </a:lnTo>
                  <a:lnTo>
                    <a:pt x="124" y="632"/>
                  </a:lnTo>
                  <a:lnTo>
                    <a:pt x="110" y="646"/>
                  </a:lnTo>
                  <a:lnTo>
                    <a:pt x="96" y="674"/>
                  </a:lnTo>
                  <a:lnTo>
                    <a:pt x="96" y="687"/>
                  </a:lnTo>
                  <a:lnTo>
                    <a:pt x="82" y="701"/>
                  </a:lnTo>
                  <a:lnTo>
                    <a:pt x="82" y="728"/>
                  </a:lnTo>
                  <a:lnTo>
                    <a:pt x="68" y="742"/>
                  </a:lnTo>
                  <a:lnTo>
                    <a:pt x="68" y="756"/>
                  </a:lnTo>
                  <a:lnTo>
                    <a:pt x="55" y="783"/>
                  </a:lnTo>
                  <a:lnTo>
                    <a:pt x="55" y="797"/>
                  </a:lnTo>
                  <a:lnTo>
                    <a:pt x="41" y="825"/>
                  </a:lnTo>
                  <a:lnTo>
                    <a:pt x="41" y="839"/>
                  </a:lnTo>
                  <a:lnTo>
                    <a:pt x="27" y="866"/>
                  </a:lnTo>
                  <a:lnTo>
                    <a:pt x="27" y="880"/>
                  </a:lnTo>
                  <a:lnTo>
                    <a:pt x="27" y="893"/>
                  </a:lnTo>
                  <a:lnTo>
                    <a:pt x="14" y="921"/>
                  </a:lnTo>
                  <a:lnTo>
                    <a:pt x="14" y="935"/>
                  </a:lnTo>
                  <a:lnTo>
                    <a:pt x="14" y="962"/>
                  </a:lnTo>
                  <a:lnTo>
                    <a:pt x="14" y="976"/>
                  </a:lnTo>
                  <a:lnTo>
                    <a:pt x="0" y="1003"/>
                  </a:lnTo>
                  <a:lnTo>
                    <a:pt x="0" y="1018"/>
                  </a:lnTo>
                  <a:lnTo>
                    <a:pt x="0" y="1044"/>
                  </a:lnTo>
                  <a:lnTo>
                    <a:pt x="0" y="1059"/>
                  </a:lnTo>
                  <a:lnTo>
                    <a:pt x="0" y="1086"/>
                  </a:lnTo>
                  <a:lnTo>
                    <a:pt x="0" y="1100"/>
                  </a:lnTo>
                  <a:lnTo>
                    <a:pt x="0" y="1128"/>
                  </a:lnTo>
                  <a:lnTo>
                    <a:pt x="0" y="1141"/>
                  </a:lnTo>
                  <a:lnTo>
                    <a:pt x="0" y="1154"/>
                  </a:lnTo>
                  <a:lnTo>
                    <a:pt x="0" y="1182"/>
                  </a:lnTo>
                  <a:lnTo>
                    <a:pt x="0" y="1196"/>
                  </a:lnTo>
                  <a:lnTo>
                    <a:pt x="0" y="1223"/>
                  </a:lnTo>
                  <a:lnTo>
                    <a:pt x="0" y="1238"/>
                  </a:lnTo>
                  <a:lnTo>
                    <a:pt x="0" y="1264"/>
                  </a:lnTo>
                  <a:lnTo>
                    <a:pt x="0" y="1279"/>
                  </a:lnTo>
                  <a:lnTo>
                    <a:pt x="0" y="1306"/>
                  </a:lnTo>
                  <a:lnTo>
                    <a:pt x="0" y="1320"/>
                  </a:lnTo>
                  <a:lnTo>
                    <a:pt x="14" y="1347"/>
                  </a:lnTo>
                  <a:lnTo>
                    <a:pt x="14" y="1361"/>
                  </a:lnTo>
                  <a:lnTo>
                    <a:pt x="14" y="1389"/>
                  </a:lnTo>
                  <a:lnTo>
                    <a:pt x="14" y="1402"/>
                  </a:lnTo>
                  <a:lnTo>
                    <a:pt x="27" y="1430"/>
                  </a:lnTo>
                  <a:lnTo>
                    <a:pt x="27" y="1443"/>
                  </a:lnTo>
                  <a:lnTo>
                    <a:pt x="27" y="1457"/>
                  </a:lnTo>
                  <a:lnTo>
                    <a:pt x="41" y="1485"/>
                  </a:lnTo>
                  <a:lnTo>
                    <a:pt x="41" y="1498"/>
                  </a:lnTo>
                  <a:lnTo>
                    <a:pt x="55" y="1526"/>
                  </a:lnTo>
                  <a:lnTo>
                    <a:pt x="55" y="1540"/>
                  </a:lnTo>
                  <a:lnTo>
                    <a:pt x="68" y="1567"/>
                  </a:lnTo>
                  <a:lnTo>
                    <a:pt x="68" y="1581"/>
                  </a:lnTo>
                  <a:lnTo>
                    <a:pt x="82" y="1595"/>
                  </a:lnTo>
                  <a:lnTo>
                    <a:pt x="82" y="1622"/>
                  </a:lnTo>
                  <a:lnTo>
                    <a:pt x="96" y="1636"/>
                  </a:lnTo>
                  <a:lnTo>
                    <a:pt x="96" y="1649"/>
                  </a:lnTo>
                  <a:lnTo>
                    <a:pt x="110" y="1677"/>
                  </a:lnTo>
                  <a:lnTo>
                    <a:pt x="124" y="1691"/>
                  </a:lnTo>
                  <a:lnTo>
                    <a:pt x="124" y="1705"/>
                  </a:lnTo>
                  <a:lnTo>
                    <a:pt x="137" y="1733"/>
                  </a:lnTo>
                  <a:lnTo>
                    <a:pt x="151" y="1746"/>
                  </a:lnTo>
                  <a:lnTo>
                    <a:pt x="165" y="1759"/>
                  </a:lnTo>
                  <a:lnTo>
                    <a:pt x="165" y="1787"/>
                  </a:lnTo>
                  <a:lnTo>
                    <a:pt x="179" y="1801"/>
                  </a:lnTo>
                  <a:lnTo>
                    <a:pt x="192" y="1815"/>
                  </a:lnTo>
                  <a:lnTo>
                    <a:pt x="206" y="1828"/>
                  </a:lnTo>
                  <a:lnTo>
                    <a:pt x="220" y="1843"/>
                  </a:lnTo>
                  <a:lnTo>
                    <a:pt x="233" y="1869"/>
                  </a:lnTo>
                  <a:lnTo>
                    <a:pt x="247" y="1884"/>
                  </a:lnTo>
                  <a:lnTo>
                    <a:pt x="247" y="1897"/>
                  </a:lnTo>
                  <a:lnTo>
                    <a:pt x="261" y="1911"/>
                  </a:lnTo>
                  <a:lnTo>
                    <a:pt x="275" y="1925"/>
                  </a:lnTo>
                  <a:lnTo>
                    <a:pt x="289" y="1938"/>
                  </a:lnTo>
                  <a:lnTo>
                    <a:pt x="302" y="1953"/>
                  </a:lnTo>
                  <a:lnTo>
                    <a:pt x="316" y="1979"/>
                  </a:lnTo>
                  <a:lnTo>
                    <a:pt x="330" y="1994"/>
                  </a:lnTo>
                  <a:lnTo>
                    <a:pt x="343" y="2007"/>
                  </a:lnTo>
                  <a:lnTo>
                    <a:pt x="371" y="2021"/>
                  </a:lnTo>
                  <a:lnTo>
                    <a:pt x="384" y="2035"/>
                  </a:lnTo>
                  <a:lnTo>
                    <a:pt x="399" y="2048"/>
                  </a:lnTo>
                  <a:lnTo>
                    <a:pt x="412" y="2062"/>
                  </a:lnTo>
                  <a:lnTo>
                    <a:pt x="426" y="2076"/>
                  </a:lnTo>
                  <a:lnTo>
                    <a:pt x="440" y="2076"/>
                  </a:lnTo>
                  <a:lnTo>
                    <a:pt x="453" y="2090"/>
                  </a:lnTo>
                  <a:lnTo>
                    <a:pt x="481" y="2104"/>
                  </a:lnTo>
                  <a:lnTo>
                    <a:pt x="494" y="2117"/>
                  </a:lnTo>
                  <a:lnTo>
                    <a:pt x="509" y="2131"/>
                  </a:lnTo>
                  <a:lnTo>
                    <a:pt x="522" y="2145"/>
                  </a:lnTo>
                  <a:lnTo>
                    <a:pt x="536" y="2158"/>
                  </a:lnTo>
                  <a:lnTo>
                    <a:pt x="563" y="2158"/>
                  </a:lnTo>
                  <a:lnTo>
                    <a:pt x="578" y="2172"/>
                  </a:lnTo>
                  <a:lnTo>
                    <a:pt x="591" y="2186"/>
                  </a:lnTo>
                  <a:lnTo>
                    <a:pt x="619" y="2200"/>
                  </a:lnTo>
                  <a:lnTo>
                    <a:pt x="632" y="2200"/>
                  </a:lnTo>
                  <a:lnTo>
                    <a:pt x="646" y="2213"/>
                  </a:lnTo>
                  <a:lnTo>
                    <a:pt x="673" y="2227"/>
                  </a:lnTo>
                  <a:lnTo>
                    <a:pt x="688" y="2227"/>
                  </a:lnTo>
                  <a:lnTo>
                    <a:pt x="701" y="2241"/>
                  </a:lnTo>
                  <a:lnTo>
                    <a:pt x="729" y="2241"/>
                  </a:lnTo>
                  <a:lnTo>
                    <a:pt x="742" y="2255"/>
                  </a:lnTo>
                  <a:lnTo>
                    <a:pt x="756" y="2255"/>
                  </a:lnTo>
                  <a:lnTo>
                    <a:pt x="783" y="2269"/>
                  </a:lnTo>
                  <a:lnTo>
                    <a:pt x="797" y="2269"/>
                  </a:lnTo>
                  <a:lnTo>
                    <a:pt x="825" y="2282"/>
                  </a:lnTo>
                  <a:lnTo>
                    <a:pt x="839" y="2282"/>
                  </a:lnTo>
                  <a:lnTo>
                    <a:pt x="866" y="2296"/>
                  </a:lnTo>
                  <a:lnTo>
                    <a:pt x="880" y="2296"/>
                  </a:lnTo>
                  <a:lnTo>
                    <a:pt x="894" y="2296"/>
                  </a:lnTo>
                  <a:lnTo>
                    <a:pt x="921" y="2310"/>
                  </a:lnTo>
                  <a:lnTo>
                    <a:pt x="935" y="2310"/>
                  </a:lnTo>
                  <a:lnTo>
                    <a:pt x="962" y="2310"/>
                  </a:lnTo>
                  <a:lnTo>
                    <a:pt x="976" y="2310"/>
                  </a:lnTo>
                  <a:lnTo>
                    <a:pt x="1004" y="2323"/>
                  </a:lnTo>
                  <a:lnTo>
                    <a:pt x="1017" y="2323"/>
                  </a:lnTo>
                  <a:lnTo>
                    <a:pt x="1045" y="2323"/>
                  </a:lnTo>
                  <a:lnTo>
                    <a:pt x="1058" y="2323"/>
                  </a:lnTo>
                  <a:lnTo>
                    <a:pt x="1086" y="2323"/>
                  </a:lnTo>
                  <a:lnTo>
                    <a:pt x="1099" y="2323"/>
                  </a:lnTo>
                  <a:lnTo>
                    <a:pt x="1127" y="2323"/>
                  </a:lnTo>
                  <a:lnTo>
                    <a:pt x="1141" y="2323"/>
                  </a:lnTo>
                  <a:lnTo>
                    <a:pt x="1155" y="2323"/>
                  </a:lnTo>
                  <a:lnTo>
                    <a:pt x="1183" y="2323"/>
                  </a:lnTo>
                  <a:lnTo>
                    <a:pt x="1196" y="2323"/>
                  </a:lnTo>
                  <a:lnTo>
                    <a:pt x="1224" y="2323"/>
                  </a:lnTo>
                  <a:lnTo>
                    <a:pt x="1237" y="2323"/>
                  </a:lnTo>
                  <a:lnTo>
                    <a:pt x="1265" y="2323"/>
                  </a:lnTo>
                  <a:lnTo>
                    <a:pt x="1278" y="2323"/>
                  </a:lnTo>
                  <a:lnTo>
                    <a:pt x="1306" y="2323"/>
                  </a:lnTo>
                  <a:lnTo>
                    <a:pt x="1319" y="2323"/>
                  </a:lnTo>
                  <a:lnTo>
                    <a:pt x="1347" y="2310"/>
                  </a:lnTo>
                  <a:lnTo>
                    <a:pt x="1361" y="2310"/>
                  </a:lnTo>
                  <a:lnTo>
                    <a:pt x="1388" y="2310"/>
                  </a:lnTo>
                  <a:lnTo>
                    <a:pt x="1402" y="2310"/>
                  </a:lnTo>
                  <a:lnTo>
                    <a:pt x="1430" y="2296"/>
                  </a:lnTo>
                  <a:lnTo>
                    <a:pt x="1444" y="2296"/>
                  </a:lnTo>
                  <a:lnTo>
                    <a:pt x="1457" y="2296"/>
                  </a:lnTo>
                  <a:lnTo>
                    <a:pt x="1485" y="2282"/>
                  </a:lnTo>
                  <a:lnTo>
                    <a:pt x="1498" y="2282"/>
                  </a:lnTo>
                  <a:lnTo>
                    <a:pt x="1526" y="2269"/>
                  </a:lnTo>
                  <a:lnTo>
                    <a:pt x="1540" y="2269"/>
                  </a:lnTo>
                  <a:lnTo>
                    <a:pt x="1567" y="2255"/>
                  </a:lnTo>
                  <a:lnTo>
                    <a:pt x="1581" y="2255"/>
                  </a:lnTo>
                  <a:lnTo>
                    <a:pt x="1595" y="2241"/>
                  </a:lnTo>
                  <a:lnTo>
                    <a:pt x="1622" y="2241"/>
                  </a:lnTo>
                  <a:lnTo>
                    <a:pt x="1636" y="2227"/>
                  </a:lnTo>
                  <a:lnTo>
                    <a:pt x="1650" y="2227"/>
                  </a:lnTo>
                  <a:lnTo>
                    <a:pt x="1677" y="2213"/>
                  </a:lnTo>
                  <a:lnTo>
                    <a:pt x="1691" y="2200"/>
                  </a:lnTo>
                  <a:lnTo>
                    <a:pt x="1705" y="2200"/>
                  </a:lnTo>
                  <a:lnTo>
                    <a:pt x="1732" y="2186"/>
                  </a:lnTo>
                  <a:lnTo>
                    <a:pt x="1746" y="2172"/>
                  </a:lnTo>
                  <a:lnTo>
                    <a:pt x="1760" y="2158"/>
                  </a:lnTo>
                  <a:lnTo>
                    <a:pt x="1788" y="2158"/>
                  </a:lnTo>
                  <a:lnTo>
                    <a:pt x="1801" y="2145"/>
                  </a:lnTo>
                  <a:lnTo>
                    <a:pt x="1814" y="2131"/>
                  </a:lnTo>
                  <a:lnTo>
                    <a:pt x="1829" y="2117"/>
                  </a:lnTo>
                  <a:lnTo>
                    <a:pt x="1842" y="2104"/>
                  </a:lnTo>
                  <a:lnTo>
                    <a:pt x="1870" y="2090"/>
                  </a:lnTo>
                  <a:lnTo>
                    <a:pt x="1883" y="2076"/>
                  </a:lnTo>
                  <a:lnTo>
                    <a:pt x="1898" y="2076"/>
                  </a:lnTo>
                  <a:lnTo>
                    <a:pt x="1911" y="2062"/>
                  </a:lnTo>
                  <a:lnTo>
                    <a:pt x="1924" y="2048"/>
                  </a:lnTo>
                  <a:lnTo>
                    <a:pt x="1939" y="2035"/>
                  </a:lnTo>
                  <a:lnTo>
                    <a:pt x="1952" y="2021"/>
                  </a:lnTo>
                  <a:lnTo>
                    <a:pt x="1980" y="2007"/>
                  </a:lnTo>
                  <a:lnTo>
                    <a:pt x="1993" y="1994"/>
                  </a:lnTo>
                  <a:lnTo>
                    <a:pt x="2008" y="1979"/>
                  </a:lnTo>
                  <a:lnTo>
                    <a:pt x="2021" y="1953"/>
                  </a:lnTo>
                  <a:lnTo>
                    <a:pt x="2034" y="1938"/>
                  </a:lnTo>
                  <a:lnTo>
                    <a:pt x="2049" y="1925"/>
                  </a:lnTo>
                  <a:lnTo>
                    <a:pt x="2062" y="1911"/>
                  </a:lnTo>
                  <a:lnTo>
                    <a:pt x="2076" y="1897"/>
                  </a:lnTo>
                  <a:lnTo>
                    <a:pt x="2076" y="1884"/>
                  </a:lnTo>
                  <a:lnTo>
                    <a:pt x="2090" y="1869"/>
                  </a:lnTo>
                  <a:lnTo>
                    <a:pt x="2103" y="1843"/>
                  </a:lnTo>
                  <a:lnTo>
                    <a:pt x="2117" y="1828"/>
                  </a:lnTo>
                  <a:lnTo>
                    <a:pt x="2131" y="1815"/>
                  </a:lnTo>
                  <a:lnTo>
                    <a:pt x="2145" y="1801"/>
                  </a:lnTo>
                  <a:lnTo>
                    <a:pt x="2159" y="1787"/>
                  </a:lnTo>
                  <a:lnTo>
                    <a:pt x="2159" y="1759"/>
                  </a:lnTo>
                  <a:lnTo>
                    <a:pt x="2172" y="1746"/>
                  </a:lnTo>
                  <a:lnTo>
                    <a:pt x="2186" y="1733"/>
                  </a:lnTo>
                  <a:lnTo>
                    <a:pt x="2200" y="1705"/>
                  </a:lnTo>
                  <a:lnTo>
                    <a:pt x="2200" y="1691"/>
                  </a:lnTo>
                  <a:lnTo>
                    <a:pt x="2213" y="1677"/>
                  </a:lnTo>
                  <a:lnTo>
                    <a:pt x="2227" y="1649"/>
                  </a:lnTo>
                  <a:lnTo>
                    <a:pt x="2227" y="1636"/>
                  </a:lnTo>
                  <a:lnTo>
                    <a:pt x="2241" y="1622"/>
                  </a:lnTo>
                  <a:lnTo>
                    <a:pt x="2241" y="1595"/>
                  </a:lnTo>
                  <a:lnTo>
                    <a:pt x="2255" y="1581"/>
                  </a:lnTo>
                  <a:lnTo>
                    <a:pt x="2255" y="1567"/>
                  </a:lnTo>
                  <a:lnTo>
                    <a:pt x="2268" y="1540"/>
                  </a:lnTo>
                  <a:lnTo>
                    <a:pt x="2268" y="1526"/>
                  </a:lnTo>
                  <a:lnTo>
                    <a:pt x="2282" y="1498"/>
                  </a:lnTo>
                  <a:lnTo>
                    <a:pt x="2282" y="1485"/>
                  </a:lnTo>
                  <a:lnTo>
                    <a:pt x="2296" y="1457"/>
                  </a:lnTo>
                  <a:lnTo>
                    <a:pt x="2296" y="1443"/>
                  </a:lnTo>
                  <a:lnTo>
                    <a:pt x="2296" y="1430"/>
                  </a:lnTo>
                  <a:lnTo>
                    <a:pt x="2310" y="1402"/>
                  </a:lnTo>
                  <a:lnTo>
                    <a:pt x="2310" y="1389"/>
                  </a:lnTo>
                  <a:lnTo>
                    <a:pt x="2310" y="1361"/>
                  </a:lnTo>
                  <a:lnTo>
                    <a:pt x="2310" y="1347"/>
                  </a:lnTo>
                  <a:lnTo>
                    <a:pt x="2324" y="1320"/>
                  </a:lnTo>
                  <a:lnTo>
                    <a:pt x="2324" y="1306"/>
                  </a:lnTo>
                  <a:lnTo>
                    <a:pt x="2324" y="1279"/>
                  </a:lnTo>
                  <a:lnTo>
                    <a:pt x="2324" y="1264"/>
                  </a:lnTo>
                  <a:lnTo>
                    <a:pt x="2324" y="1238"/>
                  </a:lnTo>
                  <a:lnTo>
                    <a:pt x="2324" y="1223"/>
                  </a:lnTo>
                  <a:lnTo>
                    <a:pt x="2324" y="1196"/>
                  </a:lnTo>
                  <a:lnTo>
                    <a:pt x="2324" y="1182"/>
                  </a:lnTo>
                  <a:lnTo>
                    <a:pt x="2337" y="1169"/>
                  </a:lnTo>
                  <a:close/>
                </a:path>
              </a:pathLst>
            </a:custGeom>
            <a:solidFill>
              <a:srgbClr val="ff33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7" name=""/>
            <p:cNvSpPr/>
            <p:nvPr/>
          </p:nvSpPr>
          <p:spPr>
            <a:xfrm>
              <a:off x="3156480" y="1487880"/>
              <a:ext cx="214560" cy="213840"/>
            </a:xfrm>
            <a:prstGeom prst="rect">
              <a:avLst/>
            </a:prstGeom>
            <a:noFill/>
            <a:ln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8" name=""/>
            <p:cNvSpPr/>
            <p:nvPr/>
          </p:nvSpPr>
          <p:spPr>
            <a:xfrm>
              <a:off x="3223800" y="1555200"/>
              <a:ext cx="79920" cy="77760"/>
            </a:xfrm>
            <a:custGeom>
              <a:avLst/>
              <a:gdLst/>
              <a:ahLst/>
              <a:rect l="l" t="t" r="r" b="b"/>
              <a:pathLst>
                <a:path w="1540" h="1525">
                  <a:moveTo>
                    <a:pt x="1540" y="769"/>
                  </a:moveTo>
                  <a:lnTo>
                    <a:pt x="1525" y="756"/>
                  </a:lnTo>
                  <a:lnTo>
                    <a:pt x="1525" y="742"/>
                  </a:lnTo>
                  <a:lnTo>
                    <a:pt x="1525" y="728"/>
                  </a:lnTo>
                  <a:lnTo>
                    <a:pt x="1525" y="715"/>
                  </a:lnTo>
                  <a:lnTo>
                    <a:pt x="1525" y="700"/>
                  </a:lnTo>
                  <a:lnTo>
                    <a:pt x="1525" y="687"/>
                  </a:lnTo>
                  <a:lnTo>
                    <a:pt x="1525" y="674"/>
                  </a:lnTo>
                  <a:lnTo>
                    <a:pt x="1525" y="659"/>
                  </a:lnTo>
                  <a:lnTo>
                    <a:pt x="1525" y="646"/>
                  </a:lnTo>
                  <a:lnTo>
                    <a:pt x="1525" y="632"/>
                  </a:lnTo>
                  <a:lnTo>
                    <a:pt x="1512" y="618"/>
                  </a:lnTo>
                  <a:lnTo>
                    <a:pt x="1512" y="605"/>
                  </a:lnTo>
                  <a:lnTo>
                    <a:pt x="1512" y="591"/>
                  </a:lnTo>
                  <a:lnTo>
                    <a:pt x="1512" y="577"/>
                  </a:lnTo>
                  <a:lnTo>
                    <a:pt x="1512" y="563"/>
                  </a:lnTo>
                  <a:lnTo>
                    <a:pt x="1499" y="549"/>
                  </a:lnTo>
                  <a:lnTo>
                    <a:pt x="1499" y="536"/>
                  </a:lnTo>
                  <a:lnTo>
                    <a:pt x="1499" y="522"/>
                  </a:lnTo>
                  <a:lnTo>
                    <a:pt x="1484" y="508"/>
                  </a:lnTo>
                  <a:lnTo>
                    <a:pt x="1484" y="495"/>
                  </a:lnTo>
                  <a:lnTo>
                    <a:pt x="1484" y="481"/>
                  </a:lnTo>
                  <a:lnTo>
                    <a:pt x="1471" y="481"/>
                  </a:lnTo>
                  <a:lnTo>
                    <a:pt x="1471" y="467"/>
                  </a:lnTo>
                  <a:lnTo>
                    <a:pt x="1471" y="453"/>
                  </a:lnTo>
                  <a:lnTo>
                    <a:pt x="1457" y="440"/>
                  </a:lnTo>
                  <a:lnTo>
                    <a:pt x="1457" y="426"/>
                  </a:lnTo>
                  <a:lnTo>
                    <a:pt x="1443" y="412"/>
                  </a:lnTo>
                  <a:lnTo>
                    <a:pt x="1443" y="398"/>
                  </a:lnTo>
                  <a:lnTo>
                    <a:pt x="1430" y="384"/>
                  </a:lnTo>
                  <a:lnTo>
                    <a:pt x="1430" y="371"/>
                  </a:lnTo>
                  <a:lnTo>
                    <a:pt x="1415" y="357"/>
                  </a:lnTo>
                  <a:lnTo>
                    <a:pt x="1402" y="343"/>
                  </a:lnTo>
                  <a:lnTo>
                    <a:pt x="1402" y="330"/>
                  </a:lnTo>
                  <a:lnTo>
                    <a:pt x="1389" y="316"/>
                  </a:lnTo>
                  <a:lnTo>
                    <a:pt x="1374" y="302"/>
                  </a:lnTo>
                  <a:lnTo>
                    <a:pt x="1374" y="289"/>
                  </a:lnTo>
                  <a:lnTo>
                    <a:pt x="1361" y="274"/>
                  </a:lnTo>
                  <a:lnTo>
                    <a:pt x="1347" y="274"/>
                  </a:lnTo>
                  <a:lnTo>
                    <a:pt x="1347" y="261"/>
                  </a:lnTo>
                  <a:lnTo>
                    <a:pt x="1333" y="247"/>
                  </a:lnTo>
                  <a:lnTo>
                    <a:pt x="1320" y="233"/>
                  </a:lnTo>
                  <a:lnTo>
                    <a:pt x="1306" y="220"/>
                  </a:lnTo>
                  <a:lnTo>
                    <a:pt x="1292" y="205"/>
                  </a:lnTo>
                  <a:lnTo>
                    <a:pt x="1278" y="192"/>
                  </a:lnTo>
                  <a:lnTo>
                    <a:pt x="1264" y="179"/>
                  </a:lnTo>
                  <a:lnTo>
                    <a:pt x="1251" y="179"/>
                  </a:lnTo>
                  <a:lnTo>
                    <a:pt x="1251" y="164"/>
                  </a:lnTo>
                  <a:lnTo>
                    <a:pt x="1237" y="151"/>
                  </a:lnTo>
                  <a:lnTo>
                    <a:pt x="1223" y="151"/>
                  </a:lnTo>
                  <a:lnTo>
                    <a:pt x="1210" y="137"/>
                  </a:lnTo>
                  <a:lnTo>
                    <a:pt x="1196" y="123"/>
                  </a:lnTo>
                  <a:lnTo>
                    <a:pt x="1182" y="123"/>
                  </a:lnTo>
                  <a:lnTo>
                    <a:pt x="1168" y="110"/>
                  </a:lnTo>
                  <a:lnTo>
                    <a:pt x="1155" y="95"/>
                  </a:lnTo>
                  <a:lnTo>
                    <a:pt x="1141" y="95"/>
                  </a:lnTo>
                  <a:lnTo>
                    <a:pt x="1127" y="82"/>
                  </a:lnTo>
                  <a:lnTo>
                    <a:pt x="1113" y="82"/>
                  </a:lnTo>
                  <a:lnTo>
                    <a:pt x="1099" y="69"/>
                  </a:lnTo>
                  <a:lnTo>
                    <a:pt x="1086" y="69"/>
                  </a:lnTo>
                  <a:lnTo>
                    <a:pt x="1072" y="54"/>
                  </a:lnTo>
                  <a:lnTo>
                    <a:pt x="1058" y="54"/>
                  </a:lnTo>
                  <a:lnTo>
                    <a:pt x="1045" y="54"/>
                  </a:lnTo>
                  <a:lnTo>
                    <a:pt x="1045" y="41"/>
                  </a:lnTo>
                  <a:lnTo>
                    <a:pt x="1031" y="41"/>
                  </a:lnTo>
                  <a:lnTo>
                    <a:pt x="1017" y="41"/>
                  </a:lnTo>
                  <a:lnTo>
                    <a:pt x="1003" y="27"/>
                  </a:lnTo>
                  <a:lnTo>
                    <a:pt x="989" y="27"/>
                  </a:lnTo>
                  <a:lnTo>
                    <a:pt x="976" y="27"/>
                  </a:lnTo>
                  <a:lnTo>
                    <a:pt x="962" y="13"/>
                  </a:lnTo>
                  <a:lnTo>
                    <a:pt x="948" y="13"/>
                  </a:lnTo>
                  <a:lnTo>
                    <a:pt x="935" y="13"/>
                  </a:lnTo>
                  <a:lnTo>
                    <a:pt x="920" y="13"/>
                  </a:lnTo>
                  <a:lnTo>
                    <a:pt x="907" y="13"/>
                  </a:lnTo>
                  <a:lnTo>
                    <a:pt x="894" y="0"/>
                  </a:lnTo>
                  <a:lnTo>
                    <a:pt x="879" y="0"/>
                  </a:lnTo>
                  <a:lnTo>
                    <a:pt x="866" y="0"/>
                  </a:lnTo>
                  <a:lnTo>
                    <a:pt x="852" y="0"/>
                  </a:lnTo>
                  <a:lnTo>
                    <a:pt x="838" y="0"/>
                  </a:lnTo>
                  <a:lnTo>
                    <a:pt x="825" y="0"/>
                  </a:lnTo>
                  <a:lnTo>
                    <a:pt x="810" y="0"/>
                  </a:lnTo>
                  <a:lnTo>
                    <a:pt x="797" y="0"/>
                  </a:lnTo>
                  <a:lnTo>
                    <a:pt x="784" y="0"/>
                  </a:lnTo>
                  <a:lnTo>
                    <a:pt x="769" y="0"/>
                  </a:lnTo>
                  <a:lnTo>
                    <a:pt x="756" y="0"/>
                  </a:lnTo>
                  <a:lnTo>
                    <a:pt x="742" y="0"/>
                  </a:lnTo>
                  <a:lnTo>
                    <a:pt x="728" y="0"/>
                  </a:lnTo>
                  <a:lnTo>
                    <a:pt x="715" y="0"/>
                  </a:lnTo>
                  <a:lnTo>
                    <a:pt x="700" y="0"/>
                  </a:lnTo>
                  <a:lnTo>
                    <a:pt x="687" y="0"/>
                  </a:lnTo>
                  <a:lnTo>
                    <a:pt x="674" y="0"/>
                  </a:lnTo>
                  <a:lnTo>
                    <a:pt x="659" y="0"/>
                  </a:lnTo>
                  <a:lnTo>
                    <a:pt x="646" y="0"/>
                  </a:lnTo>
                  <a:lnTo>
                    <a:pt x="632" y="0"/>
                  </a:lnTo>
                  <a:lnTo>
                    <a:pt x="618" y="13"/>
                  </a:lnTo>
                  <a:lnTo>
                    <a:pt x="605" y="13"/>
                  </a:lnTo>
                  <a:lnTo>
                    <a:pt x="591" y="13"/>
                  </a:lnTo>
                  <a:lnTo>
                    <a:pt x="577" y="13"/>
                  </a:lnTo>
                  <a:lnTo>
                    <a:pt x="563" y="13"/>
                  </a:lnTo>
                  <a:lnTo>
                    <a:pt x="549" y="27"/>
                  </a:lnTo>
                  <a:lnTo>
                    <a:pt x="536" y="27"/>
                  </a:lnTo>
                  <a:lnTo>
                    <a:pt x="522" y="27"/>
                  </a:lnTo>
                  <a:lnTo>
                    <a:pt x="508" y="41"/>
                  </a:lnTo>
                  <a:lnTo>
                    <a:pt x="495" y="41"/>
                  </a:lnTo>
                  <a:lnTo>
                    <a:pt x="481" y="41"/>
                  </a:lnTo>
                  <a:lnTo>
                    <a:pt x="481" y="54"/>
                  </a:lnTo>
                  <a:lnTo>
                    <a:pt x="467" y="54"/>
                  </a:lnTo>
                  <a:lnTo>
                    <a:pt x="453" y="54"/>
                  </a:lnTo>
                  <a:lnTo>
                    <a:pt x="440" y="69"/>
                  </a:lnTo>
                  <a:lnTo>
                    <a:pt x="426" y="69"/>
                  </a:lnTo>
                  <a:lnTo>
                    <a:pt x="412" y="82"/>
                  </a:lnTo>
                  <a:lnTo>
                    <a:pt x="398" y="82"/>
                  </a:lnTo>
                  <a:lnTo>
                    <a:pt x="384" y="95"/>
                  </a:lnTo>
                  <a:lnTo>
                    <a:pt x="371" y="95"/>
                  </a:lnTo>
                  <a:lnTo>
                    <a:pt x="357" y="110"/>
                  </a:lnTo>
                  <a:lnTo>
                    <a:pt x="343" y="123"/>
                  </a:lnTo>
                  <a:lnTo>
                    <a:pt x="330" y="123"/>
                  </a:lnTo>
                  <a:lnTo>
                    <a:pt x="316" y="137"/>
                  </a:lnTo>
                  <a:lnTo>
                    <a:pt x="302" y="151"/>
                  </a:lnTo>
                  <a:lnTo>
                    <a:pt x="289" y="151"/>
                  </a:lnTo>
                  <a:lnTo>
                    <a:pt x="274" y="164"/>
                  </a:lnTo>
                  <a:lnTo>
                    <a:pt x="274" y="179"/>
                  </a:lnTo>
                  <a:lnTo>
                    <a:pt x="261" y="179"/>
                  </a:lnTo>
                  <a:lnTo>
                    <a:pt x="247" y="192"/>
                  </a:lnTo>
                  <a:lnTo>
                    <a:pt x="233" y="205"/>
                  </a:lnTo>
                  <a:lnTo>
                    <a:pt x="220" y="220"/>
                  </a:lnTo>
                  <a:lnTo>
                    <a:pt x="205" y="233"/>
                  </a:lnTo>
                  <a:lnTo>
                    <a:pt x="192" y="247"/>
                  </a:lnTo>
                  <a:lnTo>
                    <a:pt x="179" y="261"/>
                  </a:lnTo>
                  <a:lnTo>
                    <a:pt x="179" y="274"/>
                  </a:lnTo>
                  <a:lnTo>
                    <a:pt x="164" y="274"/>
                  </a:lnTo>
                  <a:lnTo>
                    <a:pt x="151" y="289"/>
                  </a:lnTo>
                  <a:lnTo>
                    <a:pt x="151" y="302"/>
                  </a:lnTo>
                  <a:lnTo>
                    <a:pt x="137" y="316"/>
                  </a:lnTo>
                  <a:lnTo>
                    <a:pt x="123" y="330"/>
                  </a:lnTo>
                  <a:lnTo>
                    <a:pt x="123" y="343"/>
                  </a:lnTo>
                  <a:lnTo>
                    <a:pt x="110" y="357"/>
                  </a:lnTo>
                  <a:lnTo>
                    <a:pt x="95" y="371"/>
                  </a:lnTo>
                  <a:lnTo>
                    <a:pt x="95" y="384"/>
                  </a:lnTo>
                  <a:lnTo>
                    <a:pt x="82" y="398"/>
                  </a:lnTo>
                  <a:lnTo>
                    <a:pt x="82" y="412"/>
                  </a:lnTo>
                  <a:lnTo>
                    <a:pt x="69" y="426"/>
                  </a:lnTo>
                  <a:lnTo>
                    <a:pt x="69" y="440"/>
                  </a:lnTo>
                  <a:lnTo>
                    <a:pt x="54" y="453"/>
                  </a:lnTo>
                  <a:lnTo>
                    <a:pt x="54" y="467"/>
                  </a:lnTo>
                  <a:lnTo>
                    <a:pt x="54" y="481"/>
                  </a:lnTo>
                  <a:lnTo>
                    <a:pt x="41" y="481"/>
                  </a:lnTo>
                  <a:lnTo>
                    <a:pt x="41" y="495"/>
                  </a:lnTo>
                  <a:lnTo>
                    <a:pt x="41" y="508"/>
                  </a:lnTo>
                  <a:lnTo>
                    <a:pt x="27" y="522"/>
                  </a:lnTo>
                  <a:lnTo>
                    <a:pt x="27" y="536"/>
                  </a:lnTo>
                  <a:lnTo>
                    <a:pt x="27" y="549"/>
                  </a:lnTo>
                  <a:lnTo>
                    <a:pt x="13" y="563"/>
                  </a:lnTo>
                  <a:lnTo>
                    <a:pt x="13" y="577"/>
                  </a:lnTo>
                  <a:lnTo>
                    <a:pt x="13" y="591"/>
                  </a:lnTo>
                  <a:lnTo>
                    <a:pt x="13" y="605"/>
                  </a:lnTo>
                  <a:lnTo>
                    <a:pt x="13" y="618"/>
                  </a:lnTo>
                  <a:lnTo>
                    <a:pt x="0" y="632"/>
                  </a:lnTo>
                  <a:lnTo>
                    <a:pt x="0" y="646"/>
                  </a:lnTo>
                  <a:lnTo>
                    <a:pt x="0" y="659"/>
                  </a:lnTo>
                  <a:lnTo>
                    <a:pt x="0" y="674"/>
                  </a:lnTo>
                  <a:lnTo>
                    <a:pt x="0" y="687"/>
                  </a:lnTo>
                  <a:lnTo>
                    <a:pt x="0" y="700"/>
                  </a:lnTo>
                  <a:lnTo>
                    <a:pt x="0" y="715"/>
                  </a:lnTo>
                  <a:lnTo>
                    <a:pt x="0" y="728"/>
                  </a:lnTo>
                  <a:lnTo>
                    <a:pt x="0" y="742"/>
                  </a:lnTo>
                  <a:lnTo>
                    <a:pt x="0" y="756"/>
                  </a:lnTo>
                  <a:lnTo>
                    <a:pt x="0" y="769"/>
                  </a:lnTo>
                  <a:lnTo>
                    <a:pt x="0" y="784"/>
                  </a:lnTo>
                  <a:lnTo>
                    <a:pt x="0" y="797"/>
                  </a:lnTo>
                  <a:lnTo>
                    <a:pt x="0" y="810"/>
                  </a:lnTo>
                  <a:lnTo>
                    <a:pt x="0" y="825"/>
                  </a:lnTo>
                  <a:lnTo>
                    <a:pt x="0" y="838"/>
                  </a:lnTo>
                  <a:lnTo>
                    <a:pt x="0" y="852"/>
                  </a:lnTo>
                  <a:lnTo>
                    <a:pt x="0" y="866"/>
                  </a:lnTo>
                  <a:lnTo>
                    <a:pt x="0" y="879"/>
                  </a:lnTo>
                  <a:lnTo>
                    <a:pt x="0" y="894"/>
                  </a:lnTo>
                  <a:lnTo>
                    <a:pt x="13" y="907"/>
                  </a:lnTo>
                  <a:lnTo>
                    <a:pt x="13" y="920"/>
                  </a:lnTo>
                  <a:lnTo>
                    <a:pt x="13" y="935"/>
                  </a:lnTo>
                  <a:lnTo>
                    <a:pt x="13" y="948"/>
                  </a:lnTo>
                  <a:lnTo>
                    <a:pt x="13" y="962"/>
                  </a:lnTo>
                  <a:lnTo>
                    <a:pt x="27" y="976"/>
                  </a:lnTo>
                  <a:lnTo>
                    <a:pt x="27" y="989"/>
                  </a:lnTo>
                  <a:lnTo>
                    <a:pt x="27" y="1003"/>
                  </a:lnTo>
                  <a:lnTo>
                    <a:pt x="41" y="1017"/>
                  </a:lnTo>
                  <a:lnTo>
                    <a:pt x="41" y="1031"/>
                  </a:lnTo>
                  <a:lnTo>
                    <a:pt x="41" y="1045"/>
                  </a:lnTo>
                  <a:lnTo>
                    <a:pt x="54" y="1045"/>
                  </a:lnTo>
                  <a:lnTo>
                    <a:pt x="54" y="1058"/>
                  </a:lnTo>
                  <a:lnTo>
                    <a:pt x="54" y="1072"/>
                  </a:lnTo>
                  <a:lnTo>
                    <a:pt x="69" y="1086"/>
                  </a:lnTo>
                  <a:lnTo>
                    <a:pt x="69" y="1099"/>
                  </a:lnTo>
                  <a:lnTo>
                    <a:pt x="82" y="1113"/>
                  </a:lnTo>
                  <a:lnTo>
                    <a:pt x="82" y="1127"/>
                  </a:lnTo>
                  <a:lnTo>
                    <a:pt x="95" y="1141"/>
                  </a:lnTo>
                  <a:lnTo>
                    <a:pt x="95" y="1155"/>
                  </a:lnTo>
                  <a:lnTo>
                    <a:pt x="110" y="1168"/>
                  </a:lnTo>
                  <a:lnTo>
                    <a:pt x="123" y="1182"/>
                  </a:lnTo>
                  <a:lnTo>
                    <a:pt x="123" y="1196"/>
                  </a:lnTo>
                  <a:lnTo>
                    <a:pt x="137" y="1210"/>
                  </a:lnTo>
                  <a:lnTo>
                    <a:pt x="151" y="1223"/>
                  </a:lnTo>
                  <a:lnTo>
                    <a:pt x="151" y="1237"/>
                  </a:lnTo>
                  <a:lnTo>
                    <a:pt x="164" y="1251"/>
                  </a:lnTo>
                  <a:lnTo>
                    <a:pt x="179" y="1251"/>
                  </a:lnTo>
                  <a:lnTo>
                    <a:pt x="179" y="1264"/>
                  </a:lnTo>
                  <a:lnTo>
                    <a:pt x="192" y="1278"/>
                  </a:lnTo>
                  <a:lnTo>
                    <a:pt x="205" y="1292"/>
                  </a:lnTo>
                  <a:lnTo>
                    <a:pt x="220" y="1306"/>
                  </a:lnTo>
                  <a:lnTo>
                    <a:pt x="233" y="1320"/>
                  </a:lnTo>
                  <a:lnTo>
                    <a:pt x="247" y="1333"/>
                  </a:lnTo>
                  <a:lnTo>
                    <a:pt x="261" y="1347"/>
                  </a:lnTo>
                  <a:lnTo>
                    <a:pt x="274" y="1347"/>
                  </a:lnTo>
                  <a:lnTo>
                    <a:pt x="274" y="1361"/>
                  </a:lnTo>
                  <a:lnTo>
                    <a:pt x="289" y="1374"/>
                  </a:lnTo>
                  <a:lnTo>
                    <a:pt x="302" y="1374"/>
                  </a:lnTo>
                  <a:lnTo>
                    <a:pt x="316" y="1389"/>
                  </a:lnTo>
                  <a:lnTo>
                    <a:pt x="330" y="1402"/>
                  </a:lnTo>
                  <a:lnTo>
                    <a:pt x="343" y="1402"/>
                  </a:lnTo>
                  <a:lnTo>
                    <a:pt x="357" y="1415"/>
                  </a:lnTo>
                  <a:lnTo>
                    <a:pt x="371" y="1430"/>
                  </a:lnTo>
                  <a:lnTo>
                    <a:pt x="384" y="1430"/>
                  </a:lnTo>
                  <a:lnTo>
                    <a:pt x="398" y="1443"/>
                  </a:lnTo>
                  <a:lnTo>
                    <a:pt x="412" y="1443"/>
                  </a:lnTo>
                  <a:lnTo>
                    <a:pt x="426" y="1457"/>
                  </a:lnTo>
                  <a:lnTo>
                    <a:pt x="440" y="1457"/>
                  </a:lnTo>
                  <a:lnTo>
                    <a:pt x="453" y="1471"/>
                  </a:lnTo>
                  <a:lnTo>
                    <a:pt x="467" y="1471"/>
                  </a:lnTo>
                  <a:lnTo>
                    <a:pt x="481" y="1471"/>
                  </a:lnTo>
                  <a:lnTo>
                    <a:pt x="481" y="1484"/>
                  </a:lnTo>
                  <a:lnTo>
                    <a:pt x="495" y="1484"/>
                  </a:lnTo>
                  <a:lnTo>
                    <a:pt x="508" y="1484"/>
                  </a:lnTo>
                  <a:lnTo>
                    <a:pt x="522" y="1499"/>
                  </a:lnTo>
                  <a:lnTo>
                    <a:pt x="536" y="1499"/>
                  </a:lnTo>
                  <a:lnTo>
                    <a:pt x="549" y="1499"/>
                  </a:lnTo>
                  <a:lnTo>
                    <a:pt x="563" y="1512"/>
                  </a:lnTo>
                  <a:lnTo>
                    <a:pt x="577" y="1512"/>
                  </a:lnTo>
                  <a:lnTo>
                    <a:pt x="591" y="1512"/>
                  </a:lnTo>
                  <a:lnTo>
                    <a:pt x="605" y="1512"/>
                  </a:lnTo>
                  <a:lnTo>
                    <a:pt x="618" y="1512"/>
                  </a:lnTo>
                  <a:lnTo>
                    <a:pt x="632" y="1525"/>
                  </a:lnTo>
                  <a:lnTo>
                    <a:pt x="646" y="1525"/>
                  </a:lnTo>
                  <a:lnTo>
                    <a:pt x="659" y="1525"/>
                  </a:lnTo>
                  <a:lnTo>
                    <a:pt x="674" y="1525"/>
                  </a:lnTo>
                  <a:lnTo>
                    <a:pt x="687" y="1525"/>
                  </a:lnTo>
                  <a:lnTo>
                    <a:pt x="700" y="1525"/>
                  </a:lnTo>
                  <a:lnTo>
                    <a:pt x="715" y="1525"/>
                  </a:lnTo>
                  <a:lnTo>
                    <a:pt x="728" y="1525"/>
                  </a:lnTo>
                  <a:lnTo>
                    <a:pt x="742" y="1525"/>
                  </a:lnTo>
                  <a:lnTo>
                    <a:pt x="756" y="1525"/>
                  </a:lnTo>
                  <a:lnTo>
                    <a:pt x="769" y="1525"/>
                  </a:lnTo>
                  <a:lnTo>
                    <a:pt x="784" y="1525"/>
                  </a:lnTo>
                  <a:lnTo>
                    <a:pt x="797" y="1525"/>
                  </a:lnTo>
                  <a:lnTo>
                    <a:pt x="810" y="1525"/>
                  </a:lnTo>
                  <a:lnTo>
                    <a:pt x="825" y="1525"/>
                  </a:lnTo>
                  <a:lnTo>
                    <a:pt x="838" y="1525"/>
                  </a:lnTo>
                  <a:lnTo>
                    <a:pt x="852" y="1525"/>
                  </a:lnTo>
                  <a:lnTo>
                    <a:pt x="866" y="1525"/>
                  </a:lnTo>
                  <a:lnTo>
                    <a:pt x="879" y="1525"/>
                  </a:lnTo>
                  <a:lnTo>
                    <a:pt x="894" y="1525"/>
                  </a:lnTo>
                  <a:lnTo>
                    <a:pt x="907" y="1512"/>
                  </a:lnTo>
                  <a:lnTo>
                    <a:pt x="920" y="1512"/>
                  </a:lnTo>
                  <a:lnTo>
                    <a:pt x="935" y="1512"/>
                  </a:lnTo>
                  <a:lnTo>
                    <a:pt x="948" y="1512"/>
                  </a:lnTo>
                  <a:lnTo>
                    <a:pt x="962" y="1512"/>
                  </a:lnTo>
                  <a:lnTo>
                    <a:pt x="976" y="1499"/>
                  </a:lnTo>
                  <a:lnTo>
                    <a:pt x="989" y="1499"/>
                  </a:lnTo>
                  <a:lnTo>
                    <a:pt x="1003" y="1499"/>
                  </a:lnTo>
                  <a:lnTo>
                    <a:pt x="1017" y="1484"/>
                  </a:lnTo>
                  <a:lnTo>
                    <a:pt x="1031" y="1484"/>
                  </a:lnTo>
                  <a:lnTo>
                    <a:pt x="1045" y="1484"/>
                  </a:lnTo>
                  <a:lnTo>
                    <a:pt x="1045" y="1471"/>
                  </a:lnTo>
                  <a:lnTo>
                    <a:pt x="1058" y="1471"/>
                  </a:lnTo>
                  <a:lnTo>
                    <a:pt x="1072" y="1471"/>
                  </a:lnTo>
                  <a:lnTo>
                    <a:pt x="1086" y="1457"/>
                  </a:lnTo>
                  <a:lnTo>
                    <a:pt x="1099" y="1457"/>
                  </a:lnTo>
                  <a:lnTo>
                    <a:pt x="1113" y="1443"/>
                  </a:lnTo>
                  <a:lnTo>
                    <a:pt x="1127" y="1443"/>
                  </a:lnTo>
                  <a:lnTo>
                    <a:pt x="1141" y="1430"/>
                  </a:lnTo>
                  <a:lnTo>
                    <a:pt x="1155" y="1430"/>
                  </a:lnTo>
                  <a:lnTo>
                    <a:pt x="1168" y="1415"/>
                  </a:lnTo>
                  <a:lnTo>
                    <a:pt x="1182" y="1402"/>
                  </a:lnTo>
                  <a:lnTo>
                    <a:pt x="1196" y="1402"/>
                  </a:lnTo>
                  <a:lnTo>
                    <a:pt x="1210" y="1389"/>
                  </a:lnTo>
                  <a:lnTo>
                    <a:pt x="1223" y="1374"/>
                  </a:lnTo>
                  <a:lnTo>
                    <a:pt x="1237" y="1374"/>
                  </a:lnTo>
                  <a:lnTo>
                    <a:pt x="1251" y="1361"/>
                  </a:lnTo>
                  <a:lnTo>
                    <a:pt x="1251" y="1347"/>
                  </a:lnTo>
                  <a:lnTo>
                    <a:pt x="1264" y="1347"/>
                  </a:lnTo>
                  <a:lnTo>
                    <a:pt x="1278" y="1333"/>
                  </a:lnTo>
                  <a:lnTo>
                    <a:pt x="1292" y="1320"/>
                  </a:lnTo>
                  <a:lnTo>
                    <a:pt x="1306" y="1306"/>
                  </a:lnTo>
                  <a:lnTo>
                    <a:pt x="1320" y="1292"/>
                  </a:lnTo>
                  <a:lnTo>
                    <a:pt x="1333" y="1278"/>
                  </a:lnTo>
                  <a:lnTo>
                    <a:pt x="1347" y="1264"/>
                  </a:lnTo>
                  <a:lnTo>
                    <a:pt x="1347" y="1251"/>
                  </a:lnTo>
                  <a:lnTo>
                    <a:pt x="1361" y="1251"/>
                  </a:lnTo>
                  <a:lnTo>
                    <a:pt x="1374" y="1237"/>
                  </a:lnTo>
                  <a:lnTo>
                    <a:pt x="1374" y="1223"/>
                  </a:lnTo>
                  <a:lnTo>
                    <a:pt x="1389" y="1210"/>
                  </a:lnTo>
                  <a:lnTo>
                    <a:pt x="1402" y="1196"/>
                  </a:lnTo>
                  <a:lnTo>
                    <a:pt x="1402" y="1182"/>
                  </a:lnTo>
                  <a:lnTo>
                    <a:pt x="1415" y="1168"/>
                  </a:lnTo>
                  <a:lnTo>
                    <a:pt x="1430" y="1155"/>
                  </a:lnTo>
                  <a:lnTo>
                    <a:pt x="1430" y="1141"/>
                  </a:lnTo>
                  <a:lnTo>
                    <a:pt x="1443" y="1127"/>
                  </a:lnTo>
                  <a:lnTo>
                    <a:pt x="1443" y="1113"/>
                  </a:lnTo>
                  <a:lnTo>
                    <a:pt x="1457" y="1099"/>
                  </a:lnTo>
                  <a:lnTo>
                    <a:pt x="1457" y="1086"/>
                  </a:lnTo>
                  <a:lnTo>
                    <a:pt x="1471" y="1072"/>
                  </a:lnTo>
                  <a:lnTo>
                    <a:pt x="1471" y="1058"/>
                  </a:lnTo>
                  <a:lnTo>
                    <a:pt x="1471" y="1045"/>
                  </a:lnTo>
                  <a:lnTo>
                    <a:pt x="1484" y="1045"/>
                  </a:lnTo>
                  <a:lnTo>
                    <a:pt x="1484" y="1031"/>
                  </a:lnTo>
                  <a:lnTo>
                    <a:pt x="1484" y="1017"/>
                  </a:lnTo>
                  <a:lnTo>
                    <a:pt x="1499" y="1003"/>
                  </a:lnTo>
                  <a:lnTo>
                    <a:pt x="1499" y="989"/>
                  </a:lnTo>
                  <a:lnTo>
                    <a:pt x="1499" y="976"/>
                  </a:lnTo>
                  <a:lnTo>
                    <a:pt x="1512" y="962"/>
                  </a:lnTo>
                  <a:lnTo>
                    <a:pt x="1512" y="948"/>
                  </a:lnTo>
                  <a:lnTo>
                    <a:pt x="1512" y="935"/>
                  </a:lnTo>
                  <a:lnTo>
                    <a:pt x="1512" y="920"/>
                  </a:lnTo>
                  <a:lnTo>
                    <a:pt x="1512" y="907"/>
                  </a:lnTo>
                  <a:lnTo>
                    <a:pt x="1525" y="894"/>
                  </a:lnTo>
                  <a:lnTo>
                    <a:pt x="1525" y="879"/>
                  </a:lnTo>
                  <a:lnTo>
                    <a:pt x="1525" y="866"/>
                  </a:lnTo>
                  <a:lnTo>
                    <a:pt x="1525" y="852"/>
                  </a:lnTo>
                  <a:lnTo>
                    <a:pt x="1525" y="838"/>
                  </a:lnTo>
                  <a:lnTo>
                    <a:pt x="1525" y="825"/>
                  </a:lnTo>
                  <a:lnTo>
                    <a:pt x="1525" y="810"/>
                  </a:lnTo>
                  <a:lnTo>
                    <a:pt x="1525" y="797"/>
                  </a:lnTo>
                  <a:lnTo>
                    <a:pt x="1525" y="784"/>
                  </a:lnTo>
                  <a:lnTo>
                    <a:pt x="1525" y="769"/>
                  </a:lnTo>
                  <a:lnTo>
                    <a:pt x="1540" y="769"/>
                  </a:lnTo>
                  <a:close/>
                </a:path>
              </a:pathLst>
            </a:custGeom>
            <a:solidFill>
              <a:srgbClr val="ff33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0960" bIns="309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9" name=""/>
            <p:cNvSpPr/>
            <p:nvPr/>
          </p:nvSpPr>
          <p:spPr>
            <a:xfrm>
              <a:off x="3156480" y="1702080"/>
              <a:ext cx="214560" cy="214200"/>
            </a:xfrm>
            <a:prstGeom prst="rect">
              <a:avLst/>
            </a:prstGeom>
            <a:noFill/>
            <a:ln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0" name=""/>
            <p:cNvSpPr/>
            <p:nvPr/>
          </p:nvSpPr>
          <p:spPr>
            <a:xfrm>
              <a:off x="3191040" y="1738080"/>
              <a:ext cx="144000" cy="141840"/>
            </a:xfrm>
            <a:custGeom>
              <a:avLst/>
              <a:gdLst/>
              <a:ahLst/>
              <a:rect l="l" t="t" r="r" b="b"/>
              <a:pathLst>
                <a:path w="2750" h="2737">
                  <a:moveTo>
                    <a:pt x="2750" y="1376"/>
                  </a:moveTo>
                  <a:lnTo>
                    <a:pt x="2735" y="1348"/>
                  </a:lnTo>
                  <a:lnTo>
                    <a:pt x="2735" y="1320"/>
                  </a:lnTo>
                  <a:lnTo>
                    <a:pt x="2735" y="1293"/>
                  </a:lnTo>
                  <a:lnTo>
                    <a:pt x="2735" y="1279"/>
                  </a:lnTo>
                  <a:lnTo>
                    <a:pt x="2735" y="1252"/>
                  </a:lnTo>
                  <a:lnTo>
                    <a:pt x="2735" y="1224"/>
                  </a:lnTo>
                  <a:lnTo>
                    <a:pt x="2735" y="1197"/>
                  </a:lnTo>
                  <a:lnTo>
                    <a:pt x="2735" y="1183"/>
                  </a:lnTo>
                  <a:lnTo>
                    <a:pt x="2722" y="1156"/>
                  </a:lnTo>
                  <a:lnTo>
                    <a:pt x="2722" y="1128"/>
                  </a:lnTo>
                  <a:lnTo>
                    <a:pt x="2722" y="1101"/>
                  </a:lnTo>
                  <a:lnTo>
                    <a:pt x="2709" y="1087"/>
                  </a:lnTo>
                  <a:lnTo>
                    <a:pt x="2709" y="1059"/>
                  </a:lnTo>
                  <a:lnTo>
                    <a:pt x="2709" y="1032"/>
                  </a:lnTo>
                  <a:lnTo>
                    <a:pt x="2694" y="1018"/>
                  </a:lnTo>
                  <a:lnTo>
                    <a:pt x="2694" y="991"/>
                  </a:lnTo>
                  <a:lnTo>
                    <a:pt x="2681" y="963"/>
                  </a:lnTo>
                  <a:lnTo>
                    <a:pt x="2681" y="950"/>
                  </a:lnTo>
                  <a:lnTo>
                    <a:pt x="2667" y="922"/>
                  </a:lnTo>
                  <a:lnTo>
                    <a:pt x="2653" y="894"/>
                  </a:lnTo>
                  <a:lnTo>
                    <a:pt x="2653" y="881"/>
                  </a:lnTo>
                  <a:lnTo>
                    <a:pt x="2640" y="853"/>
                  </a:lnTo>
                  <a:lnTo>
                    <a:pt x="2640" y="825"/>
                  </a:lnTo>
                  <a:lnTo>
                    <a:pt x="2626" y="812"/>
                  </a:lnTo>
                  <a:lnTo>
                    <a:pt x="2612" y="784"/>
                  </a:lnTo>
                  <a:lnTo>
                    <a:pt x="2598" y="771"/>
                  </a:lnTo>
                  <a:lnTo>
                    <a:pt x="2598" y="743"/>
                  </a:lnTo>
                  <a:lnTo>
                    <a:pt x="2584" y="730"/>
                  </a:lnTo>
                  <a:lnTo>
                    <a:pt x="2571" y="702"/>
                  </a:lnTo>
                  <a:lnTo>
                    <a:pt x="2557" y="688"/>
                  </a:lnTo>
                  <a:lnTo>
                    <a:pt x="2543" y="661"/>
                  </a:lnTo>
                  <a:lnTo>
                    <a:pt x="2530" y="646"/>
                  </a:lnTo>
                  <a:lnTo>
                    <a:pt x="2516" y="619"/>
                  </a:lnTo>
                  <a:lnTo>
                    <a:pt x="2502" y="605"/>
                  </a:lnTo>
                  <a:lnTo>
                    <a:pt x="2488" y="578"/>
                  </a:lnTo>
                  <a:lnTo>
                    <a:pt x="2474" y="564"/>
                  </a:lnTo>
                  <a:lnTo>
                    <a:pt x="2461" y="537"/>
                  </a:lnTo>
                  <a:lnTo>
                    <a:pt x="2447" y="523"/>
                  </a:lnTo>
                  <a:lnTo>
                    <a:pt x="2433" y="509"/>
                  </a:lnTo>
                  <a:lnTo>
                    <a:pt x="2419" y="482"/>
                  </a:lnTo>
                  <a:lnTo>
                    <a:pt x="2406" y="468"/>
                  </a:lnTo>
                  <a:lnTo>
                    <a:pt x="2392" y="454"/>
                  </a:lnTo>
                  <a:lnTo>
                    <a:pt x="2378" y="427"/>
                  </a:lnTo>
                  <a:lnTo>
                    <a:pt x="2351" y="413"/>
                  </a:lnTo>
                  <a:lnTo>
                    <a:pt x="2337" y="399"/>
                  </a:lnTo>
                  <a:lnTo>
                    <a:pt x="2323" y="386"/>
                  </a:lnTo>
                  <a:lnTo>
                    <a:pt x="2309" y="358"/>
                  </a:lnTo>
                  <a:lnTo>
                    <a:pt x="2282" y="344"/>
                  </a:lnTo>
                  <a:lnTo>
                    <a:pt x="2268" y="330"/>
                  </a:lnTo>
                  <a:lnTo>
                    <a:pt x="2255" y="317"/>
                  </a:lnTo>
                  <a:lnTo>
                    <a:pt x="2227" y="303"/>
                  </a:lnTo>
                  <a:lnTo>
                    <a:pt x="2214" y="289"/>
                  </a:lnTo>
                  <a:lnTo>
                    <a:pt x="2199" y="276"/>
                  </a:lnTo>
                  <a:lnTo>
                    <a:pt x="2172" y="261"/>
                  </a:lnTo>
                  <a:lnTo>
                    <a:pt x="2158" y="248"/>
                  </a:lnTo>
                  <a:lnTo>
                    <a:pt x="2130" y="235"/>
                  </a:lnTo>
                  <a:lnTo>
                    <a:pt x="2117" y="220"/>
                  </a:lnTo>
                  <a:lnTo>
                    <a:pt x="2089" y="207"/>
                  </a:lnTo>
                  <a:lnTo>
                    <a:pt x="2076" y="193"/>
                  </a:lnTo>
                  <a:lnTo>
                    <a:pt x="2062" y="179"/>
                  </a:lnTo>
                  <a:lnTo>
                    <a:pt x="2035" y="166"/>
                  </a:lnTo>
                  <a:lnTo>
                    <a:pt x="2007" y="151"/>
                  </a:lnTo>
                  <a:lnTo>
                    <a:pt x="1994" y="138"/>
                  </a:lnTo>
                  <a:lnTo>
                    <a:pt x="1966" y="138"/>
                  </a:lnTo>
                  <a:lnTo>
                    <a:pt x="1952" y="125"/>
                  </a:lnTo>
                  <a:lnTo>
                    <a:pt x="1925" y="110"/>
                  </a:lnTo>
                  <a:lnTo>
                    <a:pt x="1911" y="97"/>
                  </a:lnTo>
                  <a:lnTo>
                    <a:pt x="1883" y="97"/>
                  </a:lnTo>
                  <a:lnTo>
                    <a:pt x="1856" y="82"/>
                  </a:lnTo>
                  <a:lnTo>
                    <a:pt x="1842" y="82"/>
                  </a:lnTo>
                  <a:lnTo>
                    <a:pt x="1815" y="69"/>
                  </a:lnTo>
                  <a:lnTo>
                    <a:pt x="1787" y="56"/>
                  </a:lnTo>
                  <a:lnTo>
                    <a:pt x="1773" y="56"/>
                  </a:lnTo>
                  <a:lnTo>
                    <a:pt x="1746" y="41"/>
                  </a:lnTo>
                  <a:lnTo>
                    <a:pt x="1718" y="41"/>
                  </a:lnTo>
                  <a:lnTo>
                    <a:pt x="1704" y="28"/>
                  </a:lnTo>
                  <a:lnTo>
                    <a:pt x="1677" y="28"/>
                  </a:lnTo>
                  <a:lnTo>
                    <a:pt x="1650" y="28"/>
                  </a:lnTo>
                  <a:lnTo>
                    <a:pt x="1636" y="15"/>
                  </a:lnTo>
                  <a:lnTo>
                    <a:pt x="1608" y="15"/>
                  </a:lnTo>
                  <a:lnTo>
                    <a:pt x="1581" y="15"/>
                  </a:lnTo>
                  <a:lnTo>
                    <a:pt x="1553" y="0"/>
                  </a:lnTo>
                  <a:lnTo>
                    <a:pt x="1540" y="0"/>
                  </a:lnTo>
                  <a:lnTo>
                    <a:pt x="1512" y="0"/>
                  </a:lnTo>
                  <a:lnTo>
                    <a:pt x="1484" y="0"/>
                  </a:lnTo>
                  <a:lnTo>
                    <a:pt x="1457" y="0"/>
                  </a:lnTo>
                  <a:lnTo>
                    <a:pt x="1443" y="0"/>
                  </a:lnTo>
                  <a:lnTo>
                    <a:pt x="1415" y="0"/>
                  </a:lnTo>
                  <a:lnTo>
                    <a:pt x="1389" y="0"/>
                  </a:lnTo>
                  <a:lnTo>
                    <a:pt x="1374" y="0"/>
                  </a:lnTo>
                  <a:lnTo>
                    <a:pt x="1347" y="0"/>
                  </a:lnTo>
                  <a:lnTo>
                    <a:pt x="1320" y="0"/>
                  </a:lnTo>
                  <a:lnTo>
                    <a:pt x="1292" y="0"/>
                  </a:lnTo>
                  <a:lnTo>
                    <a:pt x="1279" y="0"/>
                  </a:lnTo>
                  <a:lnTo>
                    <a:pt x="1251" y="0"/>
                  </a:lnTo>
                  <a:lnTo>
                    <a:pt x="1223" y="0"/>
                  </a:lnTo>
                  <a:lnTo>
                    <a:pt x="1196" y="0"/>
                  </a:lnTo>
                  <a:lnTo>
                    <a:pt x="1182" y="0"/>
                  </a:lnTo>
                  <a:lnTo>
                    <a:pt x="1154" y="15"/>
                  </a:lnTo>
                  <a:lnTo>
                    <a:pt x="1127" y="15"/>
                  </a:lnTo>
                  <a:lnTo>
                    <a:pt x="1100" y="15"/>
                  </a:lnTo>
                  <a:lnTo>
                    <a:pt x="1086" y="28"/>
                  </a:lnTo>
                  <a:lnTo>
                    <a:pt x="1058" y="28"/>
                  </a:lnTo>
                  <a:lnTo>
                    <a:pt x="1031" y="28"/>
                  </a:lnTo>
                  <a:lnTo>
                    <a:pt x="1017" y="41"/>
                  </a:lnTo>
                  <a:lnTo>
                    <a:pt x="989" y="41"/>
                  </a:lnTo>
                  <a:lnTo>
                    <a:pt x="962" y="56"/>
                  </a:lnTo>
                  <a:lnTo>
                    <a:pt x="948" y="56"/>
                  </a:lnTo>
                  <a:lnTo>
                    <a:pt x="921" y="69"/>
                  </a:lnTo>
                  <a:lnTo>
                    <a:pt x="894" y="82"/>
                  </a:lnTo>
                  <a:lnTo>
                    <a:pt x="879" y="82"/>
                  </a:lnTo>
                  <a:lnTo>
                    <a:pt x="852" y="97"/>
                  </a:lnTo>
                  <a:lnTo>
                    <a:pt x="825" y="97"/>
                  </a:lnTo>
                  <a:lnTo>
                    <a:pt x="810" y="110"/>
                  </a:lnTo>
                  <a:lnTo>
                    <a:pt x="784" y="125"/>
                  </a:lnTo>
                  <a:lnTo>
                    <a:pt x="769" y="138"/>
                  </a:lnTo>
                  <a:lnTo>
                    <a:pt x="742" y="138"/>
                  </a:lnTo>
                  <a:lnTo>
                    <a:pt x="728" y="151"/>
                  </a:lnTo>
                  <a:lnTo>
                    <a:pt x="700" y="166"/>
                  </a:lnTo>
                  <a:lnTo>
                    <a:pt x="687" y="179"/>
                  </a:lnTo>
                  <a:lnTo>
                    <a:pt x="659" y="193"/>
                  </a:lnTo>
                  <a:lnTo>
                    <a:pt x="646" y="207"/>
                  </a:lnTo>
                  <a:lnTo>
                    <a:pt x="618" y="220"/>
                  </a:lnTo>
                  <a:lnTo>
                    <a:pt x="605" y="235"/>
                  </a:lnTo>
                  <a:lnTo>
                    <a:pt x="577" y="248"/>
                  </a:lnTo>
                  <a:lnTo>
                    <a:pt x="564" y="261"/>
                  </a:lnTo>
                  <a:lnTo>
                    <a:pt x="536" y="276"/>
                  </a:lnTo>
                  <a:lnTo>
                    <a:pt x="522" y="289"/>
                  </a:lnTo>
                  <a:lnTo>
                    <a:pt x="508" y="303"/>
                  </a:lnTo>
                  <a:lnTo>
                    <a:pt x="481" y="317"/>
                  </a:lnTo>
                  <a:lnTo>
                    <a:pt x="467" y="330"/>
                  </a:lnTo>
                  <a:lnTo>
                    <a:pt x="453" y="344"/>
                  </a:lnTo>
                  <a:lnTo>
                    <a:pt x="426" y="358"/>
                  </a:lnTo>
                  <a:lnTo>
                    <a:pt x="412" y="386"/>
                  </a:lnTo>
                  <a:lnTo>
                    <a:pt x="398" y="399"/>
                  </a:lnTo>
                  <a:lnTo>
                    <a:pt x="385" y="413"/>
                  </a:lnTo>
                  <a:lnTo>
                    <a:pt x="357" y="427"/>
                  </a:lnTo>
                  <a:lnTo>
                    <a:pt x="343" y="454"/>
                  </a:lnTo>
                  <a:lnTo>
                    <a:pt x="330" y="468"/>
                  </a:lnTo>
                  <a:lnTo>
                    <a:pt x="316" y="482"/>
                  </a:lnTo>
                  <a:lnTo>
                    <a:pt x="302" y="509"/>
                  </a:lnTo>
                  <a:lnTo>
                    <a:pt x="288" y="523"/>
                  </a:lnTo>
                  <a:lnTo>
                    <a:pt x="274" y="537"/>
                  </a:lnTo>
                  <a:lnTo>
                    <a:pt x="261" y="564"/>
                  </a:lnTo>
                  <a:lnTo>
                    <a:pt x="247" y="578"/>
                  </a:lnTo>
                  <a:lnTo>
                    <a:pt x="233" y="605"/>
                  </a:lnTo>
                  <a:lnTo>
                    <a:pt x="220" y="619"/>
                  </a:lnTo>
                  <a:lnTo>
                    <a:pt x="206" y="646"/>
                  </a:lnTo>
                  <a:lnTo>
                    <a:pt x="192" y="661"/>
                  </a:lnTo>
                  <a:lnTo>
                    <a:pt x="179" y="674"/>
                  </a:lnTo>
                  <a:lnTo>
                    <a:pt x="164" y="702"/>
                  </a:lnTo>
                  <a:lnTo>
                    <a:pt x="151" y="730"/>
                  </a:lnTo>
                  <a:lnTo>
                    <a:pt x="137" y="743"/>
                  </a:lnTo>
                  <a:lnTo>
                    <a:pt x="137" y="771"/>
                  </a:lnTo>
                  <a:lnTo>
                    <a:pt x="123" y="784"/>
                  </a:lnTo>
                  <a:lnTo>
                    <a:pt x="110" y="812"/>
                  </a:lnTo>
                  <a:lnTo>
                    <a:pt x="95" y="825"/>
                  </a:lnTo>
                  <a:lnTo>
                    <a:pt x="95" y="853"/>
                  </a:lnTo>
                  <a:lnTo>
                    <a:pt x="82" y="881"/>
                  </a:lnTo>
                  <a:lnTo>
                    <a:pt x="82" y="894"/>
                  </a:lnTo>
                  <a:lnTo>
                    <a:pt x="69" y="922"/>
                  </a:lnTo>
                  <a:lnTo>
                    <a:pt x="54" y="950"/>
                  </a:lnTo>
                  <a:lnTo>
                    <a:pt x="54" y="963"/>
                  </a:lnTo>
                  <a:lnTo>
                    <a:pt x="41" y="991"/>
                  </a:lnTo>
                  <a:lnTo>
                    <a:pt x="41" y="1018"/>
                  </a:lnTo>
                  <a:lnTo>
                    <a:pt x="28" y="1032"/>
                  </a:lnTo>
                  <a:lnTo>
                    <a:pt x="28" y="1059"/>
                  </a:lnTo>
                  <a:lnTo>
                    <a:pt x="28" y="1087"/>
                  </a:lnTo>
                  <a:lnTo>
                    <a:pt x="13" y="1101"/>
                  </a:lnTo>
                  <a:lnTo>
                    <a:pt x="13" y="1128"/>
                  </a:lnTo>
                  <a:lnTo>
                    <a:pt x="13" y="1156"/>
                  </a:lnTo>
                  <a:lnTo>
                    <a:pt x="0" y="1183"/>
                  </a:lnTo>
                  <a:lnTo>
                    <a:pt x="0" y="1197"/>
                  </a:lnTo>
                  <a:lnTo>
                    <a:pt x="0" y="1224"/>
                  </a:lnTo>
                  <a:lnTo>
                    <a:pt x="0" y="1252"/>
                  </a:lnTo>
                  <a:lnTo>
                    <a:pt x="0" y="1279"/>
                  </a:lnTo>
                  <a:lnTo>
                    <a:pt x="0" y="1293"/>
                  </a:lnTo>
                  <a:lnTo>
                    <a:pt x="0" y="1320"/>
                  </a:lnTo>
                  <a:lnTo>
                    <a:pt x="0" y="1348"/>
                  </a:lnTo>
                  <a:lnTo>
                    <a:pt x="0" y="1361"/>
                  </a:lnTo>
                  <a:lnTo>
                    <a:pt x="0" y="1389"/>
                  </a:lnTo>
                  <a:lnTo>
                    <a:pt x="0" y="1417"/>
                  </a:lnTo>
                  <a:lnTo>
                    <a:pt x="0" y="1445"/>
                  </a:lnTo>
                  <a:lnTo>
                    <a:pt x="0" y="1458"/>
                  </a:lnTo>
                  <a:lnTo>
                    <a:pt x="0" y="1486"/>
                  </a:lnTo>
                  <a:lnTo>
                    <a:pt x="0" y="1514"/>
                  </a:lnTo>
                  <a:lnTo>
                    <a:pt x="0" y="1540"/>
                  </a:lnTo>
                  <a:lnTo>
                    <a:pt x="0" y="1555"/>
                  </a:lnTo>
                  <a:lnTo>
                    <a:pt x="13" y="1581"/>
                  </a:lnTo>
                  <a:lnTo>
                    <a:pt x="13" y="1609"/>
                  </a:lnTo>
                  <a:lnTo>
                    <a:pt x="13" y="1637"/>
                  </a:lnTo>
                  <a:lnTo>
                    <a:pt x="28" y="1650"/>
                  </a:lnTo>
                  <a:lnTo>
                    <a:pt x="28" y="1678"/>
                  </a:lnTo>
                  <a:lnTo>
                    <a:pt x="28" y="1706"/>
                  </a:lnTo>
                  <a:lnTo>
                    <a:pt x="41" y="1719"/>
                  </a:lnTo>
                  <a:lnTo>
                    <a:pt x="41" y="1747"/>
                  </a:lnTo>
                  <a:lnTo>
                    <a:pt x="54" y="1774"/>
                  </a:lnTo>
                  <a:lnTo>
                    <a:pt x="54" y="1788"/>
                  </a:lnTo>
                  <a:lnTo>
                    <a:pt x="69" y="1816"/>
                  </a:lnTo>
                  <a:lnTo>
                    <a:pt x="82" y="1843"/>
                  </a:lnTo>
                  <a:lnTo>
                    <a:pt x="82" y="1857"/>
                  </a:lnTo>
                  <a:lnTo>
                    <a:pt x="95" y="1884"/>
                  </a:lnTo>
                  <a:lnTo>
                    <a:pt x="95" y="1912"/>
                  </a:lnTo>
                  <a:lnTo>
                    <a:pt x="110" y="1925"/>
                  </a:lnTo>
                  <a:lnTo>
                    <a:pt x="123" y="1953"/>
                  </a:lnTo>
                  <a:lnTo>
                    <a:pt x="137" y="1967"/>
                  </a:lnTo>
                  <a:lnTo>
                    <a:pt x="137" y="1994"/>
                  </a:lnTo>
                  <a:lnTo>
                    <a:pt x="151" y="2008"/>
                  </a:lnTo>
                  <a:lnTo>
                    <a:pt x="164" y="2035"/>
                  </a:lnTo>
                  <a:lnTo>
                    <a:pt x="179" y="2050"/>
                  </a:lnTo>
                  <a:lnTo>
                    <a:pt x="192" y="2076"/>
                  </a:lnTo>
                  <a:lnTo>
                    <a:pt x="206" y="2091"/>
                  </a:lnTo>
                  <a:lnTo>
                    <a:pt x="220" y="2118"/>
                  </a:lnTo>
                  <a:lnTo>
                    <a:pt x="233" y="2132"/>
                  </a:lnTo>
                  <a:lnTo>
                    <a:pt x="247" y="2160"/>
                  </a:lnTo>
                  <a:lnTo>
                    <a:pt x="261" y="2173"/>
                  </a:lnTo>
                  <a:lnTo>
                    <a:pt x="274" y="2201"/>
                  </a:lnTo>
                  <a:lnTo>
                    <a:pt x="288" y="2214"/>
                  </a:lnTo>
                  <a:lnTo>
                    <a:pt x="302" y="2228"/>
                  </a:lnTo>
                  <a:lnTo>
                    <a:pt x="316" y="2255"/>
                  </a:lnTo>
                  <a:lnTo>
                    <a:pt x="330" y="2270"/>
                  </a:lnTo>
                  <a:lnTo>
                    <a:pt x="343" y="2283"/>
                  </a:lnTo>
                  <a:lnTo>
                    <a:pt x="357" y="2311"/>
                  </a:lnTo>
                  <a:lnTo>
                    <a:pt x="385" y="2324"/>
                  </a:lnTo>
                  <a:lnTo>
                    <a:pt x="398" y="2338"/>
                  </a:lnTo>
                  <a:lnTo>
                    <a:pt x="412" y="2352"/>
                  </a:lnTo>
                  <a:lnTo>
                    <a:pt x="426" y="2380"/>
                  </a:lnTo>
                  <a:lnTo>
                    <a:pt x="453" y="2393"/>
                  </a:lnTo>
                  <a:lnTo>
                    <a:pt x="467" y="2407"/>
                  </a:lnTo>
                  <a:lnTo>
                    <a:pt x="481" y="2421"/>
                  </a:lnTo>
                  <a:lnTo>
                    <a:pt x="508" y="2434"/>
                  </a:lnTo>
                  <a:lnTo>
                    <a:pt x="522" y="2448"/>
                  </a:lnTo>
                  <a:lnTo>
                    <a:pt x="536" y="2462"/>
                  </a:lnTo>
                  <a:lnTo>
                    <a:pt x="564" y="2475"/>
                  </a:lnTo>
                  <a:lnTo>
                    <a:pt x="577" y="2489"/>
                  </a:lnTo>
                  <a:lnTo>
                    <a:pt x="605" y="2503"/>
                  </a:lnTo>
                  <a:lnTo>
                    <a:pt x="618" y="2517"/>
                  </a:lnTo>
                  <a:lnTo>
                    <a:pt x="646" y="2531"/>
                  </a:lnTo>
                  <a:lnTo>
                    <a:pt x="659" y="2544"/>
                  </a:lnTo>
                  <a:lnTo>
                    <a:pt x="674" y="2558"/>
                  </a:lnTo>
                  <a:lnTo>
                    <a:pt x="700" y="2572"/>
                  </a:lnTo>
                  <a:lnTo>
                    <a:pt x="728" y="2586"/>
                  </a:lnTo>
                  <a:lnTo>
                    <a:pt x="742" y="2599"/>
                  </a:lnTo>
                  <a:lnTo>
                    <a:pt x="769" y="2599"/>
                  </a:lnTo>
                  <a:lnTo>
                    <a:pt x="784" y="2613"/>
                  </a:lnTo>
                  <a:lnTo>
                    <a:pt x="810" y="2627"/>
                  </a:lnTo>
                  <a:lnTo>
                    <a:pt x="825" y="2640"/>
                  </a:lnTo>
                  <a:lnTo>
                    <a:pt x="852" y="2640"/>
                  </a:lnTo>
                  <a:lnTo>
                    <a:pt x="879" y="2654"/>
                  </a:lnTo>
                  <a:lnTo>
                    <a:pt x="894" y="2654"/>
                  </a:lnTo>
                  <a:lnTo>
                    <a:pt x="921" y="2668"/>
                  </a:lnTo>
                  <a:lnTo>
                    <a:pt x="948" y="2682"/>
                  </a:lnTo>
                  <a:lnTo>
                    <a:pt x="962" y="2682"/>
                  </a:lnTo>
                  <a:lnTo>
                    <a:pt x="989" y="2696"/>
                  </a:lnTo>
                  <a:lnTo>
                    <a:pt x="1017" y="2696"/>
                  </a:lnTo>
                  <a:lnTo>
                    <a:pt x="1031" y="2709"/>
                  </a:lnTo>
                  <a:lnTo>
                    <a:pt x="1058" y="2709"/>
                  </a:lnTo>
                  <a:lnTo>
                    <a:pt x="1086" y="2709"/>
                  </a:lnTo>
                  <a:lnTo>
                    <a:pt x="1100" y="2723"/>
                  </a:lnTo>
                  <a:lnTo>
                    <a:pt x="1127" y="2723"/>
                  </a:lnTo>
                  <a:lnTo>
                    <a:pt x="1154" y="2723"/>
                  </a:lnTo>
                  <a:lnTo>
                    <a:pt x="1182" y="2737"/>
                  </a:lnTo>
                  <a:lnTo>
                    <a:pt x="1196" y="2737"/>
                  </a:lnTo>
                  <a:lnTo>
                    <a:pt x="1223" y="2737"/>
                  </a:lnTo>
                  <a:lnTo>
                    <a:pt x="1251" y="2737"/>
                  </a:lnTo>
                  <a:lnTo>
                    <a:pt x="1279" y="2737"/>
                  </a:lnTo>
                  <a:lnTo>
                    <a:pt x="1292" y="2737"/>
                  </a:lnTo>
                  <a:lnTo>
                    <a:pt x="1320" y="2737"/>
                  </a:lnTo>
                  <a:lnTo>
                    <a:pt x="1347" y="2737"/>
                  </a:lnTo>
                  <a:lnTo>
                    <a:pt x="1361" y="2737"/>
                  </a:lnTo>
                  <a:lnTo>
                    <a:pt x="1389" y="2737"/>
                  </a:lnTo>
                  <a:lnTo>
                    <a:pt x="1415" y="2737"/>
                  </a:lnTo>
                  <a:lnTo>
                    <a:pt x="1443" y="2737"/>
                  </a:lnTo>
                  <a:lnTo>
                    <a:pt x="1457" y="2737"/>
                  </a:lnTo>
                  <a:lnTo>
                    <a:pt x="1484" y="2737"/>
                  </a:lnTo>
                  <a:lnTo>
                    <a:pt x="1512" y="2737"/>
                  </a:lnTo>
                  <a:lnTo>
                    <a:pt x="1540" y="2737"/>
                  </a:lnTo>
                  <a:lnTo>
                    <a:pt x="1553" y="2737"/>
                  </a:lnTo>
                  <a:lnTo>
                    <a:pt x="1581" y="2723"/>
                  </a:lnTo>
                  <a:lnTo>
                    <a:pt x="1608" y="2723"/>
                  </a:lnTo>
                  <a:lnTo>
                    <a:pt x="1636" y="2723"/>
                  </a:lnTo>
                  <a:lnTo>
                    <a:pt x="1650" y="2709"/>
                  </a:lnTo>
                  <a:lnTo>
                    <a:pt x="1677" y="2709"/>
                  </a:lnTo>
                  <a:lnTo>
                    <a:pt x="1704" y="2709"/>
                  </a:lnTo>
                  <a:lnTo>
                    <a:pt x="1718" y="2696"/>
                  </a:lnTo>
                  <a:lnTo>
                    <a:pt x="1746" y="2696"/>
                  </a:lnTo>
                  <a:lnTo>
                    <a:pt x="1773" y="2682"/>
                  </a:lnTo>
                  <a:lnTo>
                    <a:pt x="1787" y="2682"/>
                  </a:lnTo>
                  <a:lnTo>
                    <a:pt x="1815" y="2668"/>
                  </a:lnTo>
                  <a:lnTo>
                    <a:pt x="1842" y="2654"/>
                  </a:lnTo>
                  <a:lnTo>
                    <a:pt x="1856" y="2654"/>
                  </a:lnTo>
                  <a:lnTo>
                    <a:pt x="1883" y="2640"/>
                  </a:lnTo>
                  <a:lnTo>
                    <a:pt x="1911" y="2640"/>
                  </a:lnTo>
                  <a:lnTo>
                    <a:pt x="1925" y="2627"/>
                  </a:lnTo>
                  <a:lnTo>
                    <a:pt x="1952" y="2613"/>
                  </a:lnTo>
                  <a:lnTo>
                    <a:pt x="1966" y="2599"/>
                  </a:lnTo>
                  <a:lnTo>
                    <a:pt x="1994" y="2599"/>
                  </a:lnTo>
                  <a:lnTo>
                    <a:pt x="2007" y="2586"/>
                  </a:lnTo>
                  <a:lnTo>
                    <a:pt x="2035" y="2572"/>
                  </a:lnTo>
                  <a:lnTo>
                    <a:pt x="2048" y="2558"/>
                  </a:lnTo>
                  <a:lnTo>
                    <a:pt x="2076" y="2544"/>
                  </a:lnTo>
                  <a:lnTo>
                    <a:pt x="2089" y="2531"/>
                  </a:lnTo>
                  <a:lnTo>
                    <a:pt x="2117" y="2517"/>
                  </a:lnTo>
                  <a:lnTo>
                    <a:pt x="2130" y="2503"/>
                  </a:lnTo>
                  <a:lnTo>
                    <a:pt x="2158" y="2489"/>
                  </a:lnTo>
                  <a:lnTo>
                    <a:pt x="2172" y="2475"/>
                  </a:lnTo>
                  <a:lnTo>
                    <a:pt x="2199" y="2462"/>
                  </a:lnTo>
                  <a:lnTo>
                    <a:pt x="2214" y="2448"/>
                  </a:lnTo>
                  <a:lnTo>
                    <a:pt x="2227" y="2434"/>
                  </a:lnTo>
                  <a:lnTo>
                    <a:pt x="2255" y="2421"/>
                  </a:lnTo>
                  <a:lnTo>
                    <a:pt x="2268" y="2407"/>
                  </a:lnTo>
                  <a:lnTo>
                    <a:pt x="2282" y="2393"/>
                  </a:lnTo>
                  <a:lnTo>
                    <a:pt x="2309" y="2380"/>
                  </a:lnTo>
                  <a:lnTo>
                    <a:pt x="2323" y="2352"/>
                  </a:lnTo>
                  <a:lnTo>
                    <a:pt x="2337" y="2338"/>
                  </a:lnTo>
                  <a:lnTo>
                    <a:pt x="2351" y="2324"/>
                  </a:lnTo>
                  <a:lnTo>
                    <a:pt x="2378" y="2311"/>
                  </a:lnTo>
                  <a:lnTo>
                    <a:pt x="2392" y="2283"/>
                  </a:lnTo>
                  <a:lnTo>
                    <a:pt x="2406" y="2270"/>
                  </a:lnTo>
                  <a:lnTo>
                    <a:pt x="2419" y="2255"/>
                  </a:lnTo>
                  <a:lnTo>
                    <a:pt x="2433" y="2228"/>
                  </a:lnTo>
                  <a:lnTo>
                    <a:pt x="2447" y="2214"/>
                  </a:lnTo>
                  <a:lnTo>
                    <a:pt x="2461" y="2201"/>
                  </a:lnTo>
                  <a:lnTo>
                    <a:pt x="2474" y="2173"/>
                  </a:lnTo>
                  <a:lnTo>
                    <a:pt x="2488" y="2160"/>
                  </a:lnTo>
                  <a:lnTo>
                    <a:pt x="2502" y="2132"/>
                  </a:lnTo>
                  <a:lnTo>
                    <a:pt x="2516" y="2118"/>
                  </a:lnTo>
                  <a:lnTo>
                    <a:pt x="2530" y="2091"/>
                  </a:lnTo>
                  <a:lnTo>
                    <a:pt x="2543" y="2076"/>
                  </a:lnTo>
                  <a:lnTo>
                    <a:pt x="2557" y="2063"/>
                  </a:lnTo>
                  <a:lnTo>
                    <a:pt x="2571" y="2035"/>
                  </a:lnTo>
                  <a:lnTo>
                    <a:pt x="2584" y="2008"/>
                  </a:lnTo>
                  <a:lnTo>
                    <a:pt x="2598" y="1994"/>
                  </a:lnTo>
                  <a:lnTo>
                    <a:pt x="2598" y="1967"/>
                  </a:lnTo>
                  <a:lnTo>
                    <a:pt x="2612" y="1953"/>
                  </a:lnTo>
                  <a:lnTo>
                    <a:pt x="2626" y="1925"/>
                  </a:lnTo>
                  <a:lnTo>
                    <a:pt x="2640" y="1912"/>
                  </a:lnTo>
                  <a:lnTo>
                    <a:pt x="2640" y="1884"/>
                  </a:lnTo>
                  <a:lnTo>
                    <a:pt x="2653" y="1857"/>
                  </a:lnTo>
                  <a:lnTo>
                    <a:pt x="2653" y="1843"/>
                  </a:lnTo>
                  <a:lnTo>
                    <a:pt x="2667" y="1816"/>
                  </a:lnTo>
                  <a:lnTo>
                    <a:pt x="2681" y="1788"/>
                  </a:lnTo>
                  <a:lnTo>
                    <a:pt x="2681" y="1774"/>
                  </a:lnTo>
                  <a:lnTo>
                    <a:pt x="2694" y="1747"/>
                  </a:lnTo>
                  <a:lnTo>
                    <a:pt x="2694" y="1719"/>
                  </a:lnTo>
                  <a:lnTo>
                    <a:pt x="2709" y="1706"/>
                  </a:lnTo>
                  <a:lnTo>
                    <a:pt x="2709" y="1678"/>
                  </a:lnTo>
                  <a:lnTo>
                    <a:pt x="2709" y="1650"/>
                  </a:lnTo>
                  <a:lnTo>
                    <a:pt x="2722" y="1637"/>
                  </a:lnTo>
                  <a:lnTo>
                    <a:pt x="2722" y="1609"/>
                  </a:lnTo>
                  <a:lnTo>
                    <a:pt x="2722" y="1581"/>
                  </a:lnTo>
                  <a:lnTo>
                    <a:pt x="2735" y="1555"/>
                  </a:lnTo>
                  <a:lnTo>
                    <a:pt x="2735" y="1540"/>
                  </a:lnTo>
                  <a:lnTo>
                    <a:pt x="2735" y="1514"/>
                  </a:lnTo>
                  <a:lnTo>
                    <a:pt x="2735" y="1486"/>
                  </a:lnTo>
                  <a:lnTo>
                    <a:pt x="2735" y="1458"/>
                  </a:lnTo>
                  <a:lnTo>
                    <a:pt x="2735" y="1445"/>
                  </a:lnTo>
                  <a:lnTo>
                    <a:pt x="2735" y="1417"/>
                  </a:lnTo>
                  <a:lnTo>
                    <a:pt x="2735" y="1389"/>
                  </a:lnTo>
                  <a:lnTo>
                    <a:pt x="2750" y="1376"/>
                  </a:lnTo>
                  <a:close/>
                </a:path>
              </a:pathLst>
            </a:custGeom>
            <a:solidFill>
              <a:srgbClr val="ff33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1" name=""/>
            <p:cNvSpPr/>
            <p:nvPr/>
          </p:nvSpPr>
          <p:spPr>
            <a:xfrm>
              <a:off x="3371400" y="1058760"/>
              <a:ext cx="214560" cy="213840"/>
            </a:xfrm>
            <a:prstGeom prst="rect">
              <a:avLst/>
            </a:prstGeom>
            <a:noFill/>
            <a:ln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2" name=""/>
            <p:cNvSpPr/>
            <p:nvPr/>
          </p:nvSpPr>
          <p:spPr>
            <a:xfrm>
              <a:off x="3382560" y="1068120"/>
              <a:ext cx="194400" cy="193680"/>
            </a:xfrm>
            <a:custGeom>
              <a:avLst/>
              <a:gdLst/>
              <a:ahLst/>
              <a:rect l="l" t="t" r="r" b="b"/>
              <a:pathLst>
                <a:path w="3712" h="3699">
                  <a:moveTo>
                    <a:pt x="3712" y="1856"/>
                  </a:moveTo>
                  <a:lnTo>
                    <a:pt x="3698" y="1815"/>
                  </a:lnTo>
                  <a:lnTo>
                    <a:pt x="3698" y="1787"/>
                  </a:lnTo>
                  <a:lnTo>
                    <a:pt x="3698" y="1746"/>
                  </a:lnTo>
                  <a:lnTo>
                    <a:pt x="3698" y="1718"/>
                  </a:lnTo>
                  <a:lnTo>
                    <a:pt x="3698" y="1692"/>
                  </a:lnTo>
                  <a:lnTo>
                    <a:pt x="3698" y="1651"/>
                  </a:lnTo>
                  <a:lnTo>
                    <a:pt x="3684" y="1623"/>
                  </a:lnTo>
                  <a:lnTo>
                    <a:pt x="3684" y="1595"/>
                  </a:lnTo>
                  <a:lnTo>
                    <a:pt x="3684" y="1554"/>
                  </a:lnTo>
                  <a:lnTo>
                    <a:pt x="3670" y="1526"/>
                  </a:lnTo>
                  <a:lnTo>
                    <a:pt x="3670" y="1499"/>
                  </a:lnTo>
                  <a:lnTo>
                    <a:pt x="3670" y="1458"/>
                  </a:lnTo>
                  <a:lnTo>
                    <a:pt x="3657" y="1430"/>
                  </a:lnTo>
                  <a:lnTo>
                    <a:pt x="3643" y="1403"/>
                  </a:lnTo>
                  <a:lnTo>
                    <a:pt x="3643" y="1375"/>
                  </a:lnTo>
                  <a:lnTo>
                    <a:pt x="3629" y="1334"/>
                  </a:lnTo>
                  <a:lnTo>
                    <a:pt x="3629" y="1307"/>
                  </a:lnTo>
                  <a:lnTo>
                    <a:pt x="3616" y="1279"/>
                  </a:lnTo>
                  <a:lnTo>
                    <a:pt x="3602" y="1251"/>
                  </a:lnTo>
                  <a:lnTo>
                    <a:pt x="3588" y="1210"/>
                  </a:lnTo>
                  <a:lnTo>
                    <a:pt x="3588" y="1182"/>
                  </a:lnTo>
                  <a:lnTo>
                    <a:pt x="3574" y="1156"/>
                  </a:lnTo>
                  <a:lnTo>
                    <a:pt x="3560" y="1128"/>
                  </a:lnTo>
                  <a:lnTo>
                    <a:pt x="3547" y="1100"/>
                  </a:lnTo>
                  <a:lnTo>
                    <a:pt x="3533" y="1059"/>
                  </a:lnTo>
                  <a:lnTo>
                    <a:pt x="3519" y="1031"/>
                  </a:lnTo>
                  <a:lnTo>
                    <a:pt x="3506" y="1004"/>
                  </a:lnTo>
                  <a:lnTo>
                    <a:pt x="3491" y="977"/>
                  </a:lnTo>
                  <a:lnTo>
                    <a:pt x="3478" y="949"/>
                  </a:lnTo>
                  <a:lnTo>
                    <a:pt x="3450" y="921"/>
                  </a:lnTo>
                  <a:lnTo>
                    <a:pt x="3437" y="894"/>
                  </a:lnTo>
                  <a:lnTo>
                    <a:pt x="3423" y="867"/>
                  </a:lnTo>
                  <a:lnTo>
                    <a:pt x="3409" y="839"/>
                  </a:lnTo>
                  <a:lnTo>
                    <a:pt x="3381" y="811"/>
                  </a:lnTo>
                  <a:lnTo>
                    <a:pt x="3368" y="784"/>
                  </a:lnTo>
                  <a:lnTo>
                    <a:pt x="3355" y="757"/>
                  </a:lnTo>
                  <a:lnTo>
                    <a:pt x="3327" y="729"/>
                  </a:lnTo>
                  <a:lnTo>
                    <a:pt x="3313" y="701"/>
                  </a:lnTo>
                  <a:lnTo>
                    <a:pt x="3286" y="688"/>
                  </a:lnTo>
                  <a:lnTo>
                    <a:pt x="3271" y="660"/>
                  </a:lnTo>
                  <a:lnTo>
                    <a:pt x="3245" y="633"/>
                  </a:lnTo>
                  <a:lnTo>
                    <a:pt x="3230" y="605"/>
                  </a:lnTo>
                  <a:lnTo>
                    <a:pt x="3203" y="578"/>
                  </a:lnTo>
                  <a:lnTo>
                    <a:pt x="3189" y="564"/>
                  </a:lnTo>
                  <a:lnTo>
                    <a:pt x="3162" y="536"/>
                  </a:lnTo>
                  <a:lnTo>
                    <a:pt x="3134" y="509"/>
                  </a:lnTo>
                  <a:lnTo>
                    <a:pt x="3120" y="495"/>
                  </a:lnTo>
                  <a:lnTo>
                    <a:pt x="3093" y="467"/>
                  </a:lnTo>
                  <a:lnTo>
                    <a:pt x="3066" y="454"/>
                  </a:lnTo>
                  <a:lnTo>
                    <a:pt x="3038" y="426"/>
                  </a:lnTo>
                  <a:lnTo>
                    <a:pt x="3011" y="413"/>
                  </a:lnTo>
                  <a:lnTo>
                    <a:pt x="2997" y="385"/>
                  </a:lnTo>
                  <a:lnTo>
                    <a:pt x="2969" y="372"/>
                  </a:lnTo>
                  <a:lnTo>
                    <a:pt x="2942" y="344"/>
                  </a:lnTo>
                  <a:lnTo>
                    <a:pt x="2914" y="331"/>
                  </a:lnTo>
                  <a:lnTo>
                    <a:pt x="2887" y="316"/>
                  </a:lnTo>
                  <a:lnTo>
                    <a:pt x="2860" y="289"/>
                  </a:lnTo>
                  <a:lnTo>
                    <a:pt x="2832" y="275"/>
                  </a:lnTo>
                  <a:lnTo>
                    <a:pt x="2804" y="262"/>
                  </a:lnTo>
                  <a:lnTo>
                    <a:pt x="2776" y="247"/>
                  </a:lnTo>
                  <a:lnTo>
                    <a:pt x="2750" y="221"/>
                  </a:lnTo>
                  <a:lnTo>
                    <a:pt x="2722" y="206"/>
                  </a:lnTo>
                  <a:lnTo>
                    <a:pt x="2694" y="193"/>
                  </a:lnTo>
                  <a:lnTo>
                    <a:pt x="2666" y="179"/>
                  </a:lnTo>
                  <a:lnTo>
                    <a:pt x="2640" y="165"/>
                  </a:lnTo>
                  <a:lnTo>
                    <a:pt x="2598" y="152"/>
                  </a:lnTo>
                  <a:lnTo>
                    <a:pt x="2571" y="138"/>
                  </a:lnTo>
                  <a:lnTo>
                    <a:pt x="2543" y="124"/>
                  </a:lnTo>
                  <a:lnTo>
                    <a:pt x="2515" y="110"/>
                  </a:lnTo>
                  <a:lnTo>
                    <a:pt x="2488" y="110"/>
                  </a:lnTo>
                  <a:lnTo>
                    <a:pt x="2447" y="96"/>
                  </a:lnTo>
                  <a:lnTo>
                    <a:pt x="2419" y="83"/>
                  </a:lnTo>
                  <a:lnTo>
                    <a:pt x="2392" y="69"/>
                  </a:lnTo>
                  <a:lnTo>
                    <a:pt x="2364" y="69"/>
                  </a:lnTo>
                  <a:lnTo>
                    <a:pt x="2323" y="55"/>
                  </a:lnTo>
                  <a:lnTo>
                    <a:pt x="2296" y="55"/>
                  </a:lnTo>
                  <a:lnTo>
                    <a:pt x="2268" y="42"/>
                  </a:lnTo>
                  <a:lnTo>
                    <a:pt x="2240" y="28"/>
                  </a:lnTo>
                  <a:lnTo>
                    <a:pt x="2199" y="28"/>
                  </a:lnTo>
                  <a:lnTo>
                    <a:pt x="2172" y="28"/>
                  </a:lnTo>
                  <a:lnTo>
                    <a:pt x="2145" y="14"/>
                  </a:lnTo>
                  <a:lnTo>
                    <a:pt x="2103" y="14"/>
                  </a:lnTo>
                  <a:lnTo>
                    <a:pt x="2076" y="14"/>
                  </a:lnTo>
                  <a:lnTo>
                    <a:pt x="2048" y="0"/>
                  </a:lnTo>
                  <a:lnTo>
                    <a:pt x="2007" y="0"/>
                  </a:lnTo>
                  <a:lnTo>
                    <a:pt x="1979" y="0"/>
                  </a:lnTo>
                  <a:lnTo>
                    <a:pt x="1951" y="0"/>
                  </a:lnTo>
                  <a:lnTo>
                    <a:pt x="1910" y="0"/>
                  </a:lnTo>
                  <a:lnTo>
                    <a:pt x="1883" y="0"/>
                  </a:lnTo>
                  <a:lnTo>
                    <a:pt x="1856" y="0"/>
                  </a:lnTo>
                  <a:lnTo>
                    <a:pt x="1815" y="0"/>
                  </a:lnTo>
                  <a:lnTo>
                    <a:pt x="1787" y="0"/>
                  </a:lnTo>
                  <a:lnTo>
                    <a:pt x="1746" y="0"/>
                  </a:lnTo>
                  <a:lnTo>
                    <a:pt x="1718" y="0"/>
                  </a:lnTo>
                  <a:lnTo>
                    <a:pt x="1690" y="0"/>
                  </a:lnTo>
                  <a:lnTo>
                    <a:pt x="1649" y="0"/>
                  </a:lnTo>
                  <a:lnTo>
                    <a:pt x="1622" y="14"/>
                  </a:lnTo>
                  <a:lnTo>
                    <a:pt x="1594" y="14"/>
                  </a:lnTo>
                  <a:lnTo>
                    <a:pt x="1553" y="14"/>
                  </a:lnTo>
                  <a:lnTo>
                    <a:pt x="1525" y="28"/>
                  </a:lnTo>
                  <a:lnTo>
                    <a:pt x="1498" y="28"/>
                  </a:lnTo>
                  <a:lnTo>
                    <a:pt x="1457" y="28"/>
                  </a:lnTo>
                  <a:lnTo>
                    <a:pt x="1430" y="42"/>
                  </a:lnTo>
                  <a:lnTo>
                    <a:pt x="1402" y="55"/>
                  </a:lnTo>
                  <a:lnTo>
                    <a:pt x="1374" y="55"/>
                  </a:lnTo>
                  <a:lnTo>
                    <a:pt x="1333" y="69"/>
                  </a:lnTo>
                  <a:lnTo>
                    <a:pt x="1305" y="69"/>
                  </a:lnTo>
                  <a:lnTo>
                    <a:pt x="1279" y="83"/>
                  </a:lnTo>
                  <a:lnTo>
                    <a:pt x="1251" y="96"/>
                  </a:lnTo>
                  <a:lnTo>
                    <a:pt x="1210" y="110"/>
                  </a:lnTo>
                  <a:lnTo>
                    <a:pt x="1182" y="110"/>
                  </a:lnTo>
                  <a:lnTo>
                    <a:pt x="1154" y="124"/>
                  </a:lnTo>
                  <a:lnTo>
                    <a:pt x="1126" y="138"/>
                  </a:lnTo>
                  <a:lnTo>
                    <a:pt x="1099" y="152"/>
                  </a:lnTo>
                  <a:lnTo>
                    <a:pt x="1058" y="165"/>
                  </a:lnTo>
                  <a:lnTo>
                    <a:pt x="1031" y="179"/>
                  </a:lnTo>
                  <a:lnTo>
                    <a:pt x="1003" y="193"/>
                  </a:lnTo>
                  <a:lnTo>
                    <a:pt x="975" y="206"/>
                  </a:lnTo>
                  <a:lnTo>
                    <a:pt x="948" y="221"/>
                  </a:lnTo>
                  <a:lnTo>
                    <a:pt x="920" y="247"/>
                  </a:lnTo>
                  <a:lnTo>
                    <a:pt x="893" y="262"/>
                  </a:lnTo>
                  <a:lnTo>
                    <a:pt x="866" y="275"/>
                  </a:lnTo>
                  <a:lnTo>
                    <a:pt x="838" y="289"/>
                  </a:lnTo>
                  <a:lnTo>
                    <a:pt x="810" y="316"/>
                  </a:lnTo>
                  <a:lnTo>
                    <a:pt x="783" y="331"/>
                  </a:lnTo>
                  <a:lnTo>
                    <a:pt x="756" y="344"/>
                  </a:lnTo>
                  <a:lnTo>
                    <a:pt x="728" y="372"/>
                  </a:lnTo>
                  <a:lnTo>
                    <a:pt x="700" y="385"/>
                  </a:lnTo>
                  <a:lnTo>
                    <a:pt x="687" y="413"/>
                  </a:lnTo>
                  <a:lnTo>
                    <a:pt x="659" y="426"/>
                  </a:lnTo>
                  <a:lnTo>
                    <a:pt x="631" y="454"/>
                  </a:lnTo>
                  <a:lnTo>
                    <a:pt x="605" y="467"/>
                  </a:lnTo>
                  <a:lnTo>
                    <a:pt x="577" y="495"/>
                  </a:lnTo>
                  <a:lnTo>
                    <a:pt x="562" y="509"/>
                  </a:lnTo>
                  <a:lnTo>
                    <a:pt x="536" y="536"/>
                  </a:lnTo>
                  <a:lnTo>
                    <a:pt x="508" y="564"/>
                  </a:lnTo>
                  <a:lnTo>
                    <a:pt x="495" y="578"/>
                  </a:lnTo>
                  <a:lnTo>
                    <a:pt x="467" y="605"/>
                  </a:lnTo>
                  <a:lnTo>
                    <a:pt x="453" y="633"/>
                  </a:lnTo>
                  <a:lnTo>
                    <a:pt x="426" y="660"/>
                  </a:lnTo>
                  <a:lnTo>
                    <a:pt x="411" y="688"/>
                  </a:lnTo>
                  <a:lnTo>
                    <a:pt x="384" y="701"/>
                  </a:lnTo>
                  <a:lnTo>
                    <a:pt x="370" y="729"/>
                  </a:lnTo>
                  <a:lnTo>
                    <a:pt x="343" y="757"/>
                  </a:lnTo>
                  <a:lnTo>
                    <a:pt x="329" y="784"/>
                  </a:lnTo>
                  <a:lnTo>
                    <a:pt x="316" y="811"/>
                  </a:lnTo>
                  <a:lnTo>
                    <a:pt x="288" y="839"/>
                  </a:lnTo>
                  <a:lnTo>
                    <a:pt x="274" y="867"/>
                  </a:lnTo>
                  <a:lnTo>
                    <a:pt x="260" y="894"/>
                  </a:lnTo>
                  <a:lnTo>
                    <a:pt x="247" y="921"/>
                  </a:lnTo>
                  <a:lnTo>
                    <a:pt x="219" y="949"/>
                  </a:lnTo>
                  <a:lnTo>
                    <a:pt x="205" y="977"/>
                  </a:lnTo>
                  <a:lnTo>
                    <a:pt x="192" y="1004"/>
                  </a:lnTo>
                  <a:lnTo>
                    <a:pt x="178" y="1031"/>
                  </a:lnTo>
                  <a:lnTo>
                    <a:pt x="164" y="1059"/>
                  </a:lnTo>
                  <a:lnTo>
                    <a:pt x="151" y="1100"/>
                  </a:lnTo>
                  <a:lnTo>
                    <a:pt x="137" y="1128"/>
                  </a:lnTo>
                  <a:lnTo>
                    <a:pt x="123" y="1156"/>
                  </a:lnTo>
                  <a:lnTo>
                    <a:pt x="109" y="1182"/>
                  </a:lnTo>
                  <a:lnTo>
                    <a:pt x="109" y="1210"/>
                  </a:lnTo>
                  <a:lnTo>
                    <a:pt x="95" y="1251"/>
                  </a:lnTo>
                  <a:lnTo>
                    <a:pt x="82" y="1279"/>
                  </a:lnTo>
                  <a:lnTo>
                    <a:pt x="68" y="1307"/>
                  </a:lnTo>
                  <a:lnTo>
                    <a:pt x="68" y="1334"/>
                  </a:lnTo>
                  <a:lnTo>
                    <a:pt x="54" y="1375"/>
                  </a:lnTo>
                  <a:lnTo>
                    <a:pt x="54" y="1403"/>
                  </a:lnTo>
                  <a:lnTo>
                    <a:pt x="41" y="1430"/>
                  </a:lnTo>
                  <a:lnTo>
                    <a:pt x="26" y="1458"/>
                  </a:lnTo>
                  <a:lnTo>
                    <a:pt x="26" y="1499"/>
                  </a:lnTo>
                  <a:lnTo>
                    <a:pt x="26" y="1526"/>
                  </a:lnTo>
                  <a:lnTo>
                    <a:pt x="13" y="1554"/>
                  </a:lnTo>
                  <a:lnTo>
                    <a:pt x="13" y="1595"/>
                  </a:lnTo>
                  <a:lnTo>
                    <a:pt x="13" y="1623"/>
                  </a:lnTo>
                  <a:lnTo>
                    <a:pt x="0" y="1651"/>
                  </a:lnTo>
                  <a:lnTo>
                    <a:pt x="0" y="1692"/>
                  </a:lnTo>
                  <a:lnTo>
                    <a:pt x="0" y="1718"/>
                  </a:lnTo>
                  <a:lnTo>
                    <a:pt x="0" y="1746"/>
                  </a:lnTo>
                  <a:lnTo>
                    <a:pt x="0" y="1787"/>
                  </a:lnTo>
                  <a:lnTo>
                    <a:pt x="0" y="1815"/>
                  </a:lnTo>
                  <a:lnTo>
                    <a:pt x="0" y="1843"/>
                  </a:lnTo>
                  <a:lnTo>
                    <a:pt x="0" y="1884"/>
                  </a:lnTo>
                  <a:lnTo>
                    <a:pt x="0" y="1912"/>
                  </a:lnTo>
                  <a:lnTo>
                    <a:pt x="0" y="1953"/>
                  </a:lnTo>
                  <a:lnTo>
                    <a:pt x="0" y="1980"/>
                  </a:lnTo>
                  <a:lnTo>
                    <a:pt x="0" y="2008"/>
                  </a:lnTo>
                  <a:lnTo>
                    <a:pt x="0" y="2049"/>
                  </a:lnTo>
                  <a:lnTo>
                    <a:pt x="13" y="2076"/>
                  </a:lnTo>
                  <a:lnTo>
                    <a:pt x="13" y="2104"/>
                  </a:lnTo>
                  <a:lnTo>
                    <a:pt x="13" y="2145"/>
                  </a:lnTo>
                  <a:lnTo>
                    <a:pt x="26" y="2173"/>
                  </a:lnTo>
                  <a:lnTo>
                    <a:pt x="26" y="2200"/>
                  </a:lnTo>
                  <a:lnTo>
                    <a:pt x="26" y="2241"/>
                  </a:lnTo>
                  <a:lnTo>
                    <a:pt x="41" y="2269"/>
                  </a:lnTo>
                  <a:lnTo>
                    <a:pt x="54" y="2297"/>
                  </a:lnTo>
                  <a:lnTo>
                    <a:pt x="54" y="2324"/>
                  </a:lnTo>
                  <a:lnTo>
                    <a:pt x="68" y="2366"/>
                  </a:lnTo>
                  <a:lnTo>
                    <a:pt x="68" y="2392"/>
                  </a:lnTo>
                  <a:lnTo>
                    <a:pt x="82" y="2420"/>
                  </a:lnTo>
                  <a:lnTo>
                    <a:pt x="95" y="2448"/>
                  </a:lnTo>
                  <a:lnTo>
                    <a:pt x="109" y="2489"/>
                  </a:lnTo>
                  <a:lnTo>
                    <a:pt x="109" y="2517"/>
                  </a:lnTo>
                  <a:lnTo>
                    <a:pt x="123" y="2544"/>
                  </a:lnTo>
                  <a:lnTo>
                    <a:pt x="137" y="2571"/>
                  </a:lnTo>
                  <a:lnTo>
                    <a:pt x="151" y="2599"/>
                  </a:lnTo>
                  <a:lnTo>
                    <a:pt x="164" y="2640"/>
                  </a:lnTo>
                  <a:lnTo>
                    <a:pt x="178" y="2668"/>
                  </a:lnTo>
                  <a:lnTo>
                    <a:pt x="192" y="2695"/>
                  </a:lnTo>
                  <a:lnTo>
                    <a:pt x="205" y="2723"/>
                  </a:lnTo>
                  <a:lnTo>
                    <a:pt x="219" y="2750"/>
                  </a:lnTo>
                  <a:lnTo>
                    <a:pt x="247" y="2778"/>
                  </a:lnTo>
                  <a:lnTo>
                    <a:pt x="260" y="2805"/>
                  </a:lnTo>
                  <a:lnTo>
                    <a:pt x="274" y="2833"/>
                  </a:lnTo>
                  <a:lnTo>
                    <a:pt x="288" y="2860"/>
                  </a:lnTo>
                  <a:lnTo>
                    <a:pt x="316" y="2888"/>
                  </a:lnTo>
                  <a:lnTo>
                    <a:pt x="329" y="2915"/>
                  </a:lnTo>
                  <a:lnTo>
                    <a:pt x="343" y="2943"/>
                  </a:lnTo>
                  <a:lnTo>
                    <a:pt x="370" y="2971"/>
                  </a:lnTo>
                  <a:lnTo>
                    <a:pt x="384" y="2997"/>
                  </a:lnTo>
                  <a:lnTo>
                    <a:pt x="411" y="3012"/>
                  </a:lnTo>
                  <a:lnTo>
                    <a:pt x="426" y="3039"/>
                  </a:lnTo>
                  <a:lnTo>
                    <a:pt x="453" y="3066"/>
                  </a:lnTo>
                  <a:lnTo>
                    <a:pt x="467" y="3094"/>
                  </a:lnTo>
                  <a:lnTo>
                    <a:pt x="495" y="3122"/>
                  </a:lnTo>
                  <a:lnTo>
                    <a:pt x="508" y="3135"/>
                  </a:lnTo>
                  <a:lnTo>
                    <a:pt x="536" y="3163"/>
                  </a:lnTo>
                  <a:lnTo>
                    <a:pt x="562" y="3191"/>
                  </a:lnTo>
                  <a:lnTo>
                    <a:pt x="577" y="3204"/>
                  </a:lnTo>
                  <a:lnTo>
                    <a:pt x="605" y="3232"/>
                  </a:lnTo>
                  <a:lnTo>
                    <a:pt x="631" y="3245"/>
                  </a:lnTo>
                  <a:lnTo>
                    <a:pt x="659" y="3273"/>
                  </a:lnTo>
                  <a:lnTo>
                    <a:pt x="687" y="3286"/>
                  </a:lnTo>
                  <a:lnTo>
                    <a:pt x="700" y="3314"/>
                  </a:lnTo>
                  <a:lnTo>
                    <a:pt x="728" y="3328"/>
                  </a:lnTo>
                  <a:lnTo>
                    <a:pt x="756" y="3355"/>
                  </a:lnTo>
                  <a:lnTo>
                    <a:pt x="783" y="3369"/>
                  </a:lnTo>
                  <a:lnTo>
                    <a:pt x="810" y="3383"/>
                  </a:lnTo>
                  <a:lnTo>
                    <a:pt x="838" y="3410"/>
                  </a:lnTo>
                  <a:lnTo>
                    <a:pt x="866" y="3424"/>
                  </a:lnTo>
                  <a:lnTo>
                    <a:pt x="893" y="3438"/>
                  </a:lnTo>
                  <a:lnTo>
                    <a:pt x="920" y="3452"/>
                  </a:lnTo>
                  <a:lnTo>
                    <a:pt x="948" y="3479"/>
                  </a:lnTo>
                  <a:lnTo>
                    <a:pt x="975" y="3493"/>
                  </a:lnTo>
                  <a:lnTo>
                    <a:pt x="1003" y="3507"/>
                  </a:lnTo>
                  <a:lnTo>
                    <a:pt x="1031" y="3520"/>
                  </a:lnTo>
                  <a:lnTo>
                    <a:pt x="1058" y="3534"/>
                  </a:lnTo>
                  <a:lnTo>
                    <a:pt x="1099" y="3548"/>
                  </a:lnTo>
                  <a:lnTo>
                    <a:pt x="1126" y="3561"/>
                  </a:lnTo>
                  <a:lnTo>
                    <a:pt x="1154" y="3575"/>
                  </a:lnTo>
                  <a:lnTo>
                    <a:pt x="1182" y="3589"/>
                  </a:lnTo>
                  <a:lnTo>
                    <a:pt x="1210" y="3589"/>
                  </a:lnTo>
                  <a:lnTo>
                    <a:pt x="1251" y="3603"/>
                  </a:lnTo>
                  <a:lnTo>
                    <a:pt x="1279" y="3617"/>
                  </a:lnTo>
                  <a:lnTo>
                    <a:pt x="1305" y="3630"/>
                  </a:lnTo>
                  <a:lnTo>
                    <a:pt x="1333" y="3630"/>
                  </a:lnTo>
                  <a:lnTo>
                    <a:pt x="1374" y="3644"/>
                  </a:lnTo>
                  <a:lnTo>
                    <a:pt x="1402" y="3644"/>
                  </a:lnTo>
                  <a:lnTo>
                    <a:pt x="1430" y="3658"/>
                  </a:lnTo>
                  <a:lnTo>
                    <a:pt x="1457" y="3671"/>
                  </a:lnTo>
                  <a:lnTo>
                    <a:pt x="1498" y="3671"/>
                  </a:lnTo>
                  <a:lnTo>
                    <a:pt x="1525" y="3671"/>
                  </a:lnTo>
                  <a:lnTo>
                    <a:pt x="1553" y="3686"/>
                  </a:lnTo>
                  <a:lnTo>
                    <a:pt x="1594" y="3686"/>
                  </a:lnTo>
                  <a:lnTo>
                    <a:pt x="1622" y="3686"/>
                  </a:lnTo>
                  <a:lnTo>
                    <a:pt x="1649" y="3699"/>
                  </a:lnTo>
                  <a:lnTo>
                    <a:pt x="1690" y="3699"/>
                  </a:lnTo>
                  <a:lnTo>
                    <a:pt x="1718" y="3699"/>
                  </a:lnTo>
                  <a:lnTo>
                    <a:pt x="1746" y="3699"/>
                  </a:lnTo>
                  <a:lnTo>
                    <a:pt x="1787" y="3699"/>
                  </a:lnTo>
                  <a:lnTo>
                    <a:pt x="1815" y="3699"/>
                  </a:lnTo>
                  <a:lnTo>
                    <a:pt x="1841" y="3699"/>
                  </a:lnTo>
                  <a:lnTo>
                    <a:pt x="1883" y="3699"/>
                  </a:lnTo>
                  <a:lnTo>
                    <a:pt x="1910" y="3699"/>
                  </a:lnTo>
                  <a:lnTo>
                    <a:pt x="1951" y="3699"/>
                  </a:lnTo>
                  <a:lnTo>
                    <a:pt x="1979" y="3699"/>
                  </a:lnTo>
                  <a:lnTo>
                    <a:pt x="2007" y="3699"/>
                  </a:lnTo>
                  <a:lnTo>
                    <a:pt x="2048" y="3699"/>
                  </a:lnTo>
                  <a:lnTo>
                    <a:pt x="2076" y="3686"/>
                  </a:lnTo>
                  <a:lnTo>
                    <a:pt x="2103" y="3686"/>
                  </a:lnTo>
                  <a:lnTo>
                    <a:pt x="2145" y="3686"/>
                  </a:lnTo>
                  <a:lnTo>
                    <a:pt x="2172" y="3671"/>
                  </a:lnTo>
                  <a:lnTo>
                    <a:pt x="2199" y="3671"/>
                  </a:lnTo>
                  <a:lnTo>
                    <a:pt x="2240" y="3671"/>
                  </a:lnTo>
                  <a:lnTo>
                    <a:pt x="2268" y="3658"/>
                  </a:lnTo>
                  <a:lnTo>
                    <a:pt x="2296" y="3644"/>
                  </a:lnTo>
                  <a:lnTo>
                    <a:pt x="2323" y="3644"/>
                  </a:lnTo>
                  <a:lnTo>
                    <a:pt x="2364" y="3630"/>
                  </a:lnTo>
                  <a:lnTo>
                    <a:pt x="2392" y="3630"/>
                  </a:lnTo>
                  <a:lnTo>
                    <a:pt x="2419" y="3617"/>
                  </a:lnTo>
                  <a:lnTo>
                    <a:pt x="2447" y="3603"/>
                  </a:lnTo>
                  <a:lnTo>
                    <a:pt x="2488" y="3589"/>
                  </a:lnTo>
                  <a:lnTo>
                    <a:pt x="2515" y="3589"/>
                  </a:lnTo>
                  <a:lnTo>
                    <a:pt x="2543" y="3575"/>
                  </a:lnTo>
                  <a:lnTo>
                    <a:pt x="2571" y="3561"/>
                  </a:lnTo>
                  <a:lnTo>
                    <a:pt x="2598" y="3548"/>
                  </a:lnTo>
                  <a:lnTo>
                    <a:pt x="2640" y="3534"/>
                  </a:lnTo>
                  <a:lnTo>
                    <a:pt x="2666" y="3520"/>
                  </a:lnTo>
                  <a:lnTo>
                    <a:pt x="2694" y="3507"/>
                  </a:lnTo>
                  <a:lnTo>
                    <a:pt x="2722" y="3493"/>
                  </a:lnTo>
                  <a:lnTo>
                    <a:pt x="2750" y="3479"/>
                  </a:lnTo>
                  <a:lnTo>
                    <a:pt x="2776" y="3452"/>
                  </a:lnTo>
                  <a:lnTo>
                    <a:pt x="2804" y="3438"/>
                  </a:lnTo>
                  <a:lnTo>
                    <a:pt x="2832" y="3424"/>
                  </a:lnTo>
                  <a:lnTo>
                    <a:pt x="2860" y="3410"/>
                  </a:lnTo>
                  <a:lnTo>
                    <a:pt x="2887" y="3383"/>
                  </a:lnTo>
                  <a:lnTo>
                    <a:pt x="2914" y="3369"/>
                  </a:lnTo>
                  <a:lnTo>
                    <a:pt x="2942" y="3355"/>
                  </a:lnTo>
                  <a:lnTo>
                    <a:pt x="2969" y="3328"/>
                  </a:lnTo>
                  <a:lnTo>
                    <a:pt x="2997" y="3314"/>
                  </a:lnTo>
                  <a:lnTo>
                    <a:pt x="3011" y="3286"/>
                  </a:lnTo>
                  <a:lnTo>
                    <a:pt x="3038" y="3273"/>
                  </a:lnTo>
                  <a:lnTo>
                    <a:pt x="3066" y="3245"/>
                  </a:lnTo>
                  <a:lnTo>
                    <a:pt x="3093" y="3232"/>
                  </a:lnTo>
                  <a:lnTo>
                    <a:pt x="3120" y="3204"/>
                  </a:lnTo>
                  <a:lnTo>
                    <a:pt x="3134" y="3191"/>
                  </a:lnTo>
                  <a:lnTo>
                    <a:pt x="3162" y="3163"/>
                  </a:lnTo>
                  <a:lnTo>
                    <a:pt x="3189" y="3135"/>
                  </a:lnTo>
                  <a:lnTo>
                    <a:pt x="3203" y="3122"/>
                  </a:lnTo>
                  <a:lnTo>
                    <a:pt x="3230" y="3094"/>
                  </a:lnTo>
                  <a:lnTo>
                    <a:pt x="3245" y="3066"/>
                  </a:lnTo>
                  <a:lnTo>
                    <a:pt x="3271" y="3039"/>
                  </a:lnTo>
                  <a:lnTo>
                    <a:pt x="3286" y="3012"/>
                  </a:lnTo>
                  <a:lnTo>
                    <a:pt x="3313" y="2997"/>
                  </a:lnTo>
                  <a:lnTo>
                    <a:pt x="3327" y="2971"/>
                  </a:lnTo>
                  <a:lnTo>
                    <a:pt x="3355" y="2943"/>
                  </a:lnTo>
                  <a:lnTo>
                    <a:pt x="3368" y="2915"/>
                  </a:lnTo>
                  <a:lnTo>
                    <a:pt x="3381" y="2888"/>
                  </a:lnTo>
                  <a:lnTo>
                    <a:pt x="3409" y="2860"/>
                  </a:lnTo>
                  <a:lnTo>
                    <a:pt x="3423" y="2833"/>
                  </a:lnTo>
                  <a:lnTo>
                    <a:pt x="3437" y="2805"/>
                  </a:lnTo>
                  <a:lnTo>
                    <a:pt x="3450" y="2778"/>
                  </a:lnTo>
                  <a:lnTo>
                    <a:pt x="3478" y="2750"/>
                  </a:lnTo>
                  <a:lnTo>
                    <a:pt x="3491" y="2723"/>
                  </a:lnTo>
                  <a:lnTo>
                    <a:pt x="3506" y="2695"/>
                  </a:lnTo>
                  <a:lnTo>
                    <a:pt x="3519" y="2668"/>
                  </a:lnTo>
                  <a:lnTo>
                    <a:pt x="3533" y="2640"/>
                  </a:lnTo>
                  <a:lnTo>
                    <a:pt x="3547" y="2599"/>
                  </a:lnTo>
                  <a:lnTo>
                    <a:pt x="3560" y="2571"/>
                  </a:lnTo>
                  <a:lnTo>
                    <a:pt x="3574" y="2544"/>
                  </a:lnTo>
                  <a:lnTo>
                    <a:pt x="3588" y="2517"/>
                  </a:lnTo>
                  <a:lnTo>
                    <a:pt x="3588" y="2489"/>
                  </a:lnTo>
                  <a:lnTo>
                    <a:pt x="3602" y="2448"/>
                  </a:lnTo>
                  <a:lnTo>
                    <a:pt x="3616" y="2420"/>
                  </a:lnTo>
                  <a:lnTo>
                    <a:pt x="3629" y="2392"/>
                  </a:lnTo>
                  <a:lnTo>
                    <a:pt x="3629" y="2366"/>
                  </a:lnTo>
                  <a:lnTo>
                    <a:pt x="3643" y="2324"/>
                  </a:lnTo>
                  <a:lnTo>
                    <a:pt x="3643" y="2297"/>
                  </a:lnTo>
                  <a:lnTo>
                    <a:pt x="3657" y="2269"/>
                  </a:lnTo>
                  <a:lnTo>
                    <a:pt x="3670" y="2241"/>
                  </a:lnTo>
                  <a:lnTo>
                    <a:pt x="3670" y="2200"/>
                  </a:lnTo>
                  <a:lnTo>
                    <a:pt x="3670" y="2173"/>
                  </a:lnTo>
                  <a:lnTo>
                    <a:pt x="3684" y="2145"/>
                  </a:lnTo>
                  <a:lnTo>
                    <a:pt x="3684" y="2104"/>
                  </a:lnTo>
                  <a:lnTo>
                    <a:pt x="3684" y="2076"/>
                  </a:lnTo>
                  <a:lnTo>
                    <a:pt x="3698" y="2049"/>
                  </a:lnTo>
                  <a:lnTo>
                    <a:pt x="3698" y="2008"/>
                  </a:lnTo>
                  <a:lnTo>
                    <a:pt x="3698" y="1980"/>
                  </a:lnTo>
                  <a:lnTo>
                    <a:pt x="3698" y="1953"/>
                  </a:lnTo>
                  <a:lnTo>
                    <a:pt x="3698" y="1912"/>
                  </a:lnTo>
                  <a:lnTo>
                    <a:pt x="3698" y="1884"/>
                  </a:lnTo>
                  <a:lnTo>
                    <a:pt x="3712" y="1856"/>
                  </a:lnTo>
                  <a:close/>
                </a:path>
              </a:pathLst>
            </a:custGeom>
            <a:solidFill>
              <a:srgbClr val="ff33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3" name=""/>
            <p:cNvSpPr/>
            <p:nvPr/>
          </p:nvSpPr>
          <p:spPr>
            <a:xfrm>
              <a:off x="3371400" y="1272600"/>
              <a:ext cx="214560" cy="215280"/>
            </a:xfrm>
            <a:prstGeom prst="rect">
              <a:avLst/>
            </a:prstGeom>
            <a:noFill/>
            <a:ln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4" name=""/>
            <p:cNvSpPr/>
            <p:nvPr/>
          </p:nvSpPr>
          <p:spPr>
            <a:xfrm>
              <a:off x="3420000" y="1320840"/>
              <a:ext cx="117000" cy="115560"/>
            </a:xfrm>
            <a:custGeom>
              <a:avLst/>
              <a:gdLst/>
              <a:ahLst/>
              <a:rect l="l" t="t" r="r" b="b"/>
              <a:pathLst>
                <a:path w="2241" h="2228">
                  <a:moveTo>
                    <a:pt x="2241" y="1113"/>
                  </a:moveTo>
                  <a:lnTo>
                    <a:pt x="2227" y="1100"/>
                  </a:lnTo>
                  <a:lnTo>
                    <a:pt x="2227" y="1072"/>
                  </a:lnTo>
                  <a:lnTo>
                    <a:pt x="2227" y="1059"/>
                  </a:lnTo>
                  <a:lnTo>
                    <a:pt x="2227" y="1031"/>
                  </a:lnTo>
                  <a:lnTo>
                    <a:pt x="2227" y="1018"/>
                  </a:lnTo>
                  <a:lnTo>
                    <a:pt x="2227" y="990"/>
                  </a:lnTo>
                  <a:lnTo>
                    <a:pt x="2227" y="977"/>
                  </a:lnTo>
                  <a:lnTo>
                    <a:pt x="2227" y="962"/>
                  </a:lnTo>
                  <a:lnTo>
                    <a:pt x="2214" y="935"/>
                  </a:lnTo>
                  <a:lnTo>
                    <a:pt x="2214" y="921"/>
                  </a:lnTo>
                  <a:lnTo>
                    <a:pt x="2214" y="894"/>
                  </a:lnTo>
                  <a:lnTo>
                    <a:pt x="2214" y="880"/>
                  </a:lnTo>
                  <a:lnTo>
                    <a:pt x="2200" y="866"/>
                  </a:lnTo>
                  <a:lnTo>
                    <a:pt x="2200" y="839"/>
                  </a:lnTo>
                  <a:lnTo>
                    <a:pt x="2200" y="825"/>
                  </a:lnTo>
                  <a:lnTo>
                    <a:pt x="2186" y="811"/>
                  </a:lnTo>
                  <a:lnTo>
                    <a:pt x="2186" y="784"/>
                  </a:lnTo>
                  <a:lnTo>
                    <a:pt x="2186" y="770"/>
                  </a:lnTo>
                  <a:lnTo>
                    <a:pt x="2173" y="742"/>
                  </a:lnTo>
                  <a:lnTo>
                    <a:pt x="2173" y="729"/>
                  </a:lnTo>
                  <a:lnTo>
                    <a:pt x="2159" y="715"/>
                  </a:lnTo>
                  <a:lnTo>
                    <a:pt x="2159" y="687"/>
                  </a:lnTo>
                  <a:lnTo>
                    <a:pt x="2145" y="674"/>
                  </a:lnTo>
                  <a:lnTo>
                    <a:pt x="2132" y="660"/>
                  </a:lnTo>
                  <a:lnTo>
                    <a:pt x="2132" y="646"/>
                  </a:lnTo>
                  <a:lnTo>
                    <a:pt x="2117" y="619"/>
                  </a:lnTo>
                  <a:lnTo>
                    <a:pt x="2117" y="605"/>
                  </a:lnTo>
                  <a:lnTo>
                    <a:pt x="2104" y="591"/>
                  </a:lnTo>
                  <a:lnTo>
                    <a:pt x="2090" y="564"/>
                  </a:lnTo>
                  <a:lnTo>
                    <a:pt x="2090" y="550"/>
                  </a:lnTo>
                  <a:lnTo>
                    <a:pt x="2076" y="536"/>
                  </a:lnTo>
                  <a:lnTo>
                    <a:pt x="2063" y="523"/>
                  </a:lnTo>
                  <a:lnTo>
                    <a:pt x="2048" y="508"/>
                  </a:lnTo>
                  <a:lnTo>
                    <a:pt x="2048" y="482"/>
                  </a:lnTo>
                  <a:lnTo>
                    <a:pt x="2035" y="467"/>
                  </a:lnTo>
                  <a:lnTo>
                    <a:pt x="2022" y="454"/>
                  </a:lnTo>
                  <a:lnTo>
                    <a:pt x="2007" y="440"/>
                  </a:lnTo>
                  <a:lnTo>
                    <a:pt x="1994" y="426"/>
                  </a:lnTo>
                  <a:lnTo>
                    <a:pt x="1980" y="413"/>
                  </a:lnTo>
                  <a:lnTo>
                    <a:pt x="1966" y="398"/>
                  </a:lnTo>
                  <a:lnTo>
                    <a:pt x="1966" y="385"/>
                  </a:lnTo>
                  <a:lnTo>
                    <a:pt x="1953" y="357"/>
                  </a:lnTo>
                  <a:lnTo>
                    <a:pt x="1938" y="344"/>
                  </a:lnTo>
                  <a:lnTo>
                    <a:pt x="1925" y="330"/>
                  </a:lnTo>
                  <a:lnTo>
                    <a:pt x="1912" y="316"/>
                  </a:lnTo>
                  <a:lnTo>
                    <a:pt x="1897" y="303"/>
                  </a:lnTo>
                  <a:lnTo>
                    <a:pt x="1884" y="288"/>
                  </a:lnTo>
                  <a:lnTo>
                    <a:pt x="1870" y="275"/>
                  </a:lnTo>
                  <a:lnTo>
                    <a:pt x="1843" y="262"/>
                  </a:lnTo>
                  <a:lnTo>
                    <a:pt x="1828" y="262"/>
                  </a:lnTo>
                  <a:lnTo>
                    <a:pt x="1815" y="247"/>
                  </a:lnTo>
                  <a:lnTo>
                    <a:pt x="1802" y="234"/>
                  </a:lnTo>
                  <a:lnTo>
                    <a:pt x="1787" y="220"/>
                  </a:lnTo>
                  <a:lnTo>
                    <a:pt x="1774" y="206"/>
                  </a:lnTo>
                  <a:lnTo>
                    <a:pt x="1760" y="193"/>
                  </a:lnTo>
                  <a:lnTo>
                    <a:pt x="1746" y="179"/>
                  </a:lnTo>
                  <a:lnTo>
                    <a:pt x="1719" y="179"/>
                  </a:lnTo>
                  <a:lnTo>
                    <a:pt x="1705" y="165"/>
                  </a:lnTo>
                  <a:lnTo>
                    <a:pt x="1691" y="151"/>
                  </a:lnTo>
                  <a:lnTo>
                    <a:pt x="1677" y="137"/>
                  </a:lnTo>
                  <a:lnTo>
                    <a:pt x="1664" y="137"/>
                  </a:lnTo>
                  <a:lnTo>
                    <a:pt x="1636" y="124"/>
                  </a:lnTo>
                  <a:lnTo>
                    <a:pt x="1623" y="110"/>
                  </a:lnTo>
                  <a:lnTo>
                    <a:pt x="1609" y="110"/>
                  </a:lnTo>
                  <a:lnTo>
                    <a:pt x="1581" y="96"/>
                  </a:lnTo>
                  <a:lnTo>
                    <a:pt x="1568" y="96"/>
                  </a:lnTo>
                  <a:lnTo>
                    <a:pt x="1554" y="83"/>
                  </a:lnTo>
                  <a:lnTo>
                    <a:pt x="1540" y="69"/>
                  </a:lnTo>
                  <a:lnTo>
                    <a:pt x="1512" y="69"/>
                  </a:lnTo>
                  <a:lnTo>
                    <a:pt x="1499" y="55"/>
                  </a:lnTo>
                  <a:lnTo>
                    <a:pt x="1485" y="55"/>
                  </a:lnTo>
                  <a:lnTo>
                    <a:pt x="1458" y="41"/>
                  </a:lnTo>
                  <a:lnTo>
                    <a:pt x="1444" y="41"/>
                  </a:lnTo>
                  <a:lnTo>
                    <a:pt x="1417" y="41"/>
                  </a:lnTo>
                  <a:lnTo>
                    <a:pt x="1402" y="28"/>
                  </a:lnTo>
                  <a:lnTo>
                    <a:pt x="1389" y="28"/>
                  </a:lnTo>
                  <a:lnTo>
                    <a:pt x="1361" y="28"/>
                  </a:lnTo>
                  <a:lnTo>
                    <a:pt x="1348" y="14"/>
                  </a:lnTo>
                  <a:lnTo>
                    <a:pt x="1333" y="14"/>
                  </a:lnTo>
                  <a:lnTo>
                    <a:pt x="1307" y="14"/>
                  </a:lnTo>
                  <a:lnTo>
                    <a:pt x="1292" y="14"/>
                  </a:lnTo>
                  <a:lnTo>
                    <a:pt x="1266" y="0"/>
                  </a:lnTo>
                  <a:lnTo>
                    <a:pt x="1251" y="0"/>
                  </a:lnTo>
                  <a:lnTo>
                    <a:pt x="1238" y="0"/>
                  </a:lnTo>
                  <a:lnTo>
                    <a:pt x="1210" y="0"/>
                  </a:lnTo>
                  <a:lnTo>
                    <a:pt x="1197" y="0"/>
                  </a:lnTo>
                  <a:lnTo>
                    <a:pt x="1169" y="0"/>
                  </a:lnTo>
                  <a:lnTo>
                    <a:pt x="1155" y="0"/>
                  </a:lnTo>
                  <a:lnTo>
                    <a:pt x="1128" y="0"/>
                  </a:lnTo>
                  <a:lnTo>
                    <a:pt x="1113" y="0"/>
                  </a:lnTo>
                  <a:lnTo>
                    <a:pt x="1100" y="0"/>
                  </a:lnTo>
                  <a:lnTo>
                    <a:pt x="1072" y="0"/>
                  </a:lnTo>
                  <a:lnTo>
                    <a:pt x="1059" y="0"/>
                  </a:lnTo>
                  <a:lnTo>
                    <a:pt x="1031" y="0"/>
                  </a:lnTo>
                  <a:lnTo>
                    <a:pt x="1018" y="0"/>
                  </a:lnTo>
                  <a:lnTo>
                    <a:pt x="990" y="0"/>
                  </a:lnTo>
                  <a:lnTo>
                    <a:pt x="976" y="0"/>
                  </a:lnTo>
                  <a:lnTo>
                    <a:pt x="962" y="0"/>
                  </a:lnTo>
                  <a:lnTo>
                    <a:pt x="935" y="14"/>
                  </a:lnTo>
                  <a:lnTo>
                    <a:pt x="921" y="14"/>
                  </a:lnTo>
                  <a:lnTo>
                    <a:pt x="894" y="14"/>
                  </a:lnTo>
                  <a:lnTo>
                    <a:pt x="880" y="14"/>
                  </a:lnTo>
                  <a:lnTo>
                    <a:pt x="866" y="28"/>
                  </a:lnTo>
                  <a:lnTo>
                    <a:pt x="839" y="28"/>
                  </a:lnTo>
                  <a:lnTo>
                    <a:pt x="825" y="28"/>
                  </a:lnTo>
                  <a:lnTo>
                    <a:pt x="811" y="41"/>
                  </a:lnTo>
                  <a:lnTo>
                    <a:pt x="784" y="41"/>
                  </a:lnTo>
                  <a:lnTo>
                    <a:pt x="770" y="41"/>
                  </a:lnTo>
                  <a:lnTo>
                    <a:pt x="743" y="55"/>
                  </a:lnTo>
                  <a:lnTo>
                    <a:pt x="729" y="55"/>
                  </a:lnTo>
                  <a:lnTo>
                    <a:pt x="715" y="69"/>
                  </a:lnTo>
                  <a:lnTo>
                    <a:pt x="687" y="69"/>
                  </a:lnTo>
                  <a:lnTo>
                    <a:pt x="674" y="83"/>
                  </a:lnTo>
                  <a:lnTo>
                    <a:pt x="660" y="96"/>
                  </a:lnTo>
                  <a:lnTo>
                    <a:pt x="646" y="96"/>
                  </a:lnTo>
                  <a:lnTo>
                    <a:pt x="618" y="110"/>
                  </a:lnTo>
                  <a:lnTo>
                    <a:pt x="605" y="110"/>
                  </a:lnTo>
                  <a:lnTo>
                    <a:pt x="592" y="124"/>
                  </a:lnTo>
                  <a:lnTo>
                    <a:pt x="564" y="137"/>
                  </a:lnTo>
                  <a:lnTo>
                    <a:pt x="551" y="137"/>
                  </a:lnTo>
                  <a:lnTo>
                    <a:pt x="536" y="151"/>
                  </a:lnTo>
                  <a:lnTo>
                    <a:pt x="523" y="165"/>
                  </a:lnTo>
                  <a:lnTo>
                    <a:pt x="508" y="179"/>
                  </a:lnTo>
                  <a:lnTo>
                    <a:pt x="482" y="179"/>
                  </a:lnTo>
                  <a:lnTo>
                    <a:pt x="467" y="193"/>
                  </a:lnTo>
                  <a:lnTo>
                    <a:pt x="454" y="206"/>
                  </a:lnTo>
                  <a:lnTo>
                    <a:pt x="440" y="220"/>
                  </a:lnTo>
                  <a:lnTo>
                    <a:pt x="426" y="234"/>
                  </a:lnTo>
                  <a:lnTo>
                    <a:pt x="413" y="247"/>
                  </a:lnTo>
                  <a:lnTo>
                    <a:pt x="398" y="262"/>
                  </a:lnTo>
                  <a:lnTo>
                    <a:pt x="385" y="262"/>
                  </a:lnTo>
                  <a:lnTo>
                    <a:pt x="357" y="275"/>
                  </a:lnTo>
                  <a:lnTo>
                    <a:pt x="344" y="288"/>
                  </a:lnTo>
                  <a:lnTo>
                    <a:pt x="330" y="303"/>
                  </a:lnTo>
                  <a:lnTo>
                    <a:pt x="316" y="316"/>
                  </a:lnTo>
                  <a:lnTo>
                    <a:pt x="303" y="330"/>
                  </a:lnTo>
                  <a:lnTo>
                    <a:pt x="289" y="344"/>
                  </a:lnTo>
                  <a:lnTo>
                    <a:pt x="275" y="357"/>
                  </a:lnTo>
                  <a:lnTo>
                    <a:pt x="261" y="385"/>
                  </a:lnTo>
                  <a:lnTo>
                    <a:pt x="261" y="398"/>
                  </a:lnTo>
                  <a:lnTo>
                    <a:pt x="247" y="413"/>
                  </a:lnTo>
                  <a:lnTo>
                    <a:pt x="234" y="426"/>
                  </a:lnTo>
                  <a:lnTo>
                    <a:pt x="220" y="440"/>
                  </a:lnTo>
                  <a:lnTo>
                    <a:pt x="206" y="454"/>
                  </a:lnTo>
                  <a:lnTo>
                    <a:pt x="192" y="467"/>
                  </a:lnTo>
                  <a:lnTo>
                    <a:pt x="179" y="482"/>
                  </a:lnTo>
                  <a:lnTo>
                    <a:pt x="179" y="508"/>
                  </a:lnTo>
                  <a:lnTo>
                    <a:pt x="165" y="523"/>
                  </a:lnTo>
                  <a:lnTo>
                    <a:pt x="151" y="536"/>
                  </a:lnTo>
                  <a:lnTo>
                    <a:pt x="138" y="550"/>
                  </a:lnTo>
                  <a:lnTo>
                    <a:pt x="138" y="564"/>
                  </a:lnTo>
                  <a:lnTo>
                    <a:pt x="124" y="591"/>
                  </a:lnTo>
                  <a:lnTo>
                    <a:pt x="110" y="605"/>
                  </a:lnTo>
                  <a:lnTo>
                    <a:pt x="110" y="619"/>
                  </a:lnTo>
                  <a:lnTo>
                    <a:pt x="96" y="646"/>
                  </a:lnTo>
                  <a:lnTo>
                    <a:pt x="96" y="660"/>
                  </a:lnTo>
                  <a:lnTo>
                    <a:pt x="82" y="674"/>
                  </a:lnTo>
                  <a:lnTo>
                    <a:pt x="69" y="687"/>
                  </a:lnTo>
                  <a:lnTo>
                    <a:pt x="69" y="715"/>
                  </a:lnTo>
                  <a:lnTo>
                    <a:pt x="55" y="729"/>
                  </a:lnTo>
                  <a:lnTo>
                    <a:pt x="55" y="742"/>
                  </a:lnTo>
                  <a:lnTo>
                    <a:pt x="41" y="770"/>
                  </a:lnTo>
                  <a:lnTo>
                    <a:pt x="41" y="784"/>
                  </a:lnTo>
                  <a:lnTo>
                    <a:pt x="41" y="811"/>
                  </a:lnTo>
                  <a:lnTo>
                    <a:pt x="28" y="825"/>
                  </a:lnTo>
                  <a:lnTo>
                    <a:pt x="28" y="839"/>
                  </a:lnTo>
                  <a:lnTo>
                    <a:pt x="28" y="866"/>
                  </a:lnTo>
                  <a:lnTo>
                    <a:pt x="13" y="880"/>
                  </a:lnTo>
                  <a:lnTo>
                    <a:pt x="13" y="894"/>
                  </a:lnTo>
                  <a:lnTo>
                    <a:pt x="13" y="921"/>
                  </a:lnTo>
                  <a:lnTo>
                    <a:pt x="13" y="935"/>
                  </a:lnTo>
                  <a:lnTo>
                    <a:pt x="0" y="962"/>
                  </a:lnTo>
                  <a:lnTo>
                    <a:pt x="0" y="977"/>
                  </a:lnTo>
                  <a:lnTo>
                    <a:pt x="0" y="990"/>
                  </a:lnTo>
                  <a:lnTo>
                    <a:pt x="0" y="1018"/>
                  </a:lnTo>
                  <a:lnTo>
                    <a:pt x="0" y="1031"/>
                  </a:lnTo>
                  <a:lnTo>
                    <a:pt x="0" y="1059"/>
                  </a:lnTo>
                  <a:lnTo>
                    <a:pt x="0" y="1072"/>
                  </a:lnTo>
                  <a:lnTo>
                    <a:pt x="0" y="1100"/>
                  </a:lnTo>
                  <a:lnTo>
                    <a:pt x="0" y="1113"/>
                  </a:lnTo>
                  <a:lnTo>
                    <a:pt x="0" y="1128"/>
                  </a:lnTo>
                  <a:lnTo>
                    <a:pt x="0" y="1155"/>
                  </a:lnTo>
                  <a:lnTo>
                    <a:pt x="0" y="1169"/>
                  </a:lnTo>
                  <a:lnTo>
                    <a:pt x="0" y="1197"/>
                  </a:lnTo>
                  <a:lnTo>
                    <a:pt x="0" y="1210"/>
                  </a:lnTo>
                  <a:lnTo>
                    <a:pt x="0" y="1238"/>
                  </a:lnTo>
                  <a:lnTo>
                    <a:pt x="0" y="1251"/>
                  </a:lnTo>
                  <a:lnTo>
                    <a:pt x="0" y="1265"/>
                  </a:lnTo>
                  <a:lnTo>
                    <a:pt x="13" y="1292"/>
                  </a:lnTo>
                  <a:lnTo>
                    <a:pt x="13" y="1306"/>
                  </a:lnTo>
                  <a:lnTo>
                    <a:pt x="13" y="1334"/>
                  </a:lnTo>
                  <a:lnTo>
                    <a:pt x="13" y="1348"/>
                  </a:lnTo>
                  <a:lnTo>
                    <a:pt x="28" y="1361"/>
                  </a:lnTo>
                  <a:lnTo>
                    <a:pt x="28" y="1389"/>
                  </a:lnTo>
                  <a:lnTo>
                    <a:pt x="28" y="1402"/>
                  </a:lnTo>
                  <a:lnTo>
                    <a:pt x="41" y="1416"/>
                  </a:lnTo>
                  <a:lnTo>
                    <a:pt x="41" y="1444"/>
                  </a:lnTo>
                  <a:lnTo>
                    <a:pt x="41" y="1457"/>
                  </a:lnTo>
                  <a:lnTo>
                    <a:pt x="55" y="1485"/>
                  </a:lnTo>
                  <a:lnTo>
                    <a:pt x="55" y="1499"/>
                  </a:lnTo>
                  <a:lnTo>
                    <a:pt x="69" y="1513"/>
                  </a:lnTo>
                  <a:lnTo>
                    <a:pt x="69" y="1540"/>
                  </a:lnTo>
                  <a:lnTo>
                    <a:pt x="82" y="1554"/>
                  </a:lnTo>
                  <a:lnTo>
                    <a:pt x="96" y="1567"/>
                  </a:lnTo>
                  <a:lnTo>
                    <a:pt x="96" y="1581"/>
                  </a:lnTo>
                  <a:lnTo>
                    <a:pt x="110" y="1608"/>
                  </a:lnTo>
                  <a:lnTo>
                    <a:pt x="110" y="1623"/>
                  </a:lnTo>
                  <a:lnTo>
                    <a:pt x="124" y="1636"/>
                  </a:lnTo>
                  <a:lnTo>
                    <a:pt x="138" y="1664"/>
                  </a:lnTo>
                  <a:lnTo>
                    <a:pt x="138" y="1677"/>
                  </a:lnTo>
                  <a:lnTo>
                    <a:pt x="151" y="1692"/>
                  </a:lnTo>
                  <a:lnTo>
                    <a:pt x="165" y="1705"/>
                  </a:lnTo>
                  <a:lnTo>
                    <a:pt x="179" y="1718"/>
                  </a:lnTo>
                  <a:lnTo>
                    <a:pt x="179" y="1746"/>
                  </a:lnTo>
                  <a:lnTo>
                    <a:pt x="192" y="1760"/>
                  </a:lnTo>
                  <a:lnTo>
                    <a:pt x="206" y="1774"/>
                  </a:lnTo>
                  <a:lnTo>
                    <a:pt x="220" y="1787"/>
                  </a:lnTo>
                  <a:lnTo>
                    <a:pt x="234" y="1802"/>
                  </a:lnTo>
                  <a:lnTo>
                    <a:pt x="247" y="1815"/>
                  </a:lnTo>
                  <a:lnTo>
                    <a:pt x="261" y="1828"/>
                  </a:lnTo>
                  <a:lnTo>
                    <a:pt x="261" y="1843"/>
                  </a:lnTo>
                  <a:lnTo>
                    <a:pt x="275" y="1870"/>
                  </a:lnTo>
                  <a:lnTo>
                    <a:pt x="289" y="1884"/>
                  </a:lnTo>
                  <a:lnTo>
                    <a:pt x="303" y="1897"/>
                  </a:lnTo>
                  <a:lnTo>
                    <a:pt x="316" y="1912"/>
                  </a:lnTo>
                  <a:lnTo>
                    <a:pt x="330" y="1925"/>
                  </a:lnTo>
                  <a:lnTo>
                    <a:pt x="344" y="1938"/>
                  </a:lnTo>
                  <a:lnTo>
                    <a:pt x="357" y="1953"/>
                  </a:lnTo>
                  <a:lnTo>
                    <a:pt x="385" y="1966"/>
                  </a:lnTo>
                  <a:lnTo>
                    <a:pt x="398" y="1966"/>
                  </a:lnTo>
                  <a:lnTo>
                    <a:pt x="413" y="1980"/>
                  </a:lnTo>
                  <a:lnTo>
                    <a:pt x="426" y="1994"/>
                  </a:lnTo>
                  <a:lnTo>
                    <a:pt x="440" y="2007"/>
                  </a:lnTo>
                  <a:lnTo>
                    <a:pt x="454" y="2021"/>
                  </a:lnTo>
                  <a:lnTo>
                    <a:pt x="467" y="2035"/>
                  </a:lnTo>
                  <a:lnTo>
                    <a:pt x="482" y="2049"/>
                  </a:lnTo>
                  <a:lnTo>
                    <a:pt x="508" y="2049"/>
                  </a:lnTo>
                  <a:lnTo>
                    <a:pt x="523" y="2063"/>
                  </a:lnTo>
                  <a:lnTo>
                    <a:pt x="536" y="2076"/>
                  </a:lnTo>
                  <a:lnTo>
                    <a:pt x="551" y="2090"/>
                  </a:lnTo>
                  <a:lnTo>
                    <a:pt x="564" y="2090"/>
                  </a:lnTo>
                  <a:lnTo>
                    <a:pt x="592" y="2104"/>
                  </a:lnTo>
                  <a:lnTo>
                    <a:pt x="605" y="2117"/>
                  </a:lnTo>
                  <a:lnTo>
                    <a:pt x="618" y="2117"/>
                  </a:lnTo>
                  <a:lnTo>
                    <a:pt x="646" y="2131"/>
                  </a:lnTo>
                  <a:lnTo>
                    <a:pt x="660" y="2131"/>
                  </a:lnTo>
                  <a:lnTo>
                    <a:pt x="674" y="2145"/>
                  </a:lnTo>
                  <a:lnTo>
                    <a:pt x="687" y="2159"/>
                  </a:lnTo>
                  <a:lnTo>
                    <a:pt x="715" y="2159"/>
                  </a:lnTo>
                  <a:lnTo>
                    <a:pt x="729" y="2172"/>
                  </a:lnTo>
                  <a:lnTo>
                    <a:pt x="743" y="2172"/>
                  </a:lnTo>
                  <a:lnTo>
                    <a:pt x="770" y="2186"/>
                  </a:lnTo>
                  <a:lnTo>
                    <a:pt x="784" y="2186"/>
                  </a:lnTo>
                  <a:lnTo>
                    <a:pt x="811" y="2186"/>
                  </a:lnTo>
                  <a:lnTo>
                    <a:pt x="825" y="2200"/>
                  </a:lnTo>
                  <a:lnTo>
                    <a:pt x="839" y="2200"/>
                  </a:lnTo>
                  <a:lnTo>
                    <a:pt x="866" y="2200"/>
                  </a:lnTo>
                  <a:lnTo>
                    <a:pt x="880" y="2214"/>
                  </a:lnTo>
                  <a:lnTo>
                    <a:pt x="894" y="2214"/>
                  </a:lnTo>
                  <a:lnTo>
                    <a:pt x="921" y="2214"/>
                  </a:lnTo>
                  <a:lnTo>
                    <a:pt x="935" y="2214"/>
                  </a:lnTo>
                  <a:lnTo>
                    <a:pt x="962" y="2228"/>
                  </a:lnTo>
                  <a:lnTo>
                    <a:pt x="976" y="2228"/>
                  </a:lnTo>
                  <a:lnTo>
                    <a:pt x="990" y="2228"/>
                  </a:lnTo>
                  <a:lnTo>
                    <a:pt x="1018" y="2228"/>
                  </a:lnTo>
                  <a:lnTo>
                    <a:pt x="1031" y="2228"/>
                  </a:lnTo>
                  <a:lnTo>
                    <a:pt x="1059" y="2228"/>
                  </a:lnTo>
                  <a:lnTo>
                    <a:pt x="1072" y="2228"/>
                  </a:lnTo>
                  <a:lnTo>
                    <a:pt x="1100" y="2228"/>
                  </a:lnTo>
                  <a:lnTo>
                    <a:pt x="1113" y="2228"/>
                  </a:lnTo>
                  <a:lnTo>
                    <a:pt x="1128" y="2228"/>
                  </a:lnTo>
                  <a:lnTo>
                    <a:pt x="1155" y="2228"/>
                  </a:lnTo>
                  <a:lnTo>
                    <a:pt x="1169" y="2228"/>
                  </a:lnTo>
                  <a:lnTo>
                    <a:pt x="1197" y="2228"/>
                  </a:lnTo>
                  <a:lnTo>
                    <a:pt x="1210" y="2228"/>
                  </a:lnTo>
                  <a:lnTo>
                    <a:pt x="1238" y="2228"/>
                  </a:lnTo>
                  <a:lnTo>
                    <a:pt x="1251" y="2228"/>
                  </a:lnTo>
                  <a:lnTo>
                    <a:pt x="1266" y="2228"/>
                  </a:lnTo>
                  <a:lnTo>
                    <a:pt x="1292" y="2214"/>
                  </a:lnTo>
                  <a:lnTo>
                    <a:pt x="1307" y="2214"/>
                  </a:lnTo>
                  <a:lnTo>
                    <a:pt x="1333" y="2214"/>
                  </a:lnTo>
                  <a:lnTo>
                    <a:pt x="1348" y="2214"/>
                  </a:lnTo>
                  <a:lnTo>
                    <a:pt x="1361" y="2200"/>
                  </a:lnTo>
                  <a:lnTo>
                    <a:pt x="1389" y="2200"/>
                  </a:lnTo>
                  <a:lnTo>
                    <a:pt x="1402" y="2200"/>
                  </a:lnTo>
                  <a:lnTo>
                    <a:pt x="1417" y="2186"/>
                  </a:lnTo>
                  <a:lnTo>
                    <a:pt x="1444" y="2186"/>
                  </a:lnTo>
                  <a:lnTo>
                    <a:pt x="1458" y="2186"/>
                  </a:lnTo>
                  <a:lnTo>
                    <a:pt x="1485" y="2172"/>
                  </a:lnTo>
                  <a:lnTo>
                    <a:pt x="1499" y="2172"/>
                  </a:lnTo>
                  <a:lnTo>
                    <a:pt x="1512" y="2159"/>
                  </a:lnTo>
                  <a:lnTo>
                    <a:pt x="1540" y="2159"/>
                  </a:lnTo>
                  <a:lnTo>
                    <a:pt x="1554" y="2145"/>
                  </a:lnTo>
                  <a:lnTo>
                    <a:pt x="1568" y="2131"/>
                  </a:lnTo>
                  <a:lnTo>
                    <a:pt x="1581" y="2131"/>
                  </a:lnTo>
                  <a:lnTo>
                    <a:pt x="1609" y="2117"/>
                  </a:lnTo>
                  <a:lnTo>
                    <a:pt x="1623" y="2117"/>
                  </a:lnTo>
                  <a:lnTo>
                    <a:pt x="1636" y="2104"/>
                  </a:lnTo>
                  <a:lnTo>
                    <a:pt x="1664" y="2090"/>
                  </a:lnTo>
                  <a:lnTo>
                    <a:pt x="1677" y="2090"/>
                  </a:lnTo>
                  <a:lnTo>
                    <a:pt x="1691" y="2076"/>
                  </a:lnTo>
                  <a:lnTo>
                    <a:pt x="1705" y="2063"/>
                  </a:lnTo>
                  <a:lnTo>
                    <a:pt x="1719" y="2049"/>
                  </a:lnTo>
                  <a:lnTo>
                    <a:pt x="1746" y="2049"/>
                  </a:lnTo>
                  <a:lnTo>
                    <a:pt x="1760" y="2035"/>
                  </a:lnTo>
                  <a:lnTo>
                    <a:pt x="1774" y="2021"/>
                  </a:lnTo>
                  <a:lnTo>
                    <a:pt x="1787" y="2007"/>
                  </a:lnTo>
                  <a:lnTo>
                    <a:pt x="1802" y="1994"/>
                  </a:lnTo>
                  <a:lnTo>
                    <a:pt x="1815" y="1980"/>
                  </a:lnTo>
                  <a:lnTo>
                    <a:pt x="1828" y="1966"/>
                  </a:lnTo>
                  <a:lnTo>
                    <a:pt x="1843" y="1966"/>
                  </a:lnTo>
                  <a:lnTo>
                    <a:pt x="1870" y="1953"/>
                  </a:lnTo>
                  <a:lnTo>
                    <a:pt x="1884" y="1938"/>
                  </a:lnTo>
                  <a:lnTo>
                    <a:pt x="1897" y="1925"/>
                  </a:lnTo>
                  <a:lnTo>
                    <a:pt x="1912" y="1912"/>
                  </a:lnTo>
                  <a:lnTo>
                    <a:pt x="1925" y="1897"/>
                  </a:lnTo>
                  <a:lnTo>
                    <a:pt x="1938" y="1884"/>
                  </a:lnTo>
                  <a:lnTo>
                    <a:pt x="1953" y="1870"/>
                  </a:lnTo>
                  <a:lnTo>
                    <a:pt x="1966" y="1843"/>
                  </a:lnTo>
                  <a:lnTo>
                    <a:pt x="1966" y="1828"/>
                  </a:lnTo>
                  <a:lnTo>
                    <a:pt x="1980" y="1815"/>
                  </a:lnTo>
                  <a:lnTo>
                    <a:pt x="1994" y="1802"/>
                  </a:lnTo>
                  <a:lnTo>
                    <a:pt x="2007" y="1787"/>
                  </a:lnTo>
                  <a:lnTo>
                    <a:pt x="2022" y="1774"/>
                  </a:lnTo>
                  <a:lnTo>
                    <a:pt x="2035" y="1760"/>
                  </a:lnTo>
                  <a:lnTo>
                    <a:pt x="2048" y="1746"/>
                  </a:lnTo>
                  <a:lnTo>
                    <a:pt x="2048" y="1718"/>
                  </a:lnTo>
                  <a:lnTo>
                    <a:pt x="2063" y="1705"/>
                  </a:lnTo>
                  <a:lnTo>
                    <a:pt x="2076" y="1692"/>
                  </a:lnTo>
                  <a:lnTo>
                    <a:pt x="2090" y="1677"/>
                  </a:lnTo>
                  <a:lnTo>
                    <a:pt x="2090" y="1664"/>
                  </a:lnTo>
                  <a:lnTo>
                    <a:pt x="2104" y="1636"/>
                  </a:lnTo>
                  <a:lnTo>
                    <a:pt x="2117" y="1623"/>
                  </a:lnTo>
                  <a:lnTo>
                    <a:pt x="2117" y="1608"/>
                  </a:lnTo>
                  <a:lnTo>
                    <a:pt x="2132" y="1581"/>
                  </a:lnTo>
                  <a:lnTo>
                    <a:pt x="2132" y="1567"/>
                  </a:lnTo>
                  <a:lnTo>
                    <a:pt x="2145" y="1554"/>
                  </a:lnTo>
                  <a:lnTo>
                    <a:pt x="2159" y="1540"/>
                  </a:lnTo>
                  <a:lnTo>
                    <a:pt x="2159" y="1513"/>
                  </a:lnTo>
                  <a:lnTo>
                    <a:pt x="2173" y="1499"/>
                  </a:lnTo>
                  <a:lnTo>
                    <a:pt x="2173" y="1485"/>
                  </a:lnTo>
                  <a:lnTo>
                    <a:pt x="2186" y="1457"/>
                  </a:lnTo>
                  <a:lnTo>
                    <a:pt x="2186" y="1444"/>
                  </a:lnTo>
                  <a:lnTo>
                    <a:pt x="2186" y="1416"/>
                  </a:lnTo>
                  <a:lnTo>
                    <a:pt x="2200" y="1402"/>
                  </a:lnTo>
                  <a:lnTo>
                    <a:pt x="2200" y="1389"/>
                  </a:lnTo>
                  <a:lnTo>
                    <a:pt x="2200" y="1361"/>
                  </a:lnTo>
                  <a:lnTo>
                    <a:pt x="2214" y="1348"/>
                  </a:lnTo>
                  <a:lnTo>
                    <a:pt x="2214" y="1334"/>
                  </a:lnTo>
                  <a:lnTo>
                    <a:pt x="2214" y="1306"/>
                  </a:lnTo>
                  <a:lnTo>
                    <a:pt x="2214" y="1292"/>
                  </a:lnTo>
                  <a:lnTo>
                    <a:pt x="2227" y="1265"/>
                  </a:lnTo>
                  <a:lnTo>
                    <a:pt x="2227" y="1251"/>
                  </a:lnTo>
                  <a:lnTo>
                    <a:pt x="2227" y="1238"/>
                  </a:lnTo>
                  <a:lnTo>
                    <a:pt x="2227" y="1210"/>
                  </a:lnTo>
                  <a:lnTo>
                    <a:pt x="2227" y="1197"/>
                  </a:lnTo>
                  <a:lnTo>
                    <a:pt x="2227" y="1169"/>
                  </a:lnTo>
                  <a:lnTo>
                    <a:pt x="2227" y="1155"/>
                  </a:lnTo>
                  <a:lnTo>
                    <a:pt x="2227" y="1128"/>
                  </a:lnTo>
                  <a:lnTo>
                    <a:pt x="2241" y="1113"/>
                  </a:lnTo>
                  <a:close/>
                </a:path>
              </a:pathLst>
            </a:custGeom>
            <a:solidFill>
              <a:srgbClr val="ff33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5" name=""/>
            <p:cNvSpPr/>
            <p:nvPr/>
          </p:nvSpPr>
          <p:spPr>
            <a:xfrm>
              <a:off x="3371400" y="1487880"/>
              <a:ext cx="214560" cy="213840"/>
            </a:xfrm>
            <a:prstGeom prst="rect">
              <a:avLst/>
            </a:prstGeom>
            <a:noFill/>
            <a:ln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6" name=""/>
            <p:cNvSpPr/>
            <p:nvPr/>
          </p:nvSpPr>
          <p:spPr>
            <a:xfrm>
              <a:off x="3445200" y="1559880"/>
              <a:ext cx="68760" cy="68400"/>
            </a:xfrm>
            <a:custGeom>
              <a:avLst/>
              <a:gdLst/>
              <a:ahLst/>
              <a:rect l="l" t="t" r="r" b="b"/>
              <a:pathLst>
                <a:path w="1320" h="1305">
                  <a:moveTo>
                    <a:pt x="1320" y="659"/>
                  </a:moveTo>
                  <a:lnTo>
                    <a:pt x="1307" y="646"/>
                  </a:lnTo>
                  <a:lnTo>
                    <a:pt x="1307" y="632"/>
                  </a:lnTo>
                  <a:lnTo>
                    <a:pt x="1307" y="618"/>
                  </a:lnTo>
                  <a:lnTo>
                    <a:pt x="1307" y="605"/>
                  </a:lnTo>
                  <a:lnTo>
                    <a:pt x="1307" y="590"/>
                  </a:lnTo>
                  <a:lnTo>
                    <a:pt x="1307" y="577"/>
                  </a:lnTo>
                  <a:lnTo>
                    <a:pt x="1307" y="564"/>
                  </a:lnTo>
                  <a:lnTo>
                    <a:pt x="1307" y="549"/>
                  </a:lnTo>
                  <a:lnTo>
                    <a:pt x="1307" y="536"/>
                  </a:lnTo>
                  <a:lnTo>
                    <a:pt x="1307" y="522"/>
                  </a:lnTo>
                  <a:lnTo>
                    <a:pt x="1293" y="522"/>
                  </a:lnTo>
                  <a:lnTo>
                    <a:pt x="1293" y="508"/>
                  </a:lnTo>
                  <a:lnTo>
                    <a:pt x="1293" y="495"/>
                  </a:lnTo>
                  <a:lnTo>
                    <a:pt x="1293" y="481"/>
                  </a:lnTo>
                  <a:lnTo>
                    <a:pt x="1293" y="467"/>
                  </a:lnTo>
                  <a:lnTo>
                    <a:pt x="1279" y="453"/>
                  </a:lnTo>
                  <a:lnTo>
                    <a:pt x="1279" y="439"/>
                  </a:lnTo>
                  <a:lnTo>
                    <a:pt x="1279" y="426"/>
                  </a:lnTo>
                  <a:lnTo>
                    <a:pt x="1266" y="412"/>
                  </a:lnTo>
                  <a:lnTo>
                    <a:pt x="1266" y="398"/>
                  </a:lnTo>
                  <a:lnTo>
                    <a:pt x="1252" y="385"/>
                  </a:lnTo>
                  <a:lnTo>
                    <a:pt x="1252" y="371"/>
                  </a:lnTo>
                  <a:lnTo>
                    <a:pt x="1252" y="357"/>
                  </a:lnTo>
                  <a:lnTo>
                    <a:pt x="1238" y="357"/>
                  </a:lnTo>
                  <a:lnTo>
                    <a:pt x="1238" y="343"/>
                  </a:lnTo>
                  <a:lnTo>
                    <a:pt x="1224" y="330"/>
                  </a:lnTo>
                  <a:lnTo>
                    <a:pt x="1224" y="316"/>
                  </a:lnTo>
                  <a:lnTo>
                    <a:pt x="1210" y="302"/>
                  </a:lnTo>
                  <a:lnTo>
                    <a:pt x="1210" y="288"/>
                  </a:lnTo>
                  <a:lnTo>
                    <a:pt x="1197" y="288"/>
                  </a:lnTo>
                  <a:lnTo>
                    <a:pt x="1197" y="274"/>
                  </a:lnTo>
                  <a:lnTo>
                    <a:pt x="1183" y="261"/>
                  </a:lnTo>
                  <a:lnTo>
                    <a:pt x="1169" y="247"/>
                  </a:lnTo>
                  <a:lnTo>
                    <a:pt x="1169" y="233"/>
                  </a:lnTo>
                  <a:lnTo>
                    <a:pt x="1156" y="233"/>
                  </a:lnTo>
                  <a:lnTo>
                    <a:pt x="1156" y="220"/>
                  </a:lnTo>
                  <a:lnTo>
                    <a:pt x="1142" y="206"/>
                  </a:lnTo>
                  <a:lnTo>
                    <a:pt x="1128" y="192"/>
                  </a:lnTo>
                  <a:lnTo>
                    <a:pt x="1114" y="192"/>
                  </a:lnTo>
                  <a:lnTo>
                    <a:pt x="1114" y="179"/>
                  </a:lnTo>
                  <a:lnTo>
                    <a:pt x="1101" y="164"/>
                  </a:lnTo>
                  <a:lnTo>
                    <a:pt x="1087" y="151"/>
                  </a:lnTo>
                  <a:lnTo>
                    <a:pt x="1073" y="151"/>
                  </a:lnTo>
                  <a:lnTo>
                    <a:pt x="1073" y="137"/>
                  </a:lnTo>
                  <a:lnTo>
                    <a:pt x="1059" y="137"/>
                  </a:lnTo>
                  <a:lnTo>
                    <a:pt x="1045" y="123"/>
                  </a:lnTo>
                  <a:lnTo>
                    <a:pt x="1032" y="110"/>
                  </a:lnTo>
                  <a:lnTo>
                    <a:pt x="1018" y="110"/>
                  </a:lnTo>
                  <a:lnTo>
                    <a:pt x="1018" y="95"/>
                  </a:lnTo>
                  <a:lnTo>
                    <a:pt x="1004" y="95"/>
                  </a:lnTo>
                  <a:lnTo>
                    <a:pt x="991" y="82"/>
                  </a:lnTo>
                  <a:lnTo>
                    <a:pt x="977" y="82"/>
                  </a:lnTo>
                  <a:lnTo>
                    <a:pt x="963" y="69"/>
                  </a:lnTo>
                  <a:lnTo>
                    <a:pt x="950" y="69"/>
                  </a:lnTo>
                  <a:lnTo>
                    <a:pt x="950" y="54"/>
                  </a:lnTo>
                  <a:lnTo>
                    <a:pt x="935" y="54"/>
                  </a:lnTo>
                  <a:lnTo>
                    <a:pt x="922" y="54"/>
                  </a:lnTo>
                  <a:lnTo>
                    <a:pt x="908" y="41"/>
                  </a:lnTo>
                  <a:lnTo>
                    <a:pt x="894" y="41"/>
                  </a:lnTo>
                  <a:lnTo>
                    <a:pt x="881" y="27"/>
                  </a:lnTo>
                  <a:lnTo>
                    <a:pt x="866" y="27"/>
                  </a:lnTo>
                  <a:lnTo>
                    <a:pt x="853" y="27"/>
                  </a:lnTo>
                  <a:lnTo>
                    <a:pt x="840" y="13"/>
                  </a:lnTo>
                  <a:lnTo>
                    <a:pt x="825" y="13"/>
                  </a:lnTo>
                  <a:lnTo>
                    <a:pt x="812" y="13"/>
                  </a:lnTo>
                  <a:lnTo>
                    <a:pt x="799" y="13"/>
                  </a:lnTo>
                  <a:lnTo>
                    <a:pt x="784" y="13"/>
                  </a:lnTo>
                  <a:lnTo>
                    <a:pt x="784" y="0"/>
                  </a:lnTo>
                  <a:lnTo>
                    <a:pt x="771" y="0"/>
                  </a:lnTo>
                  <a:lnTo>
                    <a:pt x="756" y="0"/>
                  </a:lnTo>
                  <a:lnTo>
                    <a:pt x="743" y="0"/>
                  </a:lnTo>
                  <a:lnTo>
                    <a:pt x="730" y="0"/>
                  </a:lnTo>
                  <a:lnTo>
                    <a:pt x="715" y="0"/>
                  </a:lnTo>
                  <a:lnTo>
                    <a:pt x="702" y="0"/>
                  </a:lnTo>
                  <a:lnTo>
                    <a:pt x="688" y="0"/>
                  </a:lnTo>
                  <a:lnTo>
                    <a:pt x="674" y="0"/>
                  </a:lnTo>
                  <a:lnTo>
                    <a:pt x="661" y="0"/>
                  </a:lnTo>
                  <a:lnTo>
                    <a:pt x="646" y="0"/>
                  </a:lnTo>
                  <a:lnTo>
                    <a:pt x="633" y="0"/>
                  </a:lnTo>
                  <a:lnTo>
                    <a:pt x="620" y="0"/>
                  </a:lnTo>
                  <a:lnTo>
                    <a:pt x="605" y="0"/>
                  </a:lnTo>
                  <a:lnTo>
                    <a:pt x="592" y="0"/>
                  </a:lnTo>
                  <a:lnTo>
                    <a:pt x="578" y="0"/>
                  </a:lnTo>
                  <a:lnTo>
                    <a:pt x="564" y="0"/>
                  </a:lnTo>
                  <a:lnTo>
                    <a:pt x="551" y="0"/>
                  </a:lnTo>
                  <a:lnTo>
                    <a:pt x="537" y="0"/>
                  </a:lnTo>
                  <a:lnTo>
                    <a:pt x="523" y="0"/>
                  </a:lnTo>
                  <a:lnTo>
                    <a:pt x="523" y="13"/>
                  </a:lnTo>
                  <a:lnTo>
                    <a:pt x="509" y="13"/>
                  </a:lnTo>
                  <a:lnTo>
                    <a:pt x="495" y="13"/>
                  </a:lnTo>
                  <a:lnTo>
                    <a:pt x="482" y="13"/>
                  </a:lnTo>
                  <a:lnTo>
                    <a:pt x="468" y="13"/>
                  </a:lnTo>
                  <a:lnTo>
                    <a:pt x="454" y="27"/>
                  </a:lnTo>
                  <a:lnTo>
                    <a:pt x="441" y="27"/>
                  </a:lnTo>
                  <a:lnTo>
                    <a:pt x="427" y="27"/>
                  </a:lnTo>
                  <a:lnTo>
                    <a:pt x="413" y="41"/>
                  </a:lnTo>
                  <a:lnTo>
                    <a:pt x="399" y="41"/>
                  </a:lnTo>
                  <a:lnTo>
                    <a:pt x="386" y="54"/>
                  </a:lnTo>
                  <a:lnTo>
                    <a:pt x="372" y="54"/>
                  </a:lnTo>
                  <a:lnTo>
                    <a:pt x="358" y="54"/>
                  </a:lnTo>
                  <a:lnTo>
                    <a:pt x="358" y="69"/>
                  </a:lnTo>
                  <a:lnTo>
                    <a:pt x="344" y="69"/>
                  </a:lnTo>
                  <a:lnTo>
                    <a:pt x="330" y="82"/>
                  </a:lnTo>
                  <a:lnTo>
                    <a:pt x="317" y="82"/>
                  </a:lnTo>
                  <a:lnTo>
                    <a:pt x="303" y="95"/>
                  </a:lnTo>
                  <a:lnTo>
                    <a:pt x="289" y="95"/>
                  </a:lnTo>
                  <a:lnTo>
                    <a:pt x="289" y="110"/>
                  </a:lnTo>
                  <a:lnTo>
                    <a:pt x="276" y="110"/>
                  </a:lnTo>
                  <a:lnTo>
                    <a:pt x="262" y="123"/>
                  </a:lnTo>
                  <a:lnTo>
                    <a:pt x="248" y="137"/>
                  </a:lnTo>
                  <a:lnTo>
                    <a:pt x="235" y="137"/>
                  </a:lnTo>
                  <a:lnTo>
                    <a:pt x="235" y="151"/>
                  </a:lnTo>
                  <a:lnTo>
                    <a:pt x="220" y="151"/>
                  </a:lnTo>
                  <a:lnTo>
                    <a:pt x="207" y="164"/>
                  </a:lnTo>
                  <a:lnTo>
                    <a:pt x="193" y="179"/>
                  </a:lnTo>
                  <a:lnTo>
                    <a:pt x="193" y="192"/>
                  </a:lnTo>
                  <a:lnTo>
                    <a:pt x="179" y="192"/>
                  </a:lnTo>
                  <a:lnTo>
                    <a:pt x="166" y="206"/>
                  </a:lnTo>
                  <a:lnTo>
                    <a:pt x="151" y="220"/>
                  </a:lnTo>
                  <a:lnTo>
                    <a:pt x="151" y="233"/>
                  </a:lnTo>
                  <a:lnTo>
                    <a:pt x="138" y="233"/>
                  </a:lnTo>
                  <a:lnTo>
                    <a:pt x="138" y="247"/>
                  </a:lnTo>
                  <a:lnTo>
                    <a:pt x="125" y="261"/>
                  </a:lnTo>
                  <a:lnTo>
                    <a:pt x="110" y="274"/>
                  </a:lnTo>
                  <a:lnTo>
                    <a:pt x="110" y="288"/>
                  </a:lnTo>
                  <a:lnTo>
                    <a:pt x="97" y="288"/>
                  </a:lnTo>
                  <a:lnTo>
                    <a:pt x="97" y="302"/>
                  </a:lnTo>
                  <a:lnTo>
                    <a:pt x="84" y="316"/>
                  </a:lnTo>
                  <a:lnTo>
                    <a:pt x="84" y="330"/>
                  </a:lnTo>
                  <a:lnTo>
                    <a:pt x="69" y="343"/>
                  </a:lnTo>
                  <a:lnTo>
                    <a:pt x="69" y="357"/>
                  </a:lnTo>
                  <a:lnTo>
                    <a:pt x="56" y="357"/>
                  </a:lnTo>
                  <a:lnTo>
                    <a:pt x="56" y="371"/>
                  </a:lnTo>
                  <a:lnTo>
                    <a:pt x="56" y="385"/>
                  </a:lnTo>
                  <a:lnTo>
                    <a:pt x="41" y="398"/>
                  </a:lnTo>
                  <a:lnTo>
                    <a:pt x="41" y="412"/>
                  </a:lnTo>
                  <a:lnTo>
                    <a:pt x="28" y="426"/>
                  </a:lnTo>
                  <a:lnTo>
                    <a:pt x="28" y="439"/>
                  </a:lnTo>
                  <a:lnTo>
                    <a:pt x="28" y="453"/>
                  </a:lnTo>
                  <a:lnTo>
                    <a:pt x="15" y="467"/>
                  </a:lnTo>
                  <a:lnTo>
                    <a:pt x="15" y="481"/>
                  </a:lnTo>
                  <a:lnTo>
                    <a:pt x="15" y="495"/>
                  </a:lnTo>
                  <a:lnTo>
                    <a:pt x="15" y="508"/>
                  </a:lnTo>
                  <a:lnTo>
                    <a:pt x="15" y="522"/>
                  </a:lnTo>
                  <a:lnTo>
                    <a:pt x="0" y="522"/>
                  </a:lnTo>
                  <a:lnTo>
                    <a:pt x="0" y="536"/>
                  </a:lnTo>
                  <a:lnTo>
                    <a:pt x="0" y="549"/>
                  </a:lnTo>
                  <a:lnTo>
                    <a:pt x="0" y="564"/>
                  </a:lnTo>
                  <a:lnTo>
                    <a:pt x="0" y="577"/>
                  </a:lnTo>
                  <a:lnTo>
                    <a:pt x="0" y="590"/>
                  </a:lnTo>
                  <a:lnTo>
                    <a:pt x="0" y="605"/>
                  </a:lnTo>
                  <a:lnTo>
                    <a:pt x="0" y="618"/>
                  </a:lnTo>
                  <a:lnTo>
                    <a:pt x="0" y="632"/>
                  </a:lnTo>
                  <a:lnTo>
                    <a:pt x="0" y="646"/>
                  </a:lnTo>
                  <a:lnTo>
                    <a:pt x="0" y="659"/>
                  </a:lnTo>
                  <a:lnTo>
                    <a:pt x="0" y="674"/>
                  </a:lnTo>
                  <a:lnTo>
                    <a:pt x="0" y="687"/>
                  </a:lnTo>
                  <a:lnTo>
                    <a:pt x="0" y="700"/>
                  </a:lnTo>
                  <a:lnTo>
                    <a:pt x="0" y="715"/>
                  </a:lnTo>
                  <a:lnTo>
                    <a:pt x="0" y="728"/>
                  </a:lnTo>
                  <a:lnTo>
                    <a:pt x="0" y="742"/>
                  </a:lnTo>
                  <a:lnTo>
                    <a:pt x="0" y="756"/>
                  </a:lnTo>
                  <a:lnTo>
                    <a:pt x="0" y="769"/>
                  </a:lnTo>
                  <a:lnTo>
                    <a:pt x="0" y="784"/>
                  </a:lnTo>
                  <a:lnTo>
                    <a:pt x="15" y="784"/>
                  </a:lnTo>
                  <a:lnTo>
                    <a:pt x="15" y="797"/>
                  </a:lnTo>
                  <a:lnTo>
                    <a:pt x="15" y="810"/>
                  </a:lnTo>
                  <a:lnTo>
                    <a:pt x="15" y="825"/>
                  </a:lnTo>
                  <a:lnTo>
                    <a:pt x="15" y="838"/>
                  </a:lnTo>
                  <a:lnTo>
                    <a:pt x="28" y="852"/>
                  </a:lnTo>
                  <a:lnTo>
                    <a:pt x="28" y="866"/>
                  </a:lnTo>
                  <a:lnTo>
                    <a:pt x="28" y="879"/>
                  </a:lnTo>
                  <a:lnTo>
                    <a:pt x="41" y="893"/>
                  </a:lnTo>
                  <a:lnTo>
                    <a:pt x="41" y="907"/>
                  </a:lnTo>
                  <a:lnTo>
                    <a:pt x="56" y="921"/>
                  </a:lnTo>
                  <a:lnTo>
                    <a:pt x="56" y="935"/>
                  </a:lnTo>
                  <a:lnTo>
                    <a:pt x="56" y="948"/>
                  </a:lnTo>
                  <a:lnTo>
                    <a:pt x="69" y="948"/>
                  </a:lnTo>
                  <a:lnTo>
                    <a:pt x="69" y="962"/>
                  </a:lnTo>
                  <a:lnTo>
                    <a:pt x="84" y="976"/>
                  </a:lnTo>
                  <a:lnTo>
                    <a:pt x="84" y="989"/>
                  </a:lnTo>
                  <a:lnTo>
                    <a:pt x="97" y="1003"/>
                  </a:lnTo>
                  <a:lnTo>
                    <a:pt x="97" y="1017"/>
                  </a:lnTo>
                  <a:lnTo>
                    <a:pt x="110" y="1017"/>
                  </a:lnTo>
                  <a:lnTo>
                    <a:pt x="110" y="1031"/>
                  </a:lnTo>
                  <a:lnTo>
                    <a:pt x="125" y="1045"/>
                  </a:lnTo>
                  <a:lnTo>
                    <a:pt x="138" y="1058"/>
                  </a:lnTo>
                  <a:lnTo>
                    <a:pt x="138" y="1072"/>
                  </a:lnTo>
                  <a:lnTo>
                    <a:pt x="151" y="1072"/>
                  </a:lnTo>
                  <a:lnTo>
                    <a:pt x="151" y="1086"/>
                  </a:lnTo>
                  <a:lnTo>
                    <a:pt x="166" y="1100"/>
                  </a:lnTo>
                  <a:lnTo>
                    <a:pt x="179" y="1113"/>
                  </a:lnTo>
                  <a:lnTo>
                    <a:pt x="193" y="1113"/>
                  </a:lnTo>
                  <a:lnTo>
                    <a:pt x="193" y="1127"/>
                  </a:lnTo>
                  <a:lnTo>
                    <a:pt x="207" y="1141"/>
                  </a:lnTo>
                  <a:lnTo>
                    <a:pt x="220" y="1154"/>
                  </a:lnTo>
                  <a:lnTo>
                    <a:pt x="235" y="1154"/>
                  </a:lnTo>
                  <a:lnTo>
                    <a:pt x="235" y="1168"/>
                  </a:lnTo>
                  <a:lnTo>
                    <a:pt x="248" y="1168"/>
                  </a:lnTo>
                  <a:lnTo>
                    <a:pt x="262" y="1182"/>
                  </a:lnTo>
                  <a:lnTo>
                    <a:pt x="276" y="1196"/>
                  </a:lnTo>
                  <a:lnTo>
                    <a:pt x="289" y="1196"/>
                  </a:lnTo>
                  <a:lnTo>
                    <a:pt x="289" y="1210"/>
                  </a:lnTo>
                  <a:lnTo>
                    <a:pt x="303" y="1210"/>
                  </a:lnTo>
                  <a:lnTo>
                    <a:pt x="317" y="1223"/>
                  </a:lnTo>
                  <a:lnTo>
                    <a:pt x="330" y="1223"/>
                  </a:lnTo>
                  <a:lnTo>
                    <a:pt x="344" y="1237"/>
                  </a:lnTo>
                  <a:lnTo>
                    <a:pt x="358" y="1237"/>
                  </a:lnTo>
                  <a:lnTo>
                    <a:pt x="358" y="1251"/>
                  </a:lnTo>
                  <a:lnTo>
                    <a:pt x="372" y="1251"/>
                  </a:lnTo>
                  <a:lnTo>
                    <a:pt x="386" y="1251"/>
                  </a:lnTo>
                  <a:lnTo>
                    <a:pt x="399" y="1264"/>
                  </a:lnTo>
                  <a:lnTo>
                    <a:pt x="413" y="1264"/>
                  </a:lnTo>
                  <a:lnTo>
                    <a:pt x="427" y="1279"/>
                  </a:lnTo>
                  <a:lnTo>
                    <a:pt x="441" y="1279"/>
                  </a:lnTo>
                  <a:lnTo>
                    <a:pt x="454" y="1279"/>
                  </a:lnTo>
                  <a:lnTo>
                    <a:pt x="468" y="1292"/>
                  </a:lnTo>
                  <a:lnTo>
                    <a:pt x="482" y="1292"/>
                  </a:lnTo>
                  <a:lnTo>
                    <a:pt x="495" y="1292"/>
                  </a:lnTo>
                  <a:lnTo>
                    <a:pt x="509" y="1292"/>
                  </a:lnTo>
                  <a:lnTo>
                    <a:pt x="523" y="1292"/>
                  </a:lnTo>
                  <a:lnTo>
                    <a:pt x="523" y="1305"/>
                  </a:lnTo>
                  <a:lnTo>
                    <a:pt x="537" y="1305"/>
                  </a:lnTo>
                  <a:lnTo>
                    <a:pt x="551" y="1305"/>
                  </a:lnTo>
                  <a:lnTo>
                    <a:pt x="564" y="1305"/>
                  </a:lnTo>
                  <a:lnTo>
                    <a:pt x="578" y="1305"/>
                  </a:lnTo>
                  <a:lnTo>
                    <a:pt x="592" y="1305"/>
                  </a:lnTo>
                  <a:lnTo>
                    <a:pt x="605" y="1305"/>
                  </a:lnTo>
                  <a:lnTo>
                    <a:pt x="620" y="1305"/>
                  </a:lnTo>
                  <a:lnTo>
                    <a:pt x="633" y="1305"/>
                  </a:lnTo>
                  <a:lnTo>
                    <a:pt x="646" y="1305"/>
                  </a:lnTo>
                  <a:lnTo>
                    <a:pt x="661" y="1305"/>
                  </a:lnTo>
                  <a:lnTo>
                    <a:pt x="674" y="1305"/>
                  </a:lnTo>
                  <a:lnTo>
                    <a:pt x="688" y="1305"/>
                  </a:lnTo>
                  <a:lnTo>
                    <a:pt x="702" y="1305"/>
                  </a:lnTo>
                  <a:lnTo>
                    <a:pt x="715" y="1305"/>
                  </a:lnTo>
                  <a:lnTo>
                    <a:pt x="730" y="1305"/>
                  </a:lnTo>
                  <a:lnTo>
                    <a:pt x="743" y="1305"/>
                  </a:lnTo>
                  <a:lnTo>
                    <a:pt x="756" y="1305"/>
                  </a:lnTo>
                  <a:lnTo>
                    <a:pt x="771" y="1305"/>
                  </a:lnTo>
                  <a:lnTo>
                    <a:pt x="784" y="1305"/>
                  </a:lnTo>
                  <a:lnTo>
                    <a:pt x="784" y="1292"/>
                  </a:lnTo>
                  <a:lnTo>
                    <a:pt x="799" y="1292"/>
                  </a:lnTo>
                  <a:lnTo>
                    <a:pt x="812" y="1292"/>
                  </a:lnTo>
                  <a:lnTo>
                    <a:pt x="825" y="1292"/>
                  </a:lnTo>
                  <a:lnTo>
                    <a:pt x="840" y="1292"/>
                  </a:lnTo>
                  <a:lnTo>
                    <a:pt x="853" y="1279"/>
                  </a:lnTo>
                  <a:lnTo>
                    <a:pt x="866" y="1279"/>
                  </a:lnTo>
                  <a:lnTo>
                    <a:pt x="881" y="1279"/>
                  </a:lnTo>
                  <a:lnTo>
                    <a:pt x="894" y="1264"/>
                  </a:lnTo>
                  <a:lnTo>
                    <a:pt x="908" y="1264"/>
                  </a:lnTo>
                  <a:lnTo>
                    <a:pt x="922" y="1251"/>
                  </a:lnTo>
                  <a:lnTo>
                    <a:pt x="935" y="1251"/>
                  </a:lnTo>
                  <a:lnTo>
                    <a:pt x="950" y="1251"/>
                  </a:lnTo>
                  <a:lnTo>
                    <a:pt x="950" y="1237"/>
                  </a:lnTo>
                  <a:lnTo>
                    <a:pt x="963" y="1237"/>
                  </a:lnTo>
                  <a:lnTo>
                    <a:pt x="977" y="1223"/>
                  </a:lnTo>
                  <a:lnTo>
                    <a:pt x="991" y="1223"/>
                  </a:lnTo>
                  <a:lnTo>
                    <a:pt x="1004" y="1210"/>
                  </a:lnTo>
                  <a:lnTo>
                    <a:pt x="1018" y="1210"/>
                  </a:lnTo>
                  <a:lnTo>
                    <a:pt x="1018" y="1196"/>
                  </a:lnTo>
                  <a:lnTo>
                    <a:pt x="1032" y="1196"/>
                  </a:lnTo>
                  <a:lnTo>
                    <a:pt x="1045" y="1182"/>
                  </a:lnTo>
                  <a:lnTo>
                    <a:pt x="1059" y="1168"/>
                  </a:lnTo>
                  <a:lnTo>
                    <a:pt x="1073" y="1168"/>
                  </a:lnTo>
                  <a:lnTo>
                    <a:pt x="1073" y="1154"/>
                  </a:lnTo>
                  <a:lnTo>
                    <a:pt x="1087" y="1154"/>
                  </a:lnTo>
                  <a:lnTo>
                    <a:pt x="1101" y="1141"/>
                  </a:lnTo>
                  <a:lnTo>
                    <a:pt x="1114" y="1127"/>
                  </a:lnTo>
                  <a:lnTo>
                    <a:pt x="1114" y="1113"/>
                  </a:lnTo>
                  <a:lnTo>
                    <a:pt x="1128" y="1113"/>
                  </a:lnTo>
                  <a:lnTo>
                    <a:pt x="1142" y="1100"/>
                  </a:lnTo>
                  <a:lnTo>
                    <a:pt x="1156" y="1086"/>
                  </a:lnTo>
                  <a:lnTo>
                    <a:pt x="1156" y="1072"/>
                  </a:lnTo>
                  <a:lnTo>
                    <a:pt x="1169" y="1072"/>
                  </a:lnTo>
                  <a:lnTo>
                    <a:pt x="1169" y="1058"/>
                  </a:lnTo>
                  <a:lnTo>
                    <a:pt x="1183" y="1045"/>
                  </a:lnTo>
                  <a:lnTo>
                    <a:pt x="1197" y="1031"/>
                  </a:lnTo>
                  <a:lnTo>
                    <a:pt x="1197" y="1017"/>
                  </a:lnTo>
                  <a:lnTo>
                    <a:pt x="1210" y="1017"/>
                  </a:lnTo>
                  <a:lnTo>
                    <a:pt x="1210" y="1003"/>
                  </a:lnTo>
                  <a:lnTo>
                    <a:pt x="1224" y="989"/>
                  </a:lnTo>
                  <a:lnTo>
                    <a:pt x="1224" y="976"/>
                  </a:lnTo>
                  <a:lnTo>
                    <a:pt x="1238" y="962"/>
                  </a:lnTo>
                  <a:lnTo>
                    <a:pt x="1238" y="948"/>
                  </a:lnTo>
                  <a:lnTo>
                    <a:pt x="1252" y="948"/>
                  </a:lnTo>
                  <a:lnTo>
                    <a:pt x="1252" y="935"/>
                  </a:lnTo>
                  <a:lnTo>
                    <a:pt x="1252" y="921"/>
                  </a:lnTo>
                  <a:lnTo>
                    <a:pt x="1266" y="907"/>
                  </a:lnTo>
                  <a:lnTo>
                    <a:pt x="1266" y="893"/>
                  </a:lnTo>
                  <a:lnTo>
                    <a:pt x="1279" y="879"/>
                  </a:lnTo>
                  <a:lnTo>
                    <a:pt x="1279" y="866"/>
                  </a:lnTo>
                  <a:lnTo>
                    <a:pt x="1279" y="852"/>
                  </a:lnTo>
                  <a:lnTo>
                    <a:pt x="1293" y="838"/>
                  </a:lnTo>
                  <a:lnTo>
                    <a:pt x="1293" y="825"/>
                  </a:lnTo>
                  <a:lnTo>
                    <a:pt x="1293" y="810"/>
                  </a:lnTo>
                  <a:lnTo>
                    <a:pt x="1293" y="797"/>
                  </a:lnTo>
                  <a:lnTo>
                    <a:pt x="1293" y="784"/>
                  </a:lnTo>
                  <a:lnTo>
                    <a:pt x="1307" y="784"/>
                  </a:lnTo>
                  <a:lnTo>
                    <a:pt x="1307" y="769"/>
                  </a:lnTo>
                  <a:lnTo>
                    <a:pt x="1307" y="756"/>
                  </a:lnTo>
                  <a:lnTo>
                    <a:pt x="1307" y="742"/>
                  </a:lnTo>
                  <a:lnTo>
                    <a:pt x="1307" y="728"/>
                  </a:lnTo>
                  <a:lnTo>
                    <a:pt x="1307" y="715"/>
                  </a:lnTo>
                  <a:lnTo>
                    <a:pt x="1307" y="700"/>
                  </a:lnTo>
                  <a:lnTo>
                    <a:pt x="1307" y="687"/>
                  </a:lnTo>
                  <a:lnTo>
                    <a:pt x="1307" y="674"/>
                  </a:lnTo>
                  <a:lnTo>
                    <a:pt x="1307" y="659"/>
                  </a:lnTo>
                  <a:lnTo>
                    <a:pt x="1320" y="659"/>
                  </a:lnTo>
                  <a:close/>
                </a:path>
              </a:pathLst>
            </a:custGeom>
            <a:solidFill>
              <a:srgbClr val="ff33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1600" bIns="216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7" name=""/>
            <p:cNvSpPr/>
            <p:nvPr/>
          </p:nvSpPr>
          <p:spPr>
            <a:xfrm>
              <a:off x="3371400" y="1702080"/>
              <a:ext cx="214560" cy="214200"/>
            </a:xfrm>
            <a:prstGeom prst="rect">
              <a:avLst/>
            </a:prstGeom>
            <a:noFill/>
            <a:ln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8" name=""/>
            <p:cNvSpPr/>
            <p:nvPr/>
          </p:nvSpPr>
          <p:spPr>
            <a:xfrm>
              <a:off x="3409200" y="1739520"/>
              <a:ext cx="141120" cy="140400"/>
            </a:xfrm>
            <a:custGeom>
              <a:avLst/>
              <a:gdLst/>
              <a:ahLst/>
              <a:rect l="l" t="t" r="r" b="b"/>
              <a:pathLst>
                <a:path w="2709" h="2695">
                  <a:moveTo>
                    <a:pt x="2709" y="1348"/>
                  </a:moveTo>
                  <a:lnTo>
                    <a:pt x="2695" y="1320"/>
                  </a:lnTo>
                  <a:lnTo>
                    <a:pt x="2695" y="1307"/>
                  </a:lnTo>
                  <a:lnTo>
                    <a:pt x="2695" y="1279"/>
                  </a:lnTo>
                  <a:lnTo>
                    <a:pt x="2695" y="1251"/>
                  </a:lnTo>
                  <a:lnTo>
                    <a:pt x="2695" y="1224"/>
                  </a:lnTo>
                  <a:lnTo>
                    <a:pt x="2695" y="1210"/>
                  </a:lnTo>
                  <a:lnTo>
                    <a:pt x="2695" y="1182"/>
                  </a:lnTo>
                  <a:lnTo>
                    <a:pt x="2695" y="1155"/>
                  </a:lnTo>
                  <a:lnTo>
                    <a:pt x="2681" y="1141"/>
                  </a:lnTo>
                  <a:lnTo>
                    <a:pt x="2681" y="1114"/>
                  </a:lnTo>
                  <a:lnTo>
                    <a:pt x="2681" y="1086"/>
                  </a:lnTo>
                  <a:lnTo>
                    <a:pt x="2668" y="1073"/>
                  </a:lnTo>
                  <a:lnTo>
                    <a:pt x="2668" y="1045"/>
                  </a:lnTo>
                  <a:lnTo>
                    <a:pt x="2668" y="1017"/>
                  </a:lnTo>
                  <a:lnTo>
                    <a:pt x="2654" y="1004"/>
                  </a:lnTo>
                  <a:lnTo>
                    <a:pt x="2654" y="976"/>
                  </a:lnTo>
                  <a:lnTo>
                    <a:pt x="2640" y="949"/>
                  </a:lnTo>
                  <a:lnTo>
                    <a:pt x="2640" y="935"/>
                  </a:lnTo>
                  <a:lnTo>
                    <a:pt x="2626" y="907"/>
                  </a:lnTo>
                  <a:lnTo>
                    <a:pt x="2626" y="880"/>
                  </a:lnTo>
                  <a:lnTo>
                    <a:pt x="2612" y="866"/>
                  </a:lnTo>
                  <a:lnTo>
                    <a:pt x="2599" y="838"/>
                  </a:lnTo>
                  <a:lnTo>
                    <a:pt x="2599" y="825"/>
                  </a:lnTo>
                  <a:lnTo>
                    <a:pt x="2585" y="797"/>
                  </a:lnTo>
                  <a:lnTo>
                    <a:pt x="2571" y="771"/>
                  </a:lnTo>
                  <a:lnTo>
                    <a:pt x="2571" y="756"/>
                  </a:lnTo>
                  <a:lnTo>
                    <a:pt x="2558" y="728"/>
                  </a:lnTo>
                  <a:lnTo>
                    <a:pt x="2544" y="715"/>
                  </a:lnTo>
                  <a:lnTo>
                    <a:pt x="2530" y="687"/>
                  </a:lnTo>
                  <a:lnTo>
                    <a:pt x="2516" y="674"/>
                  </a:lnTo>
                  <a:lnTo>
                    <a:pt x="2503" y="646"/>
                  </a:lnTo>
                  <a:lnTo>
                    <a:pt x="2503" y="633"/>
                  </a:lnTo>
                  <a:lnTo>
                    <a:pt x="2489" y="605"/>
                  </a:lnTo>
                  <a:lnTo>
                    <a:pt x="2475" y="591"/>
                  </a:lnTo>
                  <a:lnTo>
                    <a:pt x="2461" y="577"/>
                  </a:lnTo>
                  <a:lnTo>
                    <a:pt x="2447" y="550"/>
                  </a:lnTo>
                  <a:lnTo>
                    <a:pt x="2434" y="536"/>
                  </a:lnTo>
                  <a:lnTo>
                    <a:pt x="2420" y="509"/>
                  </a:lnTo>
                  <a:lnTo>
                    <a:pt x="2406" y="495"/>
                  </a:lnTo>
                  <a:lnTo>
                    <a:pt x="2379" y="481"/>
                  </a:lnTo>
                  <a:lnTo>
                    <a:pt x="2365" y="454"/>
                  </a:lnTo>
                  <a:lnTo>
                    <a:pt x="2352" y="440"/>
                  </a:lnTo>
                  <a:lnTo>
                    <a:pt x="2337" y="426"/>
                  </a:lnTo>
                  <a:lnTo>
                    <a:pt x="2324" y="412"/>
                  </a:lnTo>
                  <a:lnTo>
                    <a:pt x="2310" y="385"/>
                  </a:lnTo>
                  <a:lnTo>
                    <a:pt x="2283" y="371"/>
                  </a:lnTo>
                  <a:lnTo>
                    <a:pt x="2268" y="358"/>
                  </a:lnTo>
                  <a:lnTo>
                    <a:pt x="2255" y="344"/>
                  </a:lnTo>
                  <a:lnTo>
                    <a:pt x="2242" y="330"/>
                  </a:lnTo>
                  <a:lnTo>
                    <a:pt x="2214" y="316"/>
                  </a:lnTo>
                  <a:lnTo>
                    <a:pt x="2200" y="289"/>
                  </a:lnTo>
                  <a:lnTo>
                    <a:pt x="2186" y="275"/>
                  </a:lnTo>
                  <a:lnTo>
                    <a:pt x="2158" y="261"/>
                  </a:lnTo>
                  <a:lnTo>
                    <a:pt x="2145" y="248"/>
                  </a:lnTo>
                  <a:lnTo>
                    <a:pt x="2117" y="233"/>
                  </a:lnTo>
                  <a:lnTo>
                    <a:pt x="2104" y="220"/>
                  </a:lnTo>
                  <a:lnTo>
                    <a:pt x="2090" y="207"/>
                  </a:lnTo>
                  <a:lnTo>
                    <a:pt x="2063" y="192"/>
                  </a:lnTo>
                  <a:lnTo>
                    <a:pt x="2048" y="192"/>
                  </a:lnTo>
                  <a:lnTo>
                    <a:pt x="2022" y="179"/>
                  </a:lnTo>
                  <a:lnTo>
                    <a:pt x="2007" y="165"/>
                  </a:lnTo>
                  <a:lnTo>
                    <a:pt x="1980" y="151"/>
                  </a:lnTo>
                  <a:lnTo>
                    <a:pt x="1966" y="138"/>
                  </a:lnTo>
                  <a:lnTo>
                    <a:pt x="1939" y="123"/>
                  </a:lnTo>
                  <a:lnTo>
                    <a:pt x="1925" y="123"/>
                  </a:lnTo>
                  <a:lnTo>
                    <a:pt x="1897" y="110"/>
                  </a:lnTo>
                  <a:lnTo>
                    <a:pt x="1870" y="97"/>
                  </a:lnTo>
                  <a:lnTo>
                    <a:pt x="1856" y="97"/>
                  </a:lnTo>
                  <a:lnTo>
                    <a:pt x="1829" y="82"/>
                  </a:lnTo>
                  <a:lnTo>
                    <a:pt x="1815" y="69"/>
                  </a:lnTo>
                  <a:lnTo>
                    <a:pt x="1788" y="69"/>
                  </a:lnTo>
                  <a:lnTo>
                    <a:pt x="1760" y="54"/>
                  </a:lnTo>
                  <a:lnTo>
                    <a:pt x="1746" y="54"/>
                  </a:lnTo>
                  <a:lnTo>
                    <a:pt x="1719" y="41"/>
                  </a:lnTo>
                  <a:lnTo>
                    <a:pt x="1691" y="41"/>
                  </a:lnTo>
                  <a:lnTo>
                    <a:pt x="1678" y="28"/>
                  </a:lnTo>
                  <a:lnTo>
                    <a:pt x="1650" y="28"/>
                  </a:lnTo>
                  <a:lnTo>
                    <a:pt x="1622" y="28"/>
                  </a:lnTo>
                  <a:lnTo>
                    <a:pt x="1609" y="13"/>
                  </a:lnTo>
                  <a:lnTo>
                    <a:pt x="1581" y="13"/>
                  </a:lnTo>
                  <a:lnTo>
                    <a:pt x="1553" y="13"/>
                  </a:lnTo>
                  <a:lnTo>
                    <a:pt x="1540" y="0"/>
                  </a:lnTo>
                  <a:lnTo>
                    <a:pt x="1512" y="0"/>
                  </a:lnTo>
                  <a:lnTo>
                    <a:pt x="1486" y="0"/>
                  </a:lnTo>
                  <a:lnTo>
                    <a:pt x="1471" y="0"/>
                  </a:lnTo>
                  <a:lnTo>
                    <a:pt x="1443" y="0"/>
                  </a:lnTo>
                  <a:lnTo>
                    <a:pt x="1417" y="0"/>
                  </a:lnTo>
                  <a:lnTo>
                    <a:pt x="1389" y="0"/>
                  </a:lnTo>
                  <a:lnTo>
                    <a:pt x="1375" y="0"/>
                  </a:lnTo>
                  <a:lnTo>
                    <a:pt x="1348" y="0"/>
                  </a:lnTo>
                  <a:lnTo>
                    <a:pt x="1320" y="0"/>
                  </a:lnTo>
                  <a:lnTo>
                    <a:pt x="1307" y="0"/>
                  </a:lnTo>
                  <a:lnTo>
                    <a:pt x="1279" y="0"/>
                  </a:lnTo>
                  <a:lnTo>
                    <a:pt x="1251" y="0"/>
                  </a:lnTo>
                  <a:lnTo>
                    <a:pt x="1224" y="0"/>
                  </a:lnTo>
                  <a:lnTo>
                    <a:pt x="1210" y="0"/>
                  </a:lnTo>
                  <a:lnTo>
                    <a:pt x="1182" y="0"/>
                  </a:lnTo>
                  <a:lnTo>
                    <a:pt x="1155" y="0"/>
                  </a:lnTo>
                  <a:lnTo>
                    <a:pt x="1141" y="13"/>
                  </a:lnTo>
                  <a:lnTo>
                    <a:pt x="1114" y="13"/>
                  </a:lnTo>
                  <a:lnTo>
                    <a:pt x="1086" y="13"/>
                  </a:lnTo>
                  <a:lnTo>
                    <a:pt x="1073" y="28"/>
                  </a:lnTo>
                  <a:lnTo>
                    <a:pt x="1045" y="28"/>
                  </a:lnTo>
                  <a:lnTo>
                    <a:pt x="1017" y="28"/>
                  </a:lnTo>
                  <a:lnTo>
                    <a:pt x="1004" y="41"/>
                  </a:lnTo>
                  <a:lnTo>
                    <a:pt x="976" y="41"/>
                  </a:lnTo>
                  <a:lnTo>
                    <a:pt x="949" y="54"/>
                  </a:lnTo>
                  <a:lnTo>
                    <a:pt x="935" y="54"/>
                  </a:lnTo>
                  <a:lnTo>
                    <a:pt x="907" y="69"/>
                  </a:lnTo>
                  <a:lnTo>
                    <a:pt x="880" y="69"/>
                  </a:lnTo>
                  <a:lnTo>
                    <a:pt x="866" y="82"/>
                  </a:lnTo>
                  <a:lnTo>
                    <a:pt x="838" y="97"/>
                  </a:lnTo>
                  <a:lnTo>
                    <a:pt x="825" y="97"/>
                  </a:lnTo>
                  <a:lnTo>
                    <a:pt x="797" y="110"/>
                  </a:lnTo>
                  <a:lnTo>
                    <a:pt x="771" y="123"/>
                  </a:lnTo>
                  <a:lnTo>
                    <a:pt x="756" y="123"/>
                  </a:lnTo>
                  <a:lnTo>
                    <a:pt x="728" y="138"/>
                  </a:lnTo>
                  <a:lnTo>
                    <a:pt x="715" y="151"/>
                  </a:lnTo>
                  <a:lnTo>
                    <a:pt x="687" y="165"/>
                  </a:lnTo>
                  <a:lnTo>
                    <a:pt x="674" y="179"/>
                  </a:lnTo>
                  <a:lnTo>
                    <a:pt x="646" y="192"/>
                  </a:lnTo>
                  <a:lnTo>
                    <a:pt x="633" y="192"/>
                  </a:lnTo>
                  <a:lnTo>
                    <a:pt x="605" y="207"/>
                  </a:lnTo>
                  <a:lnTo>
                    <a:pt x="591" y="220"/>
                  </a:lnTo>
                  <a:lnTo>
                    <a:pt x="577" y="233"/>
                  </a:lnTo>
                  <a:lnTo>
                    <a:pt x="550" y="248"/>
                  </a:lnTo>
                  <a:lnTo>
                    <a:pt x="536" y="261"/>
                  </a:lnTo>
                  <a:lnTo>
                    <a:pt x="509" y="275"/>
                  </a:lnTo>
                  <a:lnTo>
                    <a:pt x="495" y="289"/>
                  </a:lnTo>
                  <a:lnTo>
                    <a:pt x="481" y="316"/>
                  </a:lnTo>
                  <a:lnTo>
                    <a:pt x="454" y="330"/>
                  </a:lnTo>
                  <a:lnTo>
                    <a:pt x="440" y="344"/>
                  </a:lnTo>
                  <a:lnTo>
                    <a:pt x="426" y="358"/>
                  </a:lnTo>
                  <a:lnTo>
                    <a:pt x="412" y="371"/>
                  </a:lnTo>
                  <a:lnTo>
                    <a:pt x="385" y="385"/>
                  </a:lnTo>
                  <a:lnTo>
                    <a:pt x="371" y="412"/>
                  </a:lnTo>
                  <a:lnTo>
                    <a:pt x="358" y="426"/>
                  </a:lnTo>
                  <a:lnTo>
                    <a:pt x="344" y="440"/>
                  </a:lnTo>
                  <a:lnTo>
                    <a:pt x="330" y="454"/>
                  </a:lnTo>
                  <a:lnTo>
                    <a:pt x="316" y="481"/>
                  </a:lnTo>
                  <a:lnTo>
                    <a:pt x="289" y="495"/>
                  </a:lnTo>
                  <a:lnTo>
                    <a:pt x="275" y="509"/>
                  </a:lnTo>
                  <a:lnTo>
                    <a:pt x="261" y="536"/>
                  </a:lnTo>
                  <a:lnTo>
                    <a:pt x="248" y="550"/>
                  </a:lnTo>
                  <a:lnTo>
                    <a:pt x="233" y="577"/>
                  </a:lnTo>
                  <a:lnTo>
                    <a:pt x="220" y="591"/>
                  </a:lnTo>
                  <a:lnTo>
                    <a:pt x="207" y="605"/>
                  </a:lnTo>
                  <a:lnTo>
                    <a:pt x="192" y="633"/>
                  </a:lnTo>
                  <a:lnTo>
                    <a:pt x="192" y="646"/>
                  </a:lnTo>
                  <a:lnTo>
                    <a:pt x="179" y="674"/>
                  </a:lnTo>
                  <a:lnTo>
                    <a:pt x="165" y="687"/>
                  </a:lnTo>
                  <a:lnTo>
                    <a:pt x="151" y="715"/>
                  </a:lnTo>
                  <a:lnTo>
                    <a:pt x="138" y="728"/>
                  </a:lnTo>
                  <a:lnTo>
                    <a:pt x="123" y="756"/>
                  </a:lnTo>
                  <a:lnTo>
                    <a:pt x="123" y="771"/>
                  </a:lnTo>
                  <a:lnTo>
                    <a:pt x="110" y="797"/>
                  </a:lnTo>
                  <a:lnTo>
                    <a:pt x="97" y="825"/>
                  </a:lnTo>
                  <a:lnTo>
                    <a:pt x="97" y="838"/>
                  </a:lnTo>
                  <a:lnTo>
                    <a:pt x="82" y="866"/>
                  </a:lnTo>
                  <a:lnTo>
                    <a:pt x="69" y="880"/>
                  </a:lnTo>
                  <a:lnTo>
                    <a:pt x="69" y="907"/>
                  </a:lnTo>
                  <a:lnTo>
                    <a:pt x="54" y="935"/>
                  </a:lnTo>
                  <a:lnTo>
                    <a:pt x="54" y="949"/>
                  </a:lnTo>
                  <a:lnTo>
                    <a:pt x="41" y="976"/>
                  </a:lnTo>
                  <a:lnTo>
                    <a:pt x="41" y="1004"/>
                  </a:lnTo>
                  <a:lnTo>
                    <a:pt x="28" y="1017"/>
                  </a:lnTo>
                  <a:lnTo>
                    <a:pt x="28" y="1045"/>
                  </a:lnTo>
                  <a:lnTo>
                    <a:pt x="28" y="1073"/>
                  </a:lnTo>
                  <a:lnTo>
                    <a:pt x="13" y="1086"/>
                  </a:lnTo>
                  <a:lnTo>
                    <a:pt x="13" y="1114"/>
                  </a:lnTo>
                  <a:lnTo>
                    <a:pt x="13" y="1141"/>
                  </a:lnTo>
                  <a:lnTo>
                    <a:pt x="0" y="1155"/>
                  </a:lnTo>
                  <a:lnTo>
                    <a:pt x="0" y="1182"/>
                  </a:lnTo>
                  <a:lnTo>
                    <a:pt x="0" y="1210"/>
                  </a:lnTo>
                  <a:lnTo>
                    <a:pt x="0" y="1224"/>
                  </a:lnTo>
                  <a:lnTo>
                    <a:pt x="0" y="1251"/>
                  </a:lnTo>
                  <a:lnTo>
                    <a:pt x="0" y="1279"/>
                  </a:lnTo>
                  <a:lnTo>
                    <a:pt x="0" y="1307"/>
                  </a:lnTo>
                  <a:lnTo>
                    <a:pt x="0" y="1320"/>
                  </a:lnTo>
                  <a:lnTo>
                    <a:pt x="0" y="1348"/>
                  </a:lnTo>
                  <a:lnTo>
                    <a:pt x="0" y="1375"/>
                  </a:lnTo>
                  <a:lnTo>
                    <a:pt x="0" y="1389"/>
                  </a:lnTo>
                  <a:lnTo>
                    <a:pt x="0" y="1417"/>
                  </a:lnTo>
                  <a:lnTo>
                    <a:pt x="0" y="1443"/>
                  </a:lnTo>
                  <a:lnTo>
                    <a:pt x="0" y="1471"/>
                  </a:lnTo>
                  <a:lnTo>
                    <a:pt x="0" y="1486"/>
                  </a:lnTo>
                  <a:lnTo>
                    <a:pt x="0" y="1512"/>
                  </a:lnTo>
                  <a:lnTo>
                    <a:pt x="0" y="1540"/>
                  </a:lnTo>
                  <a:lnTo>
                    <a:pt x="13" y="1553"/>
                  </a:lnTo>
                  <a:lnTo>
                    <a:pt x="13" y="1581"/>
                  </a:lnTo>
                  <a:lnTo>
                    <a:pt x="13" y="1609"/>
                  </a:lnTo>
                  <a:lnTo>
                    <a:pt x="28" y="1622"/>
                  </a:lnTo>
                  <a:lnTo>
                    <a:pt x="28" y="1650"/>
                  </a:lnTo>
                  <a:lnTo>
                    <a:pt x="28" y="1678"/>
                  </a:lnTo>
                  <a:lnTo>
                    <a:pt x="41" y="1691"/>
                  </a:lnTo>
                  <a:lnTo>
                    <a:pt x="41" y="1719"/>
                  </a:lnTo>
                  <a:lnTo>
                    <a:pt x="54" y="1746"/>
                  </a:lnTo>
                  <a:lnTo>
                    <a:pt x="54" y="1760"/>
                  </a:lnTo>
                  <a:lnTo>
                    <a:pt x="69" y="1788"/>
                  </a:lnTo>
                  <a:lnTo>
                    <a:pt x="69" y="1815"/>
                  </a:lnTo>
                  <a:lnTo>
                    <a:pt x="82" y="1829"/>
                  </a:lnTo>
                  <a:lnTo>
                    <a:pt x="97" y="1856"/>
                  </a:lnTo>
                  <a:lnTo>
                    <a:pt x="97" y="1870"/>
                  </a:lnTo>
                  <a:lnTo>
                    <a:pt x="110" y="1897"/>
                  </a:lnTo>
                  <a:lnTo>
                    <a:pt x="123" y="1925"/>
                  </a:lnTo>
                  <a:lnTo>
                    <a:pt x="123" y="1939"/>
                  </a:lnTo>
                  <a:lnTo>
                    <a:pt x="138" y="1966"/>
                  </a:lnTo>
                  <a:lnTo>
                    <a:pt x="151" y="1980"/>
                  </a:lnTo>
                  <a:lnTo>
                    <a:pt x="165" y="2007"/>
                  </a:lnTo>
                  <a:lnTo>
                    <a:pt x="179" y="2022"/>
                  </a:lnTo>
                  <a:lnTo>
                    <a:pt x="192" y="2048"/>
                  </a:lnTo>
                  <a:lnTo>
                    <a:pt x="192" y="2063"/>
                  </a:lnTo>
                  <a:lnTo>
                    <a:pt x="207" y="2090"/>
                  </a:lnTo>
                  <a:lnTo>
                    <a:pt x="220" y="2104"/>
                  </a:lnTo>
                  <a:lnTo>
                    <a:pt x="233" y="2117"/>
                  </a:lnTo>
                  <a:lnTo>
                    <a:pt x="248" y="2145"/>
                  </a:lnTo>
                  <a:lnTo>
                    <a:pt x="261" y="2158"/>
                  </a:lnTo>
                  <a:lnTo>
                    <a:pt x="275" y="2186"/>
                  </a:lnTo>
                  <a:lnTo>
                    <a:pt x="289" y="2200"/>
                  </a:lnTo>
                  <a:lnTo>
                    <a:pt x="316" y="2214"/>
                  </a:lnTo>
                  <a:lnTo>
                    <a:pt x="330" y="2242"/>
                  </a:lnTo>
                  <a:lnTo>
                    <a:pt x="344" y="2255"/>
                  </a:lnTo>
                  <a:lnTo>
                    <a:pt x="358" y="2268"/>
                  </a:lnTo>
                  <a:lnTo>
                    <a:pt x="371" y="2283"/>
                  </a:lnTo>
                  <a:lnTo>
                    <a:pt x="385" y="2310"/>
                  </a:lnTo>
                  <a:lnTo>
                    <a:pt x="412" y="2324"/>
                  </a:lnTo>
                  <a:lnTo>
                    <a:pt x="426" y="2337"/>
                  </a:lnTo>
                  <a:lnTo>
                    <a:pt x="440" y="2352"/>
                  </a:lnTo>
                  <a:lnTo>
                    <a:pt x="454" y="2365"/>
                  </a:lnTo>
                  <a:lnTo>
                    <a:pt x="481" y="2379"/>
                  </a:lnTo>
                  <a:lnTo>
                    <a:pt x="495" y="2406"/>
                  </a:lnTo>
                  <a:lnTo>
                    <a:pt x="509" y="2420"/>
                  </a:lnTo>
                  <a:lnTo>
                    <a:pt x="536" y="2434"/>
                  </a:lnTo>
                  <a:lnTo>
                    <a:pt x="550" y="2447"/>
                  </a:lnTo>
                  <a:lnTo>
                    <a:pt x="577" y="2461"/>
                  </a:lnTo>
                  <a:lnTo>
                    <a:pt x="591" y="2475"/>
                  </a:lnTo>
                  <a:lnTo>
                    <a:pt x="605" y="2489"/>
                  </a:lnTo>
                  <a:lnTo>
                    <a:pt x="633" y="2503"/>
                  </a:lnTo>
                  <a:lnTo>
                    <a:pt x="646" y="2503"/>
                  </a:lnTo>
                  <a:lnTo>
                    <a:pt x="674" y="2516"/>
                  </a:lnTo>
                  <a:lnTo>
                    <a:pt x="687" y="2530"/>
                  </a:lnTo>
                  <a:lnTo>
                    <a:pt x="715" y="2544"/>
                  </a:lnTo>
                  <a:lnTo>
                    <a:pt x="728" y="2558"/>
                  </a:lnTo>
                  <a:lnTo>
                    <a:pt x="756" y="2571"/>
                  </a:lnTo>
                  <a:lnTo>
                    <a:pt x="771" y="2571"/>
                  </a:lnTo>
                  <a:lnTo>
                    <a:pt x="797" y="2585"/>
                  </a:lnTo>
                  <a:lnTo>
                    <a:pt x="825" y="2599"/>
                  </a:lnTo>
                  <a:lnTo>
                    <a:pt x="838" y="2599"/>
                  </a:lnTo>
                  <a:lnTo>
                    <a:pt x="866" y="2612"/>
                  </a:lnTo>
                  <a:lnTo>
                    <a:pt x="880" y="2626"/>
                  </a:lnTo>
                  <a:lnTo>
                    <a:pt x="907" y="2626"/>
                  </a:lnTo>
                  <a:lnTo>
                    <a:pt x="935" y="2640"/>
                  </a:lnTo>
                  <a:lnTo>
                    <a:pt x="949" y="2640"/>
                  </a:lnTo>
                  <a:lnTo>
                    <a:pt x="976" y="2654"/>
                  </a:lnTo>
                  <a:lnTo>
                    <a:pt x="1004" y="2654"/>
                  </a:lnTo>
                  <a:lnTo>
                    <a:pt x="1017" y="2668"/>
                  </a:lnTo>
                  <a:lnTo>
                    <a:pt x="1045" y="2668"/>
                  </a:lnTo>
                  <a:lnTo>
                    <a:pt x="1073" y="2668"/>
                  </a:lnTo>
                  <a:lnTo>
                    <a:pt x="1086" y="2681"/>
                  </a:lnTo>
                  <a:lnTo>
                    <a:pt x="1114" y="2681"/>
                  </a:lnTo>
                  <a:lnTo>
                    <a:pt x="1141" y="2681"/>
                  </a:lnTo>
                  <a:lnTo>
                    <a:pt x="1155" y="2695"/>
                  </a:lnTo>
                  <a:lnTo>
                    <a:pt x="1182" y="2695"/>
                  </a:lnTo>
                  <a:lnTo>
                    <a:pt x="1210" y="2695"/>
                  </a:lnTo>
                  <a:lnTo>
                    <a:pt x="1224" y="2695"/>
                  </a:lnTo>
                  <a:lnTo>
                    <a:pt x="1251" y="2695"/>
                  </a:lnTo>
                  <a:lnTo>
                    <a:pt x="1279" y="2695"/>
                  </a:lnTo>
                  <a:lnTo>
                    <a:pt x="1307" y="2695"/>
                  </a:lnTo>
                  <a:lnTo>
                    <a:pt x="1320" y="2695"/>
                  </a:lnTo>
                  <a:lnTo>
                    <a:pt x="1348" y="2695"/>
                  </a:lnTo>
                  <a:lnTo>
                    <a:pt x="1375" y="2695"/>
                  </a:lnTo>
                  <a:lnTo>
                    <a:pt x="1389" y="2695"/>
                  </a:lnTo>
                  <a:lnTo>
                    <a:pt x="1417" y="2695"/>
                  </a:lnTo>
                  <a:lnTo>
                    <a:pt x="1443" y="2695"/>
                  </a:lnTo>
                  <a:lnTo>
                    <a:pt x="1471" y="2695"/>
                  </a:lnTo>
                  <a:lnTo>
                    <a:pt x="1486" y="2695"/>
                  </a:lnTo>
                  <a:lnTo>
                    <a:pt x="1512" y="2695"/>
                  </a:lnTo>
                  <a:lnTo>
                    <a:pt x="1540" y="2695"/>
                  </a:lnTo>
                  <a:lnTo>
                    <a:pt x="1553" y="2681"/>
                  </a:lnTo>
                  <a:lnTo>
                    <a:pt x="1581" y="2681"/>
                  </a:lnTo>
                  <a:lnTo>
                    <a:pt x="1609" y="2681"/>
                  </a:lnTo>
                  <a:lnTo>
                    <a:pt x="1622" y="2668"/>
                  </a:lnTo>
                  <a:lnTo>
                    <a:pt x="1650" y="2668"/>
                  </a:lnTo>
                  <a:lnTo>
                    <a:pt x="1678" y="2668"/>
                  </a:lnTo>
                  <a:lnTo>
                    <a:pt x="1691" y="2654"/>
                  </a:lnTo>
                  <a:lnTo>
                    <a:pt x="1719" y="2654"/>
                  </a:lnTo>
                  <a:lnTo>
                    <a:pt x="1746" y="2640"/>
                  </a:lnTo>
                  <a:lnTo>
                    <a:pt x="1760" y="2640"/>
                  </a:lnTo>
                  <a:lnTo>
                    <a:pt x="1788" y="2626"/>
                  </a:lnTo>
                  <a:lnTo>
                    <a:pt x="1815" y="2626"/>
                  </a:lnTo>
                  <a:lnTo>
                    <a:pt x="1829" y="2612"/>
                  </a:lnTo>
                  <a:lnTo>
                    <a:pt x="1856" y="2599"/>
                  </a:lnTo>
                  <a:lnTo>
                    <a:pt x="1870" y="2599"/>
                  </a:lnTo>
                  <a:lnTo>
                    <a:pt x="1897" y="2585"/>
                  </a:lnTo>
                  <a:lnTo>
                    <a:pt x="1925" y="2571"/>
                  </a:lnTo>
                  <a:lnTo>
                    <a:pt x="1939" y="2571"/>
                  </a:lnTo>
                  <a:lnTo>
                    <a:pt x="1966" y="2558"/>
                  </a:lnTo>
                  <a:lnTo>
                    <a:pt x="1980" y="2544"/>
                  </a:lnTo>
                  <a:lnTo>
                    <a:pt x="2007" y="2530"/>
                  </a:lnTo>
                  <a:lnTo>
                    <a:pt x="2022" y="2516"/>
                  </a:lnTo>
                  <a:lnTo>
                    <a:pt x="2048" y="2503"/>
                  </a:lnTo>
                  <a:lnTo>
                    <a:pt x="2063" y="2503"/>
                  </a:lnTo>
                  <a:lnTo>
                    <a:pt x="2090" y="2489"/>
                  </a:lnTo>
                  <a:lnTo>
                    <a:pt x="2104" y="2475"/>
                  </a:lnTo>
                  <a:lnTo>
                    <a:pt x="2117" y="2461"/>
                  </a:lnTo>
                  <a:lnTo>
                    <a:pt x="2145" y="2447"/>
                  </a:lnTo>
                  <a:lnTo>
                    <a:pt x="2158" y="2434"/>
                  </a:lnTo>
                  <a:lnTo>
                    <a:pt x="2186" y="2420"/>
                  </a:lnTo>
                  <a:lnTo>
                    <a:pt x="2200" y="2406"/>
                  </a:lnTo>
                  <a:lnTo>
                    <a:pt x="2214" y="2379"/>
                  </a:lnTo>
                  <a:lnTo>
                    <a:pt x="2242" y="2365"/>
                  </a:lnTo>
                  <a:lnTo>
                    <a:pt x="2255" y="2352"/>
                  </a:lnTo>
                  <a:lnTo>
                    <a:pt x="2268" y="2337"/>
                  </a:lnTo>
                  <a:lnTo>
                    <a:pt x="2283" y="2324"/>
                  </a:lnTo>
                  <a:lnTo>
                    <a:pt x="2310" y="2310"/>
                  </a:lnTo>
                  <a:lnTo>
                    <a:pt x="2324" y="2283"/>
                  </a:lnTo>
                  <a:lnTo>
                    <a:pt x="2337" y="2268"/>
                  </a:lnTo>
                  <a:lnTo>
                    <a:pt x="2352" y="2255"/>
                  </a:lnTo>
                  <a:lnTo>
                    <a:pt x="2365" y="2242"/>
                  </a:lnTo>
                  <a:lnTo>
                    <a:pt x="2379" y="2214"/>
                  </a:lnTo>
                  <a:lnTo>
                    <a:pt x="2406" y="2200"/>
                  </a:lnTo>
                  <a:lnTo>
                    <a:pt x="2420" y="2186"/>
                  </a:lnTo>
                  <a:lnTo>
                    <a:pt x="2434" y="2158"/>
                  </a:lnTo>
                  <a:lnTo>
                    <a:pt x="2447" y="2145"/>
                  </a:lnTo>
                  <a:lnTo>
                    <a:pt x="2461" y="2117"/>
                  </a:lnTo>
                  <a:lnTo>
                    <a:pt x="2475" y="2104"/>
                  </a:lnTo>
                  <a:lnTo>
                    <a:pt x="2489" y="2090"/>
                  </a:lnTo>
                  <a:lnTo>
                    <a:pt x="2503" y="2063"/>
                  </a:lnTo>
                  <a:lnTo>
                    <a:pt x="2503" y="2048"/>
                  </a:lnTo>
                  <a:lnTo>
                    <a:pt x="2516" y="2022"/>
                  </a:lnTo>
                  <a:lnTo>
                    <a:pt x="2530" y="2007"/>
                  </a:lnTo>
                  <a:lnTo>
                    <a:pt x="2544" y="1980"/>
                  </a:lnTo>
                  <a:lnTo>
                    <a:pt x="2558" y="1966"/>
                  </a:lnTo>
                  <a:lnTo>
                    <a:pt x="2571" y="1939"/>
                  </a:lnTo>
                  <a:lnTo>
                    <a:pt x="2571" y="1925"/>
                  </a:lnTo>
                  <a:lnTo>
                    <a:pt x="2585" y="1897"/>
                  </a:lnTo>
                  <a:lnTo>
                    <a:pt x="2599" y="1870"/>
                  </a:lnTo>
                  <a:lnTo>
                    <a:pt x="2599" y="1856"/>
                  </a:lnTo>
                  <a:lnTo>
                    <a:pt x="2612" y="1829"/>
                  </a:lnTo>
                  <a:lnTo>
                    <a:pt x="2626" y="1815"/>
                  </a:lnTo>
                  <a:lnTo>
                    <a:pt x="2626" y="1788"/>
                  </a:lnTo>
                  <a:lnTo>
                    <a:pt x="2640" y="1760"/>
                  </a:lnTo>
                  <a:lnTo>
                    <a:pt x="2640" y="1746"/>
                  </a:lnTo>
                  <a:lnTo>
                    <a:pt x="2654" y="1719"/>
                  </a:lnTo>
                  <a:lnTo>
                    <a:pt x="2654" y="1691"/>
                  </a:lnTo>
                  <a:lnTo>
                    <a:pt x="2668" y="1678"/>
                  </a:lnTo>
                  <a:lnTo>
                    <a:pt x="2668" y="1650"/>
                  </a:lnTo>
                  <a:lnTo>
                    <a:pt x="2668" y="1622"/>
                  </a:lnTo>
                  <a:lnTo>
                    <a:pt x="2681" y="1609"/>
                  </a:lnTo>
                  <a:lnTo>
                    <a:pt x="2681" y="1581"/>
                  </a:lnTo>
                  <a:lnTo>
                    <a:pt x="2681" y="1553"/>
                  </a:lnTo>
                  <a:lnTo>
                    <a:pt x="2695" y="1540"/>
                  </a:lnTo>
                  <a:lnTo>
                    <a:pt x="2695" y="1512"/>
                  </a:lnTo>
                  <a:lnTo>
                    <a:pt x="2695" y="1486"/>
                  </a:lnTo>
                  <a:lnTo>
                    <a:pt x="2695" y="1471"/>
                  </a:lnTo>
                  <a:lnTo>
                    <a:pt x="2695" y="1443"/>
                  </a:lnTo>
                  <a:lnTo>
                    <a:pt x="2695" y="1417"/>
                  </a:lnTo>
                  <a:lnTo>
                    <a:pt x="2695" y="1389"/>
                  </a:lnTo>
                  <a:lnTo>
                    <a:pt x="2695" y="1375"/>
                  </a:lnTo>
                  <a:lnTo>
                    <a:pt x="2709" y="1348"/>
                  </a:lnTo>
                  <a:close/>
                </a:path>
              </a:pathLst>
            </a:custGeom>
            <a:solidFill>
              <a:srgbClr val="ff33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79" name=""/>
          <p:cNvGrpSpPr/>
          <p:nvPr/>
        </p:nvGrpSpPr>
        <p:grpSpPr>
          <a:xfrm>
            <a:off x="4808520" y="4462560"/>
            <a:ext cx="290520" cy="155520"/>
            <a:chOff x="4808520" y="4462560"/>
            <a:chExt cx="290520" cy="155520"/>
          </a:xfrm>
        </p:grpSpPr>
        <p:sp>
          <p:nvSpPr>
            <p:cNvPr id="80" name=""/>
            <p:cNvSpPr/>
            <p:nvPr/>
          </p:nvSpPr>
          <p:spPr>
            <a:xfrm>
              <a:off x="4808520" y="4618080"/>
              <a:ext cx="290520" cy="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1" name=""/>
            <p:cNvSpPr/>
            <p:nvPr/>
          </p:nvSpPr>
          <p:spPr>
            <a:xfrm>
              <a:off x="4822920" y="4462560"/>
              <a:ext cx="0" cy="14580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82" name=""/>
          <p:cNvSpPr/>
          <p:nvPr/>
        </p:nvSpPr>
        <p:spPr>
          <a:xfrm>
            <a:off x="4250160" y="4411800"/>
            <a:ext cx="5893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40 sp/s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3" name=""/>
          <p:cNvSpPr/>
          <p:nvPr/>
        </p:nvSpPr>
        <p:spPr>
          <a:xfrm>
            <a:off x="4784040" y="4589640"/>
            <a:ext cx="3499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1 s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4" name=""/>
          <p:cNvSpPr/>
          <p:nvPr/>
        </p:nvSpPr>
        <p:spPr>
          <a:xfrm>
            <a:off x="2673360" y="855720"/>
            <a:ext cx="28584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0</a:t>
            </a:r>
            <a:r>
              <a:rPr b="0" lang="en-US" sz="900" spc="-1" strike="noStrike">
                <a:solidFill>
                  <a:srgbClr val="000000"/>
                </a:solidFill>
                <a:latin typeface="Arial"/>
                <a:ea typeface="Times New Roman"/>
              </a:rPr>
              <a:t>º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5" name=""/>
          <p:cNvSpPr/>
          <p:nvPr/>
        </p:nvSpPr>
        <p:spPr>
          <a:xfrm>
            <a:off x="2860200" y="855720"/>
            <a:ext cx="34992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90</a:t>
            </a:r>
            <a:r>
              <a:rPr b="0" lang="en-US" sz="900" spc="-1" strike="noStrike">
                <a:solidFill>
                  <a:srgbClr val="000000"/>
                </a:solidFill>
                <a:latin typeface="Arial"/>
                <a:ea typeface="Times New Roman"/>
              </a:rPr>
              <a:t>º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6" name=""/>
          <p:cNvSpPr/>
          <p:nvPr/>
        </p:nvSpPr>
        <p:spPr>
          <a:xfrm>
            <a:off x="3033360" y="855720"/>
            <a:ext cx="41364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180</a:t>
            </a:r>
            <a:r>
              <a:rPr b="0" lang="en-US" sz="900" spc="-1" strike="noStrike">
                <a:solidFill>
                  <a:srgbClr val="000000"/>
                </a:solidFill>
                <a:latin typeface="Arial"/>
                <a:ea typeface="Times New Roman"/>
              </a:rPr>
              <a:t>º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7" name=""/>
          <p:cNvSpPr/>
          <p:nvPr/>
        </p:nvSpPr>
        <p:spPr>
          <a:xfrm>
            <a:off x="3266640" y="855720"/>
            <a:ext cx="41364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270</a:t>
            </a:r>
            <a:r>
              <a:rPr b="0" lang="en-US" sz="900" spc="-1" strike="noStrike">
                <a:solidFill>
                  <a:srgbClr val="000000"/>
                </a:solidFill>
                <a:latin typeface="Arial"/>
                <a:ea typeface="Times New Roman"/>
              </a:rPr>
              <a:t>º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8" name=""/>
          <p:cNvSpPr/>
          <p:nvPr/>
        </p:nvSpPr>
        <p:spPr>
          <a:xfrm>
            <a:off x="2414520" y="1071720"/>
            <a:ext cx="28584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0</a:t>
            </a:r>
            <a:r>
              <a:rPr b="0" lang="en-US" sz="900" spc="-1" strike="noStrike">
                <a:solidFill>
                  <a:srgbClr val="000000"/>
                </a:solidFill>
                <a:latin typeface="Arial"/>
                <a:ea typeface="Times New Roman"/>
              </a:rPr>
              <a:t>º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9" name=""/>
          <p:cNvSpPr/>
          <p:nvPr/>
        </p:nvSpPr>
        <p:spPr>
          <a:xfrm>
            <a:off x="2350440" y="1290600"/>
            <a:ext cx="34992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90</a:t>
            </a:r>
            <a:r>
              <a:rPr b="0" lang="en-US" sz="900" spc="-1" strike="noStrike">
                <a:solidFill>
                  <a:srgbClr val="000000"/>
                </a:solidFill>
                <a:latin typeface="Arial"/>
                <a:ea typeface="Times New Roman"/>
              </a:rPr>
              <a:t>º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0" name=""/>
          <p:cNvSpPr/>
          <p:nvPr/>
        </p:nvSpPr>
        <p:spPr>
          <a:xfrm>
            <a:off x="2287080" y="1728720"/>
            <a:ext cx="41364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270</a:t>
            </a:r>
            <a:r>
              <a:rPr b="0" lang="en-US" sz="900" spc="-1" strike="noStrike">
                <a:solidFill>
                  <a:srgbClr val="000000"/>
                </a:solidFill>
                <a:latin typeface="Arial"/>
                <a:ea typeface="Times New Roman"/>
              </a:rPr>
              <a:t>º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1" name=""/>
          <p:cNvSpPr/>
          <p:nvPr/>
        </p:nvSpPr>
        <p:spPr>
          <a:xfrm rot="16200000">
            <a:off x="1672560" y="1242720"/>
            <a:ext cx="945720" cy="398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Remembered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location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2" name=""/>
          <p:cNvSpPr/>
          <p:nvPr/>
        </p:nvSpPr>
        <p:spPr>
          <a:xfrm>
            <a:off x="2539800" y="700200"/>
            <a:ext cx="11545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Attended location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3" name=""/>
          <p:cNvSpPr/>
          <p:nvPr/>
        </p:nvSpPr>
        <p:spPr>
          <a:xfrm>
            <a:off x="2271240" y="1509840"/>
            <a:ext cx="41364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180</a:t>
            </a:r>
            <a:r>
              <a:rPr b="0" lang="en-US" sz="900" spc="-1" strike="noStrike">
                <a:solidFill>
                  <a:srgbClr val="000000"/>
                </a:solidFill>
                <a:latin typeface="Arial"/>
                <a:ea typeface="Times New Roman"/>
              </a:rPr>
              <a:t>º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4" name=""/>
          <p:cNvSpPr/>
          <p:nvPr/>
        </p:nvSpPr>
        <p:spPr>
          <a:xfrm flipV="1">
            <a:off x="3143160" y="4297320"/>
            <a:ext cx="162000" cy="16056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5" name=""/>
          <p:cNvSpPr/>
          <p:nvPr/>
        </p:nvSpPr>
        <p:spPr>
          <a:xfrm>
            <a:off x="2765520" y="4430880"/>
            <a:ext cx="650160" cy="398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Brighten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or dim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6" name=""/>
          <p:cNvSpPr/>
          <p:nvPr/>
        </p:nvSpPr>
        <p:spPr>
          <a:xfrm>
            <a:off x="1206360" y="5504040"/>
            <a:ext cx="5048280" cy="855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r" pos="228600"/>
                <a:tab algn="r" pos="343080"/>
                <a:tab algn="l" pos="457200"/>
                <a:tab algn="l" pos="1714680"/>
                <a:tab algn="ctr" pos="2743200"/>
                <a:tab algn="l" pos="5200560"/>
                <a:tab algn="r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Supplementary Figure 2.  Rasters and histograms from a representative memory cell.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r" pos="228600"/>
                <a:tab algn="r" pos="343080"/>
                <a:tab algn="l" pos="457200"/>
                <a:tab algn="l" pos="1714680"/>
                <a:tab algn="ctr" pos="2743200"/>
                <a:tab algn="l" pos="5200560"/>
                <a:tab algn="r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r" pos="228600"/>
                <a:tab algn="r" pos="343080"/>
                <a:tab algn="l" pos="457200"/>
                <a:tab algn="l" pos="1714680"/>
                <a:tab algn="ctr" pos="2743200"/>
                <a:tab algn="l" pos="5200560"/>
                <a:tab algn="r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The activity matrix is the same as in Figure 3B, measured in the 800 ms prior to the trigger stimulus.  Format as in Supplementary Figure 1.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r" pos="228600"/>
                <a:tab algn="r" pos="343080"/>
                <a:tab algn="l" pos="457200"/>
                <a:tab algn="l" pos="1714680"/>
                <a:tab algn="ctr" pos="2743200"/>
                <a:tab algn="l" pos="5200560"/>
                <a:tab algn="r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4-09-08T19:43:40Z</dcterms:created>
  <dc:creator>Chelsea Scholl</dc:creator>
  <dc:description/>
  <dc:language>en-US</dc:language>
  <cp:lastModifiedBy>Chelsea Scholl</cp:lastModifiedBy>
  <dcterms:modified xsi:type="dcterms:W3CDTF">2004-09-08T19:44:03Z</dcterms:modified>
  <cp:revision>1</cp:revision>
  <dc:subject/>
  <dc:title>Slide 1</dc:title>
</cp:coreProperties>
</file>